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06" r:id="rId1"/>
  </p:sldMasterIdLst>
  <p:notesMasterIdLst>
    <p:notesMasterId r:id="rId16"/>
  </p:notesMasterIdLst>
  <p:handoutMasterIdLst>
    <p:handoutMasterId r:id="rId17"/>
  </p:handoutMasterIdLst>
  <p:sldIdLst>
    <p:sldId id="303" r:id="rId2"/>
    <p:sldId id="257" r:id="rId3"/>
    <p:sldId id="290" r:id="rId4"/>
    <p:sldId id="268" r:id="rId5"/>
    <p:sldId id="291" r:id="rId6"/>
    <p:sldId id="293" r:id="rId7"/>
    <p:sldId id="294" r:id="rId8"/>
    <p:sldId id="295" r:id="rId9"/>
    <p:sldId id="296" r:id="rId10"/>
    <p:sldId id="297" r:id="rId11"/>
    <p:sldId id="298" r:id="rId12"/>
    <p:sldId id="301" r:id="rId13"/>
    <p:sldId id="300" r:id="rId14"/>
    <p:sldId id="289" r:id="rId1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91" userDrawn="1">
          <p15:clr>
            <a:srgbClr val="A4A3A4"/>
          </p15:clr>
        </p15:guide>
        <p15:guide id="2" orient="horz" pos="4033" userDrawn="1">
          <p15:clr>
            <a:srgbClr val="A4A3A4"/>
          </p15:clr>
        </p15:guide>
        <p15:guide id="3" orient="horz" pos="1904" userDrawn="1">
          <p15:clr>
            <a:srgbClr val="A4A3A4"/>
          </p15:clr>
        </p15:guide>
        <p15:guide id="4" pos="5473" userDrawn="1">
          <p15:clr>
            <a:srgbClr val="A4A3A4"/>
          </p15:clr>
        </p15:guide>
        <p15:guide id="5" pos="432" userDrawn="1">
          <p15:clr>
            <a:srgbClr val="A4A3A4"/>
          </p15:clr>
        </p15:guide>
        <p15:guide id="6" pos="2776" userDrawn="1">
          <p15:clr>
            <a:srgbClr val="A4A3A4"/>
          </p15:clr>
        </p15:guide>
        <p15:guide id="7" orient="horz" pos="379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  <a:srgbClr val="B9AFC8"/>
    <a:srgbClr val="836CA2"/>
    <a:srgbClr val="53565A"/>
    <a:srgbClr val="2D2D2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E17234F-0EF8-4715-B424-83382A1CF564}" v="166" dt="2021-03-10T20:30:10.825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895" autoAdjust="0"/>
    <p:restoredTop sz="94660"/>
  </p:normalViewPr>
  <p:slideViewPr>
    <p:cSldViewPr snapToGrid="0" snapToObjects="1">
      <p:cViewPr varScale="1">
        <p:scale>
          <a:sx n="122" d="100"/>
          <a:sy n="122" d="100"/>
        </p:scale>
        <p:origin x="200" y="232"/>
      </p:cViewPr>
      <p:guideLst>
        <p:guide orient="horz" pos="291"/>
        <p:guide orient="horz" pos="4033"/>
        <p:guide orient="horz" pos="1904"/>
        <p:guide pos="5473"/>
        <p:guide pos="432"/>
        <p:guide pos="2776"/>
        <p:guide orient="horz" pos="3792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handoutMaster" Target="handoutMasters/handoutMaster1.xml"/><Relationship Id="rId2" Type="http://schemas.openxmlformats.org/officeDocument/2006/relationships/slide" Target="slides/slide1.xml"/><Relationship Id="rId16" Type="http://schemas.openxmlformats.org/officeDocument/2006/relationships/notesMaster" Target="notesMasters/notesMaster1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microsoft.com/office/2015/10/relationships/revisionInfo" Target="revisionInfo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B982044-5D26-E448-8696-F452F46A029F}" type="datetimeFigureOut">
              <a:rPr lang="en-US" smtClean="0"/>
              <a:t>4/12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159F134-A476-8F42-B0AF-2FFFE6F2B4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646119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9769D94-2B78-F841-9B5E-78BC59F8D0BB}" type="datetimeFigureOut">
              <a:rPr lang="en-US" smtClean="0"/>
              <a:t>4/12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73B1B5E-696F-8A4A-9730-0DDA82FF5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1819347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marL="0" algn="l" defTabSz="457189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189" algn="l" defTabSz="457189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377" algn="l" defTabSz="457189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566" algn="l" defTabSz="457189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754" algn="l" defTabSz="457189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5943" algn="l" defTabSz="457189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131" algn="l" defTabSz="457189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320" algn="l" defTabSz="457189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509" algn="l" defTabSz="457189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73B1B5E-696F-8A4A-9730-0DDA82FF5A34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3640359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73B1B5E-696F-8A4A-9730-0DDA82FF5A34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3030501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73B1B5E-696F-8A4A-9730-0DDA82FF5A34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5064000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73B1B5E-696F-8A4A-9730-0DDA82FF5A34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637802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73B1B5E-696F-8A4A-9730-0DDA82FF5A34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070531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>
                <a:cs typeface="Calibri"/>
              </a:rPr>
              <a:t>Authors ow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73B1B5E-696F-8A4A-9730-0DDA82FF5A34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395038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73B1B5E-696F-8A4A-9730-0DDA82FF5A34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513916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>
                <a:cs typeface="Calibri"/>
              </a:rPr>
              <a:t>Authors ow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73B1B5E-696F-8A4A-9730-0DDA82FF5A34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3992288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73B1B5E-696F-8A4A-9730-0DDA82FF5A34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3336928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73B1B5E-696F-8A4A-9730-0DDA82FF5A34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8843069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73B1B5E-696F-8A4A-9730-0DDA82FF5A34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635770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73B1B5E-696F-8A4A-9730-0DDA82FF5A34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21388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A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0" y="0"/>
            <a:ext cx="9144000" cy="5613613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0" y="0"/>
                </a:moveTo>
                <a:lnTo>
                  <a:pt x="9144000" y="0"/>
                </a:lnTo>
                <a:lnTo>
                  <a:pt x="9144000" y="3977640"/>
                </a:lnTo>
                <a:lnTo>
                  <a:pt x="939235" y="3977640"/>
                </a:lnTo>
                <a:lnTo>
                  <a:pt x="838395" y="4185971"/>
                </a:lnTo>
                <a:cubicBezTo>
                  <a:pt x="822041" y="4219181"/>
                  <a:pt x="801198" y="4217386"/>
                  <a:pt x="786640" y="4185971"/>
                </a:cubicBezTo>
                <a:lnTo>
                  <a:pt x="685800" y="3977640"/>
                </a:lnTo>
                <a:lnTo>
                  <a:pt x="0" y="3977640"/>
                </a:lnTo>
                <a:close/>
              </a:path>
            </a:pathLst>
          </a:custGeom>
          <a:solidFill>
            <a:srgbClr val="2D2D2D"/>
          </a:solidFill>
          <a:ln>
            <a:solidFill>
              <a:srgbClr val="2D2D2D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1839911"/>
            <a:ext cx="5943600" cy="2479879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30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PRESENTATION</a:t>
            </a:r>
            <a:br>
              <a:rPr lang="en-US" dirty="0"/>
            </a:br>
            <a:r>
              <a:rPr lang="en-US" dirty="0"/>
              <a:t>TITLE HER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685800" y="5833537"/>
            <a:ext cx="5943600" cy="768096"/>
          </a:xfrm>
        </p:spPr>
        <p:txBody>
          <a:bodyPr>
            <a:normAutofit/>
          </a:bodyPr>
          <a:lstStyle>
            <a:lvl1pPr marL="0" indent="0" algn="l">
              <a:lnSpc>
                <a:spcPct val="125000"/>
              </a:lnSpc>
              <a:spcBef>
                <a:spcPts val="0"/>
              </a:spcBef>
              <a:buNone/>
              <a:defRPr sz="1400" baseline="0">
                <a:solidFill>
                  <a:srgbClr val="FFFFFF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presentation subtitle or date</a:t>
            </a:r>
          </a:p>
        </p:txBody>
      </p:sp>
      <p:sp>
        <p:nvSpPr>
          <p:cNvPr id="20" name="Text Placeholder 10"/>
          <p:cNvSpPr>
            <a:spLocks noGrp="1"/>
          </p:cNvSpPr>
          <p:nvPr>
            <p:ph type="body" sz="quarter" idx="10" hasCustomPrompt="1"/>
          </p:nvPr>
        </p:nvSpPr>
        <p:spPr>
          <a:xfrm>
            <a:off x="685800" y="4525135"/>
            <a:ext cx="5943600" cy="679451"/>
          </a:xfrm>
        </p:spPr>
        <p:txBody>
          <a:bodyPr>
            <a:normAutofit/>
          </a:bodyPr>
          <a:lstStyle>
            <a:lvl1pPr indent="0">
              <a:lnSpc>
                <a:spcPct val="90000"/>
              </a:lnSpc>
              <a:spcBef>
                <a:spcPts val="0"/>
              </a:spcBef>
              <a:buFontTx/>
              <a:buNone/>
              <a:defRPr sz="1600" b="1" i="0" cap="all" baseline="0">
                <a:solidFill>
                  <a:schemeClr val="bg1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Insert subheading here if needed</a:t>
            </a:r>
          </a:p>
        </p:txBody>
      </p:sp>
      <p:sp>
        <p:nvSpPr>
          <p:cNvPr id="21" name="Text Placeholder 18"/>
          <p:cNvSpPr>
            <a:spLocks noGrp="1"/>
          </p:cNvSpPr>
          <p:nvPr>
            <p:ph type="body" sz="quarter" idx="11" hasCustomPrompt="1"/>
          </p:nvPr>
        </p:nvSpPr>
        <p:spPr>
          <a:xfrm>
            <a:off x="4570413" y="621792"/>
            <a:ext cx="4116387" cy="748912"/>
          </a:xfrm>
        </p:spPr>
        <p:txBody>
          <a:bodyPr>
            <a:normAutofit/>
          </a:bodyPr>
          <a:lstStyle>
            <a:lvl1pPr algn="r">
              <a:lnSpc>
                <a:spcPct val="125000"/>
              </a:lnSpc>
              <a:spcBef>
                <a:spcPts val="0"/>
              </a:spcBef>
              <a:defRPr sz="1400">
                <a:solidFill>
                  <a:schemeClr val="bg1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Division Name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7089" y="404121"/>
            <a:ext cx="1360263" cy="731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75041813"/>
      </p:ext>
    </p:extLst>
  </p:cSld>
  <p:clrMapOvr>
    <a:masterClrMapping/>
  </p:clrMapOvr>
  <p:hf hdr="0" dt="0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Image B - Whi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2" y="3619412"/>
            <a:ext cx="6904037" cy="614153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3"/>
          </p:nvPr>
        </p:nvSpPr>
        <p:spPr>
          <a:xfrm>
            <a:off x="0" y="-2"/>
            <a:ext cx="9144000" cy="3428619"/>
          </a:xfrm>
          <a:custGeom>
            <a:avLst/>
            <a:gdLst/>
            <a:ahLst/>
            <a:cxnLst/>
            <a:rect l="l" t="t" r="r" b="b"/>
            <a:pathLst>
              <a:path w="9144000" h="2571464">
                <a:moveTo>
                  <a:pt x="0" y="0"/>
                </a:moveTo>
                <a:lnTo>
                  <a:pt x="9144000" y="0"/>
                </a:lnTo>
                <a:lnTo>
                  <a:pt x="9144000" y="2341563"/>
                </a:lnTo>
                <a:lnTo>
                  <a:pt x="937943" y="2341563"/>
                </a:lnTo>
                <a:lnTo>
                  <a:pt x="838395" y="2547225"/>
                </a:lnTo>
                <a:cubicBezTo>
                  <a:pt x="822041" y="2580435"/>
                  <a:pt x="801198" y="2578640"/>
                  <a:pt x="786640" y="2547225"/>
                </a:cubicBezTo>
                <a:lnTo>
                  <a:pt x="687092" y="2341563"/>
                </a:lnTo>
                <a:lnTo>
                  <a:pt x="0" y="2341563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13" name="Content Placeholder 3"/>
          <p:cNvSpPr>
            <a:spLocks noGrp="1"/>
          </p:cNvSpPr>
          <p:nvPr>
            <p:ph sz="quarter" idx="15"/>
          </p:nvPr>
        </p:nvSpPr>
        <p:spPr>
          <a:xfrm>
            <a:off x="685800" y="4400551"/>
            <a:ext cx="6904038" cy="18288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/>
        <p:txBody>
          <a:bodyPr/>
          <a:lstStyle/>
          <a:p>
            <a:r>
              <a:rPr lang="en-US"/>
              <a:t>Division Name or Footer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7FEEEA1A-CB49-3744-AA40-B896987410F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18173086"/>
      </p:ext>
    </p:extLst>
  </p:cSld>
  <p:clrMapOvr>
    <a:masterClrMapping/>
  </p:clrMapOvr>
  <p:hf hdr="0" dt="0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Picture with Caption A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5752799"/>
            <a:ext cx="6904038" cy="545544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13" name="Picture Placeholder 5"/>
          <p:cNvSpPr>
            <a:spLocks noGrp="1"/>
          </p:cNvSpPr>
          <p:nvPr>
            <p:ph type="pic" sz="quarter" idx="13"/>
          </p:nvPr>
        </p:nvSpPr>
        <p:spPr>
          <a:xfrm>
            <a:off x="0" y="-1"/>
            <a:ext cx="9144000" cy="5613613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0" y="0"/>
                </a:moveTo>
                <a:lnTo>
                  <a:pt x="9144000" y="0"/>
                </a:lnTo>
                <a:lnTo>
                  <a:pt x="9144000" y="3978275"/>
                </a:lnTo>
                <a:lnTo>
                  <a:pt x="938928" y="3978275"/>
                </a:lnTo>
                <a:lnTo>
                  <a:pt x="838395" y="4185971"/>
                </a:lnTo>
                <a:cubicBezTo>
                  <a:pt x="822041" y="4219181"/>
                  <a:pt x="801198" y="4217386"/>
                  <a:pt x="786640" y="4185971"/>
                </a:cubicBezTo>
                <a:lnTo>
                  <a:pt x="686107" y="3978275"/>
                </a:lnTo>
                <a:lnTo>
                  <a:pt x="0" y="3978275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4"/>
          </p:nvPr>
        </p:nvSpPr>
        <p:spPr/>
        <p:txBody>
          <a:bodyPr/>
          <a:lstStyle/>
          <a:p>
            <a:r>
              <a:rPr lang="en-US"/>
              <a:t>Division Name or Footer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5"/>
          </p:nvPr>
        </p:nvSpPr>
        <p:spPr/>
        <p:txBody>
          <a:bodyPr/>
          <a:lstStyle/>
          <a:p>
            <a:fld id="{7FEEEA1A-CB49-3744-AA40-B896987410F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20924282"/>
      </p:ext>
    </p:extLst>
  </p:cSld>
  <p:clrMapOvr>
    <a:masterClrMapping/>
  </p:clrMapOvr>
  <p:hf hdr="0" dt="0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Picture with Caption B">
    <p:bg>
      <p:bgPr>
        <a:solidFill>
          <a:srgbClr val="2D2D2D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icture Placeholder 5"/>
          <p:cNvSpPr>
            <a:spLocks noGrp="1"/>
          </p:cNvSpPr>
          <p:nvPr>
            <p:ph type="pic" sz="quarter" idx="11"/>
          </p:nvPr>
        </p:nvSpPr>
        <p:spPr>
          <a:xfrm>
            <a:off x="0" y="1624073"/>
            <a:ext cx="9144000" cy="5242983"/>
          </a:xfrm>
          <a:custGeom>
            <a:avLst/>
            <a:gdLst/>
            <a:ahLst/>
            <a:cxnLst/>
            <a:rect l="l" t="t" r="r" b="b"/>
            <a:pathLst>
              <a:path w="9144000" h="3932237">
                <a:moveTo>
                  <a:pt x="0" y="0"/>
                </a:moveTo>
                <a:lnTo>
                  <a:pt x="688874" y="0"/>
                </a:lnTo>
                <a:lnTo>
                  <a:pt x="786640" y="201981"/>
                </a:lnTo>
                <a:cubicBezTo>
                  <a:pt x="801198" y="233396"/>
                  <a:pt x="822041" y="235191"/>
                  <a:pt x="838395" y="201981"/>
                </a:cubicBezTo>
                <a:lnTo>
                  <a:pt x="936161" y="0"/>
                </a:lnTo>
                <a:lnTo>
                  <a:pt x="9144000" y="0"/>
                </a:lnTo>
                <a:lnTo>
                  <a:pt x="9144000" y="3932237"/>
                </a:lnTo>
                <a:lnTo>
                  <a:pt x="0" y="3932237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588183"/>
            <a:ext cx="6904038" cy="925848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586829"/>
            <a:ext cx="793487" cy="426720"/>
          </a:xfrm>
          <a:prstGeom prst="rect">
            <a:avLst/>
          </a:prstGeom>
        </p:spPr>
      </p:pic>
      <p:sp>
        <p:nvSpPr>
          <p:cNvPr id="14" name="Rectangle 13"/>
          <p:cNvSpPr/>
          <p:nvPr/>
        </p:nvSpPr>
        <p:spPr>
          <a:xfrm>
            <a:off x="0" y="0"/>
            <a:ext cx="9144000" cy="24384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80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r>
              <a:rPr lang="en-US"/>
              <a:t>Division Name or Footer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3"/>
          </p:nvPr>
        </p:nvSpPr>
        <p:spPr/>
        <p:txBody>
          <a:bodyPr/>
          <a:lstStyle/>
          <a:p>
            <a:fld id="{7FEEEA1A-CB49-3744-AA40-B896987410F9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25279895"/>
      </p:ext>
    </p:extLst>
  </p:cSld>
  <p:clrMapOvr>
    <a:masterClrMapping/>
  </p:clrMapOvr>
  <p:hf hdr="0" dt="0"/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Last Page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25"/>
          <p:cNvSpPr>
            <a:spLocks noChangeAspect="1"/>
          </p:cNvSpPr>
          <p:nvPr/>
        </p:nvSpPr>
        <p:spPr>
          <a:xfrm rot="10800000">
            <a:off x="0" y="0"/>
            <a:ext cx="9144000" cy="5613613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9144000" y="4210210"/>
                </a:moveTo>
                <a:lnTo>
                  <a:pt x="0" y="421021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rgbClr val="2D2D2D"/>
          </a:solidFill>
          <a:ln w="19050">
            <a:solidFill>
              <a:srgbClr val="2D2D2D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6" name="TextBox 5"/>
          <p:cNvSpPr txBox="1"/>
          <p:nvPr/>
        </p:nvSpPr>
        <p:spPr>
          <a:xfrm>
            <a:off x="685801" y="1369841"/>
            <a:ext cx="2278957" cy="46166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3000" b="1" i="0" dirty="0">
                <a:solidFill>
                  <a:schemeClr val="bg1"/>
                </a:solidFill>
                <a:latin typeface="+mj-lt"/>
                <a:cs typeface="Arial"/>
              </a:rPr>
              <a:t>THANK YOU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7089" y="5852160"/>
            <a:ext cx="1360263" cy="731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93159750"/>
      </p:ext>
    </p:extLst>
  </p:cSld>
  <p:clrMapOvr>
    <a:masterClrMapping/>
  </p:clrMapOvr>
  <p:hf hdr="0" dt="0"/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userDrawn="1">
  <p:cSld name="Title Slide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0795" y="1686296"/>
            <a:ext cx="8006007" cy="970779"/>
          </a:xfrm>
        </p:spPr>
        <p:txBody>
          <a:bodyPr wrap="square" lIns="0" tIns="0" rIns="0" bIns="0" anchor="ctr" anchorCtr="0">
            <a:spAutoFit/>
          </a:bodyPr>
          <a:lstStyle>
            <a:lvl1pPr>
              <a:lnSpc>
                <a:spcPct val="83000"/>
              </a:lnSpc>
              <a:defRPr sz="3800" cap="all">
                <a:solidFill>
                  <a:schemeClr val="tx2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680795" y="3074388"/>
            <a:ext cx="8006007" cy="246221"/>
          </a:xfrm>
        </p:spPr>
        <p:txBody>
          <a:bodyPr wrap="square" lIns="0" tIns="0" rIns="0" bIns="0" anchor="ctr" anchorCtr="0">
            <a:spAutoFit/>
          </a:bodyPr>
          <a:lstStyle>
            <a:lvl1pPr marL="0" indent="0" algn="l">
              <a:buNone/>
              <a:defRPr sz="1600" b="0" i="0" cap="none" baseline="0">
                <a:solidFill>
                  <a:schemeClr val="tx2"/>
                </a:solidFill>
              </a:defRPr>
            </a:lvl1pPr>
            <a:lvl2pPr marL="34289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78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67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5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45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34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2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1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Master Subtitle Style</a:t>
            </a:r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1"/>
          </p:nvPr>
        </p:nvSpPr>
        <p:spPr>
          <a:xfrm>
            <a:off x="5006977" y="465192"/>
            <a:ext cx="3679825" cy="246221"/>
          </a:xfrm>
        </p:spPr>
        <p:txBody>
          <a:bodyPr anchor="ctr" anchorCtr="0">
            <a:spAutoFit/>
          </a:bodyPr>
          <a:lstStyle>
            <a:lvl1pPr marL="0" indent="0" algn="r">
              <a:buNone/>
              <a:defRPr sz="1600">
                <a:solidFill>
                  <a:schemeClr val="tx2"/>
                </a:solidFill>
              </a:defRPr>
            </a:lvl1pPr>
            <a:lvl2pPr marL="230182" indent="0">
              <a:buNone/>
              <a:defRPr/>
            </a:lvl2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8" name="Freeform 5"/>
          <p:cNvSpPr>
            <a:spLocks noEditPoints="1"/>
          </p:cNvSpPr>
          <p:nvPr userDrawn="1"/>
        </p:nvSpPr>
        <p:spPr bwMode="auto">
          <a:xfrm>
            <a:off x="590930" y="236940"/>
            <a:ext cx="1510380" cy="659561"/>
          </a:xfrm>
          <a:custGeom>
            <a:avLst/>
            <a:gdLst>
              <a:gd name="T0" fmla="*/ 32 w 511"/>
              <a:gd name="T1" fmla="*/ 39 h 221"/>
              <a:gd name="T2" fmla="*/ 106 w 511"/>
              <a:gd name="T3" fmla="*/ 0 h 221"/>
              <a:gd name="T4" fmla="*/ 188 w 511"/>
              <a:gd name="T5" fmla="*/ 44 h 221"/>
              <a:gd name="T6" fmla="*/ 139 w 511"/>
              <a:gd name="T7" fmla="*/ 208 h 221"/>
              <a:gd name="T8" fmla="*/ 161 w 511"/>
              <a:gd name="T9" fmla="*/ 194 h 221"/>
              <a:gd name="T10" fmla="*/ 2 w 511"/>
              <a:gd name="T11" fmla="*/ 101 h 221"/>
              <a:gd name="T12" fmla="*/ 91 w 511"/>
              <a:gd name="T13" fmla="*/ 70 h 221"/>
              <a:gd name="T14" fmla="*/ 123 w 511"/>
              <a:gd name="T15" fmla="*/ 108 h 221"/>
              <a:gd name="T16" fmla="*/ 208 w 511"/>
              <a:gd name="T17" fmla="*/ 70 h 221"/>
              <a:gd name="T18" fmla="*/ 73 w 511"/>
              <a:gd name="T19" fmla="*/ 70 h 221"/>
              <a:gd name="T20" fmla="*/ 53 w 511"/>
              <a:gd name="T21" fmla="*/ 96 h 221"/>
              <a:gd name="T22" fmla="*/ 54 w 511"/>
              <a:gd name="T23" fmla="*/ 70 h 221"/>
              <a:gd name="T24" fmla="*/ 144 w 511"/>
              <a:gd name="T25" fmla="*/ 70 h 221"/>
              <a:gd name="T26" fmla="*/ 175 w 511"/>
              <a:gd name="T27" fmla="*/ 70 h 221"/>
              <a:gd name="T28" fmla="*/ 267 w 511"/>
              <a:gd name="T29" fmla="*/ 206 h 221"/>
              <a:gd name="T30" fmla="*/ 267 w 511"/>
              <a:gd name="T31" fmla="*/ 193 h 221"/>
              <a:gd name="T32" fmla="*/ 259 w 511"/>
              <a:gd name="T33" fmla="*/ 199 h 221"/>
              <a:gd name="T34" fmla="*/ 416 w 511"/>
              <a:gd name="T35" fmla="*/ 92 h 221"/>
              <a:gd name="T36" fmla="*/ 402 w 511"/>
              <a:gd name="T37" fmla="*/ 86 h 221"/>
              <a:gd name="T38" fmla="*/ 402 w 511"/>
              <a:gd name="T39" fmla="*/ 123 h 221"/>
              <a:gd name="T40" fmla="*/ 397 w 511"/>
              <a:gd name="T41" fmla="*/ 184 h 221"/>
              <a:gd name="T42" fmla="*/ 373 w 511"/>
              <a:gd name="T43" fmla="*/ 152 h 221"/>
              <a:gd name="T44" fmla="*/ 511 w 511"/>
              <a:gd name="T45" fmla="*/ 124 h 221"/>
              <a:gd name="T46" fmla="*/ 511 w 511"/>
              <a:gd name="T47" fmla="*/ 111 h 221"/>
              <a:gd name="T48" fmla="*/ 503 w 511"/>
              <a:gd name="T49" fmla="*/ 117 h 221"/>
              <a:gd name="T50" fmla="*/ 487 w 511"/>
              <a:gd name="T51" fmla="*/ 105 h 221"/>
              <a:gd name="T52" fmla="*/ 450 w 511"/>
              <a:gd name="T53" fmla="*/ 98 h 221"/>
              <a:gd name="T54" fmla="*/ 443 w 511"/>
              <a:gd name="T55" fmla="*/ 87 h 221"/>
              <a:gd name="T56" fmla="*/ 366 w 511"/>
              <a:gd name="T57" fmla="*/ 169 h 221"/>
              <a:gd name="T58" fmla="*/ 365 w 511"/>
              <a:gd name="T59" fmla="*/ 205 h 221"/>
              <a:gd name="T60" fmla="*/ 343 w 511"/>
              <a:gd name="T61" fmla="*/ 203 h 221"/>
              <a:gd name="T62" fmla="*/ 343 w 511"/>
              <a:gd name="T63" fmla="*/ 156 h 221"/>
              <a:gd name="T64" fmla="*/ 318 w 511"/>
              <a:gd name="T65" fmla="*/ 133 h 221"/>
              <a:gd name="T66" fmla="*/ 294 w 511"/>
              <a:gd name="T67" fmla="*/ 133 h 221"/>
              <a:gd name="T68" fmla="*/ 332 w 511"/>
              <a:gd name="T69" fmla="*/ 98 h 221"/>
              <a:gd name="T70" fmla="*/ 271 w 511"/>
              <a:gd name="T71" fmla="*/ 103 h 221"/>
              <a:gd name="T72" fmla="*/ 249 w 511"/>
              <a:gd name="T73" fmla="*/ 94 h 221"/>
              <a:gd name="T74" fmla="*/ 286 w 511"/>
              <a:gd name="T75" fmla="*/ 132 h 221"/>
              <a:gd name="T76" fmla="*/ 261 w 511"/>
              <a:gd name="T77" fmla="*/ 119 h 221"/>
              <a:gd name="T78" fmla="*/ 311 w 511"/>
              <a:gd name="T79" fmla="*/ 215 h 221"/>
              <a:gd name="T80" fmla="*/ 272 w 511"/>
              <a:gd name="T81" fmla="*/ 203 h 221"/>
              <a:gd name="T82" fmla="*/ 280 w 511"/>
              <a:gd name="T83" fmla="*/ 184 h 221"/>
              <a:gd name="T84" fmla="*/ 309 w 511"/>
              <a:gd name="T85" fmla="*/ 203 h 221"/>
              <a:gd name="T86" fmla="*/ 296 w 511"/>
              <a:gd name="T87" fmla="*/ 201 h 221"/>
              <a:gd name="T88" fmla="*/ 318 w 511"/>
              <a:gd name="T89" fmla="*/ 215 h 221"/>
              <a:gd name="T90" fmla="*/ 208 w 511"/>
              <a:gd name="T91" fmla="*/ 215 h 221"/>
              <a:gd name="T92" fmla="*/ 174 w 511"/>
              <a:gd name="T93" fmla="*/ 153 h 221"/>
              <a:gd name="T94" fmla="*/ 342 w 511"/>
              <a:gd name="T95" fmla="*/ 130 h 221"/>
              <a:gd name="T96" fmla="*/ 370 w 511"/>
              <a:gd name="T97" fmla="*/ 90 h 221"/>
              <a:gd name="T98" fmla="*/ 374 w 511"/>
              <a:gd name="T99" fmla="*/ 98 h 221"/>
              <a:gd name="T100" fmla="*/ 354 w 511"/>
              <a:gd name="T101" fmla="*/ 122 h 221"/>
              <a:gd name="T102" fmla="*/ 342 w 511"/>
              <a:gd name="T103" fmla="*/ 130 h 221"/>
              <a:gd name="T104" fmla="*/ 352 w 511"/>
              <a:gd name="T105" fmla="*/ 103 h 221"/>
              <a:gd name="T106" fmla="*/ 351 w 511"/>
              <a:gd name="T107" fmla="*/ 133 h 2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</a:cxnLst>
            <a:rect l="0" t="0" r="r" b="b"/>
            <a:pathLst>
              <a:path w="511" h="221">
                <a:moveTo>
                  <a:pt x="188" y="44"/>
                </a:moveTo>
                <a:cubicBezTo>
                  <a:pt x="188" y="44"/>
                  <a:pt x="187" y="44"/>
                  <a:pt x="186" y="43"/>
                </a:cubicBezTo>
                <a:cubicBezTo>
                  <a:pt x="185" y="42"/>
                  <a:pt x="179" y="36"/>
                  <a:pt x="169" y="30"/>
                </a:cubicBezTo>
                <a:cubicBezTo>
                  <a:pt x="159" y="24"/>
                  <a:pt x="137" y="13"/>
                  <a:pt x="107" y="13"/>
                </a:cubicBezTo>
                <a:cubicBezTo>
                  <a:pt x="71" y="13"/>
                  <a:pt x="47" y="27"/>
                  <a:pt x="32" y="39"/>
                </a:cubicBezTo>
                <a:cubicBezTo>
                  <a:pt x="18" y="51"/>
                  <a:pt x="11" y="65"/>
                  <a:pt x="11" y="66"/>
                </a:cubicBezTo>
                <a:cubicBezTo>
                  <a:pt x="11" y="66"/>
                  <a:pt x="11" y="66"/>
                  <a:pt x="10" y="66"/>
                </a:cubicBezTo>
                <a:cubicBezTo>
                  <a:pt x="10" y="66"/>
                  <a:pt x="10" y="66"/>
                  <a:pt x="10" y="66"/>
                </a:cubicBezTo>
                <a:cubicBezTo>
                  <a:pt x="11" y="65"/>
                  <a:pt x="17" y="49"/>
                  <a:pt x="30" y="35"/>
                </a:cubicBezTo>
                <a:cubicBezTo>
                  <a:pt x="43" y="20"/>
                  <a:pt x="69" y="0"/>
                  <a:pt x="106" y="0"/>
                </a:cubicBezTo>
                <a:cubicBezTo>
                  <a:pt x="142" y="0"/>
                  <a:pt x="165" y="19"/>
                  <a:pt x="173" y="26"/>
                </a:cubicBezTo>
                <a:cubicBezTo>
                  <a:pt x="180" y="33"/>
                  <a:pt x="186" y="41"/>
                  <a:pt x="187" y="42"/>
                </a:cubicBezTo>
                <a:cubicBezTo>
                  <a:pt x="188" y="43"/>
                  <a:pt x="188" y="44"/>
                  <a:pt x="188" y="44"/>
                </a:cubicBezTo>
                <a:cubicBezTo>
                  <a:pt x="188" y="44"/>
                  <a:pt x="188" y="44"/>
                  <a:pt x="188" y="44"/>
                </a:cubicBezTo>
                <a:cubicBezTo>
                  <a:pt x="188" y="44"/>
                  <a:pt x="188" y="44"/>
                  <a:pt x="188" y="44"/>
                </a:cubicBezTo>
                <a:close/>
                <a:moveTo>
                  <a:pt x="1" y="101"/>
                </a:moveTo>
                <a:cubicBezTo>
                  <a:pt x="1" y="101"/>
                  <a:pt x="1" y="101"/>
                  <a:pt x="1" y="102"/>
                </a:cubicBezTo>
                <a:cubicBezTo>
                  <a:pt x="1" y="103"/>
                  <a:pt x="0" y="117"/>
                  <a:pt x="3" y="134"/>
                </a:cubicBezTo>
                <a:cubicBezTo>
                  <a:pt x="8" y="157"/>
                  <a:pt x="22" y="186"/>
                  <a:pt x="54" y="203"/>
                </a:cubicBezTo>
                <a:cubicBezTo>
                  <a:pt x="87" y="221"/>
                  <a:pt x="120" y="216"/>
                  <a:pt x="139" y="208"/>
                </a:cubicBezTo>
                <a:cubicBezTo>
                  <a:pt x="153" y="202"/>
                  <a:pt x="157" y="198"/>
                  <a:pt x="159" y="196"/>
                </a:cubicBezTo>
                <a:cubicBezTo>
                  <a:pt x="160" y="196"/>
                  <a:pt x="161" y="195"/>
                  <a:pt x="161" y="195"/>
                </a:cubicBezTo>
                <a:cubicBezTo>
                  <a:pt x="162" y="194"/>
                  <a:pt x="162" y="194"/>
                  <a:pt x="162" y="194"/>
                </a:cubicBezTo>
                <a:cubicBezTo>
                  <a:pt x="162" y="194"/>
                  <a:pt x="162" y="194"/>
                  <a:pt x="162" y="194"/>
                </a:cubicBezTo>
                <a:cubicBezTo>
                  <a:pt x="162" y="194"/>
                  <a:pt x="162" y="194"/>
                  <a:pt x="161" y="194"/>
                </a:cubicBezTo>
                <a:cubicBezTo>
                  <a:pt x="160" y="195"/>
                  <a:pt x="146" y="201"/>
                  <a:pt x="129" y="203"/>
                </a:cubicBezTo>
                <a:cubicBezTo>
                  <a:pt x="111" y="205"/>
                  <a:pt x="87" y="204"/>
                  <a:pt x="62" y="191"/>
                </a:cubicBezTo>
                <a:cubicBezTo>
                  <a:pt x="36" y="178"/>
                  <a:pt x="19" y="158"/>
                  <a:pt x="10" y="139"/>
                </a:cubicBezTo>
                <a:cubicBezTo>
                  <a:pt x="1" y="120"/>
                  <a:pt x="2" y="103"/>
                  <a:pt x="2" y="102"/>
                </a:cubicBezTo>
                <a:cubicBezTo>
                  <a:pt x="2" y="101"/>
                  <a:pt x="2" y="101"/>
                  <a:pt x="2" y="101"/>
                </a:cubicBezTo>
                <a:cubicBezTo>
                  <a:pt x="2" y="101"/>
                  <a:pt x="2" y="101"/>
                  <a:pt x="2" y="101"/>
                </a:cubicBezTo>
                <a:cubicBezTo>
                  <a:pt x="2" y="101"/>
                  <a:pt x="1" y="101"/>
                  <a:pt x="1" y="101"/>
                </a:cubicBezTo>
                <a:close/>
                <a:moveTo>
                  <a:pt x="108" y="133"/>
                </a:moveTo>
                <a:cubicBezTo>
                  <a:pt x="108" y="108"/>
                  <a:pt x="108" y="108"/>
                  <a:pt x="108" y="108"/>
                </a:cubicBezTo>
                <a:cubicBezTo>
                  <a:pt x="91" y="70"/>
                  <a:pt x="91" y="70"/>
                  <a:pt x="91" y="70"/>
                </a:cubicBezTo>
                <a:cubicBezTo>
                  <a:pt x="105" y="70"/>
                  <a:pt x="105" y="70"/>
                  <a:pt x="105" y="70"/>
                </a:cubicBezTo>
                <a:cubicBezTo>
                  <a:pt x="116" y="95"/>
                  <a:pt x="116" y="95"/>
                  <a:pt x="116" y="95"/>
                </a:cubicBezTo>
                <a:cubicBezTo>
                  <a:pt x="127" y="70"/>
                  <a:pt x="127" y="70"/>
                  <a:pt x="127" y="70"/>
                </a:cubicBezTo>
                <a:cubicBezTo>
                  <a:pt x="140" y="70"/>
                  <a:pt x="140" y="70"/>
                  <a:pt x="140" y="70"/>
                </a:cubicBezTo>
                <a:cubicBezTo>
                  <a:pt x="123" y="108"/>
                  <a:pt x="123" y="108"/>
                  <a:pt x="123" y="108"/>
                </a:cubicBezTo>
                <a:cubicBezTo>
                  <a:pt x="123" y="133"/>
                  <a:pt x="123" y="133"/>
                  <a:pt x="123" y="133"/>
                </a:cubicBezTo>
                <a:lnTo>
                  <a:pt x="108" y="133"/>
                </a:lnTo>
                <a:close/>
                <a:moveTo>
                  <a:pt x="241" y="133"/>
                </a:moveTo>
                <a:cubicBezTo>
                  <a:pt x="208" y="133"/>
                  <a:pt x="208" y="133"/>
                  <a:pt x="208" y="133"/>
                </a:cubicBezTo>
                <a:cubicBezTo>
                  <a:pt x="208" y="70"/>
                  <a:pt x="208" y="70"/>
                  <a:pt x="208" y="70"/>
                </a:cubicBezTo>
                <a:cubicBezTo>
                  <a:pt x="222" y="70"/>
                  <a:pt x="222" y="70"/>
                  <a:pt x="222" y="70"/>
                </a:cubicBezTo>
                <a:cubicBezTo>
                  <a:pt x="222" y="121"/>
                  <a:pt x="222" y="121"/>
                  <a:pt x="222" y="121"/>
                </a:cubicBezTo>
                <a:cubicBezTo>
                  <a:pt x="241" y="121"/>
                  <a:pt x="241" y="121"/>
                  <a:pt x="241" y="121"/>
                </a:cubicBezTo>
                <a:lnTo>
                  <a:pt x="241" y="133"/>
                </a:lnTo>
                <a:close/>
                <a:moveTo>
                  <a:pt x="73" y="70"/>
                </a:moveTo>
                <a:cubicBezTo>
                  <a:pt x="86" y="70"/>
                  <a:pt x="86" y="70"/>
                  <a:pt x="86" y="70"/>
                </a:cubicBezTo>
                <a:cubicBezTo>
                  <a:pt x="86" y="133"/>
                  <a:pt x="86" y="133"/>
                  <a:pt x="86" y="133"/>
                </a:cubicBezTo>
                <a:cubicBezTo>
                  <a:pt x="73" y="133"/>
                  <a:pt x="73" y="133"/>
                  <a:pt x="73" y="133"/>
                </a:cubicBezTo>
                <a:cubicBezTo>
                  <a:pt x="73" y="133"/>
                  <a:pt x="73" y="133"/>
                  <a:pt x="73" y="133"/>
                </a:cubicBezTo>
                <a:cubicBezTo>
                  <a:pt x="73" y="131"/>
                  <a:pt x="57" y="104"/>
                  <a:pt x="53" y="96"/>
                </a:cubicBezTo>
                <a:cubicBezTo>
                  <a:pt x="53" y="133"/>
                  <a:pt x="53" y="133"/>
                  <a:pt x="53" y="133"/>
                </a:cubicBezTo>
                <a:cubicBezTo>
                  <a:pt x="40" y="133"/>
                  <a:pt x="40" y="133"/>
                  <a:pt x="40" y="133"/>
                </a:cubicBezTo>
                <a:cubicBezTo>
                  <a:pt x="40" y="70"/>
                  <a:pt x="40" y="70"/>
                  <a:pt x="40" y="70"/>
                </a:cubicBezTo>
                <a:cubicBezTo>
                  <a:pt x="54" y="70"/>
                  <a:pt x="54" y="70"/>
                  <a:pt x="54" y="70"/>
                </a:cubicBezTo>
                <a:cubicBezTo>
                  <a:pt x="54" y="70"/>
                  <a:pt x="54" y="70"/>
                  <a:pt x="54" y="70"/>
                </a:cubicBezTo>
                <a:cubicBezTo>
                  <a:pt x="55" y="71"/>
                  <a:pt x="69" y="97"/>
                  <a:pt x="73" y="106"/>
                </a:cubicBezTo>
                <a:lnTo>
                  <a:pt x="73" y="70"/>
                </a:lnTo>
                <a:close/>
                <a:moveTo>
                  <a:pt x="166" y="134"/>
                </a:moveTo>
                <a:cubicBezTo>
                  <a:pt x="152" y="134"/>
                  <a:pt x="144" y="126"/>
                  <a:pt x="144" y="111"/>
                </a:cubicBezTo>
                <a:cubicBezTo>
                  <a:pt x="144" y="70"/>
                  <a:pt x="144" y="70"/>
                  <a:pt x="144" y="70"/>
                </a:cubicBezTo>
                <a:cubicBezTo>
                  <a:pt x="158" y="70"/>
                  <a:pt x="158" y="70"/>
                  <a:pt x="158" y="70"/>
                </a:cubicBezTo>
                <a:cubicBezTo>
                  <a:pt x="158" y="110"/>
                  <a:pt x="158" y="110"/>
                  <a:pt x="158" y="110"/>
                </a:cubicBezTo>
                <a:cubicBezTo>
                  <a:pt x="158" y="119"/>
                  <a:pt x="161" y="122"/>
                  <a:pt x="167" y="122"/>
                </a:cubicBezTo>
                <a:cubicBezTo>
                  <a:pt x="172" y="122"/>
                  <a:pt x="175" y="118"/>
                  <a:pt x="175" y="110"/>
                </a:cubicBezTo>
                <a:cubicBezTo>
                  <a:pt x="175" y="70"/>
                  <a:pt x="175" y="70"/>
                  <a:pt x="175" y="70"/>
                </a:cubicBezTo>
                <a:cubicBezTo>
                  <a:pt x="188" y="70"/>
                  <a:pt x="188" y="70"/>
                  <a:pt x="188" y="70"/>
                </a:cubicBezTo>
                <a:cubicBezTo>
                  <a:pt x="188" y="111"/>
                  <a:pt x="188" y="111"/>
                  <a:pt x="188" y="111"/>
                </a:cubicBezTo>
                <a:cubicBezTo>
                  <a:pt x="188" y="126"/>
                  <a:pt x="181" y="134"/>
                  <a:pt x="166" y="134"/>
                </a:cubicBezTo>
                <a:close/>
                <a:moveTo>
                  <a:pt x="259" y="199"/>
                </a:moveTo>
                <a:cubicBezTo>
                  <a:pt x="267" y="206"/>
                  <a:pt x="267" y="206"/>
                  <a:pt x="267" y="206"/>
                </a:cubicBezTo>
                <a:cubicBezTo>
                  <a:pt x="267" y="206"/>
                  <a:pt x="267" y="206"/>
                  <a:pt x="267" y="206"/>
                </a:cubicBezTo>
                <a:cubicBezTo>
                  <a:pt x="263" y="213"/>
                  <a:pt x="257" y="216"/>
                  <a:pt x="249" y="216"/>
                </a:cubicBezTo>
                <a:cubicBezTo>
                  <a:pt x="236" y="216"/>
                  <a:pt x="229" y="207"/>
                  <a:pt x="229" y="192"/>
                </a:cubicBezTo>
                <a:cubicBezTo>
                  <a:pt x="229" y="174"/>
                  <a:pt x="239" y="168"/>
                  <a:pt x="249" y="168"/>
                </a:cubicBezTo>
                <a:cubicBezTo>
                  <a:pt x="261" y="168"/>
                  <a:pt x="267" y="177"/>
                  <a:pt x="267" y="193"/>
                </a:cubicBezTo>
                <a:cubicBezTo>
                  <a:pt x="267" y="196"/>
                  <a:pt x="267" y="196"/>
                  <a:pt x="267" y="196"/>
                </a:cubicBezTo>
                <a:cubicBezTo>
                  <a:pt x="242" y="196"/>
                  <a:pt x="242" y="196"/>
                  <a:pt x="242" y="196"/>
                </a:cubicBezTo>
                <a:cubicBezTo>
                  <a:pt x="243" y="202"/>
                  <a:pt x="245" y="205"/>
                  <a:pt x="250" y="205"/>
                </a:cubicBezTo>
                <a:cubicBezTo>
                  <a:pt x="254" y="205"/>
                  <a:pt x="257" y="202"/>
                  <a:pt x="259" y="200"/>
                </a:cubicBezTo>
                <a:lnTo>
                  <a:pt x="259" y="199"/>
                </a:lnTo>
                <a:close/>
                <a:moveTo>
                  <a:pt x="242" y="187"/>
                </a:moveTo>
                <a:cubicBezTo>
                  <a:pt x="255" y="187"/>
                  <a:pt x="255" y="187"/>
                  <a:pt x="255" y="187"/>
                </a:cubicBezTo>
                <a:cubicBezTo>
                  <a:pt x="254" y="179"/>
                  <a:pt x="250" y="179"/>
                  <a:pt x="249" y="179"/>
                </a:cubicBezTo>
                <a:cubicBezTo>
                  <a:pt x="245" y="179"/>
                  <a:pt x="243" y="182"/>
                  <a:pt x="242" y="187"/>
                </a:cubicBezTo>
                <a:close/>
                <a:moveTo>
                  <a:pt x="416" y="92"/>
                </a:moveTo>
                <a:cubicBezTo>
                  <a:pt x="420" y="96"/>
                  <a:pt x="422" y="102"/>
                  <a:pt x="422" y="110"/>
                </a:cubicBezTo>
                <a:cubicBezTo>
                  <a:pt x="422" y="128"/>
                  <a:pt x="412" y="134"/>
                  <a:pt x="402" y="134"/>
                </a:cubicBezTo>
                <a:cubicBezTo>
                  <a:pt x="392" y="134"/>
                  <a:pt x="382" y="128"/>
                  <a:pt x="382" y="110"/>
                </a:cubicBezTo>
                <a:cubicBezTo>
                  <a:pt x="382" y="102"/>
                  <a:pt x="384" y="96"/>
                  <a:pt x="388" y="92"/>
                </a:cubicBezTo>
                <a:cubicBezTo>
                  <a:pt x="392" y="88"/>
                  <a:pt x="396" y="86"/>
                  <a:pt x="402" y="86"/>
                </a:cubicBezTo>
                <a:cubicBezTo>
                  <a:pt x="408" y="86"/>
                  <a:pt x="413" y="88"/>
                  <a:pt x="416" y="92"/>
                </a:cubicBezTo>
                <a:close/>
                <a:moveTo>
                  <a:pt x="409" y="110"/>
                </a:moveTo>
                <a:cubicBezTo>
                  <a:pt x="409" y="99"/>
                  <a:pt x="405" y="97"/>
                  <a:pt x="402" y="97"/>
                </a:cubicBezTo>
                <a:cubicBezTo>
                  <a:pt x="398" y="97"/>
                  <a:pt x="396" y="101"/>
                  <a:pt x="396" y="110"/>
                </a:cubicBezTo>
                <a:cubicBezTo>
                  <a:pt x="396" y="122"/>
                  <a:pt x="399" y="123"/>
                  <a:pt x="402" y="123"/>
                </a:cubicBezTo>
                <a:cubicBezTo>
                  <a:pt x="407" y="123"/>
                  <a:pt x="409" y="119"/>
                  <a:pt x="409" y="110"/>
                </a:cubicBezTo>
                <a:close/>
                <a:moveTo>
                  <a:pt x="410" y="180"/>
                </a:moveTo>
                <a:cubicBezTo>
                  <a:pt x="410" y="215"/>
                  <a:pt x="410" y="215"/>
                  <a:pt x="410" y="215"/>
                </a:cubicBezTo>
                <a:cubicBezTo>
                  <a:pt x="397" y="215"/>
                  <a:pt x="397" y="215"/>
                  <a:pt x="397" y="215"/>
                </a:cubicBezTo>
                <a:cubicBezTo>
                  <a:pt x="397" y="184"/>
                  <a:pt x="397" y="184"/>
                  <a:pt x="397" y="184"/>
                </a:cubicBezTo>
                <a:cubicBezTo>
                  <a:pt x="397" y="180"/>
                  <a:pt x="395" y="180"/>
                  <a:pt x="393" y="180"/>
                </a:cubicBezTo>
                <a:cubicBezTo>
                  <a:pt x="391" y="180"/>
                  <a:pt x="389" y="181"/>
                  <a:pt x="386" y="183"/>
                </a:cubicBezTo>
                <a:cubicBezTo>
                  <a:pt x="386" y="215"/>
                  <a:pt x="386" y="215"/>
                  <a:pt x="386" y="215"/>
                </a:cubicBezTo>
                <a:cubicBezTo>
                  <a:pt x="373" y="215"/>
                  <a:pt x="373" y="215"/>
                  <a:pt x="373" y="215"/>
                </a:cubicBezTo>
                <a:cubicBezTo>
                  <a:pt x="373" y="152"/>
                  <a:pt x="373" y="152"/>
                  <a:pt x="373" y="152"/>
                </a:cubicBezTo>
                <a:cubicBezTo>
                  <a:pt x="386" y="150"/>
                  <a:pt x="386" y="150"/>
                  <a:pt x="386" y="150"/>
                </a:cubicBezTo>
                <a:cubicBezTo>
                  <a:pt x="386" y="174"/>
                  <a:pt x="386" y="174"/>
                  <a:pt x="386" y="174"/>
                </a:cubicBezTo>
                <a:cubicBezTo>
                  <a:pt x="389" y="171"/>
                  <a:pt x="393" y="168"/>
                  <a:pt x="399" y="168"/>
                </a:cubicBezTo>
                <a:cubicBezTo>
                  <a:pt x="406" y="168"/>
                  <a:pt x="410" y="172"/>
                  <a:pt x="410" y="180"/>
                </a:cubicBezTo>
                <a:close/>
                <a:moveTo>
                  <a:pt x="511" y="124"/>
                </a:moveTo>
                <a:cubicBezTo>
                  <a:pt x="511" y="124"/>
                  <a:pt x="511" y="124"/>
                  <a:pt x="511" y="124"/>
                </a:cubicBezTo>
                <a:cubicBezTo>
                  <a:pt x="507" y="131"/>
                  <a:pt x="501" y="134"/>
                  <a:pt x="493" y="134"/>
                </a:cubicBezTo>
                <a:cubicBezTo>
                  <a:pt x="480" y="134"/>
                  <a:pt x="473" y="125"/>
                  <a:pt x="473" y="110"/>
                </a:cubicBezTo>
                <a:cubicBezTo>
                  <a:pt x="473" y="92"/>
                  <a:pt x="484" y="86"/>
                  <a:pt x="493" y="86"/>
                </a:cubicBezTo>
                <a:cubicBezTo>
                  <a:pt x="505" y="86"/>
                  <a:pt x="511" y="95"/>
                  <a:pt x="511" y="111"/>
                </a:cubicBezTo>
                <a:cubicBezTo>
                  <a:pt x="511" y="114"/>
                  <a:pt x="511" y="114"/>
                  <a:pt x="511" y="114"/>
                </a:cubicBezTo>
                <a:cubicBezTo>
                  <a:pt x="486" y="114"/>
                  <a:pt x="486" y="114"/>
                  <a:pt x="486" y="114"/>
                </a:cubicBezTo>
                <a:cubicBezTo>
                  <a:pt x="487" y="120"/>
                  <a:pt x="489" y="123"/>
                  <a:pt x="494" y="123"/>
                </a:cubicBezTo>
                <a:cubicBezTo>
                  <a:pt x="498" y="123"/>
                  <a:pt x="501" y="120"/>
                  <a:pt x="503" y="118"/>
                </a:cubicBezTo>
                <a:cubicBezTo>
                  <a:pt x="503" y="117"/>
                  <a:pt x="503" y="117"/>
                  <a:pt x="503" y="117"/>
                </a:cubicBezTo>
                <a:lnTo>
                  <a:pt x="511" y="124"/>
                </a:lnTo>
                <a:close/>
                <a:moveTo>
                  <a:pt x="487" y="105"/>
                </a:moveTo>
                <a:cubicBezTo>
                  <a:pt x="499" y="105"/>
                  <a:pt x="499" y="105"/>
                  <a:pt x="499" y="105"/>
                </a:cubicBezTo>
                <a:cubicBezTo>
                  <a:pt x="498" y="97"/>
                  <a:pt x="494" y="97"/>
                  <a:pt x="493" y="97"/>
                </a:cubicBezTo>
                <a:cubicBezTo>
                  <a:pt x="489" y="97"/>
                  <a:pt x="487" y="100"/>
                  <a:pt x="487" y="105"/>
                </a:cubicBezTo>
                <a:close/>
                <a:moveTo>
                  <a:pt x="467" y="98"/>
                </a:moveTo>
                <a:cubicBezTo>
                  <a:pt x="467" y="133"/>
                  <a:pt x="467" y="133"/>
                  <a:pt x="467" y="133"/>
                </a:cubicBezTo>
                <a:cubicBezTo>
                  <a:pt x="453" y="133"/>
                  <a:pt x="453" y="133"/>
                  <a:pt x="453" y="133"/>
                </a:cubicBezTo>
                <a:cubicBezTo>
                  <a:pt x="453" y="102"/>
                  <a:pt x="453" y="102"/>
                  <a:pt x="453" y="102"/>
                </a:cubicBezTo>
                <a:cubicBezTo>
                  <a:pt x="453" y="98"/>
                  <a:pt x="452" y="98"/>
                  <a:pt x="450" y="98"/>
                </a:cubicBezTo>
                <a:cubicBezTo>
                  <a:pt x="448" y="98"/>
                  <a:pt x="445" y="99"/>
                  <a:pt x="443" y="102"/>
                </a:cubicBezTo>
                <a:cubicBezTo>
                  <a:pt x="443" y="133"/>
                  <a:pt x="443" y="133"/>
                  <a:pt x="443" y="133"/>
                </a:cubicBezTo>
                <a:cubicBezTo>
                  <a:pt x="429" y="133"/>
                  <a:pt x="429" y="133"/>
                  <a:pt x="429" y="133"/>
                </a:cubicBezTo>
                <a:cubicBezTo>
                  <a:pt x="429" y="87"/>
                  <a:pt x="429" y="87"/>
                  <a:pt x="429" y="87"/>
                </a:cubicBezTo>
                <a:cubicBezTo>
                  <a:pt x="443" y="87"/>
                  <a:pt x="443" y="87"/>
                  <a:pt x="443" y="87"/>
                </a:cubicBezTo>
                <a:cubicBezTo>
                  <a:pt x="443" y="92"/>
                  <a:pt x="443" y="92"/>
                  <a:pt x="443" y="92"/>
                </a:cubicBezTo>
                <a:cubicBezTo>
                  <a:pt x="445" y="89"/>
                  <a:pt x="450" y="86"/>
                  <a:pt x="455" y="86"/>
                </a:cubicBezTo>
                <a:cubicBezTo>
                  <a:pt x="463" y="86"/>
                  <a:pt x="467" y="90"/>
                  <a:pt x="467" y="98"/>
                </a:cubicBezTo>
                <a:close/>
                <a:moveTo>
                  <a:pt x="357" y="169"/>
                </a:moveTo>
                <a:cubicBezTo>
                  <a:pt x="366" y="169"/>
                  <a:pt x="366" y="169"/>
                  <a:pt x="366" y="169"/>
                </a:cubicBezTo>
                <a:cubicBezTo>
                  <a:pt x="366" y="179"/>
                  <a:pt x="366" y="179"/>
                  <a:pt x="366" y="179"/>
                </a:cubicBezTo>
                <a:cubicBezTo>
                  <a:pt x="357" y="179"/>
                  <a:pt x="357" y="179"/>
                  <a:pt x="357" y="179"/>
                </a:cubicBezTo>
                <a:cubicBezTo>
                  <a:pt x="357" y="200"/>
                  <a:pt x="357" y="200"/>
                  <a:pt x="357" y="200"/>
                </a:cubicBezTo>
                <a:cubicBezTo>
                  <a:pt x="357" y="204"/>
                  <a:pt x="358" y="205"/>
                  <a:pt x="361" y="205"/>
                </a:cubicBezTo>
                <a:cubicBezTo>
                  <a:pt x="363" y="205"/>
                  <a:pt x="364" y="205"/>
                  <a:pt x="365" y="205"/>
                </a:cubicBezTo>
                <a:cubicBezTo>
                  <a:pt x="366" y="204"/>
                  <a:pt x="366" y="204"/>
                  <a:pt x="366" y="204"/>
                </a:cubicBezTo>
                <a:cubicBezTo>
                  <a:pt x="366" y="215"/>
                  <a:pt x="366" y="215"/>
                  <a:pt x="366" y="215"/>
                </a:cubicBezTo>
                <a:cubicBezTo>
                  <a:pt x="365" y="215"/>
                  <a:pt x="365" y="215"/>
                  <a:pt x="365" y="215"/>
                </a:cubicBezTo>
                <a:cubicBezTo>
                  <a:pt x="364" y="215"/>
                  <a:pt x="360" y="215"/>
                  <a:pt x="357" y="215"/>
                </a:cubicBezTo>
                <a:cubicBezTo>
                  <a:pt x="347" y="215"/>
                  <a:pt x="343" y="212"/>
                  <a:pt x="343" y="203"/>
                </a:cubicBezTo>
                <a:cubicBezTo>
                  <a:pt x="343" y="179"/>
                  <a:pt x="343" y="179"/>
                  <a:pt x="343" y="179"/>
                </a:cubicBezTo>
                <a:cubicBezTo>
                  <a:pt x="337" y="179"/>
                  <a:pt x="337" y="179"/>
                  <a:pt x="337" y="179"/>
                </a:cubicBezTo>
                <a:cubicBezTo>
                  <a:pt x="337" y="169"/>
                  <a:pt x="337" y="169"/>
                  <a:pt x="337" y="169"/>
                </a:cubicBezTo>
                <a:cubicBezTo>
                  <a:pt x="343" y="169"/>
                  <a:pt x="343" y="169"/>
                  <a:pt x="343" y="169"/>
                </a:cubicBezTo>
                <a:cubicBezTo>
                  <a:pt x="343" y="156"/>
                  <a:pt x="343" y="156"/>
                  <a:pt x="343" y="156"/>
                </a:cubicBezTo>
                <a:cubicBezTo>
                  <a:pt x="357" y="154"/>
                  <a:pt x="357" y="154"/>
                  <a:pt x="357" y="154"/>
                </a:cubicBezTo>
                <a:lnTo>
                  <a:pt x="357" y="169"/>
                </a:lnTo>
                <a:close/>
                <a:moveTo>
                  <a:pt x="332" y="98"/>
                </a:moveTo>
                <a:cubicBezTo>
                  <a:pt x="332" y="133"/>
                  <a:pt x="332" y="133"/>
                  <a:pt x="332" y="133"/>
                </a:cubicBezTo>
                <a:cubicBezTo>
                  <a:pt x="318" y="133"/>
                  <a:pt x="318" y="133"/>
                  <a:pt x="318" y="133"/>
                </a:cubicBezTo>
                <a:cubicBezTo>
                  <a:pt x="318" y="102"/>
                  <a:pt x="318" y="102"/>
                  <a:pt x="318" y="102"/>
                </a:cubicBezTo>
                <a:cubicBezTo>
                  <a:pt x="318" y="98"/>
                  <a:pt x="316" y="98"/>
                  <a:pt x="315" y="98"/>
                </a:cubicBezTo>
                <a:cubicBezTo>
                  <a:pt x="313" y="98"/>
                  <a:pt x="310" y="99"/>
                  <a:pt x="307" y="102"/>
                </a:cubicBezTo>
                <a:cubicBezTo>
                  <a:pt x="307" y="133"/>
                  <a:pt x="307" y="133"/>
                  <a:pt x="307" y="133"/>
                </a:cubicBezTo>
                <a:cubicBezTo>
                  <a:pt x="294" y="133"/>
                  <a:pt x="294" y="133"/>
                  <a:pt x="294" y="133"/>
                </a:cubicBezTo>
                <a:cubicBezTo>
                  <a:pt x="294" y="87"/>
                  <a:pt x="294" y="87"/>
                  <a:pt x="294" y="87"/>
                </a:cubicBezTo>
                <a:cubicBezTo>
                  <a:pt x="307" y="87"/>
                  <a:pt x="307" y="87"/>
                  <a:pt x="307" y="87"/>
                </a:cubicBezTo>
                <a:cubicBezTo>
                  <a:pt x="307" y="92"/>
                  <a:pt x="307" y="92"/>
                  <a:pt x="307" y="92"/>
                </a:cubicBezTo>
                <a:cubicBezTo>
                  <a:pt x="310" y="89"/>
                  <a:pt x="315" y="86"/>
                  <a:pt x="320" y="86"/>
                </a:cubicBezTo>
                <a:cubicBezTo>
                  <a:pt x="328" y="86"/>
                  <a:pt x="332" y="90"/>
                  <a:pt x="332" y="98"/>
                </a:cubicBezTo>
                <a:close/>
                <a:moveTo>
                  <a:pt x="272" y="132"/>
                </a:moveTo>
                <a:cubicBezTo>
                  <a:pt x="272" y="131"/>
                  <a:pt x="271" y="130"/>
                  <a:pt x="271" y="128"/>
                </a:cubicBezTo>
                <a:cubicBezTo>
                  <a:pt x="268" y="132"/>
                  <a:pt x="264" y="133"/>
                  <a:pt x="259" y="133"/>
                </a:cubicBezTo>
                <a:cubicBezTo>
                  <a:pt x="251" y="133"/>
                  <a:pt x="247" y="129"/>
                  <a:pt x="247" y="121"/>
                </a:cubicBezTo>
                <a:cubicBezTo>
                  <a:pt x="247" y="112"/>
                  <a:pt x="255" y="106"/>
                  <a:pt x="271" y="103"/>
                </a:cubicBezTo>
                <a:cubicBezTo>
                  <a:pt x="271" y="102"/>
                  <a:pt x="271" y="102"/>
                  <a:pt x="271" y="102"/>
                </a:cubicBezTo>
                <a:cubicBezTo>
                  <a:pt x="271" y="98"/>
                  <a:pt x="270" y="97"/>
                  <a:pt x="267" y="97"/>
                </a:cubicBezTo>
                <a:cubicBezTo>
                  <a:pt x="263" y="97"/>
                  <a:pt x="258" y="100"/>
                  <a:pt x="256" y="102"/>
                </a:cubicBezTo>
                <a:cubicBezTo>
                  <a:pt x="255" y="102"/>
                  <a:pt x="255" y="102"/>
                  <a:pt x="255" y="102"/>
                </a:cubicBezTo>
                <a:cubicBezTo>
                  <a:pt x="249" y="94"/>
                  <a:pt x="249" y="94"/>
                  <a:pt x="249" y="94"/>
                </a:cubicBezTo>
                <a:cubicBezTo>
                  <a:pt x="249" y="93"/>
                  <a:pt x="249" y="93"/>
                  <a:pt x="249" y="93"/>
                </a:cubicBezTo>
                <a:cubicBezTo>
                  <a:pt x="255" y="89"/>
                  <a:pt x="262" y="86"/>
                  <a:pt x="270" y="86"/>
                </a:cubicBezTo>
                <a:cubicBezTo>
                  <a:pt x="280" y="86"/>
                  <a:pt x="285" y="91"/>
                  <a:pt x="285" y="102"/>
                </a:cubicBezTo>
                <a:cubicBezTo>
                  <a:pt x="285" y="121"/>
                  <a:pt x="285" y="121"/>
                  <a:pt x="285" y="121"/>
                </a:cubicBezTo>
                <a:cubicBezTo>
                  <a:pt x="285" y="127"/>
                  <a:pt x="285" y="130"/>
                  <a:pt x="286" y="132"/>
                </a:cubicBezTo>
                <a:cubicBezTo>
                  <a:pt x="286" y="133"/>
                  <a:pt x="286" y="133"/>
                  <a:pt x="286" y="133"/>
                </a:cubicBezTo>
                <a:cubicBezTo>
                  <a:pt x="272" y="133"/>
                  <a:pt x="272" y="133"/>
                  <a:pt x="272" y="133"/>
                </a:cubicBezTo>
                <a:lnTo>
                  <a:pt x="272" y="132"/>
                </a:lnTo>
                <a:close/>
                <a:moveTo>
                  <a:pt x="271" y="111"/>
                </a:moveTo>
                <a:cubicBezTo>
                  <a:pt x="262" y="113"/>
                  <a:pt x="261" y="116"/>
                  <a:pt x="261" y="119"/>
                </a:cubicBezTo>
                <a:cubicBezTo>
                  <a:pt x="261" y="121"/>
                  <a:pt x="262" y="123"/>
                  <a:pt x="264" y="123"/>
                </a:cubicBezTo>
                <a:cubicBezTo>
                  <a:pt x="267" y="123"/>
                  <a:pt x="269" y="122"/>
                  <a:pt x="271" y="120"/>
                </a:cubicBezTo>
                <a:lnTo>
                  <a:pt x="271" y="111"/>
                </a:lnTo>
                <a:close/>
                <a:moveTo>
                  <a:pt x="310" y="214"/>
                </a:moveTo>
                <a:cubicBezTo>
                  <a:pt x="311" y="215"/>
                  <a:pt x="311" y="215"/>
                  <a:pt x="311" y="215"/>
                </a:cubicBezTo>
                <a:cubicBezTo>
                  <a:pt x="297" y="215"/>
                  <a:pt x="297" y="215"/>
                  <a:pt x="297" y="215"/>
                </a:cubicBezTo>
                <a:cubicBezTo>
                  <a:pt x="297" y="214"/>
                  <a:pt x="297" y="214"/>
                  <a:pt x="297" y="214"/>
                </a:cubicBezTo>
                <a:cubicBezTo>
                  <a:pt x="296" y="213"/>
                  <a:pt x="296" y="212"/>
                  <a:pt x="296" y="210"/>
                </a:cubicBezTo>
                <a:cubicBezTo>
                  <a:pt x="293" y="214"/>
                  <a:pt x="289" y="215"/>
                  <a:pt x="283" y="215"/>
                </a:cubicBezTo>
                <a:cubicBezTo>
                  <a:pt x="276" y="215"/>
                  <a:pt x="272" y="211"/>
                  <a:pt x="272" y="203"/>
                </a:cubicBezTo>
                <a:cubicBezTo>
                  <a:pt x="272" y="194"/>
                  <a:pt x="280" y="188"/>
                  <a:pt x="296" y="185"/>
                </a:cubicBezTo>
                <a:cubicBezTo>
                  <a:pt x="296" y="183"/>
                  <a:pt x="296" y="183"/>
                  <a:pt x="296" y="183"/>
                </a:cubicBezTo>
                <a:cubicBezTo>
                  <a:pt x="296" y="180"/>
                  <a:pt x="295" y="179"/>
                  <a:pt x="292" y="179"/>
                </a:cubicBezTo>
                <a:cubicBezTo>
                  <a:pt x="287" y="179"/>
                  <a:pt x="283" y="182"/>
                  <a:pt x="280" y="184"/>
                </a:cubicBezTo>
                <a:cubicBezTo>
                  <a:pt x="280" y="184"/>
                  <a:pt x="280" y="184"/>
                  <a:pt x="280" y="184"/>
                </a:cubicBezTo>
                <a:cubicBezTo>
                  <a:pt x="273" y="176"/>
                  <a:pt x="273" y="176"/>
                  <a:pt x="273" y="176"/>
                </a:cubicBezTo>
                <a:cubicBezTo>
                  <a:pt x="274" y="175"/>
                  <a:pt x="274" y="175"/>
                  <a:pt x="274" y="175"/>
                </a:cubicBezTo>
                <a:cubicBezTo>
                  <a:pt x="279" y="171"/>
                  <a:pt x="286" y="168"/>
                  <a:pt x="294" y="168"/>
                </a:cubicBezTo>
                <a:cubicBezTo>
                  <a:pt x="305" y="168"/>
                  <a:pt x="309" y="173"/>
                  <a:pt x="309" y="183"/>
                </a:cubicBezTo>
                <a:cubicBezTo>
                  <a:pt x="309" y="203"/>
                  <a:pt x="309" y="203"/>
                  <a:pt x="309" y="203"/>
                </a:cubicBezTo>
                <a:cubicBezTo>
                  <a:pt x="309" y="209"/>
                  <a:pt x="310" y="212"/>
                  <a:pt x="310" y="214"/>
                </a:cubicBezTo>
                <a:close/>
                <a:moveTo>
                  <a:pt x="296" y="193"/>
                </a:moveTo>
                <a:cubicBezTo>
                  <a:pt x="286" y="195"/>
                  <a:pt x="285" y="198"/>
                  <a:pt x="285" y="201"/>
                </a:cubicBezTo>
                <a:cubicBezTo>
                  <a:pt x="285" y="203"/>
                  <a:pt x="286" y="205"/>
                  <a:pt x="289" y="205"/>
                </a:cubicBezTo>
                <a:cubicBezTo>
                  <a:pt x="291" y="205"/>
                  <a:pt x="294" y="204"/>
                  <a:pt x="296" y="201"/>
                </a:cubicBezTo>
                <a:lnTo>
                  <a:pt x="296" y="193"/>
                </a:lnTo>
                <a:close/>
                <a:moveTo>
                  <a:pt x="318" y="159"/>
                </a:moveTo>
                <a:cubicBezTo>
                  <a:pt x="332" y="157"/>
                  <a:pt x="332" y="157"/>
                  <a:pt x="332" y="157"/>
                </a:cubicBezTo>
                <a:cubicBezTo>
                  <a:pt x="332" y="215"/>
                  <a:pt x="332" y="215"/>
                  <a:pt x="332" y="215"/>
                </a:cubicBezTo>
                <a:cubicBezTo>
                  <a:pt x="318" y="215"/>
                  <a:pt x="318" y="215"/>
                  <a:pt x="318" y="215"/>
                </a:cubicBezTo>
                <a:lnTo>
                  <a:pt x="318" y="159"/>
                </a:lnTo>
                <a:close/>
                <a:moveTo>
                  <a:pt x="208" y="153"/>
                </a:moveTo>
                <a:cubicBezTo>
                  <a:pt x="222" y="153"/>
                  <a:pt x="222" y="153"/>
                  <a:pt x="222" y="153"/>
                </a:cubicBezTo>
                <a:cubicBezTo>
                  <a:pt x="222" y="215"/>
                  <a:pt x="222" y="215"/>
                  <a:pt x="222" y="215"/>
                </a:cubicBezTo>
                <a:cubicBezTo>
                  <a:pt x="208" y="215"/>
                  <a:pt x="208" y="215"/>
                  <a:pt x="208" y="215"/>
                </a:cubicBezTo>
                <a:cubicBezTo>
                  <a:pt x="208" y="188"/>
                  <a:pt x="208" y="188"/>
                  <a:pt x="208" y="188"/>
                </a:cubicBezTo>
                <a:cubicBezTo>
                  <a:pt x="188" y="188"/>
                  <a:pt x="188" y="188"/>
                  <a:pt x="188" y="188"/>
                </a:cubicBezTo>
                <a:cubicBezTo>
                  <a:pt x="188" y="215"/>
                  <a:pt x="188" y="215"/>
                  <a:pt x="188" y="215"/>
                </a:cubicBezTo>
                <a:cubicBezTo>
                  <a:pt x="174" y="215"/>
                  <a:pt x="174" y="215"/>
                  <a:pt x="174" y="215"/>
                </a:cubicBezTo>
                <a:cubicBezTo>
                  <a:pt x="174" y="153"/>
                  <a:pt x="174" y="153"/>
                  <a:pt x="174" y="153"/>
                </a:cubicBezTo>
                <a:cubicBezTo>
                  <a:pt x="188" y="153"/>
                  <a:pt x="188" y="153"/>
                  <a:pt x="188" y="153"/>
                </a:cubicBezTo>
                <a:cubicBezTo>
                  <a:pt x="188" y="176"/>
                  <a:pt x="188" y="176"/>
                  <a:pt x="188" y="176"/>
                </a:cubicBezTo>
                <a:cubicBezTo>
                  <a:pt x="208" y="176"/>
                  <a:pt x="208" y="176"/>
                  <a:pt x="208" y="176"/>
                </a:cubicBezTo>
                <a:lnTo>
                  <a:pt x="208" y="153"/>
                </a:lnTo>
                <a:close/>
                <a:moveTo>
                  <a:pt x="342" y="130"/>
                </a:moveTo>
                <a:cubicBezTo>
                  <a:pt x="340" y="129"/>
                  <a:pt x="339" y="127"/>
                  <a:pt x="339" y="124"/>
                </a:cubicBezTo>
                <a:cubicBezTo>
                  <a:pt x="339" y="122"/>
                  <a:pt x="341" y="118"/>
                  <a:pt x="345" y="116"/>
                </a:cubicBezTo>
                <a:cubicBezTo>
                  <a:pt x="341" y="113"/>
                  <a:pt x="339" y="108"/>
                  <a:pt x="339" y="103"/>
                </a:cubicBezTo>
                <a:cubicBezTo>
                  <a:pt x="339" y="93"/>
                  <a:pt x="346" y="86"/>
                  <a:pt x="357" y="86"/>
                </a:cubicBezTo>
                <a:cubicBezTo>
                  <a:pt x="362" y="86"/>
                  <a:pt x="367" y="88"/>
                  <a:pt x="370" y="90"/>
                </a:cubicBezTo>
                <a:cubicBezTo>
                  <a:pt x="372" y="88"/>
                  <a:pt x="376" y="86"/>
                  <a:pt x="379" y="86"/>
                </a:cubicBezTo>
                <a:cubicBezTo>
                  <a:pt x="380" y="86"/>
                  <a:pt x="380" y="86"/>
                  <a:pt x="380" y="86"/>
                </a:cubicBezTo>
                <a:cubicBezTo>
                  <a:pt x="380" y="98"/>
                  <a:pt x="380" y="98"/>
                  <a:pt x="380" y="98"/>
                </a:cubicBezTo>
                <a:cubicBezTo>
                  <a:pt x="379" y="98"/>
                  <a:pt x="379" y="98"/>
                  <a:pt x="379" y="98"/>
                </a:cubicBezTo>
                <a:cubicBezTo>
                  <a:pt x="378" y="98"/>
                  <a:pt x="376" y="98"/>
                  <a:pt x="374" y="98"/>
                </a:cubicBezTo>
                <a:cubicBezTo>
                  <a:pt x="375" y="100"/>
                  <a:pt x="375" y="101"/>
                  <a:pt x="375" y="103"/>
                </a:cubicBezTo>
                <a:cubicBezTo>
                  <a:pt x="375" y="113"/>
                  <a:pt x="368" y="120"/>
                  <a:pt x="357" y="120"/>
                </a:cubicBezTo>
                <a:cubicBezTo>
                  <a:pt x="355" y="120"/>
                  <a:pt x="353" y="119"/>
                  <a:pt x="351" y="119"/>
                </a:cubicBezTo>
                <a:cubicBezTo>
                  <a:pt x="351" y="120"/>
                  <a:pt x="351" y="120"/>
                  <a:pt x="351" y="120"/>
                </a:cubicBezTo>
                <a:cubicBezTo>
                  <a:pt x="351" y="121"/>
                  <a:pt x="351" y="122"/>
                  <a:pt x="354" y="122"/>
                </a:cubicBezTo>
                <a:cubicBezTo>
                  <a:pt x="360" y="123"/>
                  <a:pt x="360" y="123"/>
                  <a:pt x="360" y="123"/>
                </a:cubicBezTo>
                <a:cubicBezTo>
                  <a:pt x="374" y="124"/>
                  <a:pt x="379" y="127"/>
                  <a:pt x="379" y="135"/>
                </a:cubicBezTo>
                <a:cubicBezTo>
                  <a:pt x="379" y="144"/>
                  <a:pt x="370" y="149"/>
                  <a:pt x="356" y="149"/>
                </a:cubicBezTo>
                <a:cubicBezTo>
                  <a:pt x="342" y="149"/>
                  <a:pt x="336" y="146"/>
                  <a:pt x="336" y="139"/>
                </a:cubicBezTo>
                <a:cubicBezTo>
                  <a:pt x="336" y="135"/>
                  <a:pt x="338" y="132"/>
                  <a:pt x="342" y="130"/>
                </a:cubicBezTo>
                <a:close/>
                <a:moveTo>
                  <a:pt x="352" y="103"/>
                </a:moveTo>
                <a:cubicBezTo>
                  <a:pt x="352" y="106"/>
                  <a:pt x="352" y="111"/>
                  <a:pt x="357" y="111"/>
                </a:cubicBezTo>
                <a:cubicBezTo>
                  <a:pt x="360" y="111"/>
                  <a:pt x="362" y="108"/>
                  <a:pt x="362" y="103"/>
                </a:cubicBezTo>
                <a:cubicBezTo>
                  <a:pt x="362" y="100"/>
                  <a:pt x="361" y="96"/>
                  <a:pt x="357" y="96"/>
                </a:cubicBezTo>
                <a:cubicBezTo>
                  <a:pt x="352" y="96"/>
                  <a:pt x="352" y="101"/>
                  <a:pt x="352" y="103"/>
                </a:cubicBezTo>
                <a:close/>
                <a:moveTo>
                  <a:pt x="348" y="137"/>
                </a:moveTo>
                <a:cubicBezTo>
                  <a:pt x="348" y="140"/>
                  <a:pt x="350" y="142"/>
                  <a:pt x="357" y="142"/>
                </a:cubicBezTo>
                <a:cubicBezTo>
                  <a:pt x="363" y="142"/>
                  <a:pt x="366" y="140"/>
                  <a:pt x="366" y="137"/>
                </a:cubicBezTo>
                <a:cubicBezTo>
                  <a:pt x="366" y="135"/>
                  <a:pt x="366" y="134"/>
                  <a:pt x="358" y="134"/>
                </a:cubicBezTo>
                <a:cubicBezTo>
                  <a:pt x="351" y="133"/>
                  <a:pt x="351" y="133"/>
                  <a:pt x="351" y="133"/>
                </a:cubicBezTo>
                <a:cubicBezTo>
                  <a:pt x="351" y="133"/>
                  <a:pt x="350" y="133"/>
                  <a:pt x="350" y="133"/>
                </a:cubicBezTo>
                <a:cubicBezTo>
                  <a:pt x="349" y="134"/>
                  <a:pt x="348" y="136"/>
                  <a:pt x="348" y="137"/>
                </a:cubicBezTo>
                <a:close/>
              </a:path>
            </a:pathLst>
          </a:custGeom>
          <a:solidFill>
            <a:schemeClr val="tx2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351"/>
          </a:p>
        </p:txBody>
      </p:sp>
      <p:sp>
        <p:nvSpPr>
          <p:cNvPr id="7" name="Picture Placeholder 16"/>
          <p:cNvSpPr>
            <a:spLocks noGrp="1"/>
          </p:cNvSpPr>
          <p:nvPr>
            <p:ph type="pic" sz="quarter" idx="12"/>
          </p:nvPr>
        </p:nvSpPr>
        <p:spPr>
          <a:xfrm>
            <a:off x="976" y="5059215"/>
            <a:ext cx="9145405" cy="1801706"/>
          </a:xfrm>
          <a:custGeom>
            <a:avLst/>
            <a:gdLst>
              <a:gd name="connsiteX0" fmla="*/ 0 w 9142413"/>
              <a:gd name="connsiteY0" fmla="*/ 0 h 1360841"/>
              <a:gd name="connsiteX1" fmla="*/ 9142413 w 9142413"/>
              <a:gd name="connsiteY1" fmla="*/ 0 h 1360841"/>
              <a:gd name="connsiteX2" fmla="*/ 9142413 w 9142413"/>
              <a:gd name="connsiteY2" fmla="*/ 1360841 h 1360841"/>
              <a:gd name="connsiteX3" fmla="*/ 0 w 9142413"/>
              <a:gd name="connsiteY3" fmla="*/ 1360841 h 1360841"/>
              <a:gd name="connsiteX4" fmla="*/ 0 w 9142413"/>
              <a:gd name="connsiteY4" fmla="*/ 0 h 1360841"/>
              <a:gd name="connsiteX0" fmla="*/ 0 w 9142413"/>
              <a:gd name="connsiteY0" fmla="*/ 0 h 1360841"/>
              <a:gd name="connsiteX1" fmla="*/ 702469 w 9142413"/>
              <a:gd name="connsiteY1" fmla="*/ 1147 h 1360841"/>
              <a:gd name="connsiteX2" fmla="*/ 9142413 w 9142413"/>
              <a:gd name="connsiteY2" fmla="*/ 0 h 1360841"/>
              <a:gd name="connsiteX3" fmla="*/ 9142413 w 9142413"/>
              <a:gd name="connsiteY3" fmla="*/ 1360841 h 1360841"/>
              <a:gd name="connsiteX4" fmla="*/ 0 w 9142413"/>
              <a:gd name="connsiteY4" fmla="*/ 1360841 h 1360841"/>
              <a:gd name="connsiteX5" fmla="*/ 0 w 9142413"/>
              <a:gd name="connsiteY5" fmla="*/ 0 h 1360841"/>
              <a:gd name="connsiteX0" fmla="*/ 0 w 9142413"/>
              <a:gd name="connsiteY0" fmla="*/ 1234 h 1362075"/>
              <a:gd name="connsiteX1" fmla="*/ 702469 w 9142413"/>
              <a:gd name="connsiteY1" fmla="*/ 2381 h 1362075"/>
              <a:gd name="connsiteX2" fmla="*/ 966788 w 9142413"/>
              <a:gd name="connsiteY2" fmla="*/ 0 h 1362075"/>
              <a:gd name="connsiteX3" fmla="*/ 9142413 w 9142413"/>
              <a:gd name="connsiteY3" fmla="*/ 1234 h 1362075"/>
              <a:gd name="connsiteX4" fmla="*/ 9142413 w 9142413"/>
              <a:gd name="connsiteY4" fmla="*/ 1362075 h 1362075"/>
              <a:gd name="connsiteX5" fmla="*/ 0 w 9142413"/>
              <a:gd name="connsiteY5" fmla="*/ 1362075 h 1362075"/>
              <a:gd name="connsiteX6" fmla="*/ 0 w 9142413"/>
              <a:gd name="connsiteY6" fmla="*/ 1234 h 1362075"/>
              <a:gd name="connsiteX0" fmla="*/ 0 w 9142413"/>
              <a:gd name="connsiteY0" fmla="*/ 1234 h 1362075"/>
              <a:gd name="connsiteX1" fmla="*/ 702469 w 9142413"/>
              <a:gd name="connsiteY1" fmla="*/ 2381 h 1362075"/>
              <a:gd name="connsiteX2" fmla="*/ 838200 w 9142413"/>
              <a:gd name="connsiteY2" fmla="*/ 2381 h 1362075"/>
              <a:gd name="connsiteX3" fmla="*/ 966788 w 9142413"/>
              <a:gd name="connsiteY3" fmla="*/ 0 h 1362075"/>
              <a:gd name="connsiteX4" fmla="*/ 9142413 w 9142413"/>
              <a:gd name="connsiteY4" fmla="*/ 1234 h 1362075"/>
              <a:gd name="connsiteX5" fmla="*/ 9142413 w 9142413"/>
              <a:gd name="connsiteY5" fmla="*/ 1362075 h 1362075"/>
              <a:gd name="connsiteX6" fmla="*/ 0 w 9142413"/>
              <a:gd name="connsiteY6" fmla="*/ 1362075 h 1362075"/>
              <a:gd name="connsiteX7" fmla="*/ 0 w 9142413"/>
              <a:gd name="connsiteY7" fmla="*/ 1234 h 1362075"/>
              <a:gd name="connsiteX0" fmla="*/ 0 w 9142413"/>
              <a:gd name="connsiteY0" fmla="*/ 1234 h 1362075"/>
              <a:gd name="connsiteX1" fmla="*/ 702469 w 9142413"/>
              <a:gd name="connsiteY1" fmla="*/ 2381 h 1362075"/>
              <a:gd name="connsiteX2" fmla="*/ 826294 w 9142413"/>
              <a:gd name="connsiteY2" fmla="*/ 240506 h 1362075"/>
              <a:gd name="connsiteX3" fmla="*/ 966788 w 9142413"/>
              <a:gd name="connsiteY3" fmla="*/ 0 h 1362075"/>
              <a:gd name="connsiteX4" fmla="*/ 9142413 w 9142413"/>
              <a:gd name="connsiteY4" fmla="*/ 1234 h 1362075"/>
              <a:gd name="connsiteX5" fmla="*/ 9142413 w 9142413"/>
              <a:gd name="connsiteY5" fmla="*/ 1362075 h 1362075"/>
              <a:gd name="connsiteX6" fmla="*/ 0 w 9142413"/>
              <a:gd name="connsiteY6" fmla="*/ 1362075 h 1362075"/>
              <a:gd name="connsiteX7" fmla="*/ 0 w 9142413"/>
              <a:gd name="connsiteY7" fmla="*/ 1234 h 1362075"/>
              <a:gd name="connsiteX0" fmla="*/ 0 w 9142413"/>
              <a:gd name="connsiteY0" fmla="*/ 1234 h 1362075"/>
              <a:gd name="connsiteX1" fmla="*/ 702469 w 9142413"/>
              <a:gd name="connsiteY1" fmla="*/ 2381 h 1362075"/>
              <a:gd name="connsiteX2" fmla="*/ 826294 w 9142413"/>
              <a:gd name="connsiteY2" fmla="*/ 235744 h 1362075"/>
              <a:gd name="connsiteX3" fmla="*/ 966788 w 9142413"/>
              <a:gd name="connsiteY3" fmla="*/ 0 h 1362075"/>
              <a:gd name="connsiteX4" fmla="*/ 9142413 w 9142413"/>
              <a:gd name="connsiteY4" fmla="*/ 1234 h 1362075"/>
              <a:gd name="connsiteX5" fmla="*/ 9142413 w 9142413"/>
              <a:gd name="connsiteY5" fmla="*/ 1362075 h 1362075"/>
              <a:gd name="connsiteX6" fmla="*/ 0 w 9142413"/>
              <a:gd name="connsiteY6" fmla="*/ 1362075 h 1362075"/>
              <a:gd name="connsiteX7" fmla="*/ 0 w 9142413"/>
              <a:gd name="connsiteY7" fmla="*/ 1234 h 1362075"/>
              <a:gd name="connsiteX0" fmla="*/ 0 w 9142413"/>
              <a:gd name="connsiteY0" fmla="*/ 1234 h 1362075"/>
              <a:gd name="connsiteX1" fmla="*/ 702469 w 9142413"/>
              <a:gd name="connsiteY1" fmla="*/ 2381 h 1362075"/>
              <a:gd name="connsiteX2" fmla="*/ 842962 w 9142413"/>
              <a:gd name="connsiteY2" fmla="*/ 235744 h 1362075"/>
              <a:gd name="connsiteX3" fmla="*/ 966788 w 9142413"/>
              <a:gd name="connsiteY3" fmla="*/ 0 h 1362075"/>
              <a:gd name="connsiteX4" fmla="*/ 9142413 w 9142413"/>
              <a:gd name="connsiteY4" fmla="*/ 1234 h 1362075"/>
              <a:gd name="connsiteX5" fmla="*/ 9142413 w 9142413"/>
              <a:gd name="connsiteY5" fmla="*/ 1362075 h 1362075"/>
              <a:gd name="connsiteX6" fmla="*/ 0 w 9142413"/>
              <a:gd name="connsiteY6" fmla="*/ 1362075 h 1362075"/>
              <a:gd name="connsiteX7" fmla="*/ 0 w 9142413"/>
              <a:gd name="connsiteY7" fmla="*/ 1234 h 1362075"/>
              <a:gd name="connsiteX0" fmla="*/ 0 w 9142413"/>
              <a:gd name="connsiteY0" fmla="*/ 1234 h 1362075"/>
              <a:gd name="connsiteX1" fmla="*/ 702469 w 9142413"/>
              <a:gd name="connsiteY1" fmla="*/ 2381 h 1362075"/>
              <a:gd name="connsiteX2" fmla="*/ 842962 w 9142413"/>
              <a:gd name="connsiteY2" fmla="*/ 235744 h 1362075"/>
              <a:gd name="connsiteX3" fmla="*/ 966788 w 9142413"/>
              <a:gd name="connsiteY3" fmla="*/ 0 h 1362075"/>
              <a:gd name="connsiteX4" fmla="*/ 9142413 w 9142413"/>
              <a:gd name="connsiteY4" fmla="*/ 1234 h 1362075"/>
              <a:gd name="connsiteX5" fmla="*/ 9142413 w 9142413"/>
              <a:gd name="connsiteY5" fmla="*/ 1362075 h 1362075"/>
              <a:gd name="connsiteX6" fmla="*/ 0 w 9142413"/>
              <a:gd name="connsiteY6" fmla="*/ 1362075 h 1362075"/>
              <a:gd name="connsiteX7" fmla="*/ 0 w 9142413"/>
              <a:gd name="connsiteY7" fmla="*/ 1234 h 1362075"/>
              <a:gd name="connsiteX0" fmla="*/ 0 w 9142413"/>
              <a:gd name="connsiteY0" fmla="*/ 1234 h 1362075"/>
              <a:gd name="connsiteX1" fmla="*/ 702469 w 9142413"/>
              <a:gd name="connsiteY1" fmla="*/ 2381 h 1362075"/>
              <a:gd name="connsiteX2" fmla="*/ 842962 w 9142413"/>
              <a:gd name="connsiteY2" fmla="*/ 235744 h 1362075"/>
              <a:gd name="connsiteX3" fmla="*/ 966788 w 9142413"/>
              <a:gd name="connsiteY3" fmla="*/ 0 h 1362075"/>
              <a:gd name="connsiteX4" fmla="*/ 9142413 w 9142413"/>
              <a:gd name="connsiteY4" fmla="*/ 1234 h 1362075"/>
              <a:gd name="connsiteX5" fmla="*/ 9142413 w 9142413"/>
              <a:gd name="connsiteY5" fmla="*/ 1362075 h 1362075"/>
              <a:gd name="connsiteX6" fmla="*/ 0 w 9142413"/>
              <a:gd name="connsiteY6" fmla="*/ 1362075 h 1362075"/>
              <a:gd name="connsiteX7" fmla="*/ 0 w 9142413"/>
              <a:gd name="connsiteY7" fmla="*/ 1234 h 1362075"/>
              <a:gd name="connsiteX0" fmla="*/ 0 w 9142413"/>
              <a:gd name="connsiteY0" fmla="*/ 1234 h 1362075"/>
              <a:gd name="connsiteX1" fmla="*/ 702469 w 9142413"/>
              <a:gd name="connsiteY1" fmla="*/ 2381 h 1362075"/>
              <a:gd name="connsiteX2" fmla="*/ 842962 w 9142413"/>
              <a:gd name="connsiteY2" fmla="*/ 235744 h 1362075"/>
              <a:gd name="connsiteX3" fmla="*/ 966788 w 9142413"/>
              <a:gd name="connsiteY3" fmla="*/ 0 h 1362075"/>
              <a:gd name="connsiteX4" fmla="*/ 9142413 w 9142413"/>
              <a:gd name="connsiteY4" fmla="*/ 1234 h 1362075"/>
              <a:gd name="connsiteX5" fmla="*/ 9142413 w 9142413"/>
              <a:gd name="connsiteY5" fmla="*/ 1362075 h 1362075"/>
              <a:gd name="connsiteX6" fmla="*/ 0 w 9142413"/>
              <a:gd name="connsiteY6" fmla="*/ 1362075 h 1362075"/>
              <a:gd name="connsiteX7" fmla="*/ 0 w 9142413"/>
              <a:gd name="connsiteY7" fmla="*/ 1234 h 1362075"/>
              <a:gd name="connsiteX0" fmla="*/ 0 w 9142413"/>
              <a:gd name="connsiteY0" fmla="*/ 1234 h 1362075"/>
              <a:gd name="connsiteX1" fmla="*/ 702469 w 9142413"/>
              <a:gd name="connsiteY1" fmla="*/ 2381 h 1362075"/>
              <a:gd name="connsiteX2" fmla="*/ 842962 w 9142413"/>
              <a:gd name="connsiteY2" fmla="*/ 235744 h 1362075"/>
              <a:gd name="connsiteX3" fmla="*/ 966788 w 9142413"/>
              <a:gd name="connsiteY3" fmla="*/ 0 h 1362075"/>
              <a:gd name="connsiteX4" fmla="*/ 9142413 w 9142413"/>
              <a:gd name="connsiteY4" fmla="*/ 1234 h 1362075"/>
              <a:gd name="connsiteX5" fmla="*/ 9142413 w 9142413"/>
              <a:gd name="connsiteY5" fmla="*/ 1362075 h 1362075"/>
              <a:gd name="connsiteX6" fmla="*/ 0 w 9142413"/>
              <a:gd name="connsiteY6" fmla="*/ 1362075 h 1362075"/>
              <a:gd name="connsiteX7" fmla="*/ 0 w 9142413"/>
              <a:gd name="connsiteY7" fmla="*/ 1234 h 1362075"/>
              <a:gd name="connsiteX0" fmla="*/ 0 w 9142413"/>
              <a:gd name="connsiteY0" fmla="*/ 1234 h 1362075"/>
              <a:gd name="connsiteX1" fmla="*/ 702469 w 9142413"/>
              <a:gd name="connsiteY1" fmla="*/ 2381 h 1362075"/>
              <a:gd name="connsiteX2" fmla="*/ 842962 w 9142413"/>
              <a:gd name="connsiteY2" fmla="*/ 235744 h 1362075"/>
              <a:gd name="connsiteX3" fmla="*/ 966788 w 9142413"/>
              <a:gd name="connsiteY3" fmla="*/ 0 h 1362075"/>
              <a:gd name="connsiteX4" fmla="*/ 9142413 w 9142413"/>
              <a:gd name="connsiteY4" fmla="*/ 1234 h 1362075"/>
              <a:gd name="connsiteX5" fmla="*/ 9142413 w 9142413"/>
              <a:gd name="connsiteY5" fmla="*/ 1362075 h 1362075"/>
              <a:gd name="connsiteX6" fmla="*/ 0 w 9142413"/>
              <a:gd name="connsiteY6" fmla="*/ 1362075 h 1362075"/>
              <a:gd name="connsiteX7" fmla="*/ 0 w 9142413"/>
              <a:gd name="connsiteY7" fmla="*/ 1234 h 1362075"/>
              <a:gd name="connsiteX0" fmla="*/ 0 w 9142413"/>
              <a:gd name="connsiteY0" fmla="*/ 1234 h 1362075"/>
              <a:gd name="connsiteX1" fmla="*/ 702469 w 9142413"/>
              <a:gd name="connsiteY1" fmla="*/ 2381 h 1362075"/>
              <a:gd name="connsiteX2" fmla="*/ 842962 w 9142413"/>
              <a:gd name="connsiteY2" fmla="*/ 235744 h 1362075"/>
              <a:gd name="connsiteX3" fmla="*/ 966788 w 9142413"/>
              <a:gd name="connsiteY3" fmla="*/ 0 h 1362075"/>
              <a:gd name="connsiteX4" fmla="*/ 9142413 w 9142413"/>
              <a:gd name="connsiteY4" fmla="*/ 1234 h 1362075"/>
              <a:gd name="connsiteX5" fmla="*/ 9142413 w 9142413"/>
              <a:gd name="connsiteY5" fmla="*/ 1362075 h 1362075"/>
              <a:gd name="connsiteX6" fmla="*/ 0 w 9142413"/>
              <a:gd name="connsiteY6" fmla="*/ 1362075 h 1362075"/>
              <a:gd name="connsiteX7" fmla="*/ 0 w 9142413"/>
              <a:gd name="connsiteY7" fmla="*/ 1234 h 1362075"/>
              <a:gd name="connsiteX0" fmla="*/ 0 w 9142413"/>
              <a:gd name="connsiteY0" fmla="*/ 1234 h 1362075"/>
              <a:gd name="connsiteX1" fmla="*/ 702469 w 9142413"/>
              <a:gd name="connsiteY1" fmla="*/ 2381 h 1362075"/>
              <a:gd name="connsiteX2" fmla="*/ 842962 w 9142413"/>
              <a:gd name="connsiteY2" fmla="*/ 235744 h 1362075"/>
              <a:gd name="connsiteX3" fmla="*/ 966788 w 9142413"/>
              <a:gd name="connsiteY3" fmla="*/ 0 h 1362075"/>
              <a:gd name="connsiteX4" fmla="*/ 9142413 w 9142413"/>
              <a:gd name="connsiteY4" fmla="*/ 1234 h 1362075"/>
              <a:gd name="connsiteX5" fmla="*/ 9142413 w 9142413"/>
              <a:gd name="connsiteY5" fmla="*/ 1362075 h 1362075"/>
              <a:gd name="connsiteX6" fmla="*/ 0 w 9142413"/>
              <a:gd name="connsiteY6" fmla="*/ 1362075 h 1362075"/>
              <a:gd name="connsiteX7" fmla="*/ 0 w 9142413"/>
              <a:gd name="connsiteY7" fmla="*/ 1234 h 1362075"/>
              <a:gd name="connsiteX0" fmla="*/ 0 w 9142413"/>
              <a:gd name="connsiteY0" fmla="*/ 1234 h 1362075"/>
              <a:gd name="connsiteX1" fmla="*/ 702469 w 9142413"/>
              <a:gd name="connsiteY1" fmla="*/ 2381 h 1362075"/>
              <a:gd name="connsiteX2" fmla="*/ 842962 w 9142413"/>
              <a:gd name="connsiteY2" fmla="*/ 235744 h 1362075"/>
              <a:gd name="connsiteX3" fmla="*/ 966788 w 9142413"/>
              <a:gd name="connsiteY3" fmla="*/ 0 h 1362075"/>
              <a:gd name="connsiteX4" fmla="*/ 9142413 w 9142413"/>
              <a:gd name="connsiteY4" fmla="*/ 1234 h 1362075"/>
              <a:gd name="connsiteX5" fmla="*/ 9142413 w 9142413"/>
              <a:gd name="connsiteY5" fmla="*/ 1362075 h 1362075"/>
              <a:gd name="connsiteX6" fmla="*/ 0 w 9142413"/>
              <a:gd name="connsiteY6" fmla="*/ 1362075 h 1362075"/>
              <a:gd name="connsiteX7" fmla="*/ 0 w 9142413"/>
              <a:gd name="connsiteY7" fmla="*/ 1234 h 1362075"/>
              <a:gd name="connsiteX0" fmla="*/ 0 w 9142413"/>
              <a:gd name="connsiteY0" fmla="*/ 1234 h 1362075"/>
              <a:gd name="connsiteX1" fmla="*/ 702469 w 9142413"/>
              <a:gd name="connsiteY1" fmla="*/ 2381 h 1362075"/>
              <a:gd name="connsiteX2" fmla="*/ 842962 w 9142413"/>
              <a:gd name="connsiteY2" fmla="*/ 235744 h 1362075"/>
              <a:gd name="connsiteX3" fmla="*/ 966788 w 9142413"/>
              <a:gd name="connsiteY3" fmla="*/ 0 h 1362075"/>
              <a:gd name="connsiteX4" fmla="*/ 9142413 w 9142413"/>
              <a:gd name="connsiteY4" fmla="*/ 1234 h 1362075"/>
              <a:gd name="connsiteX5" fmla="*/ 9142413 w 9142413"/>
              <a:gd name="connsiteY5" fmla="*/ 1362075 h 1362075"/>
              <a:gd name="connsiteX6" fmla="*/ 0 w 9142413"/>
              <a:gd name="connsiteY6" fmla="*/ 1362075 h 1362075"/>
              <a:gd name="connsiteX7" fmla="*/ 0 w 9142413"/>
              <a:gd name="connsiteY7" fmla="*/ 1234 h 1362075"/>
              <a:gd name="connsiteX0" fmla="*/ 0 w 9142413"/>
              <a:gd name="connsiteY0" fmla="*/ 1234 h 1362075"/>
              <a:gd name="connsiteX1" fmla="*/ 702469 w 9142413"/>
              <a:gd name="connsiteY1" fmla="*/ 2381 h 1362075"/>
              <a:gd name="connsiteX2" fmla="*/ 842962 w 9142413"/>
              <a:gd name="connsiteY2" fmla="*/ 235744 h 1362075"/>
              <a:gd name="connsiteX3" fmla="*/ 966788 w 9142413"/>
              <a:gd name="connsiteY3" fmla="*/ 0 h 1362075"/>
              <a:gd name="connsiteX4" fmla="*/ 9142413 w 9142413"/>
              <a:gd name="connsiteY4" fmla="*/ 1234 h 1362075"/>
              <a:gd name="connsiteX5" fmla="*/ 9142413 w 9142413"/>
              <a:gd name="connsiteY5" fmla="*/ 1362075 h 1362075"/>
              <a:gd name="connsiteX6" fmla="*/ 0 w 9142413"/>
              <a:gd name="connsiteY6" fmla="*/ 1362075 h 1362075"/>
              <a:gd name="connsiteX7" fmla="*/ 0 w 9142413"/>
              <a:gd name="connsiteY7" fmla="*/ 1234 h 1362075"/>
              <a:gd name="connsiteX0" fmla="*/ 0 w 9149186"/>
              <a:gd name="connsiteY0" fmla="*/ 28327 h 1362075"/>
              <a:gd name="connsiteX1" fmla="*/ 709242 w 9149186"/>
              <a:gd name="connsiteY1" fmla="*/ 2381 h 1362075"/>
              <a:gd name="connsiteX2" fmla="*/ 849735 w 9149186"/>
              <a:gd name="connsiteY2" fmla="*/ 235744 h 1362075"/>
              <a:gd name="connsiteX3" fmla="*/ 973561 w 9149186"/>
              <a:gd name="connsiteY3" fmla="*/ 0 h 1362075"/>
              <a:gd name="connsiteX4" fmla="*/ 9149186 w 9149186"/>
              <a:gd name="connsiteY4" fmla="*/ 1234 h 1362075"/>
              <a:gd name="connsiteX5" fmla="*/ 9149186 w 9149186"/>
              <a:gd name="connsiteY5" fmla="*/ 1362075 h 1362075"/>
              <a:gd name="connsiteX6" fmla="*/ 6773 w 9149186"/>
              <a:gd name="connsiteY6" fmla="*/ 1362075 h 1362075"/>
              <a:gd name="connsiteX7" fmla="*/ 0 w 9149186"/>
              <a:gd name="connsiteY7" fmla="*/ 28327 h 1362075"/>
              <a:gd name="connsiteX0" fmla="*/ 0 w 9149186"/>
              <a:gd name="connsiteY0" fmla="*/ 28327 h 1362075"/>
              <a:gd name="connsiteX1" fmla="*/ 688922 w 9149186"/>
              <a:gd name="connsiteY1" fmla="*/ 29475 h 1362075"/>
              <a:gd name="connsiteX2" fmla="*/ 849735 w 9149186"/>
              <a:gd name="connsiteY2" fmla="*/ 235744 h 1362075"/>
              <a:gd name="connsiteX3" fmla="*/ 973561 w 9149186"/>
              <a:gd name="connsiteY3" fmla="*/ 0 h 1362075"/>
              <a:gd name="connsiteX4" fmla="*/ 9149186 w 9149186"/>
              <a:gd name="connsiteY4" fmla="*/ 1234 h 1362075"/>
              <a:gd name="connsiteX5" fmla="*/ 9149186 w 9149186"/>
              <a:gd name="connsiteY5" fmla="*/ 1362075 h 1362075"/>
              <a:gd name="connsiteX6" fmla="*/ 6773 w 9149186"/>
              <a:gd name="connsiteY6" fmla="*/ 1362075 h 1362075"/>
              <a:gd name="connsiteX7" fmla="*/ 0 w 9149186"/>
              <a:gd name="connsiteY7" fmla="*/ 28327 h 1362075"/>
              <a:gd name="connsiteX0" fmla="*/ 0 w 9149186"/>
              <a:gd name="connsiteY0" fmla="*/ 27093 h 1360841"/>
              <a:gd name="connsiteX1" fmla="*/ 688922 w 9149186"/>
              <a:gd name="connsiteY1" fmla="*/ 28241 h 1360841"/>
              <a:gd name="connsiteX2" fmla="*/ 849735 w 9149186"/>
              <a:gd name="connsiteY2" fmla="*/ 234510 h 1360841"/>
              <a:gd name="connsiteX3" fmla="*/ 953241 w 9149186"/>
              <a:gd name="connsiteY3" fmla="*/ 25860 h 1360841"/>
              <a:gd name="connsiteX4" fmla="*/ 9149186 w 9149186"/>
              <a:gd name="connsiteY4" fmla="*/ 0 h 1360841"/>
              <a:gd name="connsiteX5" fmla="*/ 9149186 w 9149186"/>
              <a:gd name="connsiteY5" fmla="*/ 1360841 h 1360841"/>
              <a:gd name="connsiteX6" fmla="*/ 6773 w 9149186"/>
              <a:gd name="connsiteY6" fmla="*/ 1360841 h 1360841"/>
              <a:gd name="connsiteX7" fmla="*/ 0 w 9149186"/>
              <a:gd name="connsiteY7" fmla="*/ 27093 h 1360841"/>
              <a:gd name="connsiteX0" fmla="*/ 0 w 9149186"/>
              <a:gd name="connsiteY0" fmla="*/ 1233 h 1334981"/>
              <a:gd name="connsiteX1" fmla="*/ 688922 w 9149186"/>
              <a:gd name="connsiteY1" fmla="*/ 2381 h 1334981"/>
              <a:gd name="connsiteX2" fmla="*/ 849735 w 9149186"/>
              <a:gd name="connsiteY2" fmla="*/ 208650 h 1334981"/>
              <a:gd name="connsiteX3" fmla="*/ 953241 w 9149186"/>
              <a:gd name="connsiteY3" fmla="*/ 0 h 1334981"/>
              <a:gd name="connsiteX4" fmla="*/ 9149186 w 9149186"/>
              <a:gd name="connsiteY4" fmla="*/ 1233 h 1334981"/>
              <a:gd name="connsiteX5" fmla="*/ 9149186 w 9149186"/>
              <a:gd name="connsiteY5" fmla="*/ 1334981 h 1334981"/>
              <a:gd name="connsiteX6" fmla="*/ 6773 w 9149186"/>
              <a:gd name="connsiteY6" fmla="*/ 1334981 h 1334981"/>
              <a:gd name="connsiteX7" fmla="*/ 0 w 9149186"/>
              <a:gd name="connsiteY7" fmla="*/ 1233 h 1334981"/>
              <a:gd name="connsiteX0" fmla="*/ 0 w 9149186"/>
              <a:gd name="connsiteY0" fmla="*/ 1233 h 1334981"/>
              <a:gd name="connsiteX1" fmla="*/ 688922 w 9149186"/>
              <a:gd name="connsiteY1" fmla="*/ 2381 h 1334981"/>
              <a:gd name="connsiteX2" fmla="*/ 815868 w 9149186"/>
              <a:gd name="connsiteY2" fmla="*/ 235743 h 1334981"/>
              <a:gd name="connsiteX3" fmla="*/ 953241 w 9149186"/>
              <a:gd name="connsiteY3" fmla="*/ 0 h 1334981"/>
              <a:gd name="connsiteX4" fmla="*/ 9149186 w 9149186"/>
              <a:gd name="connsiteY4" fmla="*/ 1233 h 1334981"/>
              <a:gd name="connsiteX5" fmla="*/ 9149186 w 9149186"/>
              <a:gd name="connsiteY5" fmla="*/ 1334981 h 1334981"/>
              <a:gd name="connsiteX6" fmla="*/ 6773 w 9149186"/>
              <a:gd name="connsiteY6" fmla="*/ 1334981 h 1334981"/>
              <a:gd name="connsiteX7" fmla="*/ 0 w 9149186"/>
              <a:gd name="connsiteY7" fmla="*/ 1233 h 1334981"/>
              <a:gd name="connsiteX0" fmla="*/ 3193 w 9142854"/>
              <a:gd name="connsiteY0" fmla="*/ 5995 h 1334981"/>
              <a:gd name="connsiteX1" fmla="*/ 682590 w 9142854"/>
              <a:gd name="connsiteY1" fmla="*/ 2381 h 1334981"/>
              <a:gd name="connsiteX2" fmla="*/ 809536 w 9142854"/>
              <a:gd name="connsiteY2" fmla="*/ 235743 h 1334981"/>
              <a:gd name="connsiteX3" fmla="*/ 946909 w 9142854"/>
              <a:gd name="connsiteY3" fmla="*/ 0 h 1334981"/>
              <a:gd name="connsiteX4" fmla="*/ 9142854 w 9142854"/>
              <a:gd name="connsiteY4" fmla="*/ 1233 h 1334981"/>
              <a:gd name="connsiteX5" fmla="*/ 9142854 w 9142854"/>
              <a:gd name="connsiteY5" fmla="*/ 1334981 h 1334981"/>
              <a:gd name="connsiteX6" fmla="*/ 441 w 9142854"/>
              <a:gd name="connsiteY6" fmla="*/ 1334981 h 1334981"/>
              <a:gd name="connsiteX7" fmla="*/ 3193 w 9142854"/>
              <a:gd name="connsiteY7" fmla="*/ 5995 h 1334981"/>
              <a:gd name="connsiteX0" fmla="*/ 982 w 9143024"/>
              <a:gd name="connsiteY0" fmla="*/ 0 h 1338511"/>
              <a:gd name="connsiteX1" fmla="*/ 682760 w 9143024"/>
              <a:gd name="connsiteY1" fmla="*/ 5911 h 1338511"/>
              <a:gd name="connsiteX2" fmla="*/ 809706 w 9143024"/>
              <a:gd name="connsiteY2" fmla="*/ 239273 h 1338511"/>
              <a:gd name="connsiteX3" fmla="*/ 947079 w 9143024"/>
              <a:gd name="connsiteY3" fmla="*/ 3530 h 1338511"/>
              <a:gd name="connsiteX4" fmla="*/ 9143024 w 9143024"/>
              <a:gd name="connsiteY4" fmla="*/ 4763 h 1338511"/>
              <a:gd name="connsiteX5" fmla="*/ 9143024 w 9143024"/>
              <a:gd name="connsiteY5" fmla="*/ 1338511 h 1338511"/>
              <a:gd name="connsiteX6" fmla="*/ 611 w 9143024"/>
              <a:gd name="connsiteY6" fmla="*/ 1338511 h 1338511"/>
              <a:gd name="connsiteX7" fmla="*/ 982 w 9143024"/>
              <a:gd name="connsiteY7" fmla="*/ 0 h 1338511"/>
              <a:gd name="connsiteX0" fmla="*/ 982 w 9143024"/>
              <a:gd name="connsiteY0" fmla="*/ 0 h 1338511"/>
              <a:gd name="connsiteX1" fmla="*/ 673235 w 9143024"/>
              <a:gd name="connsiteY1" fmla="*/ 1149 h 1338511"/>
              <a:gd name="connsiteX2" fmla="*/ 809706 w 9143024"/>
              <a:gd name="connsiteY2" fmla="*/ 239273 h 1338511"/>
              <a:gd name="connsiteX3" fmla="*/ 947079 w 9143024"/>
              <a:gd name="connsiteY3" fmla="*/ 3530 h 1338511"/>
              <a:gd name="connsiteX4" fmla="*/ 9143024 w 9143024"/>
              <a:gd name="connsiteY4" fmla="*/ 4763 h 1338511"/>
              <a:gd name="connsiteX5" fmla="*/ 9143024 w 9143024"/>
              <a:gd name="connsiteY5" fmla="*/ 1338511 h 1338511"/>
              <a:gd name="connsiteX6" fmla="*/ 611 w 9143024"/>
              <a:gd name="connsiteY6" fmla="*/ 1338511 h 1338511"/>
              <a:gd name="connsiteX7" fmla="*/ 982 w 9143024"/>
              <a:gd name="connsiteY7" fmla="*/ 0 h 1338511"/>
              <a:gd name="connsiteX0" fmla="*/ 982 w 9143024"/>
              <a:gd name="connsiteY0" fmla="*/ 0 h 1338511"/>
              <a:gd name="connsiteX1" fmla="*/ 673235 w 9143024"/>
              <a:gd name="connsiteY1" fmla="*/ 1149 h 1338511"/>
              <a:gd name="connsiteX2" fmla="*/ 809706 w 9143024"/>
              <a:gd name="connsiteY2" fmla="*/ 239273 h 1338511"/>
              <a:gd name="connsiteX3" fmla="*/ 947079 w 9143024"/>
              <a:gd name="connsiteY3" fmla="*/ 3530 h 1338511"/>
              <a:gd name="connsiteX4" fmla="*/ 9143024 w 9143024"/>
              <a:gd name="connsiteY4" fmla="*/ 4763 h 1338511"/>
              <a:gd name="connsiteX5" fmla="*/ 9143024 w 9143024"/>
              <a:gd name="connsiteY5" fmla="*/ 1338511 h 1338511"/>
              <a:gd name="connsiteX6" fmla="*/ 611 w 9143024"/>
              <a:gd name="connsiteY6" fmla="*/ 1338511 h 1338511"/>
              <a:gd name="connsiteX7" fmla="*/ 982 w 9143024"/>
              <a:gd name="connsiteY7" fmla="*/ 0 h 1338511"/>
              <a:gd name="connsiteX0" fmla="*/ 982 w 9143024"/>
              <a:gd name="connsiteY0" fmla="*/ 3614 h 1342125"/>
              <a:gd name="connsiteX1" fmla="*/ 673235 w 9143024"/>
              <a:gd name="connsiteY1" fmla="*/ 4763 h 1342125"/>
              <a:gd name="connsiteX2" fmla="*/ 809706 w 9143024"/>
              <a:gd name="connsiteY2" fmla="*/ 242887 h 1342125"/>
              <a:gd name="connsiteX3" fmla="*/ 937554 w 9143024"/>
              <a:gd name="connsiteY3" fmla="*/ 0 h 1342125"/>
              <a:gd name="connsiteX4" fmla="*/ 9143024 w 9143024"/>
              <a:gd name="connsiteY4" fmla="*/ 8377 h 1342125"/>
              <a:gd name="connsiteX5" fmla="*/ 9143024 w 9143024"/>
              <a:gd name="connsiteY5" fmla="*/ 1342125 h 1342125"/>
              <a:gd name="connsiteX6" fmla="*/ 611 w 9143024"/>
              <a:gd name="connsiteY6" fmla="*/ 1342125 h 1342125"/>
              <a:gd name="connsiteX7" fmla="*/ 982 w 9143024"/>
              <a:gd name="connsiteY7" fmla="*/ 3614 h 1342125"/>
              <a:gd name="connsiteX0" fmla="*/ 982 w 9143024"/>
              <a:gd name="connsiteY0" fmla="*/ 3614 h 1342125"/>
              <a:gd name="connsiteX1" fmla="*/ 673235 w 9143024"/>
              <a:gd name="connsiteY1" fmla="*/ 4763 h 1342125"/>
              <a:gd name="connsiteX2" fmla="*/ 800181 w 9143024"/>
              <a:gd name="connsiteY2" fmla="*/ 200024 h 1342125"/>
              <a:gd name="connsiteX3" fmla="*/ 937554 w 9143024"/>
              <a:gd name="connsiteY3" fmla="*/ 0 h 1342125"/>
              <a:gd name="connsiteX4" fmla="*/ 9143024 w 9143024"/>
              <a:gd name="connsiteY4" fmla="*/ 8377 h 1342125"/>
              <a:gd name="connsiteX5" fmla="*/ 9143024 w 9143024"/>
              <a:gd name="connsiteY5" fmla="*/ 1342125 h 1342125"/>
              <a:gd name="connsiteX6" fmla="*/ 611 w 9143024"/>
              <a:gd name="connsiteY6" fmla="*/ 1342125 h 1342125"/>
              <a:gd name="connsiteX7" fmla="*/ 982 w 9143024"/>
              <a:gd name="connsiteY7" fmla="*/ 3614 h 1342125"/>
              <a:gd name="connsiteX0" fmla="*/ 982 w 9143024"/>
              <a:gd name="connsiteY0" fmla="*/ 3614 h 1342125"/>
              <a:gd name="connsiteX1" fmla="*/ 673235 w 9143024"/>
              <a:gd name="connsiteY1" fmla="*/ 4763 h 1342125"/>
              <a:gd name="connsiteX2" fmla="*/ 800181 w 9143024"/>
              <a:gd name="connsiteY2" fmla="*/ 238124 h 1342125"/>
              <a:gd name="connsiteX3" fmla="*/ 937554 w 9143024"/>
              <a:gd name="connsiteY3" fmla="*/ 0 h 1342125"/>
              <a:gd name="connsiteX4" fmla="*/ 9143024 w 9143024"/>
              <a:gd name="connsiteY4" fmla="*/ 8377 h 1342125"/>
              <a:gd name="connsiteX5" fmla="*/ 9143024 w 9143024"/>
              <a:gd name="connsiteY5" fmla="*/ 1342125 h 1342125"/>
              <a:gd name="connsiteX6" fmla="*/ 611 w 9143024"/>
              <a:gd name="connsiteY6" fmla="*/ 1342125 h 1342125"/>
              <a:gd name="connsiteX7" fmla="*/ 982 w 9143024"/>
              <a:gd name="connsiteY7" fmla="*/ 3614 h 1342125"/>
              <a:gd name="connsiteX0" fmla="*/ 982 w 9143024"/>
              <a:gd name="connsiteY0" fmla="*/ 3614 h 1342125"/>
              <a:gd name="connsiteX1" fmla="*/ 673235 w 9143024"/>
              <a:gd name="connsiteY1" fmla="*/ 4763 h 1342125"/>
              <a:gd name="connsiteX2" fmla="*/ 800181 w 9143024"/>
              <a:gd name="connsiteY2" fmla="*/ 238124 h 1342125"/>
              <a:gd name="connsiteX3" fmla="*/ 937554 w 9143024"/>
              <a:gd name="connsiteY3" fmla="*/ 0 h 1342125"/>
              <a:gd name="connsiteX4" fmla="*/ 9143024 w 9143024"/>
              <a:gd name="connsiteY4" fmla="*/ 8377 h 1342125"/>
              <a:gd name="connsiteX5" fmla="*/ 9143024 w 9143024"/>
              <a:gd name="connsiteY5" fmla="*/ 1342125 h 1342125"/>
              <a:gd name="connsiteX6" fmla="*/ 611 w 9143024"/>
              <a:gd name="connsiteY6" fmla="*/ 1342125 h 1342125"/>
              <a:gd name="connsiteX7" fmla="*/ 982 w 9143024"/>
              <a:gd name="connsiteY7" fmla="*/ 3614 h 1342125"/>
              <a:gd name="connsiteX0" fmla="*/ 982 w 9143024"/>
              <a:gd name="connsiteY0" fmla="*/ 3614 h 1342125"/>
              <a:gd name="connsiteX1" fmla="*/ 673235 w 9143024"/>
              <a:gd name="connsiteY1" fmla="*/ 4763 h 1342125"/>
              <a:gd name="connsiteX2" fmla="*/ 800181 w 9143024"/>
              <a:gd name="connsiteY2" fmla="*/ 238124 h 1342125"/>
              <a:gd name="connsiteX3" fmla="*/ 937554 w 9143024"/>
              <a:gd name="connsiteY3" fmla="*/ 0 h 1342125"/>
              <a:gd name="connsiteX4" fmla="*/ 9143024 w 9143024"/>
              <a:gd name="connsiteY4" fmla="*/ 8377 h 1342125"/>
              <a:gd name="connsiteX5" fmla="*/ 9143024 w 9143024"/>
              <a:gd name="connsiteY5" fmla="*/ 1342125 h 1342125"/>
              <a:gd name="connsiteX6" fmla="*/ 611 w 9143024"/>
              <a:gd name="connsiteY6" fmla="*/ 1342125 h 1342125"/>
              <a:gd name="connsiteX7" fmla="*/ 982 w 9143024"/>
              <a:gd name="connsiteY7" fmla="*/ 3614 h 1342125"/>
              <a:gd name="connsiteX0" fmla="*/ 982 w 9143024"/>
              <a:gd name="connsiteY0" fmla="*/ 3614 h 1342125"/>
              <a:gd name="connsiteX1" fmla="*/ 661329 w 9143024"/>
              <a:gd name="connsiteY1" fmla="*/ 2382 h 1342125"/>
              <a:gd name="connsiteX2" fmla="*/ 800181 w 9143024"/>
              <a:gd name="connsiteY2" fmla="*/ 238124 h 1342125"/>
              <a:gd name="connsiteX3" fmla="*/ 937554 w 9143024"/>
              <a:gd name="connsiteY3" fmla="*/ 0 h 1342125"/>
              <a:gd name="connsiteX4" fmla="*/ 9143024 w 9143024"/>
              <a:gd name="connsiteY4" fmla="*/ 8377 h 1342125"/>
              <a:gd name="connsiteX5" fmla="*/ 9143024 w 9143024"/>
              <a:gd name="connsiteY5" fmla="*/ 1342125 h 1342125"/>
              <a:gd name="connsiteX6" fmla="*/ 611 w 9143024"/>
              <a:gd name="connsiteY6" fmla="*/ 1342125 h 1342125"/>
              <a:gd name="connsiteX7" fmla="*/ 982 w 9143024"/>
              <a:gd name="connsiteY7" fmla="*/ 3614 h 1342125"/>
              <a:gd name="connsiteX0" fmla="*/ 982 w 9143024"/>
              <a:gd name="connsiteY0" fmla="*/ 3614 h 1342125"/>
              <a:gd name="connsiteX1" fmla="*/ 668473 w 9143024"/>
              <a:gd name="connsiteY1" fmla="*/ 2382 h 1342125"/>
              <a:gd name="connsiteX2" fmla="*/ 800181 w 9143024"/>
              <a:gd name="connsiteY2" fmla="*/ 238124 h 1342125"/>
              <a:gd name="connsiteX3" fmla="*/ 937554 w 9143024"/>
              <a:gd name="connsiteY3" fmla="*/ 0 h 1342125"/>
              <a:gd name="connsiteX4" fmla="*/ 9143024 w 9143024"/>
              <a:gd name="connsiteY4" fmla="*/ 8377 h 1342125"/>
              <a:gd name="connsiteX5" fmla="*/ 9143024 w 9143024"/>
              <a:gd name="connsiteY5" fmla="*/ 1342125 h 1342125"/>
              <a:gd name="connsiteX6" fmla="*/ 611 w 9143024"/>
              <a:gd name="connsiteY6" fmla="*/ 1342125 h 1342125"/>
              <a:gd name="connsiteX7" fmla="*/ 982 w 9143024"/>
              <a:gd name="connsiteY7" fmla="*/ 3614 h 1342125"/>
              <a:gd name="connsiteX0" fmla="*/ 982 w 9143024"/>
              <a:gd name="connsiteY0" fmla="*/ 3614 h 1342125"/>
              <a:gd name="connsiteX1" fmla="*/ 668473 w 9143024"/>
              <a:gd name="connsiteY1" fmla="*/ 2382 h 1342125"/>
              <a:gd name="connsiteX2" fmla="*/ 800181 w 9143024"/>
              <a:gd name="connsiteY2" fmla="*/ 238124 h 1342125"/>
              <a:gd name="connsiteX3" fmla="*/ 937554 w 9143024"/>
              <a:gd name="connsiteY3" fmla="*/ 0 h 1342125"/>
              <a:gd name="connsiteX4" fmla="*/ 9143024 w 9143024"/>
              <a:gd name="connsiteY4" fmla="*/ 8377 h 1342125"/>
              <a:gd name="connsiteX5" fmla="*/ 9143024 w 9143024"/>
              <a:gd name="connsiteY5" fmla="*/ 1342125 h 1342125"/>
              <a:gd name="connsiteX6" fmla="*/ 611 w 9143024"/>
              <a:gd name="connsiteY6" fmla="*/ 1342125 h 1342125"/>
              <a:gd name="connsiteX7" fmla="*/ 982 w 9143024"/>
              <a:gd name="connsiteY7" fmla="*/ 3614 h 1342125"/>
              <a:gd name="connsiteX0" fmla="*/ 982 w 9143024"/>
              <a:gd name="connsiteY0" fmla="*/ 3614 h 1342125"/>
              <a:gd name="connsiteX1" fmla="*/ 668473 w 9143024"/>
              <a:gd name="connsiteY1" fmla="*/ 2382 h 1342125"/>
              <a:gd name="connsiteX2" fmla="*/ 804944 w 9143024"/>
              <a:gd name="connsiteY2" fmla="*/ 247649 h 1342125"/>
              <a:gd name="connsiteX3" fmla="*/ 937554 w 9143024"/>
              <a:gd name="connsiteY3" fmla="*/ 0 h 1342125"/>
              <a:gd name="connsiteX4" fmla="*/ 9143024 w 9143024"/>
              <a:gd name="connsiteY4" fmla="*/ 8377 h 1342125"/>
              <a:gd name="connsiteX5" fmla="*/ 9143024 w 9143024"/>
              <a:gd name="connsiteY5" fmla="*/ 1342125 h 1342125"/>
              <a:gd name="connsiteX6" fmla="*/ 611 w 9143024"/>
              <a:gd name="connsiteY6" fmla="*/ 1342125 h 1342125"/>
              <a:gd name="connsiteX7" fmla="*/ 982 w 9143024"/>
              <a:gd name="connsiteY7" fmla="*/ 3614 h 1342125"/>
              <a:gd name="connsiteX0" fmla="*/ 982 w 9143024"/>
              <a:gd name="connsiteY0" fmla="*/ 3614 h 1342125"/>
              <a:gd name="connsiteX1" fmla="*/ 668473 w 9143024"/>
              <a:gd name="connsiteY1" fmla="*/ 2382 h 1342125"/>
              <a:gd name="connsiteX2" fmla="*/ 804944 w 9143024"/>
              <a:gd name="connsiteY2" fmla="*/ 247649 h 1342125"/>
              <a:gd name="connsiteX3" fmla="*/ 937554 w 9143024"/>
              <a:gd name="connsiteY3" fmla="*/ 0 h 1342125"/>
              <a:gd name="connsiteX4" fmla="*/ 9143024 w 9143024"/>
              <a:gd name="connsiteY4" fmla="*/ 8377 h 1342125"/>
              <a:gd name="connsiteX5" fmla="*/ 9143024 w 9143024"/>
              <a:gd name="connsiteY5" fmla="*/ 1342125 h 1342125"/>
              <a:gd name="connsiteX6" fmla="*/ 611 w 9143024"/>
              <a:gd name="connsiteY6" fmla="*/ 1342125 h 1342125"/>
              <a:gd name="connsiteX7" fmla="*/ 982 w 9143024"/>
              <a:gd name="connsiteY7" fmla="*/ 3614 h 1342125"/>
              <a:gd name="connsiteX0" fmla="*/ 982 w 9143024"/>
              <a:gd name="connsiteY0" fmla="*/ 3614 h 1342125"/>
              <a:gd name="connsiteX1" fmla="*/ 668473 w 9143024"/>
              <a:gd name="connsiteY1" fmla="*/ 2382 h 1342125"/>
              <a:gd name="connsiteX2" fmla="*/ 804944 w 9143024"/>
              <a:gd name="connsiteY2" fmla="*/ 247649 h 1342125"/>
              <a:gd name="connsiteX3" fmla="*/ 937554 w 9143024"/>
              <a:gd name="connsiteY3" fmla="*/ 0 h 1342125"/>
              <a:gd name="connsiteX4" fmla="*/ 9143024 w 9143024"/>
              <a:gd name="connsiteY4" fmla="*/ 8377 h 1342125"/>
              <a:gd name="connsiteX5" fmla="*/ 9143024 w 9143024"/>
              <a:gd name="connsiteY5" fmla="*/ 1342125 h 1342125"/>
              <a:gd name="connsiteX6" fmla="*/ 611 w 9143024"/>
              <a:gd name="connsiteY6" fmla="*/ 1342125 h 1342125"/>
              <a:gd name="connsiteX7" fmla="*/ 982 w 9143024"/>
              <a:gd name="connsiteY7" fmla="*/ 3614 h 1342125"/>
              <a:gd name="connsiteX0" fmla="*/ 982 w 9143024"/>
              <a:gd name="connsiteY0" fmla="*/ 3614 h 1342125"/>
              <a:gd name="connsiteX1" fmla="*/ 668473 w 9143024"/>
              <a:gd name="connsiteY1" fmla="*/ 2382 h 1342125"/>
              <a:gd name="connsiteX2" fmla="*/ 804944 w 9143024"/>
              <a:gd name="connsiteY2" fmla="*/ 247649 h 1342125"/>
              <a:gd name="connsiteX3" fmla="*/ 937554 w 9143024"/>
              <a:gd name="connsiteY3" fmla="*/ 0 h 1342125"/>
              <a:gd name="connsiteX4" fmla="*/ 9143024 w 9143024"/>
              <a:gd name="connsiteY4" fmla="*/ 3615 h 1342125"/>
              <a:gd name="connsiteX5" fmla="*/ 9143024 w 9143024"/>
              <a:gd name="connsiteY5" fmla="*/ 1342125 h 1342125"/>
              <a:gd name="connsiteX6" fmla="*/ 611 w 9143024"/>
              <a:gd name="connsiteY6" fmla="*/ 1342125 h 1342125"/>
              <a:gd name="connsiteX7" fmla="*/ 982 w 9143024"/>
              <a:gd name="connsiteY7" fmla="*/ 3614 h 1342125"/>
              <a:gd name="connsiteX0" fmla="*/ 982 w 9143024"/>
              <a:gd name="connsiteY0" fmla="*/ 3614 h 1342125"/>
              <a:gd name="connsiteX1" fmla="*/ 668473 w 9143024"/>
              <a:gd name="connsiteY1" fmla="*/ 2382 h 1342125"/>
              <a:gd name="connsiteX2" fmla="*/ 804944 w 9143024"/>
              <a:gd name="connsiteY2" fmla="*/ 247649 h 1342125"/>
              <a:gd name="connsiteX3" fmla="*/ 937554 w 9143024"/>
              <a:gd name="connsiteY3" fmla="*/ 0 h 1342125"/>
              <a:gd name="connsiteX4" fmla="*/ 9143024 w 9143024"/>
              <a:gd name="connsiteY4" fmla="*/ 3615 h 1342125"/>
              <a:gd name="connsiteX5" fmla="*/ 9143024 w 9143024"/>
              <a:gd name="connsiteY5" fmla="*/ 1342125 h 1342125"/>
              <a:gd name="connsiteX6" fmla="*/ 611 w 9143024"/>
              <a:gd name="connsiteY6" fmla="*/ 1342125 h 1342125"/>
              <a:gd name="connsiteX7" fmla="*/ 982 w 9143024"/>
              <a:gd name="connsiteY7" fmla="*/ 3614 h 1342125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804944 w 9143024"/>
              <a:gd name="connsiteY2" fmla="*/ 245267 h 1339743"/>
              <a:gd name="connsiteX3" fmla="*/ 947079 w 9143024"/>
              <a:gd name="connsiteY3" fmla="*/ 0 h 1339743"/>
              <a:gd name="connsiteX4" fmla="*/ 9143024 w 9143024"/>
              <a:gd name="connsiteY4" fmla="*/ 1233 h 1339743"/>
              <a:gd name="connsiteX5" fmla="*/ 9143024 w 9143024"/>
              <a:gd name="connsiteY5" fmla="*/ 1339743 h 1339743"/>
              <a:gd name="connsiteX6" fmla="*/ 611 w 9143024"/>
              <a:gd name="connsiteY6" fmla="*/ 1339743 h 1339743"/>
              <a:gd name="connsiteX7" fmla="*/ 982 w 9143024"/>
              <a:gd name="connsiteY7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804944 w 9143024"/>
              <a:gd name="connsiteY2" fmla="*/ 245267 h 1339743"/>
              <a:gd name="connsiteX3" fmla="*/ 947079 w 9143024"/>
              <a:gd name="connsiteY3" fmla="*/ 0 h 1339743"/>
              <a:gd name="connsiteX4" fmla="*/ 9143024 w 9143024"/>
              <a:gd name="connsiteY4" fmla="*/ 1233 h 1339743"/>
              <a:gd name="connsiteX5" fmla="*/ 9143024 w 9143024"/>
              <a:gd name="connsiteY5" fmla="*/ 1339743 h 1339743"/>
              <a:gd name="connsiteX6" fmla="*/ 611 w 9143024"/>
              <a:gd name="connsiteY6" fmla="*/ 1339743 h 1339743"/>
              <a:gd name="connsiteX7" fmla="*/ 982 w 9143024"/>
              <a:gd name="connsiteY7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0230 w 9143024"/>
              <a:gd name="connsiteY2" fmla="*/ 211031 h 1339743"/>
              <a:gd name="connsiteX3" fmla="*/ 804944 w 9143024"/>
              <a:gd name="connsiteY3" fmla="*/ 245267 h 1339743"/>
              <a:gd name="connsiteX4" fmla="*/ 947079 w 9143024"/>
              <a:gd name="connsiteY4" fmla="*/ 0 h 1339743"/>
              <a:gd name="connsiteX5" fmla="*/ 9143024 w 9143024"/>
              <a:gd name="connsiteY5" fmla="*/ 1233 h 1339743"/>
              <a:gd name="connsiteX6" fmla="*/ 9143024 w 9143024"/>
              <a:gd name="connsiteY6" fmla="*/ 1339743 h 1339743"/>
              <a:gd name="connsiteX7" fmla="*/ 611 w 9143024"/>
              <a:gd name="connsiteY7" fmla="*/ 1339743 h 1339743"/>
              <a:gd name="connsiteX8" fmla="*/ 982 w 9143024"/>
              <a:gd name="connsiteY8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0230 w 9143024"/>
              <a:gd name="connsiteY2" fmla="*/ 211031 h 1339743"/>
              <a:gd name="connsiteX3" fmla="*/ 804944 w 9143024"/>
              <a:gd name="connsiteY3" fmla="*/ 245267 h 1339743"/>
              <a:gd name="connsiteX4" fmla="*/ 836430 w 9143024"/>
              <a:gd name="connsiteY4" fmla="*/ 199124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0230 w 9143024"/>
              <a:gd name="connsiteY2" fmla="*/ 211031 h 1339743"/>
              <a:gd name="connsiteX3" fmla="*/ 804944 w 9143024"/>
              <a:gd name="connsiteY3" fmla="*/ 245267 h 1339743"/>
              <a:gd name="connsiteX4" fmla="*/ 843574 w 9143024"/>
              <a:gd name="connsiteY4" fmla="*/ 213412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0230 w 9143024"/>
              <a:gd name="connsiteY2" fmla="*/ 211031 h 1339743"/>
              <a:gd name="connsiteX3" fmla="*/ 804944 w 9143024"/>
              <a:gd name="connsiteY3" fmla="*/ 245267 h 1339743"/>
              <a:gd name="connsiteX4" fmla="*/ 843574 w 9143024"/>
              <a:gd name="connsiteY4" fmla="*/ 213412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0230 w 9143024"/>
              <a:gd name="connsiteY2" fmla="*/ 211031 h 1339743"/>
              <a:gd name="connsiteX3" fmla="*/ 804944 w 9143024"/>
              <a:gd name="connsiteY3" fmla="*/ 245267 h 1339743"/>
              <a:gd name="connsiteX4" fmla="*/ 843574 w 9143024"/>
              <a:gd name="connsiteY4" fmla="*/ 213412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0230 w 9143024"/>
              <a:gd name="connsiteY2" fmla="*/ 211031 h 1339743"/>
              <a:gd name="connsiteX3" fmla="*/ 804944 w 9143024"/>
              <a:gd name="connsiteY3" fmla="*/ 245267 h 1339743"/>
              <a:gd name="connsiteX4" fmla="*/ 843574 w 9143024"/>
              <a:gd name="connsiteY4" fmla="*/ 213412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0230 w 9143024"/>
              <a:gd name="connsiteY2" fmla="*/ 211031 h 1339743"/>
              <a:gd name="connsiteX3" fmla="*/ 804944 w 9143024"/>
              <a:gd name="connsiteY3" fmla="*/ 245267 h 1339743"/>
              <a:gd name="connsiteX4" fmla="*/ 843574 w 9143024"/>
              <a:gd name="connsiteY4" fmla="*/ 213412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0230 w 9143024"/>
              <a:gd name="connsiteY2" fmla="*/ 211031 h 1339743"/>
              <a:gd name="connsiteX3" fmla="*/ 804944 w 9143024"/>
              <a:gd name="connsiteY3" fmla="*/ 245267 h 1339743"/>
              <a:gd name="connsiteX4" fmla="*/ 843574 w 9143024"/>
              <a:gd name="connsiteY4" fmla="*/ 213412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0230 w 9143024"/>
              <a:gd name="connsiteY2" fmla="*/ 211031 h 1339743"/>
              <a:gd name="connsiteX3" fmla="*/ 804944 w 9143024"/>
              <a:gd name="connsiteY3" fmla="*/ 245267 h 1339743"/>
              <a:gd name="connsiteX4" fmla="*/ 843574 w 9143024"/>
              <a:gd name="connsiteY4" fmla="*/ 213412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0230 w 9143024"/>
              <a:gd name="connsiteY2" fmla="*/ 211031 h 1339743"/>
              <a:gd name="connsiteX3" fmla="*/ 804944 w 9143024"/>
              <a:gd name="connsiteY3" fmla="*/ 245267 h 1339743"/>
              <a:gd name="connsiteX4" fmla="*/ 848337 w 9143024"/>
              <a:gd name="connsiteY4" fmla="*/ 203887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0230 w 9143024"/>
              <a:gd name="connsiteY2" fmla="*/ 211031 h 1339743"/>
              <a:gd name="connsiteX3" fmla="*/ 804944 w 9143024"/>
              <a:gd name="connsiteY3" fmla="*/ 245267 h 1339743"/>
              <a:gd name="connsiteX4" fmla="*/ 848337 w 9143024"/>
              <a:gd name="connsiteY4" fmla="*/ 203887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7374 w 9143024"/>
              <a:gd name="connsiteY2" fmla="*/ 206268 h 1339743"/>
              <a:gd name="connsiteX3" fmla="*/ 804944 w 9143024"/>
              <a:gd name="connsiteY3" fmla="*/ 245267 h 1339743"/>
              <a:gd name="connsiteX4" fmla="*/ 848337 w 9143024"/>
              <a:gd name="connsiteY4" fmla="*/ 203887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7374 w 9143024"/>
              <a:gd name="connsiteY2" fmla="*/ 206268 h 1339743"/>
              <a:gd name="connsiteX3" fmla="*/ 804944 w 9143024"/>
              <a:gd name="connsiteY3" fmla="*/ 245267 h 1339743"/>
              <a:gd name="connsiteX4" fmla="*/ 848337 w 9143024"/>
              <a:gd name="connsiteY4" fmla="*/ 203887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7374 w 9143024"/>
              <a:gd name="connsiteY2" fmla="*/ 206268 h 1339743"/>
              <a:gd name="connsiteX3" fmla="*/ 804944 w 9143024"/>
              <a:gd name="connsiteY3" fmla="*/ 245267 h 1339743"/>
              <a:gd name="connsiteX4" fmla="*/ 848337 w 9143024"/>
              <a:gd name="connsiteY4" fmla="*/ 203887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7374 w 9143024"/>
              <a:gd name="connsiteY2" fmla="*/ 206268 h 1339743"/>
              <a:gd name="connsiteX3" fmla="*/ 804944 w 9143024"/>
              <a:gd name="connsiteY3" fmla="*/ 245267 h 1339743"/>
              <a:gd name="connsiteX4" fmla="*/ 843574 w 9143024"/>
              <a:gd name="connsiteY4" fmla="*/ 199125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7374 w 9143024"/>
              <a:gd name="connsiteY2" fmla="*/ 199124 h 1339743"/>
              <a:gd name="connsiteX3" fmla="*/ 804944 w 9143024"/>
              <a:gd name="connsiteY3" fmla="*/ 245267 h 1339743"/>
              <a:gd name="connsiteX4" fmla="*/ 843574 w 9143024"/>
              <a:gd name="connsiteY4" fmla="*/ 199125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7374 w 9143024"/>
              <a:gd name="connsiteY2" fmla="*/ 199124 h 1339743"/>
              <a:gd name="connsiteX3" fmla="*/ 804944 w 9143024"/>
              <a:gd name="connsiteY3" fmla="*/ 245267 h 1339743"/>
              <a:gd name="connsiteX4" fmla="*/ 843574 w 9143024"/>
              <a:gd name="connsiteY4" fmla="*/ 199125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55468 w 9143024"/>
              <a:gd name="connsiteY2" fmla="*/ 232462 h 1339743"/>
              <a:gd name="connsiteX3" fmla="*/ 804944 w 9143024"/>
              <a:gd name="connsiteY3" fmla="*/ 245267 h 1339743"/>
              <a:gd name="connsiteX4" fmla="*/ 843574 w 9143024"/>
              <a:gd name="connsiteY4" fmla="*/ 199125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4993 w 9143024"/>
              <a:gd name="connsiteY2" fmla="*/ 201506 h 1339743"/>
              <a:gd name="connsiteX3" fmla="*/ 804944 w 9143024"/>
              <a:gd name="connsiteY3" fmla="*/ 245267 h 1339743"/>
              <a:gd name="connsiteX4" fmla="*/ 843574 w 9143024"/>
              <a:gd name="connsiteY4" fmla="*/ 199125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4993 w 9143024"/>
              <a:gd name="connsiteY2" fmla="*/ 201506 h 1339743"/>
              <a:gd name="connsiteX3" fmla="*/ 804944 w 9143024"/>
              <a:gd name="connsiteY3" fmla="*/ 245267 h 1339743"/>
              <a:gd name="connsiteX4" fmla="*/ 843574 w 9143024"/>
              <a:gd name="connsiteY4" fmla="*/ 199125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4993 w 9143024"/>
              <a:gd name="connsiteY2" fmla="*/ 201506 h 1339743"/>
              <a:gd name="connsiteX3" fmla="*/ 804944 w 9143024"/>
              <a:gd name="connsiteY3" fmla="*/ 245267 h 1339743"/>
              <a:gd name="connsiteX4" fmla="*/ 843574 w 9143024"/>
              <a:gd name="connsiteY4" fmla="*/ 199125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4993 w 9143024"/>
              <a:gd name="connsiteY2" fmla="*/ 201506 h 1339743"/>
              <a:gd name="connsiteX3" fmla="*/ 785894 w 9143024"/>
              <a:gd name="connsiteY3" fmla="*/ 245267 h 1339743"/>
              <a:gd name="connsiteX4" fmla="*/ 843574 w 9143024"/>
              <a:gd name="connsiteY4" fmla="*/ 199125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4993 w 9143024"/>
              <a:gd name="connsiteY2" fmla="*/ 201506 h 1339743"/>
              <a:gd name="connsiteX3" fmla="*/ 797800 w 9143024"/>
              <a:gd name="connsiteY3" fmla="*/ 245267 h 1339743"/>
              <a:gd name="connsiteX4" fmla="*/ 843574 w 9143024"/>
              <a:gd name="connsiteY4" fmla="*/ 199125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4993 w 9143024"/>
              <a:gd name="connsiteY2" fmla="*/ 201506 h 1339743"/>
              <a:gd name="connsiteX3" fmla="*/ 797800 w 9143024"/>
              <a:gd name="connsiteY3" fmla="*/ 245267 h 1339743"/>
              <a:gd name="connsiteX4" fmla="*/ 843574 w 9143024"/>
              <a:gd name="connsiteY4" fmla="*/ 199125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4993 w 9143024"/>
              <a:gd name="connsiteY2" fmla="*/ 201506 h 1339743"/>
              <a:gd name="connsiteX3" fmla="*/ 797800 w 9143024"/>
              <a:gd name="connsiteY3" fmla="*/ 245267 h 1339743"/>
              <a:gd name="connsiteX4" fmla="*/ 843574 w 9143024"/>
              <a:gd name="connsiteY4" fmla="*/ 199125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4993 w 9143024"/>
              <a:gd name="connsiteY2" fmla="*/ 201506 h 1339743"/>
              <a:gd name="connsiteX3" fmla="*/ 797800 w 9143024"/>
              <a:gd name="connsiteY3" fmla="*/ 245267 h 1339743"/>
              <a:gd name="connsiteX4" fmla="*/ 843574 w 9143024"/>
              <a:gd name="connsiteY4" fmla="*/ 199125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4993 w 9143024"/>
              <a:gd name="connsiteY2" fmla="*/ 201506 h 1339743"/>
              <a:gd name="connsiteX3" fmla="*/ 802562 w 9143024"/>
              <a:gd name="connsiteY3" fmla="*/ 245267 h 1339743"/>
              <a:gd name="connsiteX4" fmla="*/ 843574 w 9143024"/>
              <a:gd name="connsiteY4" fmla="*/ 199125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4993 w 9143024"/>
              <a:gd name="connsiteY2" fmla="*/ 201506 h 1339743"/>
              <a:gd name="connsiteX3" fmla="*/ 804943 w 9143024"/>
              <a:gd name="connsiteY3" fmla="*/ 242886 h 1339743"/>
              <a:gd name="connsiteX4" fmla="*/ 843574 w 9143024"/>
              <a:gd name="connsiteY4" fmla="*/ 199125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4993 w 9143024"/>
              <a:gd name="connsiteY2" fmla="*/ 201506 h 1339743"/>
              <a:gd name="connsiteX3" fmla="*/ 804943 w 9143024"/>
              <a:gd name="connsiteY3" fmla="*/ 242886 h 1339743"/>
              <a:gd name="connsiteX4" fmla="*/ 843574 w 9143024"/>
              <a:gd name="connsiteY4" fmla="*/ 199125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0 w 9142042"/>
              <a:gd name="connsiteY0" fmla="*/ 1232 h 1339743"/>
              <a:gd name="connsiteX1" fmla="*/ 667491 w 9142042"/>
              <a:gd name="connsiteY1" fmla="*/ 0 h 1339743"/>
              <a:gd name="connsiteX2" fmla="*/ 764011 w 9142042"/>
              <a:gd name="connsiteY2" fmla="*/ 201506 h 1339743"/>
              <a:gd name="connsiteX3" fmla="*/ 803961 w 9142042"/>
              <a:gd name="connsiteY3" fmla="*/ 242886 h 1339743"/>
              <a:gd name="connsiteX4" fmla="*/ 842592 w 9142042"/>
              <a:gd name="connsiteY4" fmla="*/ 199125 h 1339743"/>
              <a:gd name="connsiteX5" fmla="*/ 946097 w 9142042"/>
              <a:gd name="connsiteY5" fmla="*/ 0 h 1339743"/>
              <a:gd name="connsiteX6" fmla="*/ 9142042 w 9142042"/>
              <a:gd name="connsiteY6" fmla="*/ 1233 h 1339743"/>
              <a:gd name="connsiteX7" fmla="*/ 9142042 w 9142042"/>
              <a:gd name="connsiteY7" fmla="*/ 1339743 h 1339743"/>
              <a:gd name="connsiteX8" fmla="*/ 121073 w 9142042"/>
              <a:gd name="connsiteY8" fmla="*/ 1215918 h 1339743"/>
              <a:gd name="connsiteX9" fmla="*/ 0 w 9142042"/>
              <a:gd name="connsiteY9" fmla="*/ 1232 h 1339743"/>
              <a:gd name="connsiteX0" fmla="*/ 982 w 9143024"/>
              <a:gd name="connsiteY0" fmla="*/ 1232 h 1342124"/>
              <a:gd name="connsiteX1" fmla="*/ 668473 w 9143024"/>
              <a:gd name="connsiteY1" fmla="*/ 0 h 1342124"/>
              <a:gd name="connsiteX2" fmla="*/ 764993 w 9143024"/>
              <a:gd name="connsiteY2" fmla="*/ 201506 h 1342124"/>
              <a:gd name="connsiteX3" fmla="*/ 804943 w 9143024"/>
              <a:gd name="connsiteY3" fmla="*/ 242886 h 1342124"/>
              <a:gd name="connsiteX4" fmla="*/ 843574 w 9143024"/>
              <a:gd name="connsiteY4" fmla="*/ 199125 h 1342124"/>
              <a:gd name="connsiteX5" fmla="*/ 947079 w 9143024"/>
              <a:gd name="connsiteY5" fmla="*/ 0 h 1342124"/>
              <a:gd name="connsiteX6" fmla="*/ 9143024 w 9143024"/>
              <a:gd name="connsiteY6" fmla="*/ 1233 h 1342124"/>
              <a:gd name="connsiteX7" fmla="*/ 9143024 w 9143024"/>
              <a:gd name="connsiteY7" fmla="*/ 1339743 h 1342124"/>
              <a:gd name="connsiteX8" fmla="*/ 611 w 9143024"/>
              <a:gd name="connsiteY8" fmla="*/ 1342124 h 1342124"/>
              <a:gd name="connsiteX9" fmla="*/ 982 w 9143024"/>
              <a:gd name="connsiteY9" fmla="*/ 1232 h 1342124"/>
              <a:gd name="connsiteX0" fmla="*/ 371 w 9142413"/>
              <a:gd name="connsiteY0" fmla="*/ 1232 h 1342124"/>
              <a:gd name="connsiteX1" fmla="*/ 667862 w 9142413"/>
              <a:gd name="connsiteY1" fmla="*/ 0 h 1342124"/>
              <a:gd name="connsiteX2" fmla="*/ 764382 w 9142413"/>
              <a:gd name="connsiteY2" fmla="*/ 201506 h 1342124"/>
              <a:gd name="connsiteX3" fmla="*/ 804332 w 9142413"/>
              <a:gd name="connsiteY3" fmla="*/ 242886 h 1342124"/>
              <a:gd name="connsiteX4" fmla="*/ 842963 w 9142413"/>
              <a:gd name="connsiteY4" fmla="*/ 199125 h 1342124"/>
              <a:gd name="connsiteX5" fmla="*/ 946468 w 9142413"/>
              <a:gd name="connsiteY5" fmla="*/ 0 h 1342124"/>
              <a:gd name="connsiteX6" fmla="*/ 9142413 w 9142413"/>
              <a:gd name="connsiteY6" fmla="*/ 1233 h 1342124"/>
              <a:gd name="connsiteX7" fmla="*/ 9142413 w 9142413"/>
              <a:gd name="connsiteY7" fmla="*/ 1339743 h 1342124"/>
              <a:gd name="connsiteX8" fmla="*/ 0 w 9142413"/>
              <a:gd name="connsiteY8" fmla="*/ 1342124 h 1342124"/>
              <a:gd name="connsiteX9" fmla="*/ 371 w 9142413"/>
              <a:gd name="connsiteY9" fmla="*/ 1232 h 1342124"/>
              <a:gd name="connsiteX0" fmla="*/ 371 w 9142413"/>
              <a:gd name="connsiteY0" fmla="*/ 1232 h 1342124"/>
              <a:gd name="connsiteX1" fmla="*/ 667862 w 9142413"/>
              <a:gd name="connsiteY1" fmla="*/ 0 h 1342124"/>
              <a:gd name="connsiteX2" fmla="*/ 764382 w 9142413"/>
              <a:gd name="connsiteY2" fmla="*/ 201506 h 1342124"/>
              <a:gd name="connsiteX3" fmla="*/ 804332 w 9142413"/>
              <a:gd name="connsiteY3" fmla="*/ 242886 h 1342124"/>
              <a:gd name="connsiteX4" fmla="*/ 842963 w 9142413"/>
              <a:gd name="connsiteY4" fmla="*/ 199125 h 1342124"/>
              <a:gd name="connsiteX5" fmla="*/ 946468 w 9142413"/>
              <a:gd name="connsiteY5" fmla="*/ 0 h 1342124"/>
              <a:gd name="connsiteX6" fmla="*/ 9142413 w 9142413"/>
              <a:gd name="connsiteY6" fmla="*/ 1233 h 1342124"/>
              <a:gd name="connsiteX7" fmla="*/ 9142413 w 9142413"/>
              <a:gd name="connsiteY7" fmla="*/ 1339743 h 1342124"/>
              <a:gd name="connsiteX8" fmla="*/ 0 w 9142413"/>
              <a:gd name="connsiteY8" fmla="*/ 1342124 h 1342124"/>
              <a:gd name="connsiteX9" fmla="*/ 371 w 9142413"/>
              <a:gd name="connsiteY9" fmla="*/ 1232 h 1342124"/>
              <a:gd name="connsiteX0" fmla="*/ 0 w 9142042"/>
              <a:gd name="connsiteY0" fmla="*/ 1232 h 1339743"/>
              <a:gd name="connsiteX1" fmla="*/ 667491 w 9142042"/>
              <a:gd name="connsiteY1" fmla="*/ 0 h 1339743"/>
              <a:gd name="connsiteX2" fmla="*/ 764011 w 9142042"/>
              <a:gd name="connsiteY2" fmla="*/ 201506 h 1339743"/>
              <a:gd name="connsiteX3" fmla="*/ 803961 w 9142042"/>
              <a:gd name="connsiteY3" fmla="*/ 242886 h 1339743"/>
              <a:gd name="connsiteX4" fmla="*/ 842592 w 9142042"/>
              <a:gd name="connsiteY4" fmla="*/ 199125 h 1339743"/>
              <a:gd name="connsiteX5" fmla="*/ 946097 w 9142042"/>
              <a:gd name="connsiteY5" fmla="*/ 0 h 1339743"/>
              <a:gd name="connsiteX6" fmla="*/ 9142042 w 9142042"/>
              <a:gd name="connsiteY6" fmla="*/ 1233 h 1339743"/>
              <a:gd name="connsiteX7" fmla="*/ 9142042 w 9142042"/>
              <a:gd name="connsiteY7" fmla="*/ 1339743 h 1339743"/>
              <a:gd name="connsiteX8" fmla="*/ 97260 w 9142042"/>
              <a:gd name="connsiteY8" fmla="*/ 1177817 h 1339743"/>
              <a:gd name="connsiteX9" fmla="*/ 0 w 9142042"/>
              <a:gd name="connsiteY9" fmla="*/ 1232 h 1339743"/>
              <a:gd name="connsiteX0" fmla="*/ 0 w 9142042"/>
              <a:gd name="connsiteY0" fmla="*/ 1232 h 1342124"/>
              <a:gd name="connsiteX1" fmla="*/ 667491 w 9142042"/>
              <a:gd name="connsiteY1" fmla="*/ 0 h 1342124"/>
              <a:gd name="connsiteX2" fmla="*/ 764011 w 9142042"/>
              <a:gd name="connsiteY2" fmla="*/ 201506 h 1342124"/>
              <a:gd name="connsiteX3" fmla="*/ 803961 w 9142042"/>
              <a:gd name="connsiteY3" fmla="*/ 242886 h 1342124"/>
              <a:gd name="connsiteX4" fmla="*/ 842592 w 9142042"/>
              <a:gd name="connsiteY4" fmla="*/ 199125 h 1342124"/>
              <a:gd name="connsiteX5" fmla="*/ 946097 w 9142042"/>
              <a:gd name="connsiteY5" fmla="*/ 0 h 1342124"/>
              <a:gd name="connsiteX6" fmla="*/ 9142042 w 9142042"/>
              <a:gd name="connsiteY6" fmla="*/ 1233 h 1342124"/>
              <a:gd name="connsiteX7" fmla="*/ 9142042 w 9142042"/>
              <a:gd name="connsiteY7" fmla="*/ 1339743 h 1342124"/>
              <a:gd name="connsiteX8" fmla="*/ 2010 w 9142042"/>
              <a:gd name="connsiteY8" fmla="*/ 1342124 h 1342124"/>
              <a:gd name="connsiteX9" fmla="*/ 0 w 9142042"/>
              <a:gd name="connsiteY9" fmla="*/ 1232 h 1342124"/>
              <a:gd name="connsiteX0" fmla="*/ 0 w 9142042"/>
              <a:gd name="connsiteY0" fmla="*/ 1232 h 1342124"/>
              <a:gd name="connsiteX1" fmla="*/ 667491 w 9142042"/>
              <a:gd name="connsiteY1" fmla="*/ 0 h 1342124"/>
              <a:gd name="connsiteX2" fmla="*/ 764011 w 9142042"/>
              <a:gd name="connsiteY2" fmla="*/ 201506 h 1342124"/>
              <a:gd name="connsiteX3" fmla="*/ 803961 w 9142042"/>
              <a:gd name="connsiteY3" fmla="*/ 242886 h 1342124"/>
              <a:gd name="connsiteX4" fmla="*/ 842592 w 9142042"/>
              <a:gd name="connsiteY4" fmla="*/ 199125 h 1342124"/>
              <a:gd name="connsiteX5" fmla="*/ 946097 w 9142042"/>
              <a:gd name="connsiteY5" fmla="*/ 0 h 1342124"/>
              <a:gd name="connsiteX6" fmla="*/ 9142042 w 9142042"/>
              <a:gd name="connsiteY6" fmla="*/ 1233 h 1342124"/>
              <a:gd name="connsiteX7" fmla="*/ 9142042 w 9142042"/>
              <a:gd name="connsiteY7" fmla="*/ 1339743 h 1342124"/>
              <a:gd name="connsiteX8" fmla="*/ 2010 w 9142042"/>
              <a:gd name="connsiteY8" fmla="*/ 1342124 h 1342124"/>
              <a:gd name="connsiteX9" fmla="*/ 0 w 9142042"/>
              <a:gd name="connsiteY9" fmla="*/ 1232 h 1342124"/>
              <a:gd name="connsiteX0" fmla="*/ 0 w 9142042"/>
              <a:gd name="connsiteY0" fmla="*/ 1232 h 1342124"/>
              <a:gd name="connsiteX1" fmla="*/ 667491 w 9142042"/>
              <a:gd name="connsiteY1" fmla="*/ 0 h 1342124"/>
              <a:gd name="connsiteX2" fmla="*/ 764011 w 9142042"/>
              <a:gd name="connsiteY2" fmla="*/ 201506 h 1342124"/>
              <a:gd name="connsiteX3" fmla="*/ 803961 w 9142042"/>
              <a:gd name="connsiteY3" fmla="*/ 242886 h 1342124"/>
              <a:gd name="connsiteX4" fmla="*/ 842592 w 9142042"/>
              <a:gd name="connsiteY4" fmla="*/ 199125 h 1342124"/>
              <a:gd name="connsiteX5" fmla="*/ 946097 w 9142042"/>
              <a:gd name="connsiteY5" fmla="*/ 0 h 1342124"/>
              <a:gd name="connsiteX6" fmla="*/ 9142042 w 9142042"/>
              <a:gd name="connsiteY6" fmla="*/ 1233 h 1342124"/>
              <a:gd name="connsiteX7" fmla="*/ 9142042 w 9142042"/>
              <a:gd name="connsiteY7" fmla="*/ 1339743 h 1342124"/>
              <a:gd name="connsiteX8" fmla="*/ 2010 w 9142042"/>
              <a:gd name="connsiteY8" fmla="*/ 1342124 h 1342124"/>
              <a:gd name="connsiteX9" fmla="*/ 0 w 9142042"/>
              <a:gd name="connsiteY9" fmla="*/ 1232 h 1342124"/>
              <a:gd name="connsiteX0" fmla="*/ 0 w 9142042"/>
              <a:gd name="connsiteY0" fmla="*/ 1232 h 1342124"/>
              <a:gd name="connsiteX1" fmla="*/ 667491 w 9142042"/>
              <a:gd name="connsiteY1" fmla="*/ 0 h 1342124"/>
              <a:gd name="connsiteX2" fmla="*/ 764011 w 9142042"/>
              <a:gd name="connsiteY2" fmla="*/ 201506 h 1342124"/>
              <a:gd name="connsiteX3" fmla="*/ 803961 w 9142042"/>
              <a:gd name="connsiteY3" fmla="*/ 242886 h 1342124"/>
              <a:gd name="connsiteX4" fmla="*/ 842592 w 9142042"/>
              <a:gd name="connsiteY4" fmla="*/ 199125 h 1342124"/>
              <a:gd name="connsiteX5" fmla="*/ 946097 w 9142042"/>
              <a:gd name="connsiteY5" fmla="*/ 0 h 1342124"/>
              <a:gd name="connsiteX6" fmla="*/ 9142042 w 9142042"/>
              <a:gd name="connsiteY6" fmla="*/ 1233 h 1342124"/>
              <a:gd name="connsiteX7" fmla="*/ 9142042 w 9142042"/>
              <a:gd name="connsiteY7" fmla="*/ 1339743 h 1342124"/>
              <a:gd name="connsiteX8" fmla="*/ 2010 w 9142042"/>
              <a:gd name="connsiteY8" fmla="*/ 1342124 h 1342124"/>
              <a:gd name="connsiteX9" fmla="*/ 0 w 9142042"/>
              <a:gd name="connsiteY9" fmla="*/ 1232 h 1342124"/>
              <a:gd name="connsiteX0" fmla="*/ 0 w 9142042"/>
              <a:gd name="connsiteY0" fmla="*/ 1232 h 1342124"/>
              <a:gd name="connsiteX1" fmla="*/ 667491 w 9142042"/>
              <a:gd name="connsiteY1" fmla="*/ 0 h 1342124"/>
              <a:gd name="connsiteX2" fmla="*/ 764011 w 9142042"/>
              <a:gd name="connsiteY2" fmla="*/ 201506 h 1342124"/>
              <a:gd name="connsiteX3" fmla="*/ 803961 w 9142042"/>
              <a:gd name="connsiteY3" fmla="*/ 242886 h 1342124"/>
              <a:gd name="connsiteX4" fmla="*/ 842592 w 9142042"/>
              <a:gd name="connsiteY4" fmla="*/ 199125 h 1342124"/>
              <a:gd name="connsiteX5" fmla="*/ 946097 w 9142042"/>
              <a:gd name="connsiteY5" fmla="*/ 0 h 1342124"/>
              <a:gd name="connsiteX6" fmla="*/ 9142042 w 9142042"/>
              <a:gd name="connsiteY6" fmla="*/ 1233 h 1342124"/>
              <a:gd name="connsiteX7" fmla="*/ 9142042 w 9142042"/>
              <a:gd name="connsiteY7" fmla="*/ 1339743 h 1342124"/>
              <a:gd name="connsiteX8" fmla="*/ 2010 w 9142042"/>
              <a:gd name="connsiteY8" fmla="*/ 1342124 h 1342124"/>
              <a:gd name="connsiteX9" fmla="*/ 0 w 9142042"/>
              <a:gd name="connsiteY9" fmla="*/ 1232 h 1342124"/>
              <a:gd name="connsiteX0" fmla="*/ 0 w 9142042"/>
              <a:gd name="connsiteY0" fmla="*/ 1232 h 1342124"/>
              <a:gd name="connsiteX1" fmla="*/ 667491 w 9142042"/>
              <a:gd name="connsiteY1" fmla="*/ 0 h 1342124"/>
              <a:gd name="connsiteX2" fmla="*/ 764011 w 9142042"/>
              <a:gd name="connsiteY2" fmla="*/ 201506 h 1342124"/>
              <a:gd name="connsiteX3" fmla="*/ 803961 w 9142042"/>
              <a:gd name="connsiteY3" fmla="*/ 242886 h 1342124"/>
              <a:gd name="connsiteX4" fmla="*/ 842592 w 9142042"/>
              <a:gd name="connsiteY4" fmla="*/ 199125 h 1342124"/>
              <a:gd name="connsiteX5" fmla="*/ 946097 w 9142042"/>
              <a:gd name="connsiteY5" fmla="*/ 0 h 1342124"/>
              <a:gd name="connsiteX6" fmla="*/ 9142042 w 9142042"/>
              <a:gd name="connsiteY6" fmla="*/ 1233 h 1342124"/>
              <a:gd name="connsiteX7" fmla="*/ 9142042 w 9142042"/>
              <a:gd name="connsiteY7" fmla="*/ 1339743 h 1342124"/>
              <a:gd name="connsiteX8" fmla="*/ 2010 w 9142042"/>
              <a:gd name="connsiteY8" fmla="*/ 1342124 h 1342124"/>
              <a:gd name="connsiteX9" fmla="*/ 0 w 9142042"/>
              <a:gd name="connsiteY9" fmla="*/ 1232 h 1342124"/>
              <a:gd name="connsiteX0" fmla="*/ 982 w 9143024"/>
              <a:gd name="connsiteY0" fmla="*/ 1232 h 1799324"/>
              <a:gd name="connsiteX1" fmla="*/ 668473 w 9143024"/>
              <a:gd name="connsiteY1" fmla="*/ 0 h 1799324"/>
              <a:gd name="connsiteX2" fmla="*/ 764993 w 9143024"/>
              <a:gd name="connsiteY2" fmla="*/ 201506 h 1799324"/>
              <a:gd name="connsiteX3" fmla="*/ 804943 w 9143024"/>
              <a:gd name="connsiteY3" fmla="*/ 242886 h 1799324"/>
              <a:gd name="connsiteX4" fmla="*/ 843574 w 9143024"/>
              <a:gd name="connsiteY4" fmla="*/ 199125 h 1799324"/>
              <a:gd name="connsiteX5" fmla="*/ 947079 w 9143024"/>
              <a:gd name="connsiteY5" fmla="*/ 0 h 1799324"/>
              <a:gd name="connsiteX6" fmla="*/ 9143024 w 9143024"/>
              <a:gd name="connsiteY6" fmla="*/ 1233 h 1799324"/>
              <a:gd name="connsiteX7" fmla="*/ 9143024 w 9143024"/>
              <a:gd name="connsiteY7" fmla="*/ 1339743 h 1799324"/>
              <a:gd name="connsiteX8" fmla="*/ 611 w 9143024"/>
              <a:gd name="connsiteY8" fmla="*/ 1799324 h 1799324"/>
              <a:gd name="connsiteX9" fmla="*/ 982 w 9143024"/>
              <a:gd name="connsiteY9" fmla="*/ 1232 h 1799324"/>
              <a:gd name="connsiteX0" fmla="*/ 982 w 9145405"/>
              <a:gd name="connsiteY0" fmla="*/ 1232 h 1801706"/>
              <a:gd name="connsiteX1" fmla="*/ 668473 w 9145405"/>
              <a:gd name="connsiteY1" fmla="*/ 0 h 1801706"/>
              <a:gd name="connsiteX2" fmla="*/ 764993 w 9145405"/>
              <a:gd name="connsiteY2" fmla="*/ 201506 h 1801706"/>
              <a:gd name="connsiteX3" fmla="*/ 804943 w 9145405"/>
              <a:gd name="connsiteY3" fmla="*/ 242886 h 1801706"/>
              <a:gd name="connsiteX4" fmla="*/ 843574 w 9145405"/>
              <a:gd name="connsiteY4" fmla="*/ 199125 h 1801706"/>
              <a:gd name="connsiteX5" fmla="*/ 947079 w 9145405"/>
              <a:gd name="connsiteY5" fmla="*/ 0 h 1801706"/>
              <a:gd name="connsiteX6" fmla="*/ 9143024 w 9145405"/>
              <a:gd name="connsiteY6" fmla="*/ 1233 h 1801706"/>
              <a:gd name="connsiteX7" fmla="*/ 9145405 w 9145405"/>
              <a:gd name="connsiteY7" fmla="*/ 1801706 h 1801706"/>
              <a:gd name="connsiteX8" fmla="*/ 611 w 9145405"/>
              <a:gd name="connsiteY8" fmla="*/ 1799324 h 1801706"/>
              <a:gd name="connsiteX9" fmla="*/ 982 w 9145405"/>
              <a:gd name="connsiteY9" fmla="*/ 1232 h 180170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</a:cxnLst>
            <a:rect l="l" t="t" r="r" b="b"/>
            <a:pathLst>
              <a:path w="9145405" h="1801706">
                <a:moveTo>
                  <a:pt x="982" y="1232"/>
                </a:moveTo>
                <a:lnTo>
                  <a:pt x="668473" y="0"/>
                </a:lnTo>
                <a:cubicBezTo>
                  <a:pt x="721195" y="108785"/>
                  <a:pt x="751773" y="175313"/>
                  <a:pt x="764993" y="201506"/>
                </a:cubicBezTo>
                <a:cubicBezTo>
                  <a:pt x="778213" y="227699"/>
                  <a:pt x="784702" y="243371"/>
                  <a:pt x="804943" y="242886"/>
                </a:cubicBezTo>
                <a:cubicBezTo>
                  <a:pt x="815659" y="242629"/>
                  <a:pt x="829410" y="227700"/>
                  <a:pt x="843574" y="199125"/>
                </a:cubicBezTo>
                <a:cubicBezTo>
                  <a:pt x="857738" y="170550"/>
                  <a:pt x="881859" y="123469"/>
                  <a:pt x="947079" y="0"/>
                </a:cubicBezTo>
                <a:lnTo>
                  <a:pt x="9143024" y="1233"/>
                </a:lnTo>
                <a:cubicBezTo>
                  <a:pt x="9143818" y="601391"/>
                  <a:pt x="9144611" y="1201548"/>
                  <a:pt x="9145405" y="1801706"/>
                </a:cubicBezTo>
                <a:lnTo>
                  <a:pt x="611" y="1799324"/>
                </a:lnTo>
                <a:cubicBezTo>
                  <a:pt x="-1646" y="1402366"/>
                  <a:pt x="3240" y="445815"/>
                  <a:pt x="982" y="1232"/>
                </a:cubicBezTo>
                <a:close/>
              </a:path>
            </a:pathLst>
          </a:custGeom>
        </p:spPr>
        <p:txBody>
          <a:bodyPr anchor="ctr" anchorCtr="0"/>
          <a:lstStyle>
            <a:lvl1pPr marL="0" indent="0" algn="ctr">
              <a:buNone/>
              <a:defRPr>
                <a:solidFill>
                  <a:schemeClr val="tx1"/>
                </a:solidFill>
              </a:defRPr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24736486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769949" y="6551759"/>
            <a:ext cx="3387817" cy="123111"/>
          </a:xfrm>
          <a:prstGeom prst="rect">
            <a:avLst/>
          </a:prstGeom>
        </p:spPr>
        <p:txBody>
          <a:bodyPr vert="horz" wrap="square" lIns="0" tIns="0" rIns="0" bIns="0" rtlCol="0" anchor="ctr">
            <a:spAutoFit/>
          </a:bodyPr>
          <a:lstStyle>
            <a:lvl1pPr algn="l">
              <a:defRPr sz="800"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Division Name or Footer</a:t>
            </a:r>
          </a:p>
        </p:txBody>
      </p:sp>
      <p:sp>
        <p:nvSpPr>
          <p:cNvPr id="12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202" y="6544227"/>
            <a:ext cx="254719" cy="123111"/>
          </a:xfrm>
          <a:prstGeom prst="rect">
            <a:avLst/>
          </a:prstGeom>
        </p:spPr>
        <p:txBody>
          <a:bodyPr vert="horz" wrap="square" lIns="0" tIns="0" rIns="0" bIns="0" rtlCol="0" anchor="ctr">
            <a:spAutoFit/>
          </a:bodyPr>
          <a:lstStyle>
            <a:lvl1pPr algn="l">
              <a:defRPr sz="800">
                <a:solidFill>
                  <a:schemeClr val="tx1"/>
                </a:solidFill>
              </a:defRPr>
            </a:lvl1pPr>
          </a:lstStyle>
          <a:p>
            <a:fld id="{7FEEEA1A-CB49-3744-AA40-B896987410F9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quarter" idx="10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3" name="Title Placeholder 1"/>
          <p:cNvSpPr>
            <a:spLocks noGrp="1"/>
          </p:cNvSpPr>
          <p:nvPr>
            <p:ph type="title"/>
          </p:nvPr>
        </p:nvSpPr>
        <p:spPr>
          <a:xfrm>
            <a:off x="457199" y="761455"/>
            <a:ext cx="8229600" cy="313932"/>
          </a:xfrm>
          <a:prstGeom prst="rect">
            <a:avLst/>
          </a:prstGeom>
        </p:spPr>
        <p:txBody>
          <a:bodyPr vert="horz" lIns="0" tIns="0" rIns="0" bIns="0" rtlCol="0" anchor="b" anchorCtr="0">
            <a:noAutofit/>
          </a:bodyPr>
          <a:lstStyle/>
          <a:p>
            <a:pPr lvl="0"/>
            <a:r>
              <a:rPr lang="en-US"/>
              <a:t>Click to edit Master 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32976950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3824">
          <p15:clr>
            <a:srgbClr val="FBAE40"/>
          </p15:clr>
        </p15:guide>
        <p15:guide id="2" pos="2880">
          <p15:clr>
            <a:srgbClr val="FBAE40"/>
          </p15:clr>
        </p15:guide>
        <p15:guide id="4" pos="432">
          <p15:clr>
            <a:srgbClr val="FBAE40"/>
          </p15:clr>
        </p15:guide>
      </p15:sldGuideLst>
    </p:ext>
  </p:extLst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769949" y="6551759"/>
            <a:ext cx="3387817" cy="123111"/>
          </a:xfrm>
          <a:prstGeom prst="rect">
            <a:avLst/>
          </a:prstGeom>
        </p:spPr>
        <p:txBody>
          <a:bodyPr vert="horz" wrap="square" lIns="0" tIns="0" rIns="0" bIns="0" rtlCol="0" anchor="ctr">
            <a:spAutoFit/>
          </a:bodyPr>
          <a:lstStyle>
            <a:lvl1pPr algn="l">
              <a:defRPr sz="800"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Division Name or Footer</a:t>
            </a:r>
          </a:p>
        </p:txBody>
      </p:sp>
      <p:sp>
        <p:nvSpPr>
          <p:cNvPr id="10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202" y="6544227"/>
            <a:ext cx="254719" cy="123111"/>
          </a:xfrm>
          <a:prstGeom prst="rect">
            <a:avLst/>
          </a:prstGeom>
        </p:spPr>
        <p:txBody>
          <a:bodyPr vert="horz" wrap="square" lIns="0" tIns="0" rIns="0" bIns="0" rtlCol="0" anchor="ctr">
            <a:spAutoFit/>
          </a:bodyPr>
          <a:lstStyle>
            <a:lvl1pPr algn="l">
              <a:defRPr sz="800">
                <a:solidFill>
                  <a:schemeClr val="tx1"/>
                </a:solidFill>
              </a:defRPr>
            </a:lvl1pPr>
          </a:lstStyle>
          <a:p>
            <a:fld id="{7FEEEA1A-CB49-3744-AA40-B896987410F9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12" name="Title Placeholder 1"/>
          <p:cNvSpPr>
            <a:spLocks noGrp="1"/>
          </p:cNvSpPr>
          <p:nvPr>
            <p:ph type="title"/>
          </p:nvPr>
        </p:nvSpPr>
        <p:spPr>
          <a:xfrm>
            <a:off x="457199" y="761455"/>
            <a:ext cx="8229600" cy="313932"/>
          </a:xfrm>
          <a:prstGeom prst="rect">
            <a:avLst/>
          </a:prstGeom>
        </p:spPr>
        <p:txBody>
          <a:bodyPr vert="horz" lIns="0" tIns="0" rIns="0" bIns="0" rtlCol="0" anchor="b" anchorCtr="0">
            <a:noAutofit/>
          </a:bodyPr>
          <a:lstStyle/>
          <a:p>
            <a:pPr lvl="0"/>
            <a:r>
              <a:rPr lang="en-US"/>
              <a:t>Click to edit Master 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58971619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userDrawn="1">
  <p:cSld name="Thank You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 userDrawn="1"/>
        </p:nvSpPr>
        <p:spPr>
          <a:xfrm>
            <a:off x="597655" y="5455427"/>
            <a:ext cx="3274131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000" b="1" dirty="0">
                <a:solidFill>
                  <a:schemeClr val="tx2"/>
                </a:solidFill>
                <a:latin typeface="+mj-lt"/>
              </a:rPr>
              <a:t>THANK</a:t>
            </a:r>
            <a:r>
              <a:rPr lang="en-US" sz="3000" b="1" baseline="0" dirty="0">
                <a:solidFill>
                  <a:schemeClr val="tx2"/>
                </a:solidFill>
                <a:latin typeface="+mj-lt"/>
              </a:rPr>
              <a:t> YOU</a:t>
            </a:r>
            <a:endParaRPr lang="en-US" sz="3000" b="1" dirty="0">
              <a:solidFill>
                <a:schemeClr val="tx2"/>
              </a:solidFill>
              <a:latin typeface="+mj-lt"/>
            </a:endParaRPr>
          </a:p>
        </p:txBody>
      </p:sp>
      <p:sp>
        <p:nvSpPr>
          <p:cNvPr id="8" name="Picture Placeholder 2"/>
          <p:cNvSpPr>
            <a:spLocks noGrp="1"/>
          </p:cNvSpPr>
          <p:nvPr>
            <p:ph type="pic" sz="quarter" idx="11"/>
          </p:nvPr>
        </p:nvSpPr>
        <p:spPr>
          <a:xfrm>
            <a:off x="0" y="-2766"/>
            <a:ext cx="9144000" cy="5377641"/>
          </a:xfrm>
          <a:custGeom>
            <a:avLst/>
            <a:gdLst>
              <a:gd name="connsiteX0" fmla="*/ 0 w 9144000"/>
              <a:gd name="connsiteY0" fmla="*/ 0 h 3783806"/>
              <a:gd name="connsiteX1" fmla="*/ 9144000 w 9144000"/>
              <a:gd name="connsiteY1" fmla="*/ 0 h 3783806"/>
              <a:gd name="connsiteX2" fmla="*/ 9144000 w 9144000"/>
              <a:gd name="connsiteY2" fmla="*/ 3783806 h 3783806"/>
              <a:gd name="connsiteX3" fmla="*/ 0 w 9144000"/>
              <a:gd name="connsiteY3" fmla="*/ 3783806 h 3783806"/>
              <a:gd name="connsiteX4" fmla="*/ 0 w 9144000"/>
              <a:gd name="connsiteY4" fmla="*/ 0 h 3783806"/>
              <a:gd name="connsiteX0" fmla="*/ 0 w 9144000"/>
              <a:gd name="connsiteY0" fmla="*/ 0 h 3783806"/>
              <a:gd name="connsiteX1" fmla="*/ 9144000 w 9144000"/>
              <a:gd name="connsiteY1" fmla="*/ 0 h 3783806"/>
              <a:gd name="connsiteX2" fmla="*/ 9144000 w 9144000"/>
              <a:gd name="connsiteY2" fmla="*/ 3783806 h 3783806"/>
              <a:gd name="connsiteX3" fmla="*/ 723900 w 9144000"/>
              <a:gd name="connsiteY3" fmla="*/ 3781425 h 3783806"/>
              <a:gd name="connsiteX4" fmla="*/ 0 w 9144000"/>
              <a:gd name="connsiteY4" fmla="*/ 3783806 h 3783806"/>
              <a:gd name="connsiteX5" fmla="*/ 0 w 9144000"/>
              <a:gd name="connsiteY5" fmla="*/ 0 h 3783806"/>
              <a:gd name="connsiteX0" fmla="*/ 0 w 9144000"/>
              <a:gd name="connsiteY0" fmla="*/ 0 h 3783806"/>
              <a:gd name="connsiteX1" fmla="*/ 9144000 w 9144000"/>
              <a:gd name="connsiteY1" fmla="*/ 0 h 3783806"/>
              <a:gd name="connsiteX2" fmla="*/ 9144000 w 9144000"/>
              <a:gd name="connsiteY2" fmla="*/ 3783806 h 3783806"/>
              <a:gd name="connsiteX3" fmla="*/ 692944 w 9144000"/>
              <a:gd name="connsiteY3" fmla="*/ 3781425 h 3783806"/>
              <a:gd name="connsiteX4" fmla="*/ 0 w 9144000"/>
              <a:gd name="connsiteY4" fmla="*/ 3783806 h 3783806"/>
              <a:gd name="connsiteX5" fmla="*/ 0 w 9144000"/>
              <a:gd name="connsiteY5" fmla="*/ 0 h 3783806"/>
              <a:gd name="connsiteX0" fmla="*/ 0 w 9144000"/>
              <a:gd name="connsiteY0" fmla="*/ 0 h 3783806"/>
              <a:gd name="connsiteX1" fmla="*/ 9144000 w 9144000"/>
              <a:gd name="connsiteY1" fmla="*/ 0 h 3783806"/>
              <a:gd name="connsiteX2" fmla="*/ 9144000 w 9144000"/>
              <a:gd name="connsiteY2" fmla="*/ 3783806 h 3783806"/>
              <a:gd name="connsiteX3" fmla="*/ 954881 w 9144000"/>
              <a:gd name="connsiteY3" fmla="*/ 3779044 h 3783806"/>
              <a:gd name="connsiteX4" fmla="*/ 692944 w 9144000"/>
              <a:gd name="connsiteY4" fmla="*/ 3781425 h 3783806"/>
              <a:gd name="connsiteX5" fmla="*/ 0 w 9144000"/>
              <a:gd name="connsiteY5" fmla="*/ 3783806 h 3783806"/>
              <a:gd name="connsiteX6" fmla="*/ 0 w 9144000"/>
              <a:gd name="connsiteY6" fmla="*/ 0 h 3783806"/>
              <a:gd name="connsiteX0" fmla="*/ 0 w 9144000"/>
              <a:gd name="connsiteY0" fmla="*/ 0 h 3783806"/>
              <a:gd name="connsiteX1" fmla="*/ 9144000 w 9144000"/>
              <a:gd name="connsiteY1" fmla="*/ 0 h 3783806"/>
              <a:gd name="connsiteX2" fmla="*/ 9144000 w 9144000"/>
              <a:gd name="connsiteY2" fmla="*/ 3783806 h 3783806"/>
              <a:gd name="connsiteX3" fmla="*/ 954881 w 9144000"/>
              <a:gd name="connsiteY3" fmla="*/ 3779044 h 3783806"/>
              <a:gd name="connsiteX4" fmla="*/ 821531 w 9144000"/>
              <a:gd name="connsiteY4" fmla="*/ 3779044 h 3783806"/>
              <a:gd name="connsiteX5" fmla="*/ 692944 w 9144000"/>
              <a:gd name="connsiteY5" fmla="*/ 3781425 h 3783806"/>
              <a:gd name="connsiteX6" fmla="*/ 0 w 9144000"/>
              <a:gd name="connsiteY6" fmla="*/ 3783806 h 3783806"/>
              <a:gd name="connsiteX7" fmla="*/ 0 w 9144000"/>
              <a:gd name="connsiteY7" fmla="*/ 0 h 3783806"/>
              <a:gd name="connsiteX0" fmla="*/ 0 w 9144000"/>
              <a:gd name="connsiteY0" fmla="*/ 0 h 4024313"/>
              <a:gd name="connsiteX1" fmla="*/ 9144000 w 9144000"/>
              <a:gd name="connsiteY1" fmla="*/ 0 h 4024313"/>
              <a:gd name="connsiteX2" fmla="*/ 9144000 w 9144000"/>
              <a:gd name="connsiteY2" fmla="*/ 3783806 h 4024313"/>
              <a:gd name="connsiteX3" fmla="*/ 954881 w 9144000"/>
              <a:gd name="connsiteY3" fmla="*/ 3779044 h 4024313"/>
              <a:gd name="connsiteX4" fmla="*/ 826293 w 9144000"/>
              <a:gd name="connsiteY4" fmla="*/ 4024313 h 4024313"/>
              <a:gd name="connsiteX5" fmla="*/ 692944 w 9144000"/>
              <a:gd name="connsiteY5" fmla="*/ 3781425 h 4024313"/>
              <a:gd name="connsiteX6" fmla="*/ 0 w 9144000"/>
              <a:gd name="connsiteY6" fmla="*/ 3783806 h 4024313"/>
              <a:gd name="connsiteX7" fmla="*/ 0 w 9144000"/>
              <a:gd name="connsiteY7" fmla="*/ 0 h 4024313"/>
              <a:gd name="connsiteX0" fmla="*/ 0 w 9144000"/>
              <a:gd name="connsiteY0" fmla="*/ 0 h 4024313"/>
              <a:gd name="connsiteX1" fmla="*/ 9144000 w 9144000"/>
              <a:gd name="connsiteY1" fmla="*/ 0 h 4024313"/>
              <a:gd name="connsiteX2" fmla="*/ 9144000 w 9144000"/>
              <a:gd name="connsiteY2" fmla="*/ 3783806 h 4024313"/>
              <a:gd name="connsiteX3" fmla="*/ 954881 w 9144000"/>
              <a:gd name="connsiteY3" fmla="*/ 3779044 h 4024313"/>
              <a:gd name="connsiteX4" fmla="*/ 826293 w 9144000"/>
              <a:gd name="connsiteY4" fmla="*/ 4024313 h 4024313"/>
              <a:gd name="connsiteX5" fmla="*/ 692944 w 9144000"/>
              <a:gd name="connsiteY5" fmla="*/ 3781425 h 4024313"/>
              <a:gd name="connsiteX6" fmla="*/ 0 w 9144000"/>
              <a:gd name="connsiteY6" fmla="*/ 3783806 h 4024313"/>
              <a:gd name="connsiteX7" fmla="*/ 0 w 9144000"/>
              <a:gd name="connsiteY7" fmla="*/ 0 h 4024313"/>
              <a:gd name="connsiteX0" fmla="*/ 0 w 9144000"/>
              <a:gd name="connsiteY0" fmla="*/ 0 h 4024313"/>
              <a:gd name="connsiteX1" fmla="*/ 9144000 w 9144000"/>
              <a:gd name="connsiteY1" fmla="*/ 0 h 4024313"/>
              <a:gd name="connsiteX2" fmla="*/ 9144000 w 9144000"/>
              <a:gd name="connsiteY2" fmla="*/ 3783806 h 4024313"/>
              <a:gd name="connsiteX3" fmla="*/ 954881 w 9144000"/>
              <a:gd name="connsiteY3" fmla="*/ 3779044 h 4024313"/>
              <a:gd name="connsiteX4" fmla="*/ 826293 w 9144000"/>
              <a:gd name="connsiteY4" fmla="*/ 4024313 h 4024313"/>
              <a:gd name="connsiteX5" fmla="*/ 692944 w 9144000"/>
              <a:gd name="connsiteY5" fmla="*/ 3781425 h 4024313"/>
              <a:gd name="connsiteX6" fmla="*/ 0 w 9144000"/>
              <a:gd name="connsiteY6" fmla="*/ 3783806 h 4024313"/>
              <a:gd name="connsiteX7" fmla="*/ 0 w 9144000"/>
              <a:gd name="connsiteY7" fmla="*/ 0 h 4024313"/>
              <a:gd name="connsiteX0" fmla="*/ 0 w 9144000"/>
              <a:gd name="connsiteY0" fmla="*/ 0 h 4024313"/>
              <a:gd name="connsiteX1" fmla="*/ 9144000 w 9144000"/>
              <a:gd name="connsiteY1" fmla="*/ 0 h 4024313"/>
              <a:gd name="connsiteX2" fmla="*/ 9144000 w 9144000"/>
              <a:gd name="connsiteY2" fmla="*/ 3783806 h 4024313"/>
              <a:gd name="connsiteX3" fmla="*/ 954881 w 9144000"/>
              <a:gd name="connsiteY3" fmla="*/ 3779044 h 4024313"/>
              <a:gd name="connsiteX4" fmla="*/ 826293 w 9144000"/>
              <a:gd name="connsiteY4" fmla="*/ 4024313 h 4024313"/>
              <a:gd name="connsiteX5" fmla="*/ 692944 w 9144000"/>
              <a:gd name="connsiteY5" fmla="*/ 3781425 h 4024313"/>
              <a:gd name="connsiteX6" fmla="*/ 0 w 9144000"/>
              <a:gd name="connsiteY6" fmla="*/ 3783806 h 4024313"/>
              <a:gd name="connsiteX7" fmla="*/ 0 w 9144000"/>
              <a:gd name="connsiteY7" fmla="*/ 0 h 4024313"/>
              <a:gd name="connsiteX0" fmla="*/ 0 w 9144000"/>
              <a:gd name="connsiteY0" fmla="*/ 0 h 4024313"/>
              <a:gd name="connsiteX1" fmla="*/ 9144000 w 9144000"/>
              <a:gd name="connsiteY1" fmla="*/ 0 h 4024313"/>
              <a:gd name="connsiteX2" fmla="*/ 9144000 w 9144000"/>
              <a:gd name="connsiteY2" fmla="*/ 3783806 h 4024313"/>
              <a:gd name="connsiteX3" fmla="*/ 954881 w 9144000"/>
              <a:gd name="connsiteY3" fmla="*/ 3779044 h 4024313"/>
              <a:gd name="connsiteX4" fmla="*/ 826293 w 9144000"/>
              <a:gd name="connsiteY4" fmla="*/ 4024313 h 4024313"/>
              <a:gd name="connsiteX5" fmla="*/ 692944 w 9144000"/>
              <a:gd name="connsiteY5" fmla="*/ 3781425 h 4024313"/>
              <a:gd name="connsiteX6" fmla="*/ 0 w 9144000"/>
              <a:gd name="connsiteY6" fmla="*/ 3783806 h 4024313"/>
              <a:gd name="connsiteX7" fmla="*/ 0 w 9144000"/>
              <a:gd name="connsiteY7" fmla="*/ 0 h 4024313"/>
              <a:gd name="connsiteX0" fmla="*/ 0 w 9144000"/>
              <a:gd name="connsiteY0" fmla="*/ 0 h 4024344"/>
              <a:gd name="connsiteX1" fmla="*/ 9144000 w 9144000"/>
              <a:gd name="connsiteY1" fmla="*/ 0 h 4024344"/>
              <a:gd name="connsiteX2" fmla="*/ 9144000 w 9144000"/>
              <a:gd name="connsiteY2" fmla="*/ 3783806 h 4024344"/>
              <a:gd name="connsiteX3" fmla="*/ 954881 w 9144000"/>
              <a:gd name="connsiteY3" fmla="*/ 3779044 h 4024344"/>
              <a:gd name="connsiteX4" fmla="*/ 826293 w 9144000"/>
              <a:gd name="connsiteY4" fmla="*/ 4024313 h 4024344"/>
              <a:gd name="connsiteX5" fmla="*/ 692944 w 9144000"/>
              <a:gd name="connsiteY5" fmla="*/ 3781425 h 4024344"/>
              <a:gd name="connsiteX6" fmla="*/ 0 w 9144000"/>
              <a:gd name="connsiteY6" fmla="*/ 3783806 h 4024344"/>
              <a:gd name="connsiteX7" fmla="*/ 0 w 9144000"/>
              <a:gd name="connsiteY7" fmla="*/ 0 h 4024344"/>
              <a:gd name="connsiteX0" fmla="*/ 0 w 9144000"/>
              <a:gd name="connsiteY0" fmla="*/ 0 h 4024665"/>
              <a:gd name="connsiteX1" fmla="*/ 9144000 w 9144000"/>
              <a:gd name="connsiteY1" fmla="*/ 0 h 4024665"/>
              <a:gd name="connsiteX2" fmla="*/ 9144000 w 9144000"/>
              <a:gd name="connsiteY2" fmla="*/ 3783806 h 4024665"/>
              <a:gd name="connsiteX3" fmla="*/ 954881 w 9144000"/>
              <a:gd name="connsiteY3" fmla="*/ 3779044 h 4024665"/>
              <a:gd name="connsiteX4" fmla="*/ 826293 w 9144000"/>
              <a:gd name="connsiteY4" fmla="*/ 4024313 h 4024665"/>
              <a:gd name="connsiteX5" fmla="*/ 692944 w 9144000"/>
              <a:gd name="connsiteY5" fmla="*/ 3781425 h 4024665"/>
              <a:gd name="connsiteX6" fmla="*/ 0 w 9144000"/>
              <a:gd name="connsiteY6" fmla="*/ 3783806 h 4024665"/>
              <a:gd name="connsiteX7" fmla="*/ 0 w 9144000"/>
              <a:gd name="connsiteY7" fmla="*/ 0 h 4024665"/>
              <a:gd name="connsiteX0" fmla="*/ 0 w 9144000"/>
              <a:gd name="connsiteY0" fmla="*/ 0 h 4024519"/>
              <a:gd name="connsiteX1" fmla="*/ 9144000 w 9144000"/>
              <a:gd name="connsiteY1" fmla="*/ 0 h 4024519"/>
              <a:gd name="connsiteX2" fmla="*/ 9144000 w 9144000"/>
              <a:gd name="connsiteY2" fmla="*/ 3783806 h 4024519"/>
              <a:gd name="connsiteX3" fmla="*/ 954881 w 9144000"/>
              <a:gd name="connsiteY3" fmla="*/ 3779044 h 4024519"/>
              <a:gd name="connsiteX4" fmla="*/ 826293 w 9144000"/>
              <a:gd name="connsiteY4" fmla="*/ 4024313 h 4024519"/>
              <a:gd name="connsiteX5" fmla="*/ 692944 w 9144000"/>
              <a:gd name="connsiteY5" fmla="*/ 3781425 h 4024519"/>
              <a:gd name="connsiteX6" fmla="*/ 0 w 9144000"/>
              <a:gd name="connsiteY6" fmla="*/ 3783806 h 4024519"/>
              <a:gd name="connsiteX7" fmla="*/ 0 w 9144000"/>
              <a:gd name="connsiteY7" fmla="*/ 0 h 4024519"/>
              <a:gd name="connsiteX0" fmla="*/ 0 w 9144000"/>
              <a:gd name="connsiteY0" fmla="*/ 0 h 4024313"/>
              <a:gd name="connsiteX1" fmla="*/ 9144000 w 9144000"/>
              <a:gd name="connsiteY1" fmla="*/ 0 h 4024313"/>
              <a:gd name="connsiteX2" fmla="*/ 9144000 w 9144000"/>
              <a:gd name="connsiteY2" fmla="*/ 3783806 h 4024313"/>
              <a:gd name="connsiteX3" fmla="*/ 964406 w 9144000"/>
              <a:gd name="connsiteY3" fmla="*/ 3781426 h 4024313"/>
              <a:gd name="connsiteX4" fmla="*/ 826293 w 9144000"/>
              <a:gd name="connsiteY4" fmla="*/ 4024313 h 4024313"/>
              <a:gd name="connsiteX5" fmla="*/ 692944 w 9144000"/>
              <a:gd name="connsiteY5" fmla="*/ 3781425 h 4024313"/>
              <a:gd name="connsiteX6" fmla="*/ 0 w 9144000"/>
              <a:gd name="connsiteY6" fmla="*/ 3783806 h 4024313"/>
              <a:gd name="connsiteX7" fmla="*/ 0 w 9144000"/>
              <a:gd name="connsiteY7" fmla="*/ 0 h 4024313"/>
              <a:gd name="connsiteX0" fmla="*/ 0 w 9144000"/>
              <a:gd name="connsiteY0" fmla="*/ 0 h 4024313"/>
              <a:gd name="connsiteX1" fmla="*/ 9144000 w 9144000"/>
              <a:gd name="connsiteY1" fmla="*/ 0 h 4024313"/>
              <a:gd name="connsiteX2" fmla="*/ 9144000 w 9144000"/>
              <a:gd name="connsiteY2" fmla="*/ 3783806 h 4024313"/>
              <a:gd name="connsiteX3" fmla="*/ 964406 w 9144000"/>
              <a:gd name="connsiteY3" fmla="*/ 3781426 h 4024313"/>
              <a:gd name="connsiteX4" fmla="*/ 826293 w 9144000"/>
              <a:gd name="connsiteY4" fmla="*/ 4024313 h 4024313"/>
              <a:gd name="connsiteX5" fmla="*/ 692944 w 9144000"/>
              <a:gd name="connsiteY5" fmla="*/ 3781425 h 4024313"/>
              <a:gd name="connsiteX6" fmla="*/ 0 w 9144000"/>
              <a:gd name="connsiteY6" fmla="*/ 3783806 h 4024313"/>
              <a:gd name="connsiteX7" fmla="*/ 0 w 9144000"/>
              <a:gd name="connsiteY7" fmla="*/ 0 h 4024313"/>
              <a:gd name="connsiteX0" fmla="*/ 0 w 9144000"/>
              <a:gd name="connsiteY0" fmla="*/ 0 h 4028131"/>
              <a:gd name="connsiteX1" fmla="*/ 9144000 w 9144000"/>
              <a:gd name="connsiteY1" fmla="*/ 0 h 4028131"/>
              <a:gd name="connsiteX2" fmla="*/ 9144000 w 9144000"/>
              <a:gd name="connsiteY2" fmla="*/ 3783806 h 4028131"/>
              <a:gd name="connsiteX3" fmla="*/ 964406 w 9144000"/>
              <a:gd name="connsiteY3" fmla="*/ 3781426 h 4028131"/>
              <a:gd name="connsiteX4" fmla="*/ 826293 w 9144000"/>
              <a:gd name="connsiteY4" fmla="*/ 4024313 h 4028131"/>
              <a:gd name="connsiteX5" fmla="*/ 692944 w 9144000"/>
              <a:gd name="connsiteY5" fmla="*/ 3781425 h 4028131"/>
              <a:gd name="connsiteX6" fmla="*/ 0 w 9144000"/>
              <a:gd name="connsiteY6" fmla="*/ 3783806 h 4028131"/>
              <a:gd name="connsiteX7" fmla="*/ 0 w 9144000"/>
              <a:gd name="connsiteY7" fmla="*/ 0 h 4028131"/>
              <a:gd name="connsiteX0" fmla="*/ 0 w 9144000"/>
              <a:gd name="connsiteY0" fmla="*/ 0 h 4024412"/>
              <a:gd name="connsiteX1" fmla="*/ 9144000 w 9144000"/>
              <a:gd name="connsiteY1" fmla="*/ 0 h 4024412"/>
              <a:gd name="connsiteX2" fmla="*/ 9144000 w 9144000"/>
              <a:gd name="connsiteY2" fmla="*/ 3783806 h 4024412"/>
              <a:gd name="connsiteX3" fmla="*/ 964406 w 9144000"/>
              <a:gd name="connsiteY3" fmla="*/ 3781426 h 4024412"/>
              <a:gd name="connsiteX4" fmla="*/ 826293 w 9144000"/>
              <a:gd name="connsiteY4" fmla="*/ 4024313 h 4024412"/>
              <a:gd name="connsiteX5" fmla="*/ 692944 w 9144000"/>
              <a:gd name="connsiteY5" fmla="*/ 3781425 h 4024412"/>
              <a:gd name="connsiteX6" fmla="*/ 0 w 9144000"/>
              <a:gd name="connsiteY6" fmla="*/ 3783806 h 4024412"/>
              <a:gd name="connsiteX7" fmla="*/ 0 w 9144000"/>
              <a:gd name="connsiteY7" fmla="*/ 0 h 4024412"/>
              <a:gd name="connsiteX0" fmla="*/ 0 w 9144000"/>
              <a:gd name="connsiteY0" fmla="*/ 0 h 4024313"/>
              <a:gd name="connsiteX1" fmla="*/ 9144000 w 9144000"/>
              <a:gd name="connsiteY1" fmla="*/ 0 h 4024313"/>
              <a:gd name="connsiteX2" fmla="*/ 9144000 w 9144000"/>
              <a:gd name="connsiteY2" fmla="*/ 3783806 h 4024313"/>
              <a:gd name="connsiteX3" fmla="*/ 964406 w 9144000"/>
              <a:gd name="connsiteY3" fmla="*/ 3781426 h 4024313"/>
              <a:gd name="connsiteX4" fmla="*/ 826293 w 9144000"/>
              <a:gd name="connsiteY4" fmla="*/ 4024313 h 4024313"/>
              <a:gd name="connsiteX5" fmla="*/ 692944 w 9144000"/>
              <a:gd name="connsiteY5" fmla="*/ 3781425 h 4024313"/>
              <a:gd name="connsiteX6" fmla="*/ 0 w 9144000"/>
              <a:gd name="connsiteY6" fmla="*/ 3783806 h 4024313"/>
              <a:gd name="connsiteX7" fmla="*/ 0 w 9144000"/>
              <a:gd name="connsiteY7" fmla="*/ 0 h 4024313"/>
              <a:gd name="connsiteX0" fmla="*/ 0 w 9144000"/>
              <a:gd name="connsiteY0" fmla="*/ 0 h 4024313"/>
              <a:gd name="connsiteX1" fmla="*/ 9144000 w 9144000"/>
              <a:gd name="connsiteY1" fmla="*/ 0 h 4024313"/>
              <a:gd name="connsiteX2" fmla="*/ 9144000 w 9144000"/>
              <a:gd name="connsiteY2" fmla="*/ 3783806 h 4024313"/>
              <a:gd name="connsiteX3" fmla="*/ 964406 w 9144000"/>
              <a:gd name="connsiteY3" fmla="*/ 3781426 h 4024313"/>
              <a:gd name="connsiteX4" fmla="*/ 826293 w 9144000"/>
              <a:gd name="connsiteY4" fmla="*/ 4024313 h 4024313"/>
              <a:gd name="connsiteX5" fmla="*/ 692944 w 9144000"/>
              <a:gd name="connsiteY5" fmla="*/ 3781425 h 4024313"/>
              <a:gd name="connsiteX6" fmla="*/ 0 w 9144000"/>
              <a:gd name="connsiteY6" fmla="*/ 3783806 h 4024313"/>
              <a:gd name="connsiteX7" fmla="*/ 0 w 9144000"/>
              <a:gd name="connsiteY7" fmla="*/ 0 h 4024313"/>
              <a:gd name="connsiteX0" fmla="*/ 0 w 9144000"/>
              <a:gd name="connsiteY0" fmla="*/ 0 h 4024313"/>
              <a:gd name="connsiteX1" fmla="*/ 9144000 w 9144000"/>
              <a:gd name="connsiteY1" fmla="*/ 0 h 4024313"/>
              <a:gd name="connsiteX2" fmla="*/ 9144000 w 9144000"/>
              <a:gd name="connsiteY2" fmla="*/ 3783806 h 4024313"/>
              <a:gd name="connsiteX3" fmla="*/ 964406 w 9144000"/>
              <a:gd name="connsiteY3" fmla="*/ 3781426 h 4024313"/>
              <a:gd name="connsiteX4" fmla="*/ 826293 w 9144000"/>
              <a:gd name="connsiteY4" fmla="*/ 4024313 h 4024313"/>
              <a:gd name="connsiteX5" fmla="*/ 692944 w 9144000"/>
              <a:gd name="connsiteY5" fmla="*/ 3781425 h 4024313"/>
              <a:gd name="connsiteX6" fmla="*/ 0 w 9144000"/>
              <a:gd name="connsiteY6" fmla="*/ 3783806 h 4024313"/>
              <a:gd name="connsiteX7" fmla="*/ 0 w 9144000"/>
              <a:gd name="connsiteY7" fmla="*/ 0 h 4024313"/>
              <a:gd name="connsiteX0" fmla="*/ 0 w 9144000"/>
              <a:gd name="connsiteY0" fmla="*/ 0 h 4024313"/>
              <a:gd name="connsiteX1" fmla="*/ 9144000 w 9144000"/>
              <a:gd name="connsiteY1" fmla="*/ 0 h 4024313"/>
              <a:gd name="connsiteX2" fmla="*/ 9144000 w 9144000"/>
              <a:gd name="connsiteY2" fmla="*/ 3783806 h 4024313"/>
              <a:gd name="connsiteX3" fmla="*/ 964406 w 9144000"/>
              <a:gd name="connsiteY3" fmla="*/ 3781426 h 4024313"/>
              <a:gd name="connsiteX4" fmla="*/ 826293 w 9144000"/>
              <a:gd name="connsiteY4" fmla="*/ 4024313 h 4024313"/>
              <a:gd name="connsiteX5" fmla="*/ 692944 w 9144000"/>
              <a:gd name="connsiteY5" fmla="*/ 3781425 h 4024313"/>
              <a:gd name="connsiteX6" fmla="*/ 0 w 9144000"/>
              <a:gd name="connsiteY6" fmla="*/ 3783806 h 4024313"/>
              <a:gd name="connsiteX7" fmla="*/ 0 w 9144000"/>
              <a:gd name="connsiteY7" fmla="*/ 0 h 4024313"/>
              <a:gd name="connsiteX0" fmla="*/ 0 w 9144000"/>
              <a:gd name="connsiteY0" fmla="*/ 0 h 4024313"/>
              <a:gd name="connsiteX1" fmla="*/ 9144000 w 9144000"/>
              <a:gd name="connsiteY1" fmla="*/ 0 h 4024313"/>
              <a:gd name="connsiteX2" fmla="*/ 9144000 w 9144000"/>
              <a:gd name="connsiteY2" fmla="*/ 3783806 h 4024313"/>
              <a:gd name="connsiteX3" fmla="*/ 964406 w 9144000"/>
              <a:gd name="connsiteY3" fmla="*/ 3781426 h 4024313"/>
              <a:gd name="connsiteX4" fmla="*/ 826293 w 9144000"/>
              <a:gd name="connsiteY4" fmla="*/ 4024313 h 4024313"/>
              <a:gd name="connsiteX5" fmla="*/ 666750 w 9144000"/>
              <a:gd name="connsiteY5" fmla="*/ 3781425 h 4024313"/>
              <a:gd name="connsiteX6" fmla="*/ 0 w 9144000"/>
              <a:gd name="connsiteY6" fmla="*/ 3783806 h 4024313"/>
              <a:gd name="connsiteX7" fmla="*/ 0 w 9144000"/>
              <a:gd name="connsiteY7" fmla="*/ 0 h 4024313"/>
              <a:gd name="connsiteX0" fmla="*/ 0 w 9144000"/>
              <a:gd name="connsiteY0" fmla="*/ 0 h 4024316"/>
              <a:gd name="connsiteX1" fmla="*/ 9144000 w 9144000"/>
              <a:gd name="connsiteY1" fmla="*/ 0 h 4024316"/>
              <a:gd name="connsiteX2" fmla="*/ 9144000 w 9144000"/>
              <a:gd name="connsiteY2" fmla="*/ 3783806 h 4024316"/>
              <a:gd name="connsiteX3" fmla="*/ 945356 w 9144000"/>
              <a:gd name="connsiteY3" fmla="*/ 3786189 h 4024316"/>
              <a:gd name="connsiteX4" fmla="*/ 826293 w 9144000"/>
              <a:gd name="connsiteY4" fmla="*/ 4024313 h 4024316"/>
              <a:gd name="connsiteX5" fmla="*/ 666750 w 9144000"/>
              <a:gd name="connsiteY5" fmla="*/ 3781425 h 4024316"/>
              <a:gd name="connsiteX6" fmla="*/ 0 w 9144000"/>
              <a:gd name="connsiteY6" fmla="*/ 3783806 h 4024316"/>
              <a:gd name="connsiteX7" fmla="*/ 0 w 9144000"/>
              <a:gd name="connsiteY7" fmla="*/ 0 h 4024316"/>
              <a:gd name="connsiteX0" fmla="*/ 0 w 9144000"/>
              <a:gd name="connsiteY0" fmla="*/ 0 h 4029078"/>
              <a:gd name="connsiteX1" fmla="*/ 9144000 w 9144000"/>
              <a:gd name="connsiteY1" fmla="*/ 0 h 4029078"/>
              <a:gd name="connsiteX2" fmla="*/ 9144000 w 9144000"/>
              <a:gd name="connsiteY2" fmla="*/ 3783806 h 4029078"/>
              <a:gd name="connsiteX3" fmla="*/ 945356 w 9144000"/>
              <a:gd name="connsiteY3" fmla="*/ 3786189 h 4029078"/>
              <a:gd name="connsiteX4" fmla="*/ 809624 w 9144000"/>
              <a:gd name="connsiteY4" fmla="*/ 4029075 h 4029078"/>
              <a:gd name="connsiteX5" fmla="*/ 666750 w 9144000"/>
              <a:gd name="connsiteY5" fmla="*/ 3781425 h 4029078"/>
              <a:gd name="connsiteX6" fmla="*/ 0 w 9144000"/>
              <a:gd name="connsiteY6" fmla="*/ 3783806 h 4029078"/>
              <a:gd name="connsiteX7" fmla="*/ 0 w 9144000"/>
              <a:gd name="connsiteY7" fmla="*/ 0 h 4029078"/>
              <a:gd name="connsiteX0" fmla="*/ 0 w 9144000"/>
              <a:gd name="connsiteY0" fmla="*/ 0 h 4029106"/>
              <a:gd name="connsiteX1" fmla="*/ 9144000 w 9144000"/>
              <a:gd name="connsiteY1" fmla="*/ 0 h 4029106"/>
              <a:gd name="connsiteX2" fmla="*/ 9144000 w 9144000"/>
              <a:gd name="connsiteY2" fmla="*/ 3783806 h 4029106"/>
              <a:gd name="connsiteX3" fmla="*/ 945356 w 9144000"/>
              <a:gd name="connsiteY3" fmla="*/ 3786189 h 4029106"/>
              <a:gd name="connsiteX4" fmla="*/ 809624 w 9144000"/>
              <a:gd name="connsiteY4" fmla="*/ 4029075 h 4029106"/>
              <a:gd name="connsiteX5" fmla="*/ 666750 w 9144000"/>
              <a:gd name="connsiteY5" fmla="*/ 3781425 h 4029106"/>
              <a:gd name="connsiteX6" fmla="*/ 0 w 9144000"/>
              <a:gd name="connsiteY6" fmla="*/ 3783806 h 4029106"/>
              <a:gd name="connsiteX7" fmla="*/ 0 w 9144000"/>
              <a:gd name="connsiteY7" fmla="*/ 0 h 4029106"/>
              <a:gd name="connsiteX0" fmla="*/ 0 w 9144000"/>
              <a:gd name="connsiteY0" fmla="*/ 0 h 4029106"/>
              <a:gd name="connsiteX1" fmla="*/ 9144000 w 9144000"/>
              <a:gd name="connsiteY1" fmla="*/ 0 h 4029106"/>
              <a:gd name="connsiteX2" fmla="*/ 9144000 w 9144000"/>
              <a:gd name="connsiteY2" fmla="*/ 3783806 h 4029106"/>
              <a:gd name="connsiteX3" fmla="*/ 945356 w 9144000"/>
              <a:gd name="connsiteY3" fmla="*/ 3786189 h 4029106"/>
              <a:gd name="connsiteX4" fmla="*/ 809624 w 9144000"/>
              <a:gd name="connsiteY4" fmla="*/ 4029075 h 4029106"/>
              <a:gd name="connsiteX5" fmla="*/ 666750 w 9144000"/>
              <a:gd name="connsiteY5" fmla="*/ 3781425 h 4029106"/>
              <a:gd name="connsiteX6" fmla="*/ 0 w 9144000"/>
              <a:gd name="connsiteY6" fmla="*/ 3783806 h 4029106"/>
              <a:gd name="connsiteX7" fmla="*/ 0 w 9144000"/>
              <a:gd name="connsiteY7" fmla="*/ 0 h 4029106"/>
              <a:gd name="connsiteX0" fmla="*/ 0 w 9144000"/>
              <a:gd name="connsiteY0" fmla="*/ 0 h 4039816"/>
              <a:gd name="connsiteX1" fmla="*/ 9144000 w 9144000"/>
              <a:gd name="connsiteY1" fmla="*/ 0 h 4039816"/>
              <a:gd name="connsiteX2" fmla="*/ 9144000 w 9144000"/>
              <a:gd name="connsiteY2" fmla="*/ 3783806 h 4039816"/>
              <a:gd name="connsiteX3" fmla="*/ 945356 w 9144000"/>
              <a:gd name="connsiteY3" fmla="*/ 3786189 h 4039816"/>
              <a:gd name="connsiteX4" fmla="*/ 854869 w 9144000"/>
              <a:gd name="connsiteY4" fmla="*/ 3974305 h 4039816"/>
              <a:gd name="connsiteX5" fmla="*/ 809624 w 9144000"/>
              <a:gd name="connsiteY5" fmla="*/ 4029075 h 4039816"/>
              <a:gd name="connsiteX6" fmla="*/ 666750 w 9144000"/>
              <a:gd name="connsiteY6" fmla="*/ 3781425 h 4039816"/>
              <a:gd name="connsiteX7" fmla="*/ 0 w 9144000"/>
              <a:gd name="connsiteY7" fmla="*/ 3783806 h 4039816"/>
              <a:gd name="connsiteX8" fmla="*/ 0 w 9144000"/>
              <a:gd name="connsiteY8" fmla="*/ 0 h 4039816"/>
              <a:gd name="connsiteX0" fmla="*/ 0 w 9144000"/>
              <a:gd name="connsiteY0" fmla="*/ 0 h 4029309"/>
              <a:gd name="connsiteX1" fmla="*/ 9144000 w 9144000"/>
              <a:gd name="connsiteY1" fmla="*/ 0 h 4029309"/>
              <a:gd name="connsiteX2" fmla="*/ 9144000 w 9144000"/>
              <a:gd name="connsiteY2" fmla="*/ 3783806 h 4029309"/>
              <a:gd name="connsiteX3" fmla="*/ 945356 w 9144000"/>
              <a:gd name="connsiteY3" fmla="*/ 3786189 h 4029309"/>
              <a:gd name="connsiteX4" fmla="*/ 854869 w 9144000"/>
              <a:gd name="connsiteY4" fmla="*/ 3974305 h 4029309"/>
              <a:gd name="connsiteX5" fmla="*/ 809624 w 9144000"/>
              <a:gd name="connsiteY5" fmla="*/ 4029075 h 4029309"/>
              <a:gd name="connsiteX6" fmla="*/ 766763 w 9144000"/>
              <a:gd name="connsiteY6" fmla="*/ 3983830 h 4029309"/>
              <a:gd name="connsiteX7" fmla="*/ 666750 w 9144000"/>
              <a:gd name="connsiteY7" fmla="*/ 3781425 h 4029309"/>
              <a:gd name="connsiteX8" fmla="*/ 0 w 9144000"/>
              <a:gd name="connsiteY8" fmla="*/ 3783806 h 4029309"/>
              <a:gd name="connsiteX9" fmla="*/ 0 w 9144000"/>
              <a:gd name="connsiteY9" fmla="*/ 0 h 4029309"/>
              <a:gd name="connsiteX0" fmla="*/ 0 w 9144000"/>
              <a:gd name="connsiteY0" fmla="*/ 0 h 4029309"/>
              <a:gd name="connsiteX1" fmla="*/ 9144000 w 9144000"/>
              <a:gd name="connsiteY1" fmla="*/ 0 h 4029309"/>
              <a:gd name="connsiteX2" fmla="*/ 9144000 w 9144000"/>
              <a:gd name="connsiteY2" fmla="*/ 3783806 h 4029309"/>
              <a:gd name="connsiteX3" fmla="*/ 945356 w 9144000"/>
              <a:gd name="connsiteY3" fmla="*/ 3786189 h 4029309"/>
              <a:gd name="connsiteX4" fmla="*/ 854869 w 9144000"/>
              <a:gd name="connsiteY4" fmla="*/ 3974305 h 4029309"/>
              <a:gd name="connsiteX5" fmla="*/ 809624 w 9144000"/>
              <a:gd name="connsiteY5" fmla="*/ 4029075 h 4029309"/>
              <a:gd name="connsiteX6" fmla="*/ 766763 w 9144000"/>
              <a:gd name="connsiteY6" fmla="*/ 3983830 h 4029309"/>
              <a:gd name="connsiteX7" fmla="*/ 666750 w 9144000"/>
              <a:gd name="connsiteY7" fmla="*/ 3781425 h 4029309"/>
              <a:gd name="connsiteX8" fmla="*/ 0 w 9144000"/>
              <a:gd name="connsiteY8" fmla="*/ 3783806 h 4029309"/>
              <a:gd name="connsiteX9" fmla="*/ 0 w 9144000"/>
              <a:gd name="connsiteY9" fmla="*/ 0 h 4029309"/>
              <a:gd name="connsiteX0" fmla="*/ 0 w 9144000"/>
              <a:gd name="connsiteY0" fmla="*/ 0 h 4029309"/>
              <a:gd name="connsiteX1" fmla="*/ 9144000 w 9144000"/>
              <a:gd name="connsiteY1" fmla="*/ 0 h 4029309"/>
              <a:gd name="connsiteX2" fmla="*/ 9144000 w 9144000"/>
              <a:gd name="connsiteY2" fmla="*/ 3783806 h 4029309"/>
              <a:gd name="connsiteX3" fmla="*/ 945356 w 9144000"/>
              <a:gd name="connsiteY3" fmla="*/ 3786189 h 4029309"/>
              <a:gd name="connsiteX4" fmla="*/ 850106 w 9144000"/>
              <a:gd name="connsiteY4" fmla="*/ 3974305 h 4029309"/>
              <a:gd name="connsiteX5" fmla="*/ 809624 w 9144000"/>
              <a:gd name="connsiteY5" fmla="*/ 4029075 h 4029309"/>
              <a:gd name="connsiteX6" fmla="*/ 766763 w 9144000"/>
              <a:gd name="connsiteY6" fmla="*/ 3983830 h 4029309"/>
              <a:gd name="connsiteX7" fmla="*/ 666750 w 9144000"/>
              <a:gd name="connsiteY7" fmla="*/ 3781425 h 4029309"/>
              <a:gd name="connsiteX8" fmla="*/ 0 w 9144000"/>
              <a:gd name="connsiteY8" fmla="*/ 3783806 h 4029309"/>
              <a:gd name="connsiteX9" fmla="*/ 0 w 9144000"/>
              <a:gd name="connsiteY9" fmla="*/ 0 h 4029309"/>
              <a:gd name="connsiteX0" fmla="*/ 0 w 9144000"/>
              <a:gd name="connsiteY0" fmla="*/ 0 h 4029309"/>
              <a:gd name="connsiteX1" fmla="*/ 9144000 w 9144000"/>
              <a:gd name="connsiteY1" fmla="*/ 0 h 4029309"/>
              <a:gd name="connsiteX2" fmla="*/ 9144000 w 9144000"/>
              <a:gd name="connsiteY2" fmla="*/ 3783806 h 4029309"/>
              <a:gd name="connsiteX3" fmla="*/ 945356 w 9144000"/>
              <a:gd name="connsiteY3" fmla="*/ 3786189 h 4029309"/>
              <a:gd name="connsiteX4" fmla="*/ 850106 w 9144000"/>
              <a:gd name="connsiteY4" fmla="*/ 3974305 h 4029309"/>
              <a:gd name="connsiteX5" fmla="*/ 809624 w 9144000"/>
              <a:gd name="connsiteY5" fmla="*/ 4029075 h 4029309"/>
              <a:gd name="connsiteX6" fmla="*/ 766763 w 9144000"/>
              <a:gd name="connsiteY6" fmla="*/ 3983830 h 4029309"/>
              <a:gd name="connsiteX7" fmla="*/ 666750 w 9144000"/>
              <a:gd name="connsiteY7" fmla="*/ 3781425 h 4029309"/>
              <a:gd name="connsiteX8" fmla="*/ 0 w 9144000"/>
              <a:gd name="connsiteY8" fmla="*/ 3783806 h 4029309"/>
              <a:gd name="connsiteX9" fmla="*/ 0 w 9144000"/>
              <a:gd name="connsiteY9" fmla="*/ 0 h 4029309"/>
              <a:gd name="connsiteX0" fmla="*/ 0 w 9144000"/>
              <a:gd name="connsiteY0" fmla="*/ 0 h 4029309"/>
              <a:gd name="connsiteX1" fmla="*/ 9144000 w 9144000"/>
              <a:gd name="connsiteY1" fmla="*/ 0 h 4029309"/>
              <a:gd name="connsiteX2" fmla="*/ 9144000 w 9144000"/>
              <a:gd name="connsiteY2" fmla="*/ 3783806 h 4029309"/>
              <a:gd name="connsiteX3" fmla="*/ 945356 w 9144000"/>
              <a:gd name="connsiteY3" fmla="*/ 3786189 h 4029309"/>
              <a:gd name="connsiteX4" fmla="*/ 850106 w 9144000"/>
              <a:gd name="connsiteY4" fmla="*/ 3974305 h 4029309"/>
              <a:gd name="connsiteX5" fmla="*/ 809624 w 9144000"/>
              <a:gd name="connsiteY5" fmla="*/ 4029075 h 4029309"/>
              <a:gd name="connsiteX6" fmla="*/ 766763 w 9144000"/>
              <a:gd name="connsiteY6" fmla="*/ 3983830 h 4029309"/>
              <a:gd name="connsiteX7" fmla="*/ 666750 w 9144000"/>
              <a:gd name="connsiteY7" fmla="*/ 3781425 h 4029309"/>
              <a:gd name="connsiteX8" fmla="*/ 0 w 9144000"/>
              <a:gd name="connsiteY8" fmla="*/ 3783806 h 4029309"/>
              <a:gd name="connsiteX9" fmla="*/ 0 w 9144000"/>
              <a:gd name="connsiteY9" fmla="*/ 0 h 4029309"/>
              <a:gd name="connsiteX0" fmla="*/ 0 w 9144000"/>
              <a:gd name="connsiteY0" fmla="*/ 0 h 4029309"/>
              <a:gd name="connsiteX1" fmla="*/ 9144000 w 9144000"/>
              <a:gd name="connsiteY1" fmla="*/ 0 h 4029309"/>
              <a:gd name="connsiteX2" fmla="*/ 9144000 w 9144000"/>
              <a:gd name="connsiteY2" fmla="*/ 3783806 h 4029309"/>
              <a:gd name="connsiteX3" fmla="*/ 945356 w 9144000"/>
              <a:gd name="connsiteY3" fmla="*/ 3786189 h 4029309"/>
              <a:gd name="connsiteX4" fmla="*/ 850106 w 9144000"/>
              <a:gd name="connsiteY4" fmla="*/ 3974305 h 4029309"/>
              <a:gd name="connsiteX5" fmla="*/ 809624 w 9144000"/>
              <a:gd name="connsiteY5" fmla="*/ 4029075 h 4029309"/>
              <a:gd name="connsiteX6" fmla="*/ 766763 w 9144000"/>
              <a:gd name="connsiteY6" fmla="*/ 3983830 h 4029309"/>
              <a:gd name="connsiteX7" fmla="*/ 666750 w 9144000"/>
              <a:gd name="connsiteY7" fmla="*/ 3781425 h 4029309"/>
              <a:gd name="connsiteX8" fmla="*/ 0 w 9144000"/>
              <a:gd name="connsiteY8" fmla="*/ 3783806 h 4029309"/>
              <a:gd name="connsiteX9" fmla="*/ 0 w 9144000"/>
              <a:gd name="connsiteY9" fmla="*/ 0 h 4029309"/>
              <a:gd name="connsiteX0" fmla="*/ 0 w 9144000"/>
              <a:gd name="connsiteY0" fmla="*/ 0 h 4088634"/>
              <a:gd name="connsiteX1" fmla="*/ 9144000 w 9144000"/>
              <a:gd name="connsiteY1" fmla="*/ 0 h 4088634"/>
              <a:gd name="connsiteX2" fmla="*/ 9144000 w 9144000"/>
              <a:gd name="connsiteY2" fmla="*/ 3783806 h 4088634"/>
              <a:gd name="connsiteX3" fmla="*/ 945356 w 9144000"/>
              <a:gd name="connsiteY3" fmla="*/ 3786189 h 4088634"/>
              <a:gd name="connsiteX4" fmla="*/ 850106 w 9144000"/>
              <a:gd name="connsiteY4" fmla="*/ 3974305 h 4088634"/>
              <a:gd name="connsiteX5" fmla="*/ 809624 w 9144000"/>
              <a:gd name="connsiteY5" fmla="*/ 4088606 h 4088634"/>
              <a:gd name="connsiteX6" fmla="*/ 766763 w 9144000"/>
              <a:gd name="connsiteY6" fmla="*/ 3983830 h 4088634"/>
              <a:gd name="connsiteX7" fmla="*/ 666750 w 9144000"/>
              <a:gd name="connsiteY7" fmla="*/ 3781425 h 4088634"/>
              <a:gd name="connsiteX8" fmla="*/ 0 w 9144000"/>
              <a:gd name="connsiteY8" fmla="*/ 3783806 h 4088634"/>
              <a:gd name="connsiteX9" fmla="*/ 0 w 9144000"/>
              <a:gd name="connsiteY9" fmla="*/ 0 h 4088634"/>
              <a:gd name="connsiteX0" fmla="*/ 0 w 9144000"/>
              <a:gd name="connsiteY0" fmla="*/ 0 h 4098155"/>
              <a:gd name="connsiteX1" fmla="*/ 9144000 w 9144000"/>
              <a:gd name="connsiteY1" fmla="*/ 0 h 4098155"/>
              <a:gd name="connsiteX2" fmla="*/ 9144000 w 9144000"/>
              <a:gd name="connsiteY2" fmla="*/ 3783806 h 4098155"/>
              <a:gd name="connsiteX3" fmla="*/ 945356 w 9144000"/>
              <a:gd name="connsiteY3" fmla="*/ 3786189 h 4098155"/>
              <a:gd name="connsiteX4" fmla="*/ 850106 w 9144000"/>
              <a:gd name="connsiteY4" fmla="*/ 3974305 h 4098155"/>
              <a:gd name="connsiteX5" fmla="*/ 814386 w 9144000"/>
              <a:gd name="connsiteY5" fmla="*/ 4098131 h 4098155"/>
              <a:gd name="connsiteX6" fmla="*/ 766763 w 9144000"/>
              <a:gd name="connsiteY6" fmla="*/ 3983830 h 4098155"/>
              <a:gd name="connsiteX7" fmla="*/ 666750 w 9144000"/>
              <a:gd name="connsiteY7" fmla="*/ 3781425 h 4098155"/>
              <a:gd name="connsiteX8" fmla="*/ 0 w 9144000"/>
              <a:gd name="connsiteY8" fmla="*/ 3783806 h 4098155"/>
              <a:gd name="connsiteX9" fmla="*/ 0 w 9144000"/>
              <a:gd name="connsiteY9" fmla="*/ 0 h 4098155"/>
              <a:gd name="connsiteX0" fmla="*/ 0 w 9144000"/>
              <a:gd name="connsiteY0" fmla="*/ 0 h 4098155"/>
              <a:gd name="connsiteX1" fmla="*/ 9144000 w 9144000"/>
              <a:gd name="connsiteY1" fmla="*/ 0 h 4098155"/>
              <a:gd name="connsiteX2" fmla="*/ 9144000 w 9144000"/>
              <a:gd name="connsiteY2" fmla="*/ 3783806 h 4098155"/>
              <a:gd name="connsiteX3" fmla="*/ 945356 w 9144000"/>
              <a:gd name="connsiteY3" fmla="*/ 3786189 h 4098155"/>
              <a:gd name="connsiteX4" fmla="*/ 850106 w 9144000"/>
              <a:gd name="connsiteY4" fmla="*/ 3974305 h 4098155"/>
              <a:gd name="connsiteX5" fmla="*/ 802480 w 9144000"/>
              <a:gd name="connsiteY5" fmla="*/ 4098131 h 4098155"/>
              <a:gd name="connsiteX6" fmla="*/ 766763 w 9144000"/>
              <a:gd name="connsiteY6" fmla="*/ 3983830 h 4098155"/>
              <a:gd name="connsiteX7" fmla="*/ 666750 w 9144000"/>
              <a:gd name="connsiteY7" fmla="*/ 3781425 h 4098155"/>
              <a:gd name="connsiteX8" fmla="*/ 0 w 9144000"/>
              <a:gd name="connsiteY8" fmla="*/ 3783806 h 4098155"/>
              <a:gd name="connsiteX9" fmla="*/ 0 w 9144000"/>
              <a:gd name="connsiteY9" fmla="*/ 0 h 4098155"/>
              <a:gd name="connsiteX0" fmla="*/ 0 w 9144000"/>
              <a:gd name="connsiteY0" fmla="*/ 0 h 4099570"/>
              <a:gd name="connsiteX1" fmla="*/ 9144000 w 9144000"/>
              <a:gd name="connsiteY1" fmla="*/ 0 h 4099570"/>
              <a:gd name="connsiteX2" fmla="*/ 9144000 w 9144000"/>
              <a:gd name="connsiteY2" fmla="*/ 3783806 h 4099570"/>
              <a:gd name="connsiteX3" fmla="*/ 945356 w 9144000"/>
              <a:gd name="connsiteY3" fmla="*/ 3786189 h 4099570"/>
              <a:gd name="connsiteX4" fmla="*/ 850106 w 9144000"/>
              <a:gd name="connsiteY4" fmla="*/ 3974305 h 4099570"/>
              <a:gd name="connsiteX5" fmla="*/ 802480 w 9144000"/>
              <a:gd name="connsiteY5" fmla="*/ 4098131 h 4099570"/>
              <a:gd name="connsiteX6" fmla="*/ 766763 w 9144000"/>
              <a:gd name="connsiteY6" fmla="*/ 3983830 h 4099570"/>
              <a:gd name="connsiteX7" fmla="*/ 666750 w 9144000"/>
              <a:gd name="connsiteY7" fmla="*/ 3781425 h 4099570"/>
              <a:gd name="connsiteX8" fmla="*/ 0 w 9144000"/>
              <a:gd name="connsiteY8" fmla="*/ 3783806 h 4099570"/>
              <a:gd name="connsiteX9" fmla="*/ 0 w 9144000"/>
              <a:gd name="connsiteY9" fmla="*/ 0 h 4099570"/>
              <a:gd name="connsiteX0" fmla="*/ 0 w 9144000"/>
              <a:gd name="connsiteY0" fmla="*/ 0 h 4098135"/>
              <a:gd name="connsiteX1" fmla="*/ 9144000 w 9144000"/>
              <a:gd name="connsiteY1" fmla="*/ 0 h 4098135"/>
              <a:gd name="connsiteX2" fmla="*/ 9144000 w 9144000"/>
              <a:gd name="connsiteY2" fmla="*/ 3783806 h 4098135"/>
              <a:gd name="connsiteX3" fmla="*/ 945356 w 9144000"/>
              <a:gd name="connsiteY3" fmla="*/ 3786189 h 4098135"/>
              <a:gd name="connsiteX4" fmla="*/ 850106 w 9144000"/>
              <a:gd name="connsiteY4" fmla="*/ 3974305 h 4098135"/>
              <a:gd name="connsiteX5" fmla="*/ 802480 w 9144000"/>
              <a:gd name="connsiteY5" fmla="*/ 4098131 h 4098135"/>
              <a:gd name="connsiteX6" fmla="*/ 766763 w 9144000"/>
              <a:gd name="connsiteY6" fmla="*/ 3983830 h 4098135"/>
              <a:gd name="connsiteX7" fmla="*/ 666750 w 9144000"/>
              <a:gd name="connsiteY7" fmla="*/ 3781425 h 4098135"/>
              <a:gd name="connsiteX8" fmla="*/ 0 w 9144000"/>
              <a:gd name="connsiteY8" fmla="*/ 3783806 h 4098135"/>
              <a:gd name="connsiteX9" fmla="*/ 0 w 9144000"/>
              <a:gd name="connsiteY9" fmla="*/ 0 h 4098135"/>
              <a:gd name="connsiteX0" fmla="*/ 0 w 9144000"/>
              <a:gd name="connsiteY0" fmla="*/ 0 h 4100517"/>
              <a:gd name="connsiteX1" fmla="*/ 9144000 w 9144000"/>
              <a:gd name="connsiteY1" fmla="*/ 0 h 4100517"/>
              <a:gd name="connsiteX2" fmla="*/ 9144000 w 9144000"/>
              <a:gd name="connsiteY2" fmla="*/ 3783806 h 4100517"/>
              <a:gd name="connsiteX3" fmla="*/ 945356 w 9144000"/>
              <a:gd name="connsiteY3" fmla="*/ 3786189 h 4100517"/>
              <a:gd name="connsiteX4" fmla="*/ 850106 w 9144000"/>
              <a:gd name="connsiteY4" fmla="*/ 3974305 h 4100517"/>
              <a:gd name="connsiteX5" fmla="*/ 816767 w 9144000"/>
              <a:gd name="connsiteY5" fmla="*/ 4100513 h 4100517"/>
              <a:gd name="connsiteX6" fmla="*/ 766763 w 9144000"/>
              <a:gd name="connsiteY6" fmla="*/ 3983830 h 4100517"/>
              <a:gd name="connsiteX7" fmla="*/ 666750 w 9144000"/>
              <a:gd name="connsiteY7" fmla="*/ 3781425 h 4100517"/>
              <a:gd name="connsiteX8" fmla="*/ 0 w 9144000"/>
              <a:gd name="connsiteY8" fmla="*/ 3783806 h 4100517"/>
              <a:gd name="connsiteX9" fmla="*/ 0 w 9144000"/>
              <a:gd name="connsiteY9" fmla="*/ 0 h 4100517"/>
              <a:gd name="connsiteX0" fmla="*/ 0 w 9144000"/>
              <a:gd name="connsiteY0" fmla="*/ 0 h 4021977"/>
              <a:gd name="connsiteX1" fmla="*/ 9144000 w 9144000"/>
              <a:gd name="connsiteY1" fmla="*/ 0 h 4021977"/>
              <a:gd name="connsiteX2" fmla="*/ 9144000 w 9144000"/>
              <a:gd name="connsiteY2" fmla="*/ 3783806 h 4021977"/>
              <a:gd name="connsiteX3" fmla="*/ 945356 w 9144000"/>
              <a:gd name="connsiteY3" fmla="*/ 3786189 h 4021977"/>
              <a:gd name="connsiteX4" fmla="*/ 850106 w 9144000"/>
              <a:gd name="connsiteY4" fmla="*/ 3974305 h 4021977"/>
              <a:gd name="connsiteX5" fmla="*/ 807242 w 9144000"/>
              <a:gd name="connsiteY5" fmla="*/ 4021931 h 4021977"/>
              <a:gd name="connsiteX6" fmla="*/ 766763 w 9144000"/>
              <a:gd name="connsiteY6" fmla="*/ 3983830 h 4021977"/>
              <a:gd name="connsiteX7" fmla="*/ 666750 w 9144000"/>
              <a:gd name="connsiteY7" fmla="*/ 3781425 h 4021977"/>
              <a:gd name="connsiteX8" fmla="*/ 0 w 9144000"/>
              <a:gd name="connsiteY8" fmla="*/ 3783806 h 4021977"/>
              <a:gd name="connsiteX9" fmla="*/ 0 w 9144000"/>
              <a:gd name="connsiteY9" fmla="*/ 0 h 4021977"/>
              <a:gd name="connsiteX0" fmla="*/ 0 w 9144000"/>
              <a:gd name="connsiteY0" fmla="*/ 0 h 4022430"/>
              <a:gd name="connsiteX1" fmla="*/ 9144000 w 9144000"/>
              <a:gd name="connsiteY1" fmla="*/ 0 h 4022430"/>
              <a:gd name="connsiteX2" fmla="*/ 9144000 w 9144000"/>
              <a:gd name="connsiteY2" fmla="*/ 3783806 h 4022430"/>
              <a:gd name="connsiteX3" fmla="*/ 945356 w 9144000"/>
              <a:gd name="connsiteY3" fmla="*/ 3786189 h 4022430"/>
              <a:gd name="connsiteX4" fmla="*/ 850106 w 9144000"/>
              <a:gd name="connsiteY4" fmla="*/ 3974305 h 4022430"/>
              <a:gd name="connsiteX5" fmla="*/ 807242 w 9144000"/>
              <a:gd name="connsiteY5" fmla="*/ 4021931 h 4022430"/>
              <a:gd name="connsiteX6" fmla="*/ 766763 w 9144000"/>
              <a:gd name="connsiteY6" fmla="*/ 3983830 h 4022430"/>
              <a:gd name="connsiteX7" fmla="*/ 666750 w 9144000"/>
              <a:gd name="connsiteY7" fmla="*/ 3781425 h 4022430"/>
              <a:gd name="connsiteX8" fmla="*/ 0 w 9144000"/>
              <a:gd name="connsiteY8" fmla="*/ 3783806 h 4022430"/>
              <a:gd name="connsiteX9" fmla="*/ 0 w 9144000"/>
              <a:gd name="connsiteY9" fmla="*/ 0 h 4022430"/>
              <a:gd name="connsiteX0" fmla="*/ 0 w 9144000"/>
              <a:gd name="connsiteY0" fmla="*/ 0 h 4022430"/>
              <a:gd name="connsiteX1" fmla="*/ 9144000 w 9144000"/>
              <a:gd name="connsiteY1" fmla="*/ 0 h 4022430"/>
              <a:gd name="connsiteX2" fmla="*/ 9144000 w 9144000"/>
              <a:gd name="connsiteY2" fmla="*/ 3783806 h 4022430"/>
              <a:gd name="connsiteX3" fmla="*/ 945356 w 9144000"/>
              <a:gd name="connsiteY3" fmla="*/ 3786189 h 4022430"/>
              <a:gd name="connsiteX4" fmla="*/ 850106 w 9144000"/>
              <a:gd name="connsiteY4" fmla="*/ 3974305 h 4022430"/>
              <a:gd name="connsiteX5" fmla="*/ 807242 w 9144000"/>
              <a:gd name="connsiteY5" fmla="*/ 4021931 h 4022430"/>
              <a:gd name="connsiteX6" fmla="*/ 766763 w 9144000"/>
              <a:gd name="connsiteY6" fmla="*/ 3983830 h 4022430"/>
              <a:gd name="connsiteX7" fmla="*/ 666750 w 9144000"/>
              <a:gd name="connsiteY7" fmla="*/ 3781425 h 4022430"/>
              <a:gd name="connsiteX8" fmla="*/ 0 w 9144000"/>
              <a:gd name="connsiteY8" fmla="*/ 3783806 h 4022430"/>
              <a:gd name="connsiteX9" fmla="*/ 0 w 9144000"/>
              <a:gd name="connsiteY9" fmla="*/ 0 h 4022430"/>
              <a:gd name="connsiteX0" fmla="*/ 0 w 9144000"/>
              <a:gd name="connsiteY0" fmla="*/ 0 h 4024744"/>
              <a:gd name="connsiteX1" fmla="*/ 9144000 w 9144000"/>
              <a:gd name="connsiteY1" fmla="*/ 0 h 4024744"/>
              <a:gd name="connsiteX2" fmla="*/ 9144000 w 9144000"/>
              <a:gd name="connsiteY2" fmla="*/ 3783806 h 4024744"/>
              <a:gd name="connsiteX3" fmla="*/ 945356 w 9144000"/>
              <a:gd name="connsiteY3" fmla="*/ 3786189 h 4024744"/>
              <a:gd name="connsiteX4" fmla="*/ 850106 w 9144000"/>
              <a:gd name="connsiteY4" fmla="*/ 3974305 h 4024744"/>
              <a:gd name="connsiteX5" fmla="*/ 804860 w 9144000"/>
              <a:gd name="connsiteY5" fmla="*/ 4024313 h 4024744"/>
              <a:gd name="connsiteX6" fmla="*/ 766763 w 9144000"/>
              <a:gd name="connsiteY6" fmla="*/ 3983830 h 4024744"/>
              <a:gd name="connsiteX7" fmla="*/ 666750 w 9144000"/>
              <a:gd name="connsiteY7" fmla="*/ 3781425 h 4024744"/>
              <a:gd name="connsiteX8" fmla="*/ 0 w 9144000"/>
              <a:gd name="connsiteY8" fmla="*/ 3783806 h 4024744"/>
              <a:gd name="connsiteX9" fmla="*/ 0 w 9144000"/>
              <a:gd name="connsiteY9" fmla="*/ 0 h 4024744"/>
              <a:gd name="connsiteX0" fmla="*/ 0 w 9144000"/>
              <a:gd name="connsiteY0" fmla="*/ 0 h 4024342"/>
              <a:gd name="connsiteX1" fmla="*/ 9144000 w 9144000"/>
              <a:gd name="connsiteY1" fmla="*/ 0 h 4024342"/>
              <a:gd name="connsiteX2" fmla="*/ 9144000 w 9144000"/>
              <a:gd name="connsiteY2" fmla="*/ 3783806 h 4024342"/>
              <a:gd name="connsiteX3" fmla="*/ 945356 w 9144000"/>
              <a:gd name="connsiteY3" fmla="*/ 3786189 h 4024342"/>
              <a:gd name="connsiteX4" fmla="*/ 850106 w 9144000"/>
              <a:gd name="connsiteY4" fmla="*/ 3974305 h 4024342"/>
              <a:gd name="connsiteX5" fmla="*/ 804860 w 9144000"/>
              <a:gd name="connsiteY5" fmla="*/ 4024313 h 4024342"/>
              <a:gd name="connsiteX6" fmla="*/ 766763 w 9144000"/>
              <a:gd name="connsiteY6" fmla="*/ 3983830 h 4024342"/>
              <a:gd name="connsiteX7" fmla="*/ 666750 w 9144000"/>
              <a:gd name="connsiteY7" fmla="*/ 3781425 h 4024342"/>
              <a:gd name="connsiteX8" fmla="*/ 0 w 9144000"/>
              <a:gd name="connsiteY8" fmla="*/ 3783806 h 4024342"/>
              <a:gd name="connsiteX9" fmla="*/ 0 w 9144000"/>
              <a:gd name="connsiteY9" fmla="*/ 0 h 4024342"/>
              <a:gd name="connsiteX0" fmla="*/ 0 w 9144000"/>
              <a:gd name="connsiteY0" fmla="*/ 0 h 4024342"/>
              <a:gd name="connsiteX1" fmla="*/ 9144000 w 9144000"/>
              <a:gd name="connsiteY1" fmla="*/ 0 h 4024342"/>
              <a:gd name="connsiteX2" fmla="*/ 9144000 w 9144000"/>
              <a:gd name="connsiteY2" fmla="*/ 3783806 h 4024342"/>
              <a:gd name="connsiteX3" fmla="*/ 945356 w 9144000"/>
              <a:gd name="connsiteY3" fmla="*/ 3786189 h 4024342"/>
              <a:gd name="connsiteX4" fmla="*/ 850106 w 9144000"/>
              <a:gd name="connsiteY4" fmla="*/ 3974305 h 4024342"/>
              <a:gd name="connsiteX5" fmla="*/ 804860 w 9144000"/>
              <a:gd name="connsiteY5" fmla="*/ 4024313 h 4024342"/>
              <a:gd name="connsiteX6" fmla="*/ 766763 w 9144000"/>
              <a:gd name="connsiteY6" fmla="*/ 3983830 h 4024342"/>
              <a:gd name="connsiteX7" fmla="*/ 666750 w 9144000"/>
              <a:gd name="connsiteY7" fmla="*/ 3781425 h 4024342"/>
              <a:gd name="connsiteX8" fmla="*/ 0 w 9144000"/>
              <a:gd name="connsiteY8" fmla="*/ 3783806 h 4024342"/>
              <a:gd name="connsiteX9" fmla="*/ 0 w 9144000"/>
              <a:gd name="connsiteY9" fmla="*/ 0 h 4024342"/>
              <a:gd name="connsiteX0" fmla="*/ 0 w 9144000"/>
              <a:gd name="connsiteY0" fmla="*/ 0 h 4024784"/>
              <a:gd name="connsiteX1" fmla="*/ 9144000 w 9144000"/>
              <a:gd name="connsiteY1" fmla="*/ 0 h 4024784"/>
              <a:gd name="connsiteX2" fmla="*/ 9144000 w 9144000"/>
              <a:gd name="connsiteY2" fmla="*/ 3783806 h 4024784"/>
              <a:gd name="connsiteX3" fmla="*/ 945356 w 9144000"/>
              <a:gd name="connsiteY3" fmla="*/ 3786189 h 4024784"/>
              <a:gd name="connsiteX4" fmla="*/ 850106 w 9144000"/>
              <a:gd name="connsiteY4" fmla="*/ 3974305 h 4024784"/>
              <a:gd name="connsiteX5" fmla="*/ 804860 w 9144000"/>
              <a:gd name="connsiteY5" fmla="*/ 4024313 h 4024784"/>
              <a:gd name="connsiteX6" fmla="*/ 766763 w 9144000"/>
              <a:gd name="connsiteY6" fmla="*/ 3983830 h 4024784"/>
              <a:gd name="connsiteX7" fmla="*/ 666750 w 9144000"/>
              <a:gd name="connsiteY7" fmla="*/ 3781425 h 4024784"/>
              <a:gd name="connsiteX8" fmla="*/ 0 w 9144000"/>
              <a:gd name="connsiteY8" fmla="*/ 3783806 h 4024784"/>
              <a:gd name="connsiteX9" fmla="*/ 0 w 9144000"/>
              <a:gd name="connsiteY9" fmla="*/ 0 h 4024784"/>
              <a:gd name="connsiteX0" fmla="*/ 0 w 9144000"/>
              <a:gd name="connsiteY0" fmla="*/ 0 h 4024784"/>
              <a:gd name="connsiteX1" fmla="*/ 9144000 w 9144000"/>
              <a:gd name="connsiteY1" fmla="*/ 0 h 4024784"/>
              <a:gd name="connsiteX2" fmla="*/ 9144000 w 9144000"/>
              <a:gd name="connsiteY2" fmla="*/ 3783806 h 4024784"/>
              <a:gd name="connsiteX3" fmla="*/ 942975 w 9144000"/>
              <a:gd name="connsiteY3" fmla="*/ 3788570 h 4024784"/>
              <a:gd name="connsiteX4" fmla="*/ 850106 w 9144000"/>
              <a:gd name="connsiteY4" fmla="*/ 3974305 h 4024784"/>
              <a:gd name="connsiteX5" fmla="*/ 804860 w 9144000"/>
              <a:gd name="connsiteY5" fmla="*/ 4024313 h 4024784"/>
              <a:gd name="connsiteX6" fmla="*/ 766763 w 9144000"/>
              <a:gd name="connsiteY6" fmla="*/ 3983830 h 4024784"/>
              <a:gd name="connsiteX7" fmla="*/ 666750 w 9144000"/>
              <a:gd name="connsiteY7" fmla="*/ 3781425 h 4024784"/>
              <a:gd name="connsiteX8" fmla="*/ 0 w 9144000"/>
              <a:gd name="connsiteY8" fmla="*/ 3783806 h 4024784"/>
              <a:gd name="connsiteX9" fmla="*/ 0 w 9144000"/>
              <a:gd name="connsiteY9" fmla="*/ 0 h 4024784"/>
              <a:gd name="connsiteX0" fmla="*/ 0 w 9144000"/>
              <a:gd name="connsiteY0" fmla="*/ 0 h 4024870"/>
              <a:gd name="connsiteX1" fmla="*/ 9144000 w 9144000"/>
              <a:gd name="connsiteY1" fmla="*/ 0 h 4024870"/>
              <a:gd name="connsiteX2" fmla="*/ 9144000 w 9144000"/>
              <a:gd name="connsiteY2" fmla="*/ 3783806 h 4024870"/>
              <a:gd name="connsiteX3" fmla="*/ 942975 w 9144000"/>
              <a:gd name="connsiteY3" fmla="*/ 3788570 h 4024870"/>
              <a:gd name="connsiteX4" fmla="*/ 850106 w 9144000"/>
              <a:gd name="connsiteY4" fmla="*/ 3971924 h 4024870"/>
              <a:gd name="connsiteX5" fmla="*/ 804860 w 9144000"/>
              <a:gd name="connsiteY5" fmla="*/ 4024313 h 4024870"/>
              <a:gd name="connsiteX6" fmla="*/ 766763 w 9144000"/>
              <a:gd name="connsiteY6" fmla="*/ 3983830 h 4024870"/>
              <a:gd name="connsiteX7" fmla="*/ 666750 w 9144000"/>
              <a:gd name="connsiteY7" fmla="*/ 3781425 h 4024870"/>
              <a:gd name="connsiteX8" fmla="*/ 0 w 9144000"/>
              <a:gd name="connsiteY8" fmla="*/ 3783806 h 4024870"/>
              <a:gd name="connsiteX9" fmla="*/ 0 w 9144000"/>
              <a:gd name="connsiteY9" fmla="*/ 0 h 4024870"/>
              <a:gd name="connsiteX0" fmla="*/ 0 w 9144000"/>
              <a:gd name="connsiteY0" fmla="*/ 0 h 4024870"/>
              <a:gd name="connsiteX1" fmla="*/ 9144000 w 9144000"/>
              <a:gd name="connsiteY1" fmla="*/ 0 h 4024870"/>
              <a:gd name="connsiteX2" fmla="*/ 9144000 w 9144000"/>
              <a:gd name="connsiteY2" fmla="*/ 3783806 h 4024870"/>
              <a:gd name="connsiteX3" fmla="*/ 940594 w 9144000"/>
              <a:gd name="connsiteY3" fmla="*/ 3786188 h 4024870"/>
              <a:gd name="connsiteX4" fmla="*/ 850106 w 9144000"/>
              <a:gd name="connsiteY4" fmla="*/ 3971924 h 4024870"/>
              <a:gd name="connsiteX5" fmla="*/ 804860 w 9144000"/>
              <a:gd name="connsiteY5" fmla="*/ 4024313 h 4024870"/>
              <a:gd name="connsiteX6" fmla="*/ 766763 w 9144000"/>
              <a:gd name="connsiteY6" fmla="*/ 3983830 h 4024870"/>
              <a:gd name="connsiteX7" fmla="*/ 666750 w 9144000"/>
              <a:gd name="connsiteY7" fmla="*/ 3781425 h 4024870"/>
              <a:gd name="connsiteX8" fmla="*/ 0 w 9144000"/>
              <a:gd name="connsiteY8" fmla="*/ 3783806 h 4024870"/>
              <a:gd name="connsiteX9" fmla="*/ 0 w 9144000"/>
              <a:gd name="connsiteY9" fmla="*/ 0 h 4024870"/>
              <a:gd name="connsiteX0" fmla="*/ 0 w 9144000"/>
              <a:gd name="connsiteY0" fmla="*/ 0 h 4024870"/>
              <a:gd name="connsiteX1" fmla="*/ 9144000 w 9144000"/>
              <a:gd name="connsiteY1" fmla="*/ 0 h 4024870"/>
              <a:gd name="connsiteX2" fmla="*/ 9144000 w 9144000"/>
              <a:gd name="connsiteY2" fmla="*/ 3783806 h 4024870"/>
              <a:gd name="connsiteX3" fmla="*/ 940594 w 9144000"/>
              <a:gd name="connsiteY3" fmla="*/ 3786188 h 4024870"/>
              <a:gd name="connsiteX4" fmla="*/ 850106 w 9144000"/>
              <a:gd name="connsiteY4" fmla="*/ 3971924 h 4024870"/>
              <a:gd name="connsiteX5" fmla="*/ 804860 w 9144000"/>
              <a:gd name="connsiteY5" fmla="*/ 4024313 h 4024870"/>
              <a:gd name="connsiteX6" fmla="*/ 766763 w 9144000"/>
              <a:gd name="connsiteY6" fmla="*/ 3983830 h 4024870"/>
              <a:gd name="connsiteX7" fmla="*/ 669131 w 9144000"/>
              <a:gd name="connsiteY7" fmla="*/ 3786188 h 4024870"/>
              <a:gd name="connsiteX8" fmla="*/ 0 w 9144000"/>
              <a:gd name="connsiteY8" fmla="*/ 3783806 h 4024870"/>
              <a:gd name="connsiteX9" fmla="*/ 0 w 9144000"/>
              <a:gd name="connsiteY9" fmla="*/ 0 h 4024870"/>
              <a:gd name="connsiteX0" fmla="*/ 0 w 9144000"/>
              <a:gd name="connsiteY0" fmla="*/ 0 h 4024870"/>
              <a:gd name="connsiteX1" fmla="*/ 9144000 w 9144000"/>
              <a:gd name="connsiteY1" fmla="*/ 0 h 4024870"/>
              <a:gd name="connsiteX2" fmla="*/ 9144000 w 9144000"/>
              <a:gd name="connsiteY2" fmla="*/ 3790950 h 4024870"/>
              <a:gd name="connsiteX3" fmla="*/ 940594 w 9144000"/>
              <a:gd name="connsiteY3" fmla="*/ 3786188 h 4024870"/>
              <a:gd name="connsiteX4" fmla="*/ 850106 w 9144000"/>
              <a:gd name="connsiteY4" fmla="*/ 3971924 h 4024870"/>
              <a:gd name="connsiteX5" fmla="*/ 804860 w 9144000"/>
              <a:gd name="connsiteY5" fmla="*/ 4024313 h 4024870"/>
              <a:gd name="connsiteX6" fmla="*/ 766763 w 9144000"/>
              <a:gd name="connsiteY6" fmla="*/ 3983830 h 4024870"/>
              <a:gd name="connsiteX7" fmla="*/ 669131 w 9144000"/>
              <a:gd name="connsiteY7" fmla="*/ 3786188 h 4024870"/>
              <a:gd name="connsiteX8" fmla="*/ 0 w 9144000"/>
              <a:gd name="connsiteY8" fmla="*/ 3783806 h 4024870"/>
              <a:gd name="connsiteX9" fmla="*/ 0 w 9144000"/>
              <a:gd name="connsiteY9" fmla="*/ 0 h 4024870"/>
              <a:gd name="connsiteX0" fmla="*/ 0 w 9144000"/>
              <a:gd name="connsiteY0" fmla="*/ 0 h 4079133"/>
              <a:gd name="connsiteX1" fmla="*/ 9144000 w 9144000"/>
              <a:gd name="connsiteY1" fmla="*/ 0 h 4079133"/>
              <a:gd name="connsiteX2" fmla="*/ 9144000 w 9144000"/>
              <a:gd name="connsiteY2" fmla="*/ 3790950 h 4079133"/>
              <a:gd name="connsiteX3" fmla="*/ 940594 w 9144000"/>
              <a:gd name="connsiteY3" fmla="*/ 3786188 h 4079133"/>
              <a:gd name="connsiteX4" fmla="*/ 850106 w 9144000"/>
              <a:gd name="connsiteY4" fmla="*/ 3971924 h 4079133"/>
              <a:gd name="connsiteX5" fmla="*/ 804860 w 9144000"/>
              <a:gd name="connsiteY5" fmla="*/ 4079082 h 4079133"/>
              <a:gd name="connsiteX6" fmla="*/ 766763 w 9144000"/>
              <a:gd name="connsiteY6" fmla="*/ 3983830 h 4079133"/>
              <a:gd name="connsiteX7" fmla="*/ 669131 w 9144000"/>
              <a:gd name="connsiteY7" fmla="*/ 3786188 h 4079133"/>
              <a:gd name="connsiteX8" fmla="*/ 0 w 9144000"/>
              <a:gd name="connsiteY8" fmla="*/ 3783806 h 4079133"/>
              <a:gd name="connsiteX9" fmla="*/ 0 w 9144000"/>
              <a:gd name="connsiteY9" fmla="*/ 0 h 4079133"/>
              <a:gd name="connsiteX0" fmla="*/ 0 w 9144000"/>
              <a:gd name="connsiteY0" fmla="*/ 0 h 4079133"/>
              <a:gd name="connsiteX1" fmla="*/ 9144000 w 9144000"/>
              <a:gd name="connsiteY1" fmla="*/ 0 h 4079133"/>
              <a:gd name="connsiteX2" fmla="*/ 9144000 w 9144000"/>
              <a:gd name="connsiteY2" fmla="*/ 3790950 h 4079133"/>
              <a:gd name="connsiteX3" fmla="*/ 940594 w 9144000"/>
              <a:gd name="connsiteY3" fmla="*/ 3786188 h 4079133"/>
              <a:gd name="connsiteX4" fmla="*/ 850106 w 9144000"/>
              <a:gd name="connsiteY4" fmla="*/ 3971924 h 4079133"/>
              <a:gd name="connsiteX5" fmla="*/ 804860 w 9144000"/>
              <a:gd name="connsiteY5" fmla="*/ 4079082 h 4079133"/>
              <a:gd name="connsiteX6" fmla="*/ 766763 w 9144000"/>
              <a:gd name="connsiteY6" fmla="*/ 3983830 h 4079133"/>
              <a:gd name="connsiteX7" fmla="*/ 669131 w 9144000"/>
              <a:gd name="connsiteY7" fmla="*/ 3786188 h 4079133"/>
              <a:gd name="connsiteX8" fmla="*/ 0 w 9144000"/>
              <a:gd name="connsiteY8" fmla="*/ 3783806 h 4079133"/>
              <a:gd name="connsiteX9" fmla="*/ 0 w 9144000"/>
              <a:gd name="connsiteY9" fmla="*/ 0 h 4079133"/>
              <a:gd name="connsiteX0" fmla="*/ 0 w 9144000"/>
              <a:gd name="connsiteY0" fmla="*/ 0 h 4022693"/>
              <a:gd name="connsiteX1" fmla="*/ 9144000 w 9144000"/>
              <a:gd name="connsiteY1" fmla="*/ 0 h 4022693"/>
              <a:gd name="connsiteX2" fmla="*/ 9144000 w 9144000"/>
              <a:gd name="connsiteY2" fmla="*/ 3790950 h 4022693"/>
              <a:gd name="connsiteX3" fmla="*/ 940594 w 9144000"/>
              <a:gd name="connsiteY3" fmla="*/ 3786188 h 4022693"/>
              <a:gd name="connsiteX4" fmla="*/ 850106 w 9144000"/>
              <a:gd name="connsiteY4" fmla="*/ 3971924 h 4022693"/>
              <a:gd name="connsiteX5" fmla="*/ 800097 w 9144000"/>
              <a:gd name="connsiteY5" fmla="*/ 4021932 h 4022693"/>
              <a:gd name="connsiteX6" fmla="*/ 766763 w 9144000"/>
              <a:gd name="connsiteY6" fmla="*/ 3983830 h 4022693"/>
              <a:gd name="connsiteX7" fmla="*/ 669131 w 9144000"/>
              <a:gd name="connsiteY7" fmla="*/ 3786188 h 4022693"/>
              <a:gd name="connsiteX8" fmla="*/ 0 w 9144000"/>
              <a:gd name="connsiteY8" fmla="*/ 3783806 h 4022693"/>
              <a:gd name="connsiteX9" fmla="*/ 0 w 9144000"/>
              <a:gd name="connsiteY9" fmla="*/ 0 h 4022693"/>
              <a:gd name="connsiteX0" fmla="*/ 0 w 9144000"/>
              <a:gd name="connsiteY0" fmla="*/ 0 h 4022693"/>
              <a:gd name="connsiteX1" fmla="*/ 9144000 w 9144000"/>
              <a:gd name="connsiteY1" fmla="*/ 0 h 4022693"/>
              <a:gd name="connsiteX2" fmla="*/ 9144000 w 9144000"/>
              <a:gd name="connsiteY2" fmla="*/ 3790950 h 4022693"/>
              <a:gd name="connsiteX3" fmla="*/ 940594 w 9144000"/>
              <a:gd name="connsiteY3" fmla="*/ 3786188 h 4022693"/>
              <a:gd name="connsiteX4" fmla="*/ 850106 w 9144000"/>
              <a:gd name="connsiteY4" fmla="*/ 3971924 h 4022693"/>
              <a:gd name="connsiteX5" fmla="*/ 800097 w 9144000"/>
              <a:gd name="connsiteY5" fmla="*/ 4021932 h 4022693"/>
              <a:gd name="connsiteX6" fmla="*/ 766763 w 9144000"/>
              <a:gd name="connsiteY6" fmla="*/ 3983830 h 4022693"/>
              <a:gd name="connsiteX7" fmla="*/ 669131 w 9144000"/>
              <a:gd name="connsiteY7" fmla="*/ 3786188 h 4022693"/>
              <a:gd name="connsiteX8" fmla="*/ 0 w 9144000"/>
              <a:gd name="connsiteY8" fmla="*/ 3783806 h 4022693"/>
              <a:gd name="connsiteX9" fmla="*/ 0 w 9144000"/>
              <a:gd name="connsiteY9" fmla="*/ 0 h 4022693"/>
              <a:gd name="connsiteX0" fmla="*/ 0 w 9144000"/>
              <a:gd name="connsiteY0" fmla="*/ 0 h 4022693"/>
              <a:gd name="connsiteX1" fmla="*/ 9144000 w 9144000"/>
              <a:gd name="connsiteY1" fmla="*/ 0 h 4022693"/>
              <a:gd name="connsiteX2" fmla="*/ 9144000 w 9144000"/>
              <a:gd name="connsiteY2" fmla="*/ 3790950 h 4022693"/>
              <a:gd name="connsiteX3" fmla="*/ 940594 w 9144000"/>
              <a:gd name="connsiteY3" fmla="*/ 3786188 h 4022693"/>
              <a:gd name="connsiteX4" fmla="*/ 850106 w 9144000"/>
              <a:gd name="connsiteY4" fmla="*/ 3971924 h 4022693"/>
              <a:gd name="connsiteX5" fmla="*/ 800097 w 9144000"/>
              <a:gd name="connsiteY5" fmla="*/ 4021932 h 4022693"/>
              <a:gd name="connsiteX6" fmla="*/ 766763 w 9144000"/>
              <a:gd name="connsiteY6" fmla="*/ 3983830 h 4022693"/>
              <a:gd name="connsiteX7" fmla="*/ 669131 w 9144000"/>
              <a:gd name="connsiteY7" fmla="*/ 3786188 h 4022693"/>
              <a:gd name="connsiteX8" fmla="*/ 0 w 9144000"/>
              <a:gd name="connsiteY8" fmla="*/ 3783806 h 4022693"/>
              <a:gd name="connsiteX9" fmla="*/ 0 w 9144000"/>
              <a:gd name="connsiteY9" fmla="*/ 0 h 4022693"/>
              <a:gd name="connsiteX0" fmla="*/ 0 w 9144000"/>
              <a:gd name="connsiteY0" fmla="*/ 0 h 4022693"/>
              <a:gd name="connsiteX1" fmla="*/ 9144000 w 9144000"/>
              <a:gd name="connsiteY1" fmla="*/ 0 h 4022693"/>
              <a:gd name="connsiteX2" fmla="*/ 9144000 w 9144000"/>
              <a:gd name="connsiteY2" fmla="*/ 3790950 h 4022693"/>
              <a:gd name="connsiteX3" fmla="*/ 940594 w 9144000"/>
              <a:gd name="connsiteY3" fmla="*/ 3786188 h 4022693"/>
              <a:gd name="connsiteX4" fmla="*/ 850106 w 9144000"/>
              <a:gd name="connsiteY4" fmla="*/ 3971924 h 4022693"/>
              <a:gd name="connsiteX5" fmla="*/ 804860 w 9144000"/>
              <a:gd name="connsiteY5" fmla="*/ 4021932 h 4022693"/>
              <a:gd name="connsiteX6" fmla="*/ 766763 w 9144000"/>
              <a:gd name="connsiteY6" fmla="*/ 3983830 h 4022693"/>
              <a:gd name="connsiteX7" fmla="*/ 669131 w 9144000"/>
              <a:gd name="connsiteY7" fmla="*/ 3786188 h 4022693"/>
              <a:gd name="connsiteX8" fmla="*/ 0 w 9144000"/>
              <a:gd name="connsiteY8" fmla="*/ 3783806 h 4022693"/>
              <a:gd name="connsiteX9" fmla="*/ 0 w 9144000"/>
              <a:gd name="connsiteY9" fmla="*/ 0 h 4022693"/>
              <a:gd name="connsiteX0" fmla="*/ 0 w 9144000"/>
              <a:gd name="connsiteY0" fmla="*/ 0 h 4021943"/>
              <a:gd name="connsiteX1" fmla="*/ 9144000 w 9144000"/>
              <a:gd name="connsiteY1" fmla="*/ 0 h 4021943"/>
              <a:gd name="connsiteX2" fmla="*/ 9144000 w 9144000"/>
              <a:gd name="connsiteY2" fmla="*/ 3790950 h 4021943"/>
              <a:gd name="connsiteX3" fmla="*/ 940594 w 9144000"/>
              <a:gd name="connsiteY3" fmla="*/ 3786188 h 4021943"/>
              <a:gd name="connsiteX4" fmla="*/ 850106 w 9144000"/>
              <a:gd name="connsiteY4" fmla="*/ 3971924 h 4021943"/>
              <a:gd name="connsiteX5" fmla="*/ 804860 w 9144000"/>
              <a:gd name="connsiteY5" fmla="*/ 4021932 h 4021943"/>
              <a:gd name="connsiteX6" fmla="*/ 766763 w 9144000"/>
              <a:gd name="connsiteY6" fmla="*/ 3983830 h 4021943"/>
              <a:gd name="connsiteX7" fmla="*/ 669131 w 9144000"/>
              <a:gd name="connsiteY7" fmla="*/ 3786188 h 4021943"/>
              <a:gd name="connsiteX8" fmla="*/ 0 w 9144000"/>
              <a:gd name="connsiteY8" fmla="*/ 3783806 h 4021943"/>
              <a:gd name="connsiteX9" fmla="*/ 0 w 9144000"/>
              <a:gd name="connsiteY9" fmla="*/ 0 h 4021943"/>
              <a:gd name="connsiteX0" fmla="*/ 0 w 9144000"/>
              <a:gd name="connsiteY0" fmla="*/ 0 h 4021943"/>
              <a:gd name="connsiteX1" fmla="*/ 9144000 w 9144000"/>
              <a:gd name="connsiteY1" fmla="*/ 0 h 4021943"/>
              <a:gd name="connsiteX2" fmla="*/ 9144000 w 9144000"/>
              <a:gd name="connsiteY2" fmla="*/ 3790950 h 4021943"/>
              <a:gd name="connsiteX3" fmla="*/ 940594 w 9144000"/>
              <a:gd name="connsiteY3" fmla="*/ 3786188 h 4021943"/>
              <a:gd name="connsiteX4" fmla="*/ 850106 w 9144000"/>
              <a:gd name="connsiteY4" fmla="*/ 3971924 h 4021943"/>
              <a:gd name="connsiteX5" fmla="*/ 804860 w 9144000"/>
              <a:gd name="connsiteY5" fmla="*/ 4021932 h 4021943"/>
              <a:gd name="connsiteX6" fmla="*/ 766763 w 9144000"/>
              <a:gd name="connsiteY6" fmla="*/ 3983830 h 4021943"/>
              <a:gd name="connsiteX7" fmla="*/ 669131 w 9144000"/>
              <a:gd name="connsiteY7" fmla="*/ 3786188 h 4021943"/>
              <a:gd name="connsiteX8" fmla="*/ 0 w 9144000"/>
              <a:gd name="connsiteY8" fmla="*/ 3783806 h 4021943"/>
              <a:gd name="connsiteX9" fmla="*/ 0 w 9144000"/>
              <a:gd name="connsiteY9" fmla="*/ 0 h 4021943"/>
              <a:gd name="connsiteX0" fmla="*/ 0 w 9144000"/>
              <a:gd name="connsiteY0" fmla="*/ 0 h 4021932"/>
              <a:gd name="connsiteX1" fmla="*/ 9144000 w 9144000"/>
              <a:gd name="connsiteY1" fmla="*/ 0 h 4021932"/>
              <a:gd name="connsiteX2" fmla="*/ 9144000 w 9144000"/>
              <a:gd name="connsiteY2" fmla="*/ 3790950 h 4021932"/>
              <a:gd name="connsiteX3" fmla="*/ 940594 w 9144000"/>
              <a:gd name="connsiteY3" fmla="*/ 3786188 h 4021932"/>
              <a:gd name="connsiteX4" fmla="*/ 850106 w 9144000"/>
              <a:gd name="connsiteY4" fmla="*/ 3971924 h 4021932"/>
              <a:gd name="connsiteX5" fmla="*/ 804860 w 9144000"/>
              <a:gd name="connsiteY5" fmla="*/ 4021932 h 4021932"/>
              <a:gd name="connsiteX6" fmla="*/ 762000 w 9144000"/>
              <a:gd name="connsiteY6" fmla="*/ 3971923 h 4021932"/>
              <a:gd name="connsiteX7" fmla="*/ 669131 w 9144000"/>
              <a:gd name="connsiteY7" fmla="*/ 3786188 h 4021932"/>
              <a:gd name="connsiteX8" fmla="*/ 0 w 9144000"/>
              <a:gd name="connsiteY8" fmla="*/ 3783806 h 4021932"/>
              <a:gd name="connsiteX9" fmla="*/ 0 w 9144000"/>
              <a:gd name="connsiteY9" fmla="*/ 0 h 4021932"/>
              <a:gd name="connsiteX0" fmla="*/ 0 w 9144000"/>
              <a:gd name="connsiteY0" fmla="*/ 0 h 4021932"/>
              <a:gd name="connsiteX1" fmla="*/ 9144000 w 9144000"/>
              <a:gd name="connsiteY1" fmla="*/ 0 h 4021932"/>
              <a:gd name="connsiteX2" fmla="*/ 9144000 w 9144000"/>
              <a:gd name="connsiteY2" fmla="*/ 3790950 h 4021932"/>
              <a:gd name="connsiteX3" fmla="*/ 940594 w 9144000"/>
              <a:gd name="connsiteY3" fmla="*/ 3786188 h 4021932"/>
              <a:gd name="connsiteX4" fmla="*/ 850106 w 9144000"/>
              <a:gd name="connsiteY4" fmla="*/ 3971924 h 4021932"/>
              <a:gd name="connsiteX5" fmla="*/ 804860 w 9144000"/>
              <a:gd name="connsiteY5" fmla="*/ 4021932 h 4021932"/>
              <a:gd name="connsiteX6" fmla="*/ 762000 w 9144000"/>
              <a:gd name="connsiteY6" fmla="*/ 3971923 h 4021932"/>
              <a:gd name="connsiteX7" fmla="*/ 669131 w 9144000"/>
              <a:gd name="connsiteY7" fmla="*/ 3786188 h 4021932"/>
              <a:gd name="connsiteX8" fmla="*/ 0 w 9144000"/>
              <a:gd name="connsiteY8" fmla="*/ 3783806 h 4021932"/>
              <a:gd name="connsiteX9" fmla="*/ 0 w 9144000"/>
              <a:gd name="connsiteY9" fmla="*/ 0 h 4021932"/>
              <a:gd name="connsiteX0" fmla="*/ 9330 w 9144000"/>
              <a:gd name="connsiteY0" fmla="*/ 0 h 5365540"/>
              <a:gd name="connsiteX1" fmla="*/ 9144000 w 9144000"/>
              <a:gd name="connsiteY1" fmla="*/ 1343608 h 5365540"/>
              <a:gd name="connsiteX2" fmla="*/ 9144000 w 9144000"/>
              <a:gd name="connsiteY2" fmla="*/ 5134558 h 5365540"/>
              <a:gd name="connsiteX3" fmla="*/ 940594 w 9144000"/>
              <a:gd name="connsiteY3" fmla="*/ 5129796 h 5365540"/>
              <a:gd name="connsiteX4" fmla="*/ 850106 w 9144000"/>
              <a:gd name="connsiteY4" fmla="*/ 5315532 h 5365540"/>
              <a:gd name="connsiteX5" fmla="*/ 804860 w 9144000"/>
              <a:gd name="connsiteY5" fmla="*/ 5365540 h 5365540"/>
              <a:gd name="connsiteX6" fmla="*/ 762000 w 9144000"/>
              <a:gd name="connsiteY6" fmla="*/ 5315531 h 5365540"/>
              <a:gd name="connsiteX7" fmla="*/ 669131 w 9144000"/>
              <a:gd name="connsiteY7" fmla="*/ 5129796 h 5365540"/>
              <a:gd name="connsiteX8" fmla="*/ 0 w 9144000"/>
              <a:gd name="connsiteY8" fmla="*/ 5127414 h 5365540"/>
              <a:gd name="connsiteX9" fmla="*/ 9330 w 9144000"/>
              <a:gd name="connsiteY9" fmla="*/ 0 h 5365540"/>
              <a:gd name="connsiteX0" fmla="*/ 9330 w 9144000"/>
              <a:gd name="connsiteY0" fmla="*/ 0 h 5365540"/>
              <a:gd name="connsiteX1" fmla="*/ 9144000 w 9144000"/>
              <a:gd name="connsiteY1" fmla="*/ 18661 h 5365540"/>
              <a:gd name="connsiteX2" fmla="*/ 9144000 w 9144000"/>
              <a:gd name="connsiteY2" fmla="*/ 5134558 h 5365540"/>
              <a:gd name="connsiteX3" fmla="*/ 940594 w 9144000"/>
              <a:gd name="connsiteY3" fmla="*/ 5129796 h 5365540"/>
              <a:gd name="connsiteX4" fmla="*/ 850106 w 9144000"/>
              <a:gd name="connsiteY4" fmla="*/ 5315532 h 5365540"/>
              <a:gd name="connsiteX5" fmla="*/ 804860 w 9144000"/>
              <a:gd name="connsiteY5" fmla="*/ 5365540 h 5365540"/>
              <a:gd name="connsiteX6" fmla="*/ 762000 w 9144000"/>
              <a:gd name="connsiteY6" fmla="*/ 5315531 h 5365540"/>
              <a:gd name="connsiteX7" fmla="*/ 669131 w 9144000"/>
              <a:gd name="connsiteY7" fmla="*/ 5129796 h 5365540"/>
              <a:gd name="connsiteX8" fmla="*/ 0 w 9144000"/>
              <a:gd name="connsiteY8" fmla="*/ 5127414 h 5365540"/>
              <a:gd name="connsiteX9" fmla="*/ 9330 w 9144000"/>
              <a:gd name="connsiteY9" fmla="*/ 0 h 5365540"/>
              <a:gd name="connsiteX0" fmla="*/ 9330 w 9144000"/>
              <a:gd name="connsiteY0" fmla="*/ 0 h 5365540"/>
              <a:gd name="connsiteX1" fmla="*/ 9144000 w 9144000"/>
              <a:gd name="connsiteY1" fmla="*/ 9331 h 5365540"/>
              <a:gd name="connsiteX2" fmla="*/ 9144000 w 9144000"/>
              <a:gd name="connsiteY2" fmla="*/ 5134558 h 5365540"/>
              <a:gd name="connsiteX3" fmla="*/ 940594 w 9144000"/>
              <a:gd name="connsiteY3" fmla="*/ 5129796 h 5365540"/>
              <a:gd name="connsiteX4" fmla="*/ 850106 w 9144000"/>
              <a:gd name="connsiteY4" fmla="*/ 5315532 h 5365540"/>
              <a:gd name="connsiteX5" fmla="*/ 804860 w 9144000"/>
              <a:gd name="connsiteY5" fmla="*/ 5365540 h 5365540"/>
              <a:gd name="connsiteX6" fmla="*/ 762000 w 9144000"/>
              <a:gd name="connsiteY6" fmla="*/ 5315531 h 5365540"/>
              <a:gd name="connsiteX7" fmla="*/ 669131 w 9144000"/>
              <a:gd name="connsiteY7" fmla="*/ 5129796 h 5365540"/>
              <a:gd name="connsiteX8" fmla="*/ 0 w 9144000"/>
              <a:gd name="connsiteY8" fmla="*/ 5127414 h 5365540"/>
              <a:gd name="connsiteX9" fmla="*/ 9330 w 9144000"/>
              <a:gd name="connsiteY9" fmla="*/ 0 h 5365540"/>
              <a:gd name="connsiteX0" fmla="*/ 9330 w 9144000"/>
              <a:gd name="connsiteY0" fmla="*/ 18661 h 5384201"/>
              <a:gd name="connsiteX1" fmla="*/ 9144000 w 9144000"/>
              <a:gd name="connsiteY1" fmla="*/ 0 h 5384201"/>
              <a:gd name="connsiteX2" fmla="*/ 9144000 w 9144000"/>
              <a:gd name="connsiteY2" fmla="*/ 5153219 h 5384201"/>
              <a:gd name="connsiteX3" fmla="*/ 940594 w 9144000"/>
              <a:gd name="connsiteY3" fmla="*/ 5148457 h 5384201"/>
              <a:gd name="connsiteX4" fmla="*/ 850106 w 9144000"/>
              <a:gd name="connsiteY4" fmla="*/ 5334193 h 5384201"/>
              <a:gd name="connsiteX5" fmla="*/ 804860 w 9144000"/>
              <a:gd name="connsiteY5" fmla="*/ 5384201 h 5384201"/>
              <a:gd name="connsiteX6" fmla="*/ 762000 w 9144000"/>
              <a:gd name="connsiteY6" fmla="*/ 5334192 h 5384201"/>
              <a:gd name="connsiteX7" fmla="*/ 669131 w 9144000"/>
              <a:gd name="connsiteY7" fmla="*/ 5148457 h 5384201"/>
              <a:gd name="connsiteX8" fmla="*/ 0 w 9144000"/>
              <a:gd name="connsiteY8" fmla="*/ 5146075 h 5384201"/>
              <a:gd name="connsiteX9" fmla="*/ 9330 w 9144000"/>
              <a:gd name="connsiteY9" fmla="*/ 18661 h 5384201"/>
              <a:gd name="connsiteX0" fmla="*/ 9330 w 9144000"/>
              <a:gd name="connsiteY0" fmla="*/ 18661 h 5384201"/>
              <a:gd name="connsiteX1" fmla="*/ 9144000 w 9144000"/>
              <a:gd name="connsiteY1" fmla="*/ 0 h 5384201"/>
              <a:gd name="connsiteX2" fmla="*/ 9144000 w 9144000"/>
              <a:gd name="connsiteY2" fmla="*/ 5153219 h 5384201"/>
              <a:gd name="connsiteX3" fmla="*/ 940594 w 9144000"/>
              <a:gd name="connsiteY3" fmla="*/ 5148457 h 5384201"/>
              <a:gd name="connsiteX4" fmla="*/ 850106 w 9144000"/>
              <a:gd name="connsiteY4" fmla="*/ 5334193 h 5384201"/>
              <a:gd name="connsiteX5" fmla="*/ 804860 w 9144000"/>
              <a:gd name="connsiteY5" fmla="*/ 5384201 h 5384201"/>
              <a:gd name="connsiteX6" fmla="*/ 762000 w 9144000"/>
              <a:gd name="connsiteY6" fmla="*/ 5334192 h 5384201"/>
              <a:gd name="connsiteX7" fmla="*/ 669131 w 9144000"/>
              <a:gd name="connsiteY7" fmla="*/ 5148457 h 5384201"/>
              <a:gd name="connsiteX8" fmla="*/ 0 w 9144000"/>
              <a:gd name="connsiteY8" fmla="*/ 5146075 h 5384201"/>
              <a:gd name="connsiteX9" fmla="*/ 9330 w 9144000"/>
              <a:gd name="connsiteY9" fmla="*/ 18661 h 5384201"/>
              <a:gd name="connsiteX0" fmla="*/ 9330 w 9144000"/>
              <a:gd name="connsiteY0" fmla="*/ 27992 h 5384201"/>
              <a:gd name="connsiteX1" fmla="*/ 9144000 w 9144000"/>
              <a:gd name="connsiteY1" fmla="*/ 0 h 5384201"/>
              <a:gd name="connsiteX2" fmla="*/ 9144000 w 9144000"/>
              <a:gd name="connsiteY2" fmla="*/ 5153219 h 5384201"/>
              <a:gd name="connsiteX3" fmla="*/ 940594 w 9144000"/>
              <a:gd name="connsiteY3" fmla="*/ 5148457 h 5384201"/>
              <a:gd name="connsiteX4" fmla="*/ 850106 w 9144000"/>
              <a:gd name="connsiteY4" fmla="*/ 5334193 h 5384201"/>
              <a:gd name="connsiteX5" fmla="*/ 804860 w 9144000"/>
              <a:gd name="connsiteY5" fmla="*/ 5384201 h 5384201"/>
              <a:gd name="connsiteX6" fmla="*/ 762000 w 9144000"/>
              <a:gd name="connsiteY6" fmla="*/ 5334192 h 5384201"/>
              <a:gd name="connsiteX7" fmla="*/ 669131 w 9144000"/>
              <a:gd name="connsiteY7" fmla="*/ 5148457 h 5384201"/>
              <a:gd name="connsiteX8" fmla="*/ 0 w 9144000"/>
              <a:gd name="connsiteY8" fmla="*/ 5146075 h 5384201"/>
              <a:gd name="connsiteX9" fmla="*/ 9330 w 9144000"/>
              <a:gd name="connsiteY9" fmla="*/ 27992 h 5384201"/>
              <a:gd name="connsiteX0" fmla="*/ 6949 w 9144000"/>
              <a:gd name="connsiteY0" fmla="*/ 8941 h 5384201"/>
              <a:gd name="connsiteX1" fmla="*/ 9144000 w 9144000"/>
              <a:gd name="connsiteY1" fmla="*/ 0 h 5384201"/>
              <a:gd name="connsiteX2" fmla="*/ 9144000 w 9144000"/>
              <a:gd name="connsiteY2" fmla="*/ 5153219 h 5384201"/>
              <a:gd name="connsiteX3" fmla="*/ 940594 w 9144000"/>
              <a:gd name="connsiteY3" fmla="*/ 5148457 h 5384201"/>
              <a:gd name="connsiteX4" fmla="*/ 850106 w 9144000"/>
              <a:gd name="connsiteY4" fmla="*/ 5334193 h 5384201"/>
              <a:gd name="connsiteX5" fmla="*/ 804860 w 9144000"/>
              <a:gd name="connsiteY5" fmla="*/ 5384201 h 5384201"/>
              <a:gd name="connsiteX6" fmla="*/ 762000 w 9144000"/>
              <a:gd name="connsiteY6" fmla="*/ 5334192 h 5384201"/>
              <a:gd name="connsiteX7" fmla="*/ 669131 w 9144000"/>
              <a:gd name="connsiteY7" fmla="*/ 5148457 h 5384201"/>
              <a:gd name="connsiteX8" fmla="*/ 0 w 9144000"/>
              <a:gd name="connsiteY8" fmla="*/ 5146075 h 5384201"/>
              <a:gd name="connsiteX9" fmla="*/ 6949 w 9144000"/>
              <a:gd name="connsiteY9" fmla="*/ 8941 h 5384201"/>
              <a:gd name="connsiteX0" fmla="*/ 6949 w 9144000"/>
              <a:gd name="connsiteY0" fmla="*/ 0 h 5375260"/>
              <a:gd name="connsiteX1" fmla="*/ 9144000 w 9144000"/>
              <a:gd name="connsiteY1" fmla="*/ 584 h 5375260"/>
              <a:gd name="connsiteX2" fmla="*/ 9144000 w 9144000"/>
              <a:gd name="connsiteY2" fmla="*/ 5144278 h 5375260"/>
              <a:gd name="connsiteX3" fmla="*/ 940594 w 9144000"/>
              <a:gd name="connsiteY3" fmla="*/ 5139516 h 5375260"/>
              <a:gd name="connsiteX4" fmla="*/ 850106 w 9144000"/>
              <a:gd name="connsiteY4" fmla="*/ 5325252 h 5375260"/>
              <a:gd name="connsiteX5" fmla="*/ 804860 w 9144000"/>
              <a:gd name="connsiteY5" fmla="*/ 5375260 h 5375260"/>
              <a:gd name="connsiteX6" fmla="*/ 762000 w 9144000"/>
              <a:gd name="connsiteY6" fmla="*/ 5325251 h 5375260"/>
              <a:gd name="connsiteX7" fmla="*/ 669131 w 9144000"/>
              <a:gd name="connsiteY7" fmla="*/ 5139516 h 5375260"/>
              <a:gd name="connsiteX8" fmla="*/ 0 w 9144000"/>
              <a:gd name="connsiteY8" fmla="*/ 5137134 h 5375260"/>
              <a:gd name="connsiteX9" fmla="*/ 6949 w 9144000"/>
              <a:gd name="connsiteY9" fmla="*/ 0 h 5375260"/>
              <a:gd name="connsiteX0" fmla="*/ 2186 w 9144000"/>
              <a:gd name="connsiteY0" fmla="*/ 0 h 5377641"/>
              <a:gd name="connsiteX1" fmla="*/ 9144000 w 9144000"/>
              <a:gd name="connsiteY1" fmla="*/ 2965 h 5377641"/>
              <a:gd name="connsiteX2" fmla="*/ 9144000 w 9144000"/>
              <a:gd name="connsiteY2" fmla="*/ 5146659 h 5377641"/>
              <a:gd name="connsiteX3" fmla="*/ 940594 w 9144000"/>
              <a:gd name="connsiteY3" fmla="*/ 5141897 h 5377641"/>
              <a:gd name="connsiteX4" fmla="*/ 850106 w 9144000"/>
              <a:gd name="connsiteY4" fmla="*/ 5327633 h 5377641"/>
              <a:gd name="connsiteX5" fmla="*/ 804860 w 9144000"/>
              <a:gd name="connsiteY5" fmla="*/ 5377641 h 5377641"/>
              <a:gd name="connsiteX6" fmla="*/ 762000 w 9144000"/>
              <a:gd name="connsiteY6" fmla="*/ 5327632 h 5377641"/>
              <a:gd name="connsiteX7" fmla="*/ 669131 w 9144000"/>
              <a:gd name="connsiteY7" fmla="*/ 5141897 h 5377641"/>
              <a:gd name="connsiteX8" fmla="*/ 0 w 9144000"/>
              <a:gd name="connsiteY8" fmla="*/ 5139515 h 5377641"/>
              <a:gd name="connsiteX9" fmla="*/ 2186 w 9144000"/>
              <a:gd name="connsiteY9" fmla="*/ 0 h 537764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</a:cxnLst>
            <a:rect l="l" t="t" r="r" b="b"/>
            <a:pathLst>
              <a:path w="9144000" h="5377641">
                <a:moveTo>
                  <a:pt x="2186" y="0"/>
                </a:moveTo>
                <a:lnTo>
                  <a:pt x="9144000" y="2965"/>
                </a:lnTo>
                <a:lnTo>
                  <a:pt x="9144000" y="5146659"/>
                </a:lnTo>
                <a:lnTo>
                  <a:pt x="940594" y="5141897"/>
                </a:lnTo>
                <a:cubicBezTo>
                  <a:pt x="897334" y="5226035"/>
                  <a:pt x="872728" y="5287152"/>
                  <a:pt x="850106" y="5327633"/>
                </a:cubicBezTo>
                <a:cubicBezTo>
                  <a:pt x="827484" y="5368114"/>
                  <a:pt x="819544" y="5377641"/>
                  <a:pt x="804860" y="5377641"/>
                </a:cubicBezTo>
                <a:cubicBezTo>
                  <a:pt x="790176" y="5377641"/>
                  <a:pt x="778668" y="5357001"/>
                  <a:pt x="762000" y="5327632"/>
                </a:cubicBezTo>
                <a:cubicBezTo>
                  <a:pt x="738188" y="5286357"/>
                  <a:pt x="711200" y="5232384"/>
                  <a:pt x="669131" y="5141897"/>
                </a:cubicBezTo>
                <a:lnTo>
                  <a:pt x="0" y="5139515"/>
                </a:lnTo>
                <a:cubicBezTo>
                  <a:pt x="2316" y="3427137"/>
                  <a:pt x="-130" y="1712378"/>
                  <a:pt x="2186" y="0"/>
                </a:cubicBezTo>
                <a:close/>
              </a:path>
            </a:pathLst>
          </a:custGeom>
        </p:spPr>
        <p:txBody>
          <a:bodyPr anchor="ctr" anchorCtr="0"/>
          <a:lstStyle>
            <a:lvl1pPr marL="0" indent="0" algn="ctr">
              <a:buNone/>
              <a:defRPr>
                <a:solidFill>
                  <a:schemeClr val="tx1"/>
                </a:solidFill>
              </a:defRPr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5" name="Freeform 5">
            <a:extLst>
              <a:ext uri="{FF2B5EF4-FFF2-40B4-BE49-F238E27FC236}">
                <a16:creationId xmlns:a16="http://schemas.microsoft.com/office/drawing/2014/main" id="{1945FD4D-FAD0-4D87-B186-1185BCA994B8}"/>
              </a:ext>
            </a:extLst>
          </p:cNvPr>
          <p:cNvSpPr>
            <a:spLocks noEditPoints="1"/>
          </p:cNvSpPr>
          <p:nvPr userDrawn="1"/>
        </p:nvSpPr>
        <p:spPr bwMode="auto">
          <a:xfrm>
            <a:off x="7174036" y="5810277"/>
            <a:ext cx="1510380" cy="659561"/>
          </a:xfrm>
          <a:custGeom>
            <a:avLst/>
            <a:gdLst>
              <a:gd name="T0" fmla="*/ 32 w 511"/>
              <a:gd name="T1" fmla="*/ 39 h 221"/>
              <a:gd name="T2" fmla="*/ 106 w 511"/>
              <a:gd name="T3" fmla="*/ 0 h 221"/>
              <a:gd name="T4" fmla="*/ 188 w 511"/>
              <a:gd name="T5" fmla="*/ 44 h 221"/>
              <a:gd name="T6" fmla="*/ 139 w 511"/>
              <a:gd name="T7" fmla="*/ 208 h 221"/>
              <a:gd name="T8" fmla="*/ 161 w 511"/>
              <a:gd name="T9" fmla="*/ 194 h 221"/>
              <a:gd name="T10" fmla="*/ 2 w 511"/>
              <a:gd name="T11" fmla="*/ 101 h 221"/>
              <a:gd name="T12" fmla="*/ 91 w 511"/>
              <a:gd name="T13" fmla="*/ 70 h 221"/>
              <a:gd name="T14" fmla="*/ 123 w 511"/>
              <a:gd name="T15" fmla="*/ 108 h 221"/>
              <a:gd name="T16" fmla="*/ 208 w 511"/>
              <a:gd name="T17" fmla="*/ 70 h 221"/>
              <a:gd name="T18" fmla="*/ 73 w 511"/>
              <a:gd name="T19" fmla="*/ 70 h 221"/>
              <a:gd name="T20" fmla="*/ 53 w 511"/>
              <a:gd name="T21" fmla="*/ 96 h 221"/>
              <a:gd name="T22" fmla="*/ 54 w 511"/>
              <a:gd name="T23" fmla="*/ 70 h 221"/>
              <a:gd name="T24" fmla="*/ 144 w 511"/>
              <a:gd name="T25" fmla="*/ 70 h 221"/>
              <a:gd name="T26" fmla="*/ 175 w 511"/>
              <a:gd name="T27" fmla="*/ 70 h 221"/>
              <a:gd name="T28" fmla="*/ 267 w 511"/>
              <a:gd name="T29" fmla="*/ 206 h 221"/>
              <a:gd name="T30" fmla="*/ 267 w 511"/>
              <a:gd name="T31" fmla="*/ 193 h 221"/>
              <a:gd name="T32" fmla="*/ 259 w 511"/>
              <a:gd name="T33" fmla="*/ 199 h 221"/>
              <a:gd name="T34" fmla="*/ 416 w 511"/>
              <a:gd name="T35" fmla="*/ 92 h 221"/>
              <a:gd name="T36" fmla="*/ 402 w 511"/>
              <a:gd name="T37" fmla="*/ 86 h 221"/>
              <a:gd name="T38" fmla="*/ 402 w 511"/>
              <a:gd name="T39" fmla="*/ 123 h 221"/>
              <a:gd name="T40" fmla="*/ 397 w 511"/>
              <a:gd name="T41" fmla="*/ 184 h 221"/>
              <a:gd name="T42" fmla="*/ 373 w 511"/>
              <a:gd name="T43" fmla="*/ 152 h 221"/>
              <a:gd name="T44" fmla="*/ 511 w 511"/>
              <a:gd name="T45" fmla="*/ 124 h 221"/>
              <a:gd name="T46" fmla="*/ 511 w 511"/>
              <a:gd name="T47" fmla="*/ 111 h 221"/>
              <a:gd name="T48" fmla="*/ 503 w 511"/>
              <a:gd name="T49" fmla="*/ 117 h 221"/>
              <a:gd name="T50" fmla="*/ 487 w 511"/>
              <a:gd name="T51" fmla="*/ 105 h 221"/>
              <a:gd name="T52" fmla="*/ 450 w 511"/>
              <a:gd name="T53" fmla="*/ 98 h 221"/>
              <a:gd name="T54" fmla="*/ 443 w 511"/>
              <a:gd name="T55" fmla="*/ 87 h 221"/>
              <a:gd name="T56" fmla="*/ 366 w 511"/>
              <a:gd name="T57" fmla="*/ 169 h 221"/>
              <a:gd name="T58" fmla="*/ 365 w 511"/>
              <a:gd name="T59" fmla="*/ 205 h 221"/>
              <a:gd name="T60" fmla="*/ 343 w 511"/>
              <a:gd name="T61" fmla="*/ 203 h 221"/>
              <a:gd name="T62" fmla="*/ 343 w 511"/>
              <a:gd name="T63" fmla="*/ 156 h 221"/>
              <a:gd name="T64" fmla="*/ 318 w 511"/>
              <a:gd name="T65" fmla="*/ 133 h 221"/>
              <a:gd name="T66" fmla="*/ 294 w 511"/>
              <a:gd name="T67" fmla="*/ 133 h 221"/>
              <a:gd name="T68" fmla="*/ 332 w 511"/>
              <a:gd name="T69" fmla="*/ 98 h 221"/>
              <a:gd name="T70" fmla="*/ 271 w 511"/>
              <a:gd name="T71" fmla="*/ 103 h 221"/>
              <a:gd name="T72" fmla="*/ 249 w 511"/>
              <a:gd name="T73" fmla="*/ 94 h 221"/>
              <a:gd name="T74" fmla="*/ 286 w 511"/>
              <a:gd name="T75" fmla="*/ 132 h 221"/>
              <a:gd name="T76" fmla="*/ 261 w 511"/>
              <a:gd name="T77" fmla="*/ 119 h 221"/>
              <a:gd name="T78" fmla="*/ 311 w 511"/>
              <a:gd name="T79" fmla="*/ 215 h 221"/>
              <a:gd name="T80" fmla="*/ 272 w 511"/>
              <a:gd name="T81" fmla="*/ 203 h 221"/>
              <a:gd name="T82" fmla="*/ 280 w 511"/>
              <a:gd name="T83" fmla="*/ 184 h 221"/>
              <a:gd name="T84" fmla="*/ 309 w 511"/>
              <a:gd name="T85" fmla="*/ 203 h 221"/>
              <a:gd name="T86" fmla="*/ 296 w 511"/>
              <a:gd name="T87" fmla="*/ 201 h 221"/>
              <a:gd name="T88" fmla="*/ 318 w 511"/>
              <a:gd name="T89" fmla="*/ 215 h 221"/>
              <a:gd name="T90" fmla="*/ 208 w 511"/>
              <a:gd name="T91" fmla="*/ 215 h 221"/>
              <a:gd name="T92" fmla="*/ 174 w 511"/>
              <a:gd name="T93" fmla="*/ 153 h 221"/>
              <a:gd name="T94" fmla="*/ 342 w 511"/>
              <a:gd name="T95" fmla="*/ 130 h 221"/>
              <a:gd name="T96" fmla="*/ 370 w 511"/>
              <a:gd name="T97" fmla="*/ 90 h 221"/>
              <a:gd name="T98" fmla="*/ 374 w 511"/>
              <a:gd name="T99" fmla="*/ 98 h 221"/>
              <a:gd name="T100" fmla="*/ 354 w 511"/>
              <a:gd name="T101" fmla="*/ 122 h 221"/>
              <a:gd name="T102" fmla="*/ 342 w 511"/>
              <a:gd name="T103" fmla="*/ 130 h 221"/>
              <a:gd name="T104" fmla="*/ 352 w 511"/>
              <a:gd name="T105" fmla="*/ 103 h 221"/>
              <a:gd name="T106" fmla="*/ 351 w 511"/>
              <a:gd name="T107" fmla="*/ 133 h 2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</a:cxnLst>
            <a:rect l="0" t="0" r="r" b="b"/>
            <a:pathLst>
              <a:path w="511" h="221">
                <a:moveTo>
                  <a:pt x="188" y="44"/>
                </a:moveTo>
                <a:cubicBezTo>
                  <a:pt x="188" y="44"/>
                  <a:pt x="187" y="44"/>
                  <a:pt x="186" y="43"/>
                </a:cubicBezTo>
                <a:cubicBezTo>
                  <a:pt x="185" y="42"/>
                  <a:pt x="179" y="36"/>
                  <a:pt x="169" y="30"/>
                </a:cubicBezTo>
                <a:cubicBezTo>
                  <a:pt x="159" y="24"/>
                  <a:pt x="137" y="13"/>
                  <a:pt x="107" y="13"/>
                </a:cubicBezTo>
                <a:cubicBezTo>
                  <a:pt x="71" y="13"/>
                  <a:pt x="47" y="27"/>
                  <a:pt x="32" y="39"/>
                </a:cubicBezTo>
                <a:cubicBezTo>
                  <a:pt x="18" y="51"/>
                  <a:pt x="11" y="65"/>
                  <a:pt x="11" y="66"/>
                </a:cubicBezTo>
                <a:cubicBezTo>
                  <a:pt x="11" y="66"/>
                  <a:pt x="11" y="66"/>
                  <a:pt x="10" y="66"/>
                </a:cubicBezTo>
                <a:cubicBezTo>
                  <a:pt x="10" y="66"/>
                  <a:pt x="10" y="66"/>
                  <a:pt x="10" y="66"/>
                </a:cubicBezTo>
                <a:cubicBezTo>
                  <a:pt x="11" y="65"/>
                  <a:pt x="17" y="49"/>
                  <a:pt x="30" y="35"/>
                </a:cubicBezTo>
                <a:cubicBezTo>
                  <a:pt x="43" y="20"/>
                  <a:pt x="69" y="0"/>
                  <a:pt x="106" y="0"/>
                </a:cubicBezTo>
                <a:cubicBezTo>
                  <a:pt x="142" y="0"/>
                  <a:pt x="165" y="19"/>
                  <a:pt x="173" y="26"/>
                </a:cubicBezTo>
                <a:cubicBezTo>
                  <a:pt x="180" y="33"/>
                  <a:pt x="186" y="41"/>
                  <a:pt x="187" y="42"/>
                </a:cubicBezTo>
                <a:cubicBezTo>
                  <a:pt x="188" y="43"/>
                  <a:pt x="188" y="44"/>
                  <a:pt x="188" y="44"/>
                </a:cubicBezTo>
                <a:cubicBezTo>
                  <a:pt x="188" y="44"/>
                  <a:pt x="188" y="44"/>
                  <a:pt x="188" y="44"/>
                </a:cubicBezTo>
                <a:cubicBezTo>
                  <a:pt x="188" y="44"/>
                  <a:pt x="188" y="44"/>
                  <a:pt x="188" y="44"/>
                </a:cubicBezTo>
                <a:close/>
                <a:moveTo>
                  <a:pt x="1" y="101"/>
                </a:moveTo>
                <a:cubicBezTo>
                  <a:pt x="1" y="101"/>
                  <a:pt x="1" y="101"/>
                  <a:pt x="1" y="102"/>
                </a:cubicBezTo>
                <a:cubicBezTo>
                  <a:pt x="1" y="103"/>
                  <a:pt x="0" y="117"/>
                  <a:pt x="3" y="134"/>
                </a:cubicBezTo>
                <a:cubicBezTo>
                  <a:pt x="8" y="157"/>
                  <a:pt x="22" y="186"/>
                  <a:pt x="54" y="203"/>
                </a:cubicBezTo>
                <a:cubicBezTo>
                  <a:pt x="87" y="221"/>
                  <a:pt x="120" y="216"/>
                  <a:pt x="139" y="208"/>
                </a:cubicBezTo>
                <a:cubicBezTo>
                  <a:pt x="153" y="202"/>
                  <a:pt x="157" y="198"/>
                  <a:pt x="159" y="196"/>
                </a:cubicBezTo>
                <a:cubicBezTo>
                  <a:pt x="160" y="196"/>
                  <a:pt x="161" y="195"/>
                  <a:pt x="161" y="195"/>
                </a:cubicBezTo>
                <a:cubicBezTo>
                  <a:pt x="162" y="194"/>
                  <a:pt x="162" y="194"/>
                  <a:pt x="162" y="194"/>
                </a:cubicBezTo>
                <a:cubicBezTo>
                  <a:pt x="162" y="194"/>
                  <a:pt x="162" y="194"/>
                  <a:pt x="162" y="194"/>
                </a:cubicBezTo>
                <a:cubicBezTo>
                  <a:pt x="162" y="194"/>
                  <a:pt x="162" y="194"/>
                  <a:pt x="161" y="194"/>
                </a:cubicBezTo>
                <a:cubicBezTo>
                  <a:pt x="160" y="195"/>
                  <a:pt x="146" y="201"/>
                  <a:pt x="129" y="203"/>
                </a:cubicBezTo>
                <a:cubicBezTo>
                  <a:pt x="111" y="205"/>
                  <a:pt x="87" y="204"/>
                  <a:pt x="62" y="191"/>
                </a:cubicBezTo>
                <a:cubicBezTo>
                  <a:pt x="36" y="178"/>
                  <a:pt x="19" y="158"/>
                  <a:pt x="10" y="139"/>
                </a:cubicBezTo>
                <a:cubicBezTo>
                  <a:pt x="1" y="120"/>
                  <a:pt x="2" y="103"/>
                  <a:pt x="2" y="102"/>
                </a:cubicBezTo>
                <a:cubicBezTo>
                  <a:pt x="2" y="101"/>
                  <a:pt x="2" y="101"/>
                  <a:pt x="2" y="101"/>
                </a:cubicBezTo>
                <a:cubicBezTo>
                  <a:pt x="2" y="101"/>
                  <a:pt x="2" y="101"/>
                  <a:pt x="2" y="101"/>
                </a:cubicBezTo>
                <a:cubicBezTo>
                  <a:pt x="2" y="101"/>
                  <a:pt x="1" y="101"/>
                  <a:pt x="1" y="101"/>
                </a:cubicBezTo>
                <a:close/>
                <a:moveTo>
                  <a:pt x="108" y="133"/>
                </a:moveTo>
                <a:cubicBezTo>
                  <a:pt x="108" y="108"/>
                  <a:pt x="108" y="108"/>
                  <a:pt x="108" y="108"/>
                </a:cubicBezTo>
                <a:cubicBezTo>
                  <a:pt x="91" y="70"/>
                  <a:pt x="91" y="70"/>
                  <a:pt x="91" y="70"/>
                </a:cubicBezTo>
                <a:cubicBezTo>
                  <a:pt x="105" y="70"/>
                  <a:pt x="105" y="70"/>
                  <a:pt x="105" y="70"/>
                </a:cubicBezTo>
                <a:cubicBezTo>
                  <a:pt x="116" y="95"/>
                  <a:pt x="116" y="95"/>
                  <a:pt x="116" y="95"/>
                </a:cubicBezTo>
                <a:cubicBezTo>
                  <a:pt x="127" y="70"/>
                  <a:pt x="127" y="70"/>
                  <a:pt x="127" y="70"/>
                </a:cubicBezTo>
                <a:cubicBezTo>
                  <a:pt x="140" y="70"/>
                  <a:pt x="140" y="70"/>
                  <a:pt x="140" y="70"/>
                </a:cubicBezTo>
                <a:cubicBezTo>
                  <a:pt x="123" y="108"/>
                  <a:pt x="123" y="108"/>
                  <a:pt x="123" y="108"/>
                </a:cubicBezTo>
                <a:cubicBezTo>
                  <a:pt x="123" y="133"/>
                  <a:pt x="123" y="133"/>
                  <a:pt x="123" y="133"/>
                </a:cubicBezTo>
                <a:lnTo>
                  <a:pt x="108" y="133"/>
                </a:lnTo>
                <a:close/>
                <a:moveTo>
                  <a:pt x="241" y="133"/>
                </a:moveTo>
                <a:cubicBezTo>
                  <a:pt x="208" y="133"/>
                  <a:pt x="208" y="133"/>
                  <a:pt x="208" y="133"/>
                </a:cubicBezTo>
                <a:cubicBezTo>
                  <a:pt x="208" y="70"/>
                  <a:pt x="208" y="70"/>
                  <a:pt x="208" y="70"/>
                </a:cubicBezTo>
                <a:cubicBezTo>
                  <a:pt x="222" y="70"/>
                  <a:pt x="222" y="70"/>
                  <a:pt x="222" y="70"/>
                </a:cubicBezTo>
                <a:cubicBezTo>
                  <a:pt x="222" y="121"/>
                  <a:pt x="222" y="121"/>
                  <a:pt x="222" y="121"/>
                </a:cubicBezTo>
                <a:cubicBezTo>
                  <a:pt x="241" y="121"/>
                  <a:pt x="241" y="121"/>
                  <a:pt x="241" y="121"/>
                </a:cubicBezTo>
                <a:lnTo>
                  <a:pt x="241" y="133"/>
                </a:lnTo>
                <a:close/>
                <a:moveTo>
                  <a:pt x="73" y="70"/>
                </a:moveTo>
                <a:cubicBezTo>
                  <a:pt x="86" y="70"/>
                  <a:pt x="86" y="70"/>
                  <a:pt x="86" y="70"/>
                </a:cubicBezTo>
                <a:cubicBezTo>
                  <a:pt x="86" y="133"/>
                  <a:pt x="86" y="133"/>
                  <a:pt x="86" y="133"/>
                </a:cubicBezTo>
                <a:cubicBezTo>
                  <a:pt x="73" y="133"/>
                  <a:pt x="73" y="133"/>
                  <a:pt x="73" y="133"/>
                </a:cubicBezTo>
                <a:cubicBezTo>
                  <a:pt x="73" y="133"/>
                  <a:pt x="73" y="133"/>
                  <a:pt x="73" y="133"/>
                </a:cubicBezTo>
                <a:cubicBezTo>
                  <a:pt x="73" y="131"/>
                  <a:pt x="57" y="104"/>
                  <a:pt x="53" y="96"/>
                </a:cubicBezTo>
                <a:cubicBezTo>
                  <a:pt x="53" y="133"/>
                  <a:pt x="53" y="133"/>
                  <a:pt x="53" y="133"/>
                </a:cubicBezTo>
                <a:cubicBezTo>
                  <a:pt x="40" y="133"/>
                  <a:pt x="40" y="133"/>
                  <a:pt x="40" y="133"/>
                </a:cubicBezTo>
                <a:cubicBezTo>
                  <a:pt x="40" y="70"/>
                  <a:pt x="40" y="70"/>
                  <a:pt x="40" y="70"/>
                </a:cubicBezTo>
                <a:cubicBezTo>
                  <a:pt x="54" y="70"/>
                  <a:pt x="54" y="70"/>
                  <a:pt x="54" y="70"/>
                </a:cubicBezTo>
                <a:cubicBezTo>
                  <a:pt x="54" y="70"/>
                  <a:pt x="54" y="70"/>
                  <a:pt x="54" y="70"/>
                </a:cubicBezTo>
                <a:cubicBezTo>
                  <a:pt x="55" y="71"/>
                  <a:pt x="69" y="97"/>
                  <a:pt x="73" y="106"/>
                </a:cubicBezTo>
                <a:lnTo>
                  <a:pt x="73" y="70"/>
                </a:lnTo>
                <a:close/>
                <a:moveTo>
                  <a:pt x="166" y="134"/>
                </a:moveTo>
                <a:cubicBezTo>
                  <a:pt x="152" y="134"/>
                  <a:pt x="144" y="126"/>
                  <a:pt x="144" y="111"/>
                </a:cubicBezTo>
                <a:cubicBezTo>
                  <a:pt x="144" y="70"/>
                  <a:pt x="144" y="70"/>
                  <a:pt x="144" y="70"/>
                </a:cubicBezTo>
                <a:cubicBezTo>
                  <a:pt x="158" y="70"/>
                  <a:pt x="158" y="70"/>
                  <a:pt x="158" y="70"/>
                </a:cubicBezTo>
                <a:cubicBezTo>
                  <a:pt x="158" y="110"/>
                  <a:pt x="158" y="110"/>
                  <a:pt x="158" y="110"/>
                </a:cubicBezTo>
                <a:cubicBezTo>
                  <a:pt x="158" y="119"/>
                  <a:pt x="161" y="122"/>
                  <a:pt x="167" y="122"/>
                </a:cubicBezTo>
                <a:cubicBezTo>
                  <a:pt x="172" y="122"/>
                  <a:pt x="175" y="118"/>
                  <a:pt x="175" y="110"/>
                </a:cubicBezTo>
                <a:cubicBezTo>
                  <a:pt x="175" y="70"/>
                  <a:pt x="175" y="70"/>
                  <a:pt x="175" y="70"/>
                </a:cubicBezTo>
                <a:cubicBezTo>
                  <a:pt x="188" y="70"/>
                  <a:pt x="188" y="70"/>
                  <a:pt x="188" y="70"/>
                </a:cubicBezTo>
                <a:cubicBezTo>
                  <a:pt x="188" y="111"/>
                  <a:pt x="188" y="111"/>
                  <a:pt x="188" y="111"/>
                </a:cubicBezTo>
                <a:cubicBezTo>
                  <a:pt x="188" y="126"/>
                  <a:pt x="181" y="134"/>
                  <a:pt x="166" y="134"/>
                </a:cubicBezTo>
                <a:close/>
                <a:moveTo>
                  <a:pt x="259" y="199"/>
                </a:moveTo>
                <a:cubicBezTo>
                  <a:pt x="267" y="206"/>
                  <a:pt x="267" y="206"/>
                  <a:pt x="267" y="206"/>
                </a:cubicBezTo>
                <a:cubicBezTo>
                  <a:pt x="267" y="206"/>
                  <a:pt x="267" y="206"/>
                  <a:pt x="267" y="206"/>
                </a:cubicBezTo>
                <a:cubicBezTo>
                  <a:pt x="263" y="213"/>
                  <a:pt x="257" y="216"/>
                  <a:pt x="249" y="216"/>
                </a:cubicBezTo>
                <a:cubicBezTo>
                  <a:pt x="236" y="216"/>
                  <a:pt x="229" y="207"/>
                  <a:pt x="229" y="192"/>
                </a:cubicBezTo>
                <a:cubicBezTo>
                  <a:pt x="229" y="174"/>
                  <a:pt x="239" y="168"/>
                  <a:pt x="249" y="168"/>
                </a:cubicBezTo>
                <a:cubicBezTo>
                  <a:pt x="261" y="168"/>
                  <a:pt x="267" y="177"/>
                  <a:pt x="267" y="193"/>
                </a:cubicBezTo>
                <a:cubicBezTo>
                  <a:pt x="267" y="196"/>
                  <a:pt x="267" y="196"/>
                  <a:pt x="267" y="196"/>
                </a:cubicBezTo>
                <a:cubicBezTo>
                  <a:pt x="242" y="196"/>
                  <a:pt x="242" y="196"/>
                  <a:pt x="242" y="196"/>
                </a:cubicBezTo>
                <a:cubicBezTo>
                  <a:pt x="243" y="202"/>
                  <a:pt x="245" y="205"/>
                  <a:pt x="250" y="205"/>
                </a:cubicBezTo>
                <a:cubicBezTo>
                  <a:pt x="254" y="205"/>
                  <a:pt x="257" y="202"/>
                  <a:pt x="259" y="200"/>
                </a:cubicBezTo>
                <a:lnTo>
                  <a:pt x="259" y="199"/>
                </a:lnTo>
                <a:close/>
                <a:moveTo>
                  <a:pt x="242" y="187"/>
                </a:moveTo>
                <a:cubicBezTo>
                  <a:pt x="255" y="187"/>
                  <a:pt x="255" y="187"/>
                  <a:pt x="255" y="187"/>
                </a:cubicBezTo>
                <a:cubicBezTo>
                  <a:pt x="254" y="179"/>
                  <a:pt x="250" y="179"/>
                  <a:pt x="249" y="179"/>
                </a:cubicBezTo>
                <a:cubicBezTo>
                  <a:pt x="245" y="179"/>
                  <a:pt x="243" y="182"/>
                  <a:pt x="242" y="187"/>
                </a:cubicBezTo>
                <a:close/>
                <a:moveTo>
                  <a:pt x="416" y="92"/>
                </a:moveTo>
                <a:cubicBezTo>
                  <a:pt x="420" y="96"/>
                  <a:pt x="422" y="102"/>
                  <a:pt x="422" y="110"/>
                </a:cubicBezTo>
                <a:cubicBezTo>
                  <a:pt x="422" y="128"/>
                  <a:pt x="412" y="134"/>
                  <a:pt x="402" y="134"/>
                </a:cubicBezTo>
                <a:cubicBezTo>
                  <a:pt x="392" y="134"/>
                  <a:pt x="382" y="128"/>
                  <a:pt x="382" y="110"/>
                </a:cubicBezTo>
                <a:cubicBezTo>
                  <a:pt x="382" y="102"/>
                  <a:pt x="384" y="96"/>
                  <a:pt x="388" y="92"/>
                </a:cubicBezTo>
                <a:cubicBezTo>
                  <a:pt x="392" y="88"/>
                  <a:pt x="396" y="86"/>
                  <a:pt x="402" y="86"/>
                </a:cubicBezTo>
                <a:cubicBezTo>
                  <a:pt x="408" y="86"/>
                  <a:pt x="413" y="88"/>
                  <a:pt x="416" y="92"/>
                </a:cubicBezTo>
                <a:close/>
                <a:moveTo>
                  <a:pt x="409" y="110"/>
                </a:moveTo>
                <a:cubicBezTo>
                  <a:pt x="409" y="99"/>
                  <a:pt x="405" y="97"/>
                  <a:pt x="402" y="97"/>
                </a:cubicBezTo>
                <a:cubicBezTo>
                  <a:pt x="398" y="97"/>
                  <a:pt x="396" y="101"/>
                  <a:pt x="396" y="110"/>
                </a:cubicBezTo>
                <a:cubicBezTo>
                  <a:pt x="396" y="122"/>
                  <a:pt x="399" y="123"/>
                  <a:pt x="402" y="123"/>
                </a:cubicBezTo>
                <a:cubicBezTo>
                  <a:pt x="407" y="123"/>
                  <a:pt x="409" y="119"/>
                  <a:pt x="409" y="110"/>
                </a:cubicBezTo>
                <a:close/>
                <a:moveTo>
                  <a:pt x="410" y="180"/>
                </a:moveTo>
                <a:cubicBezTo>
                  <a:pt x="410" y="215"/>
                  <a:pt x="410" y="215"/>
                  <a:pt x="410" y="215"/>
                </a:cubicBezTo>
                <a:cubicBezTo>
                  <a:pt x="397" y="215"/>
                  <a:pt x="397" y="215"/>
                  <a:pt x="397" y="215"/>
                </a:cubicBezTo>
                <a:cubicBezTo>
                  <a:pt x="397" y="184"/>
                  <a:pt x="397" y="184"/>
                  <a:pt x="397" y="184"/>
                </a:cubicBezTo>
                <a:cubicBezTo>
                  <a:pt x="397" y="180"/>
                  <a:pt x="395" y="180"/>
                  <a:pt x="393" y="180"/>
                </a:cubicBezTo>
                <a:cubicBezTo>
                  <a:pt x="391" y="180"/>
                  <a:pt x="389" y="181"/>
                  <a:pt x="386" y="183"/>
                </a:cubicBezTo>
                <a:cubicBezTo>
                  <a:pt x="386" y="215"/>
                  <a:pt x="386" y="215"/>
                  <a:pt x="386" y="215"/>
                </a:cubicBezTo>
                <a:cubicBezTo>
                  <a:pt x="373" y="215"/>
                  <a:pt x="373" y="215"/>
                  <a:pt x="373" y="215"/>
                </a:cubicBezTo>
                <a:cubicBezTo>
                  <a:pt x="373" y="152"/>
                  <a:pt x="373" y="152"/>
                  <a:pt x="373" y="152"/>
                </a:cubicBezTo>
                <a:cubicBezTo>
                  <a:pt x="386" y="150"/>
                  <a:pt x="386" y="150"/>
                  <a:pt x="386" y="150"/>
                </a:cubicBezTo>
                <a:cubicBezTo>
                  <a:pt x="386" y="174"/>
                  <a:pt x="386" y="174"/>
                  <a:pt x="386" y="174"/>
                </a:cubicBezTo>
                <a:cubicBezTo>
                  <a:pt x="389" y="171"/>
                  <a:pt x="393" y="168"/>
                  <a:pt x="399" y="168"/>
                </a:cubicBezTo>
                <a:cubicBezTo>
                  <a:pt x="406" y="168"/>
                  <a:pt x="410" y="172"/>
                  <a:pt x="410" y="180"/>
                </a:cubicBezTo>
                <a:close/>
                <a:moveTo>
                  <a:pt x="511" y="124"/>
                </a:moveTo>
                <a:cubicBezTo>
                  <a:pt x="511" y="124"/>
                  <a:pt x="511" y="124"/>
                  <a:pt x="511" y="124"/>
                </a:cubicBezTo>
                <a:cubicBezTo>
                  <a:pt x="507" y="131"/>
                  <a:pt x="501" y="134"/>
                  <a:pt x="493" y="134"/>
                </a:cubicBezTo>
                <a:cubicBezTo>
                  <a:pt x="480" y="134"/>
                  <a:pt x="473" y="125"/>
                  <a:pt x="473" y="110"/>
                </a:cubicBezTo>
                <a:cubicBezTo>
                  <a:pt x="473" y="92"/>
                  <a:pt x="484" y="86"/>
                  <a:pt x="493" y="86"/>
                </a:cubicBezTo>
                <a:cubicBezTo>
                  <a:pt x="505" y="86"/>
                  <a:pt x="511" y="95"/>
                  <a:pt x="511" y="111"/>
                </a:cubicBezTo>
                <a:cubicBezTo>
                  <a:pt x="511" y="114"/>
                  <a:pt x="511" y="114"/>
                  <a:pt x="511" y="114"/>
                </a:cubicBezTo>
                <a:cubicBezTo>
                  <a:pt x="486" y="114"/>
                  <a:pt x="486" y="114"/>
                  <a:pt x="486" y="114"/>
                </a:cubicBezTo>
                <a:cubicBezTo>
                  <a:pt x="487" y="120"/>
                  <a:pt x="489" y="123"/>
                  <a:pt x="494" y="123"/>
                </a:cubicBezTo>
                <a:cubicBezTo>
                  <a:pt x="498" y="123"/>
                  <a:pt x="501" y="120"/>
                  <a:pt x="503" y="118"/>
                </a:cubicBezTo>
                <a:cubicBezTo>
                  <a:pt x="503" y="117"/>
                  <a:pt x="503" y="117"/>
                  <a:pt x="503" y="117"/>
                </a:cubicBezTo>
                <a:lnTo>
                  <a:pt x="511" y="124"/>
                </a:lnTo>
                <a:close/>
                <a:moveTo>
                  <a:pt x="487" y="105"/>
                </a:moveTo>
                <a:cubicBezTo>
                  <a:pt x="499" y="105"/>
                  <a:pt x="499" y="105"/>
                  <a:pt x="499" y="105"/>
                </a:cubicBezTo>
                <a:cubicBezTo>
                  <a:pt x="498" y="97"/>
                  <a:pt x="494" y="97"/>
                  <a:pt x="493" y="97"/>
                </a:cubicBezTo>
                <a:cubicBezTo>
                  <a:pt x="489" y="97"/>
                  <a:pt x="487" y="100"/>
                  <a:pt x="487" y="105"/>
                </a:cubicBezTo>
                <a:close/>
                <a:moveTo>
                  <a:pt x="467" y="98"/>
                </a:moveTo>
                <a:cubicBezTo>
                  <a:pt x="467" y="133"/>
                  <a:pt x="467" y="133"/>
                  <a:pt x="467" y="133"/>
                </a:cubicBezTo>
                <a:cubicBezTo>
                  <a:pt x="453" y="133"/>
                  <a:pt x="453" y="133"/>
                  <a:pt x="453" y="133"/>
                </a:cubicBezTo>
                <a:cubicBezTo>
                  <a:pt x="453" y="102"/>
                  <a:pt x="453" y="102"/>
                  <a:pt x="453" y="102"/>
                </a:cubicBezTo>
                <a:cubicBezTo>
                  <a:pt x="453" y="98"/>
                  <a:pt x="452" y="98"/>
                  <a:pt x="450" y="98"/>
                </a:cubicBezTo>
                <a:cubicBezTo>
                  <a:pt x="448" y="98"/>
                  <a:pt x="445" y="99"/>
                  <a:pt x="443" y="102"/>
                </a:cubicBezTo>
                <a:cubicBezTo>
                  <a:pt x="443" y="133"/>
                  <a:pt x="443" y="133"/>
                  <a:pt x="443" y="133"/>
                </a:cubicBezTo>
                <a:cubicBezTo>
                  <a:pt x="429" y="133"/>
                  <a:pt x="429" y="133"/>
                  <a:pt x="429" y="133"/>
                </a:cubicBezTo>
                <a:cubicBezTo>
                  <a:pt x="429" y="87"/>
                  <a:pt x="429" y="87"/>
                  <a:pt x="429" y="87"/>
                </a:cubicBezTo>
                <a:cubicBezTo>
                  <a:pt x="443" y="87"/>
                  <a:pt x="443" y="87"/>
                  <a:pt x="443" y="87"/>
                </a:cubicBezTo>
                <a:cubicBezTo>
                  <a:pt x="443" y="92"/>
                  <a:pt x="443" y="92"/>
                  <a:pt x="443" y="92"/>
                </a:cubicBezTo>
                <a:cubicBezTo>
                  <a:pt x="445" y="89"/>
                  <a:pt x="450" y="86"/>
                  <a:pt x="455" y="86"/>
                </a:cubicBezTo>
                <a:cubicBezTo>
                  <a:pt x="463" y="86"/>
                  <a:pt x="467" y="90"/>
                  <a:pt x="467" y="98"/>
                </a:cubicBezTo>
                <a:close/>
                <a:moveTo>
                  <a:pt x="357" y="169"/>
                </a:moveTo>
                <a:cubicBezTo>
                  <a:pt x="366" y="169"/>
                  <a:pt x="366" y="169"/>
                  <a:pt x="366" y="169"/>
                </a:cubicBezTo>
                <a:cubicBezTo>
                  <a:pt x="366" y="179"/>
                  <a:pt x="366" y="179"/>
                  <a:pt x="366" y="179"/>
                </a:cubicBezTo>
                <a:cubicBezTo>
                  <a:pt x="357" y="179"/>
                  <a:pt x="357" y="179"/>
                  <a:pt x="357" y="179"/>
                </a:cubicBezTo>
                <a:cubicBezTo>
                  <a:pt x="357" y="200"/>
                  <a:pt x="357" y="200"/>
                  <a:pt x="357" y="200"/>
                </a:cubicBezTo>
                <a:cubicBezTo>
                  <a:pt x="357" y="204"/>
                  <a:pt x="358" y="205"/>
                  <a:pt x="361" y="205"/>
                </a:cubicBezTo>
                <a:cubicBezTo>
                  <a:pt x="363" y="205"/>
                  <a:pt x="364" y="205"/>
                  <a:pt x="365" y="205"/>
                </a:cubicBezTo>
                <a:cubicBezTo>
                  <a:pt x="366" y="204"/>
                  <a:pt x="366" y="204"/>
                  <a:pt x="366" y="204"/>
                </a:cubicBezTo>
                <a:cubicBezTo>
                  <a:pt x="366" y="215"/>
                  <a:pt x="366" y="215"/>
                  <a:pt x="366" y="215"/>
                </a:cubicBezTo>
                <a:cubicBezTo>
                  <a:pt x="365" y="215"/>
                  <a:pt x="365" y="215"/>
                  <a:pt x="365" y="215"/>
                </a:cubicBezTo>
                <a:cubicBezTo>
                  <a:pt x="364" y="215"/>
                  <a:pt x="360" y="215"/>
                  <a:pt x="357" y="215"/>
                </a:cubicBezTo>
                <a:cubicBezTo>
                  <a:pt x="347" y="215"/>
                  <a:pt x="343" y="212"/>
                  <a:pt x="343" y="203"/>
                </a:cubicBezTo>
                <a:cubicBezTo>
                  <a:pt x="343" y="179"/>
                  <a:pt x="343" y="179"/>
                  <a:pt x="343" y="179"/>
                </a:cubicBezTo>
                <a:cubicBezTo>
                  <a:pt x="337" y="179"/>
                  <a:pt x="337" y="179"/>
                  <a:pt x="337" y="179"/>
                </a:cubicBezTo>
                <a:cubicBezTo>
                  <a:pt x="337" y="169"/>
                  <a:pt x="337" y="169"/>
                  <a:pt x="337" y="169"/>
                </a:cubicBezTo>
                <a:cubicBezTo>
                  <a:pt x="343" y="169"/>
                  <a:pt x="343" y="169"/>
                  <a:pt x="343" y="169"/>
                </a:cubicBezTo>
                <a:cubicBezTo>
                  <a:pt x="343" y="156"/>
                  <a:pt x="343" y="156"/>
                  <a:pt x="343" y="156"/>
                </a:cubicBezTo>
                <a:cubicBezTo>
                  <a:pt x="357" y="154"/>
                  <a:pt x="357" y="154"/>
                  <a:pt x="357" y="154"/>
                </a:cubicBezTo>
                <a:lnTo>
                  <a:pt x="357" y="169"/>
                </a:lnTo>
                <a:close/>
                <a:moveTo>
                  <a:pt x="332" y="98"/>
                </a:moveTo>
                <a:cubicBezTo>
                  <a:pt x="332" y="133"/>
                  <a:pt x="332" y="133"/>
                  <a:pt x="332" y="133"/>
                </a:cubicBezTo>
                <a:cubicBezTo>
                  <a:pt x="318" y="133"/>
                  <a:pt x="318" y="133"/>
                  <a:pt x="318" y="133"/>
                </a:cubicBezTo>
                <a:cubicBezTo>
                  <a:pt x="318" y="102"/>
                  <a:pt x="318" y="102"/>
                  <a:pt x="318" y="102"/>
                </a:cubicBezTo>
                <a:cubicBezTo>
                  <a:pt x="318" y="98"/>
                  <a:pt x="316" y="98"/>
                  <a:pt x="315" y="98"/>
                </a:cubicBezTo>
                <a:cubicBezTo>
                  <a:pt x="313" y="98"/>
                  <a:pt x="310" y="99"/>
                  <a:pt x="307" y="102"/>
                </a:cubicBezTo>
                <a:cubicBezTo>
                  <a:pt x="307" y="133"/>
                  <a:pt x="307" y="133"/>
                  <a:pt x="307" y="133"/>
                </a:cubicBezTo>
                <a:cubicBezTo>
                  <a:pt x="294" y="133"/>
                  <a:pt x="294" y="133"/>
                  <a:pt x="294" y="133"/>
                </a:cubicBezTo>
                <a:cubicBezTo>
                  <a:pt x="294" y="87"/>
                  <a:pt x="294" y="87"/>
                  <a:pt x="294" y="87"/>
                </a:cubicBezTo>
                <a:cubicBezTo>
                  <a:pt x="307" y="87"/>
                  <a:pt x="307" y="87"/>
                  <a:pt x="307" y="87"/>
                </a:cubicBezTo>
                <a:cubicBezTo>
                  <a:pt x="307" y="92"/>
                  <a:pt x="307" y="92"/>
                  <a:pt x="307" y="92"/>
                </a:cubicBezTo>
                <a:cubicBezTo>
                  <a:pt x="310" y="89"/>
                  <a:pt x="315" y="86"/>
                  <a:pt x="320" y="86"/>
                </a:cubicBezTo>
                <a:cubicBezTo>
                  <a:pt x="328" y="86"/>
                  <a:pt x="332" y="90"/>
                  <a:pt x="332" y="98"/>
                </a:cubicBezTo>
                <a:close/>
                <a:moveTo>
                  <a:pt x="272" y="132"/>
                </a:moveTo>
                <a:cubicBezTo>
                  <a:pt x="272" y="131"/>
                  <a:pt x="271" y="130"/>
                  <a:pt x="271" y="128"/>
                </a:cubicBezTo>
                <a:cubicBezTo>
                  <a:pt x="268" y="132"/>
                  <a:pt x="264" y="133"/>
                  <a:pt x="259" y="133"/>
                </a:cubicBezTo>
                <a:cubicBezTo>
                  <a:pt x="251" y="133"/>
                  <a:pt x="247" y="129"/>
                  <a:pt x="247" y="121"/>
                </a:cubicBezTo>
                <a:cubicBezTo>
                  <a:pt x="247" y="112"/>
                  <a:pt x="255" y="106"/>
                  <a:pt x="271" y="103"/>
                </a:cubicBezTo>
                <a:cubicBezTo>
                  <a:pt x="271" y="102"/>
                  <a:pt x="271" y="102"/>
                  <a:pt x="271" y="102"/>
                </a:cubicBezTo>
                <a:cubicBezTo>
                  <a:pt x="271" y="98"/>
                  <a:pt x="270" y="97"/>
                  <a:pt x="267" y="97"/>
                </a:cubicBezTo>
                <a:cubicBezTo>
                  <a:pt x="263" y="97"/>
                  <a:pt x="258" y="100"/>
                  <a:pt x="256" y="102"/>
                </a:cubicBezTo>
                <a:cubicBezTo>
                  <a:pt x="255" y="102"/>
                  <a:pt x="255" y="102"/>
                  <a:pt x="255" y="102"/>
                </a:cubicBezTo>
                <a:cubicBezTo>
                  <a:pt x="249" y="94"/>
                  <a:pt x="249" y="94"/>
                  <a:pt x="249" y="94"/>
                </a:cubicBezTo>
                <a:cubicBezTo>
                  <a:pt x="249" y="93"/>
                  <a:pt x="249" y="93"/>
                  <a:pt x="249" y="93"/>
                </a:cubicBezTo>
                <a:cubicBezTo>
                  <a:pt x="255" y="89"/>
                  <a:pt x="262" y="86"/>
                  <a:pt x="270" y="86"/>
                </a:cubicBezTo>
                <a:cubicBezTo>
                  <a:pt x="280" y="86"/>
                  <a:pt x="285" y="91"/>
                  <a:pt x="285" y="102"/>
                </a:cubicBezTo>
                <a:cubicBezTo>
                  <a:pt x="285" y="121"/>
                  <a:pt x="285" y="121"/>
                  <a:pt x="285" y="121"/>
                </a:cubicBezTo>
                <a:cubicBezTo>
                  <a:pt x="285" y="127"/>
                  <a:pt x="285" y="130"/>
                  <a:pt x="286" y="132"/>
                </a:cubicBezTo>
                <a:cubicBezTo>
                  <a:pt x="286" y="133"/>
                  <a:pt x="286" y="133"/>
                  <a:pt x="286" y="133"/>
                </a:cubicBezTo>
                <a:cubicBezTo>
                  <a:pt x="272" y="133"/>
                  <a:pt x="272" y="133"/>
                  <a:pt x="272" y="133"/>
                </a:cubicBezTo>
                <a:lnTo>
                  <a:pt x="272" y="132"/>
                </a:lnTo>
                <a:close/>
                <a:moveTo>
                  <a:pt x="271" y="111"/>
                </a:moveTo>
                <a:cubicBezTo>
                  <a:pt x="262" y="113"/>
                  <a:pt x="261" y="116"/>
                  <a:pt x="261" y="119"/>
                </a:cubicBezTo>
                <a:cubicBezTo>
                  <a:pt x="261" y="121"/>
                  <a:pt x="262" y="123"/>
                  <a:pt x="264" y="123"/>
                </a:cubicBezTo>
                <a:cubicBezTo>
                  <a:pt x="267" y="123"/>
                  <a:pt x="269" y="122"/>
                  <a:pt x="271" y="120"/>
                </a:cubicBezTo>
                <a:lnTo>
                  <a:pt x="271" y="111"/>
                </a:lnTo>
                <a:close/>
                <a:moveTo>
                  <a:pt x="310" y="214"/>
                </a:moveTo>
                <a:cubicBezTo>
                  <a:pt x="311" y="215"/>
                  <a:pt x="311" y="215"/>
                  <a:pt x="311" y="215"/>
                </a:cubicBezTo>
                <a:cubicBezTo>
                  <a:pt x="297" y="215"/>
                  <a:pt x="297" y="215"/>
                  <a:pt x="297" y="215"/>
                </a:cubicBezTo>
                <a:cubicBezTo>
                  <a:pt x="297" y="214"/>
                  <a:pt x="297" y="214"/>
                  <a:pt x="297" y="214"/>
                </a:cubicBezTo>
                <a:cubicBezTo>
                  <a:pt x="296" y="213"/>
                  <a:pt x="296" y="212"/>
                  <a:pt x="296" y="210"/>
                </a:cubicBezTo>
                <a:cubicBezTo>
                  <a:pt x="293" y="214"/>
                  <a:pt x="289" y="215"/>
                  <a:pt x="283" y="215"/>
                </a:cubicBezTo>
                <a:cubicBezTo>
                  <a:pt x="276" y="215"/>
                  <a:pt x="272" y="211"/>
                  <a:pt x="272" y="203"/>
                </a:cubicBezTo>
                <a:cubicBezTo>
                  <a:pt x="272" y="194"/>
                  <a:pt x="280" y="188"/>
                  <a:pt x="296" y="185"/>
                </a:cubicBezTo>
                <a:cubicBezTo>
                  <a:pt x="296" y="183"/>
                  <a:pt x="296" y="183"/>
                  <a:pt x="296" y="183"/>
                </a:cubicBezTo>
                <a:cubicBezTo>
                  <a:pt x="296" y="180"/>
                  <a:pt x="295" y="179"/>
                  <a:pt x="292" y="179"/>
                </a:cubicBezTo>
                <a:cubicBezTo>
                  <a:pt x="287" y="179"/>
                  <a:pt x="283" y="182"/>
                  <a:pt x="280" y="184"/>
                </a:cubicBezTo>
                <a:cubicBezTo>
                  <a:pt x="280" y="184"/>
                  <a:pt x="280" y="184"/>
                  <a:pt x="280" y="184"/>
                </a:cubicBezTo>
                <a:cubicBezTo>
                  <a:pt x="273" y="176"/>
                  <a:pt x="273" y="176"/>
                  <a:pt x="273" y="176"/>
                </a:cubicBezTo>
                <a:cubicBezTo>
                  <a:pt x="274" y="175"/>
                  <a:pt x="274" y="175"/>
                  <a:pt x="274" y="175"/>
                </a:cubicBezTo>
                <a:cubicBezTo>
                  <a:pt x="279" y="171"/>
                  <a:pt x="286" y="168"/>
                  <a:pt x="294" y="168"/>
                </a:cubicBezTo>
                <a:cubicBezTo>
                  <a:pt x="305" y="168"/>
                  <a:pt x="309" y="173"/>
                  <a:pt x="309" y="183"/>
                </a:cubicBezTo>
                <a:cubicBezTo>
                  <a:pt x="309" y="203"/>
                  <a:pt x="309" y="203"/>
                  <a:pt x="309" y="203"/>
                </a:cubicBezTo>
                <a:cubicBezTo>
                  <a:pt x="309" y="209"/>
                  <a:pt x="310" y="212"/>
                  <a:pt x="310" y="214"/>
                </a:cubicBezTo>
                <a:close/>
                <a:moveTo>
                  <a:pt x="296" y="193"/>
                </a:moveTo>
                <a:cubicBezTo>
                  <a:pt x="286" y="195"/>
                  <a:pt x="285" y="198"/>
                  <a:pt x="285" y="201"/>
                </a:cubicBezTo>
                <a:cubicBezTo>
                  <a:pt x="285" y="203"/>
                  <a:pt x="286" y="205"/>
                  <a:pt x="289" y="205"/>
                </a:cubicBezTo>
                <a:cubicBezTo>
                  <a:pt x="291" y="205"/>
                  <a:pt x="294" y="204"/>
                  <a:pt x="296" y="201"/>
                </a:cubicBezTo>
                <a:lnTo>
                  <a:pt x="296" y="193"/>
                </a:lnTo>
                <a:close/>
                <a:moveTo>
                  <a:pt x="318" y="159"/>
                </a:moveTo>
                <a:cubicBezTo>
                  <a:pt x="332" y="157"/>
                  <a:pt x="332" y="157"/>
                  <a:pt x="332" y="157"/>
                </a:cubicBezTo>
                <a:cubicBezTo>
                  <a:pt x="332" y="215"/>
                  <a:pt x="332" y="215"/>
                  <a:pt x="332" y="215"/>
                </a:cubicBezTo>
                <a:cubicBezTo>
                  <a:pt x="318" y="215"/>
                  <a:pt x="318" y="215"/>
                  <a:pt x="318" y="215"/>
                </a:cubicBezTo>
                <a:lnTo>
                  <a:pt x="318" y="159"/>
                </a:lnTo>
                <a:close/>
                <a:moveTo>
                  <a:pt x="208" y="153"/>
                </a:moveTo>
                <a:cubicBezTo>
                  <a:pt x="222" y="153"/>
                  <a:pt x="222" y="153"/>
                  <a:pt x="222" y="153"/>
                </a:cubicBezTo>
                <a:cubicBezTo>
                  <a:pt x="222" y="215"/>
                  <a:pt x="222" y="215"/>
                  <a:pt x="222" y="215"/>
                </a:cubicBezTo>
                <a:cubicBezTo>
                  <a:pt x="208" y="215"/>
                  <a:pt x="208" y="215"/>
                  <a:pt x="208" y="215"/>
                </a:cubicBezTo>
                <a:cubicBezTo>
                  <a:pt x="208" y="188"/>
                  <a:pt x="208" y="188"/>
                  <a:pt x="208" y="188"/>
                </a:cubicBezTo>
                <a:cubicBezTo>
                  <a:pt x="188" y="188"/>
                  <a:pt x="188" y="188"/>
                  <a:pt x="188" y="188"/>
                </a:cubicBezTo>
                <a:cubicBezTo>
                  <a:pt x="188" y="215"/>
                  <a:pt x="188" y="215"/>
                  <a:pt x="188" y="215"/>
                </a:cubicBezTo>
                <a:cubicBezTo>
                  <a:pt x="174" y="215"/>
                  <a:pt x="174" y="215"/>
                  <a:pt x="174" y="215"/>
                </a:cubicBezTo>
                <a:cubicBezTo>
                  <a:pt x="174" y="153"/>
                  <a:pt x="174" y="153"/>
                  <a:pt x="174" y="153"/>
                </a:cubicBezTo>
                <a:cubicBezTo>
                  <a:pt x="188" y="153"/>
                  <a:pt x="188" y="153"/>
                  <a:pt x="188" y="153"/>
                </a:cubicBezTo>
                <a:cubicBezTo>
                  <a:pt x="188" y="176"/>
                  <a:pt x="188" y="176"/>
                  <a:pt x="188" y="176"/>
                </a:cubicBezTo>
                <a:cubicBezTo>
                  <a:pt x="208" y="176"/>
                  <a:pt x="208" y="176"/>
                  <a:pt x="208" y="176"/>
                </a:cubicBezTo>
                <a:lnTo>
                  <a:pt x="208" y="153"/>
                </a:lnTo>
                <a:close/>
                <a:moveTo>
                  <a:pt x="342" y="130"/>
                </a:moveTo>
                <a:cubicBezTo>
                  <a:pt x="340" y="129"/>
                  <a:pt x="339" y="127"/>
                  <a:pt x="339" y="124"/>
                </a:cubicBezTo>
                <a:cubicBezTo>
                  <a:pt x="339" y="122"/>
                  <a:pt x="341" y="118"/>
                  <a:pt x="345" y="116"/>
                </a:cubicBezTo>
                <a:cubicBezTo>
                  <a:pt x="341" y="113"/>
                  <a:pt x="339" y="108"/>
                  <a:pt x="339" y="103"/>
                </a:cubicBezTo>
                <a:cubicBezTo>
                  <a:pt x="339" y="93"/>
                  <a:pt x="346" y="86"/>
                  <a:pt x="357" y="86"/>
                </a:cubicBezTo>
                <a:cubicBezTo>
                  <a:pt x="362" y="86"/>
                  <a:pt x="367" y="88"/>
                  <a:pt x="370" y="90"/>
                </a:cubicBezTo>
                <a:cubicBezTo>
                  <a:pt x="372" y="88"/>
                  <a:pt x="376" y="86"/>
                  <a:pt x="379" y="86"/>
                </a:cubicBezTo>
                <a:cubicBezTo>
                  <a:pt x="380" y="86"/>
                  <a:pt x="380" y="86"/>
                  <a:pt x="380" y="86"/>
                </a:cubicBezTo>
                <a:cubicBezTo>
                  <a:pt x="380" y="98"/>
                  <a:pt x="380" y="98"/>
                  <a:pt x="380" y="98"/>
                </a:cubicBezTo>
                <a:cubicBezTo>
                  <a:pt x="379" y="98"/>
                  <a:pt x="379" y="98"/>
                  <a:pt x="379" y="98"/>
                </a:cubicBezTo>
                <a:cubicBezTo>
                  <a:pt x="378" y="98"/>
                  <a:pt x="376" y="98"/>
                  <a:pt x="374" y="98"/>
                </a:cubicBezTo>
                <a:cubicBezTo>
                  <a:pt x="375" y="100"/>
                  <a:pt x="375" y="101"/>
                  <a:pt x="375" y="103"/>
                </a:cubicBezTo>
                <a:cubicBezTo>
                  <a:pt x="375" y="113"/>
                  <a:pt x="368" y="120"/>
                  <a:pt x="357" y="120"/>
                </a:cubicBezTo>
                <a:cubicBezTo>
                  <a:pt x="355" y="120"/>
                  <a:pt x="353" y="119"/>
                  <a:pt x="351" y="119"/>
                </a:cubicBezTo>
                <a:cubicBezTo>
                  <a:pt x="351" y="120"/>
                  <a:pt x="351" y="120"/>
                  <a:pt x="351" y="120"/>
                </a:cubicBezTo>
                <a:cubicBezTo>
                  <a:pt x="351" y="121"/>
                  <a:pt x="351" y="122"/>
                  <a:pt x="354" y="122"/>
                </a:cubicBezTo>
                <a:cubicBezTo>
                  <a:pt x="360" y="123"/>
                  <a:pt x="360" y="123"/>
                  <a:pt x="360" y="123"/>
                </a:cubicBezTo>
                <a:cubicBezTo>
                  <a:pt x="374" y="124"/>
                  <a:pt x="379" y="127"/>
                  <a:pt x="379" y="135"/>
                </a:cubicBezTo>
                <a:cubicBezTo>
                  <a:pt x="379" y="144"/>
                  <a:pt x="370" y="149"/>
                  <a:pt x="356" y="149"/>
                </a:cubicBezTo>
                <a:cubicBezTo>
                  <a:pt x="342" y="149"/>
                  <a:pt x="336" y="146"/>
                  <a:pt x="336" y="139"/>
                </a:cubicBezTo>
                <a:cubicBezTo>
                  <a:pt x="336" y="135"/>
                  <a:pt x="338" y="132"/>
                  <a:pt x="342" y="130"/>
                </a:cubicBezTo>
                <a:close/>
                <a:moveTo>
                  <a:pt x="352" y="103"/>
                </a:moveTo>
                <a:cubicBezTo>
                  <a:pt x="352" y="106"/>
                  <a:pt x="352" y="111"/>
                  <a:pt x="357" y="111"/>
                </a:cubicBezTo>
                <a:cubicBezTo>
                  <a:pt x="360" y="111"/>
                  <a:pt x="362" y="108"/>
                  <a:pt x="362" y="103"/>
                </a:cubicBezTo>
                <a:cubicBezTo>
                  <a:pt x="362" y="100"/>
                  <a:pt x="361" y="96"/>
                  <a:pt x="357" y="96"/>
                </a:cubicBezTo>
                <a:cubicBezTo>
                  <a:pt x="352" y="96"/>
                  <a:pt x="352" y="101"/>
                  <a:pt x="352" y="103"/>
                </a:cubicBezTo>
                <a:close/>
                <a:moveTo>
                  <a:pt x="348" y="137"/>
                </a:moveTo>
                <a:cubicBezTo>
                  <a:pt x="348" y="140"/>
                  <a:pt x="350" y="142"/>
                  <a:pt x="357" y="142"/>
                </a:cubicBezTo>
                <a:cubicBezTo>
                  <a:pt x="363" y="142"/>
                  <a:pt x="366" y="140"/>
                  <a:pt x="366" y="137"/>
                </a:cubicBezTo>
                <a:cubicBezTo>
                  <a:pt x="366" y="135"/>
                  <a:pt x="366" y="134"/>
                  <a:pt x="358" y="134"/>
                </a:cubicBezTo>
                <a:cubicBezTo>
                  <a:pt x="351" y="133"/>
                  <a:pt x="351" y="133"/>
                  <a:pt x="351" y="133"/>
                </a:cubicBezTo>
                <a:cubicBezTo>
                  <a:pt x="351" y="133"/>
                  <a:pt x="350" y="133"/>
                  <a:pt x="350" y="133"/>
                </a:cubicBezTo>
                <a:cubicBezTo>
                  <a:pt x="349" y="134"/>
                  <a:pt x="348" y="136"/>
                  <a:pt x="348" y="137"/>
                </a:cubicBezTo>
                <a:close/>
              </a:path>
            </a:pathLst>
          </a:custGeom>
          <a:solidFill>
            <a:schemeClr val="tx2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2251753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Section Header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8024" y="2277432"/>
            <a:ext cx="8014059" cy="4088141"/>
          </a:xfrm>
        </p:spPr>
        <p:txBody>
          <a:bodyPr anchor="b" anchorCtr="0">
            <a:noAutofit/>
          </a:bodyPr>
          <a:lstStyle>
            <a:lvl1pPr algn="l">
              <a:defRPr sz="6400" b="1" cap="all">
                <a:solidFill>
                  <a:schemeClr val="tx2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4" name="Freeform 5"/>
          <p:cNvSpPr>
            <a:spLocks noEditPoints="1"/>
          </p:cNvSpPr>
          <p:nvPr userDrawn="1"/>
        </p:nvSpPr>
        <p:spPr bwMode="auto">
          <a:xfrm>
            <a:off x="7919867" y="6350476"/>
            <a:ext cx="766764" cy="334835"/>
          </a:xfrm>
          <a:custGeom>
            <a:avLst/>
            <a:gdLst>
              <a:gd name="T0" fmla="*/ 32 w 511"/>
              <a:gd name="T1" fmla="*/ 39 h 221"/>
              <a:gd name="T2" fmla="*/ 106 w 511"/>
              <a:gd name="T3" fmla="*/ 0 h 221"/>
              <a:gd name="T4" fmla="*/ 188 w 511"/>
              <a:gd name="T5" fmla="*/ 44 h 221"/>
              <a:gd name="T6" fmla="*/ 139 w 511"/>
              <a:gd name="T7" fmla="*/ 208 h 221"/>
              <a:gd name="T8" fmla="*/ 161 w 511"/>
              <a:gd name="T9" fmla="*/ 194 h 221"/>
              <a:gd name="T10" fmla="*/ 2 w 511"/>
              <a:gd name="T11" fmla="*/ 101 h 221"/>
              <a:gd name="T12" fmla="*/ 91 w 511"/>
              <a:gd name="T13" fmla="*/ 70 h 221"/>
              <a:gd name="T14" fmla="*/ 123 w 511"/>
              <a:gd name="T15" fmla="*/ 108 h 221"/>
              <a:gd name="T16" fmla="*/ 208 w 511"/>
              <a:gd name="T17" fmla="*/ 70 h 221"/>
              <a:gd name="T18" fmla="*/ 73 w 511"/>
              <a:gd name="T19" fmla="*/ 70 h 221"/>
              <a:gd name="T20" fmla="*/ 53 w 511"/>
              <a:gd name="T21" fmla="*/ 96 h 221"/>
              <a:gd name="T22" fmla="*/ 54 w 511"/>
              <a:gd name="T23" fmla="*/ 70 h 221"/>
              <a:gd name="T24" fmla="*/ 144 w 511"/>
              <a:gd name="T25" fmla="*/ 70 h 221"/>
              <a:gd name="T26" fmla="*/ 175 w 511"/>
              <a:gd name="T27" fmla="*/ 70 h 221"/>
              <a:gd name="T28" fmla="*/ 267 w 511"/>
              <a:gd name="T29" fmla="*/ 206 h 221"/>
              <a:gd name="T30" fmla="*/ 267 w 511"/>
              <a:gd name="T31" fmla="*/ 193 h 221"/>
              <a:gd name="T32" fmla="*/ 259 w 511"/>
              <a:gd name="T33" fmla="*/ 199 h 221"/>
              <a:gd name="T34" fmla="*/ 416 w 511"/>
              <a:gd name="T35" fmla="*/ 92 h 221"/>
              <a:gd name="T36" fmla="*/ 402 w 511"/>
              <a:gd name="T37" fmla="*/ 86 h 221"/>
              <a:gd name="T38" fmla="*/ 402 w 511"/>
              <a:gd name="T39" fmla="*/ 123 h 221"/>
              <a:gd name="T40" fmla="*/ 397 w 511"/>
              <a:gd name="T41" fmla="*/ 184 h 221"/>
              <a:gd name="T42" fmla="*/ 373 w 511"/>
              <a:gd name="T43" fmla="*/ 152 h 221"/>
              <a:gd name="T44" fmla="*/ 511 w 511"/>
              <a:gd name="T45" fmla="*/ 124 h 221"/>
              <a:gd name="T46" fmla="*/ 511 w 511"/>
              <a:gd name="T47" fmla="*/ 111 h 221"/>
              <a:gd name="T48" fmla="*/ 503 w 511"/>
              <a:gd name="T49" fmla="*/ 117 h 221"/>
              <a:gd name="T50" fmla="*/ 487 w 511"/>
              <a:gd name="T51" fmla="*/ 105 h 221"/>
              <a:gd name="T52" fmla="*/ 450 w 511"/>
              <a:gd name="T53" fmla="*/ 98 h 221"/>
              <a:gd name="T54" fmla="*/ 443 w 511"/>
              <a:gd name="T55" fmla="*/ 87 h 221"/>
              <a:gd name="T56" fmla="*/ 366 w 511"/>
              <a:gd name="T57" fmla="*/ 169 h 221"/>
              <a:gd name="T58" fmla="*/ 365 w 511"/>
              <a:gd name="T59" fmla="*/ 205 h 221"/>
              <a:gd name="T60" fmla="*/ 343 w 511"/>
              <a:gd name="T61" fmla="*/ 203 h 221"/>
              <a:gd name="T62" fmla="*/ 343 w 511"/>
              <a:gd name="T63" fmla="*/ 156 h 221"/>
              <a:gd name="T64" fmla="*/ 318 w 511"/>
              <a:gd name="T65" fmla="*/ 133 h 221"/>
              <a:gd name="T66" fmla="*/ 294 w 511"/>
              <a:gd name="T67" fmla="*/ 133 h 221"/>
              <a:gd name="T68" fmla="*/ 332 w 511"/>
              <a:gd name="T69" fmla="*/ 98 h 221"/>
              <a:gd name="T70" fmla="*/ 271 w 511"/>
              <a:gd name="T71" fmla="*/ 103 h 221"/>
              <a:gd name="T72" fmla="*/ 249 w 511"/>
              <a:gd name="T73" fmla="*/ 94 h 221"/>
              <a:gd name="T74" fmla="*/ 286 w 511"/>
              <a:gd name="T75" fmla="*/ 132 h 221"/>
              <a:gd name="T76" fmla="*/ 261 w 511"/>
              <a:gd name="T77" fmla="*/ 119 h 221"/>
              <a:gd name="T78" fmla="*/ 311 w 511"/>
              <a:gd name="T79" fmla="*/ 215 h 221"/>
              <a:gd name="T80" fmla="*/ 272 w 511"/>
              <a:gd name="T81" fmla="*/ 203 h 221"/>
              <a:gd name="T82" fmla="*/ 280 w 511"/>
              <a:gd name="T83" fmla="*/ 184 h 221"/>
              <a:gd name="T84" fmla="*/ 309 w 511"/>
              <a:gd name="T85" fmla="*/ 203 h 221"/>
              <a:gd name="T86" fmla="*/ 296 w 511"/>
              <a:gd name="T87" fmla="*/ 201 h 221"/>
              <a:gd name="T88" fmla="*/ 318 w 511"/>
              <a:gd name="T89" fmla="*/ 215 h 221"/>
              <a:gd name="T90" fmla="*/ 208 w 511"/>
              <a:gd name="T91" fmla="*/ 215 h 221"/>
              <a:gd name="T92" fmla="*/ 174 w 511"/>
              <a:gd name="T93" fmla="*/ 153 h 221"/>
              <a:gd name="T94" fmla="*/ 342 w 511"/>
              <a:gd name="T95" fmla="*/ 130 h 221"/>
              <a:gd name="T96" fmla="*/ 370 w 511"/>
              <a:gd name="T97" fmla="*/ 90 h 221"/>
              <a:gd name="T98" fmla="*/ 374 w 511"/>
              <a:gd name="T99" fmla="*/ 98 h 221"/>
              <a:gd name="T100" fmla="*/ 354 w 511"/>
              <a:gd name="T101" fmla="*/ 122 h 221"/>
              <a:gd name="T102" fmla="*/ 342 w 511"/>
              <a:gd name="T103" fmla="*/ 130 h 221"/>
              <a:gd name="T104" fmla="*/ 352 w 511"/>
              <a:gd name="T105" fmla="*/ 103 h 221"/>
              <a:gd name="T106" fmla="*/ 351 w 511"/>
              <a:gd name="T107" fmla="*/ 133 h 2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</a:cxnLst>
            <a:rect l="0" t="0" r="r" b="b"/>
            <a:pathLst>
              <a:path w="511" h="221">
                <a:moveTo>
                  <a:pt x="188" y="44"/>
                </a:moveTo>
                <a:cubicBezTo>
                  <a:pt x="188" y="44"/>
                  <a:pt x="187" y="44"/>
                  <a:pt x="186" y="43"/>
                </a:cubicBezTo>
                <a:cubicBezTo>
                  <a:pt x="185" y="42"/>
                  <a:pt x="179" y="36"/>
                  <a:pt x="169" y="30"/>
                </a:cubicBezTo>
                <a:cubicBezTo>
                  <a:pt x="159" y="24"/>
                  <a:pt x="137" y="13"/>
                  <a:pt x="107" y="13"/>
                </a:cubicBezTo>
                <a:cubicBezTo>
                  <a:pt x="71" y="13"/>
                  <a:pt x="47" y="27"/>
                  <a:pt x="32" y="39"/>
                </a:cubicBezTo>
                <a:cubicBezTo>
                  <a:pt x="18" y="51"/>
                  <a:pt x="11" y="65"/>
                  <a:pt x="11" y="66"/>
                </a:cubicBezTo>
                <a:cubicBezTo>
                  <a:pt x="11" y="66"/>
                  <a:pt x="11" y="66"/>
                  <a:pt x="10" y="66"/>
                </a:cubicBezTo>
                <a:cubicBezTo>
                  <a:pt x="10" y="66"/>
                  <a:pt x="10" y="66"/>
                  <a:pt x="10" y="66"/>
                </a:cubicBezTo>
                <a:cubicBezTo>
                  <a:pt x="11" y="65"/>
                  <a:pt x="17" y="49"/>
                  <a:pt x="30" y="35"/>
                </a:cubicBezTo>
                <a:cubicBezTo>
                  <a:pt x="43" y="20"/>
                  <a:pt x="69" y="0"/>
                  <a:pt x="106" y="0"/>
                </a:cubicBezTo>
                <a:cubicBezTo>
                  <a:pt x="142" y="0"/>
                  <a:pt x="165" y="19"/>
                  <a:pt x="173" y="26"/>
                </a:cubicBezTo>
                <a:cubicBezTo>
                  <a:pt x="180" y="33"/>
                  <a:pt x="186" y="41"/>
                  <a:pt x="187" y="42"/>
                </a:cubicBezTo>
                <a:cubicBezTo>
                  <a:pt x="188" y="43"/>
                  <a:pt x="188" y="44"/>
                  <a:pt x="188" y="44"/>
                </a:cubicBezTo>
                <a:cubicBezTo>
                  <a:pt x="188" y="44"/>
                  <a:pt x="188" y="44"/>
                  <a:pt x="188" y="44"/>
                </a:cubicBezTo>
                <a:cubicBezTo>
                  <a:pt x="188" y="44"/>
                  <a:pt x="188" y="44"/>
                  <a:pt x="188" y="44"/>
                </a:cubicBezTo>
                <a:close/>
                <a:moveTo>
                  <a:pt x="1" y="101"/>
                </a:moveTo>
                <a:cubicBezTo>
                  <a:pt x="1" y="101"/>
                  <a:pt x="1" y="101"/>
                  <a:pt x="1" y="102"/>
                </a:cubicBezTo>
                <a:cubicBezTo>
                  <a:pt x="1" y="103"/>
                  <a:pt x="0" y="117"/>
                  <a:pt x="3" y="134"/>
                </a:cubicBezTo>
                <a:cubicBezTo>
                  <a:pt x="8" y="157"/>
                  <a:pt x="22" y="186"/>
                  <a:pt x="54" y="203"/>
                </a:cubicBezTo>
                <a:cubicBezTo>
                  <a:pt x="87" y="221"/>
                  <a:pt x="120" y="216"/>
                  <a:pt x="139" y="208"/>
                </a:cubicBezTo>
                <a:cubicBezTo>
                  <a:pt x="153" y="202"/>
                  <a:pt x="157" y="198"/>
                  <a:pt x="159" y="196"/>
                </a:cubicBezTo>
                <a:cubicBezTo>
                  <a:pt x="160" y="196"/>
                  <a:pt x="161" y="195"/>
                  <a:pt x="161" y="195"/>
                </a:cubicBezTo>
                <a:cubicBezTo>
                  <a:pt x="162" y="194"/>
                  <a:pt x="162" y="194"/>
                  <a:pt x="162" y="194"/>
                </a:cubicBezTo>
                <a:cubicBezTo>
                  <a:pt x="162" y="194"/>
                  <a:pt x="162" y="194"/>
                  <a:pt x="162" y="194"/>
                </a:cubicBezTo>
                <a:cubicBezTo>
                  <a:pt x="162" y="194"/>
                  <a:pt x="162" y="194"/>
                  <a:pt x="161" y="194"/>
                </a:cubicBezTo>
                <a:cubicBezTo>
                  <a:pt x="160" y="195"/>
                  <a:pt x="146" y="201"/>
                  <a:pt x="129" y="203"/>
                </a:cubicBezTo>
                <a:cubicBezTo>
                  <a:pt x="111" y="205"/>
                  <a:pt x="87" y="204"/>
                  <a:pt x="62" y="191"/>
                </a:cubicBezTo>
                <a:cubicBezTo>
                  <a:pt x="36" y="178"/>
                  <a:pt x="19" y="158"/>
                  <a:pt x="10" y="139"/>
                </a:cubicBezTo>
                <a:cubicBezTo>
                  <a:pt x="1" y="120"/>
                  <a:pt x="2" y="103"/>
                  <a:pt x="2" y="102"/>
                </a:cubicBezTo>
                <a:cubicBezTo>
                  <a:pt x="2" y="101"/>
                  <a:pt x="2" y="101"/>
                  <a:pt x="2" y="101"/>
                </a:cubicBezTo>
                <a:cubicBezTo>
                  <a:pt x="2" y="101"/>
                  <a:pt x="2" y="101"/>
                  <a:pt x="2" y="101"/>
                </a:cubicBezTo>
                <a:cubicBezTo>
                  <a:pt x="2" y="101"/>
                  <a:pt x="1" y="101"/>
                  <a:pt x="1" y="101"/>
                </a:cubicBezTo>
                <a:close/>
                <a:moveTo>
                  <a:pt x="108" y="133"/>
                </a:moveTo>
                <a:cubicBezTo>
                  <a:pt x="108" y="108"/>
                  <a:pt x="108" y="108"/>
                  <a:pt x="108" y="108"/>
                </a:cubicBezTo>
                <a:cubicBezTo>
                  <a:pt x="91" y="70"/>
                  <a:pt x="91" y="70"/>
                  <a:pt x="91" y="70"/>
                </a:cubicBezTo>
                <a:cubicBezTo>
                  <a:pt x="105" y="70"/>
                  <a:pt x="105" y="70"/>
                  <a:pt x="105" y="70"/>
                </a:cubicBezTo>
                <a:cubicBezTo>
                  <a:pt x="116" y="95"/>
                  <a:pt x="116" y="95"/>
                  <a:pt x="116" y="95"/>
                </a:cubicBezTo>
                <a:cubicBezTo>
                  <a:pt x="127" y="70"/>
                  <a:pt x="127" y="70"/>
                  <a:pt x="127" y="70"/>
                </a:cubicBezTo>
                <a:cubicBezTo>
                  <a:pt x="140" y="70"/>
                  <a:pt x="140" y="70"/>
                  <a:pt x="140" y="70"/>
                </a:cubicBezTo>
                <a:cubicBezTo>
                  <a:pt x="123" y="108"/>
                  <a:pt x="123" y="108"/>
                  <a:pt x="123" y="108"/>
                </a:cubicBezTo>
                <a:cubicBezTo>
                  <a:pt x="123" y="133"/>
                  <a:pt x="123" y="133"/>
                  <a:pt x="123" y="133"/>
                </a:cubicBezTo>
                <a:lnTo>
                  <a:pt x="108" y="133"/>
                </a:lnTo>
                <a:close/>
                <a:moveTo>
                  <a:pt x="241" y="133"/>
                </a:moveTo>
                <a:cubicBezTo>
                  <a:pt x="208" y="133"/>
                  <a:pt x="208" y="133"/>
                  <a:pt x="208" y="133"/>
                </a:cubicBezTo>
                <a:cubicBezTo>
                  <a:pt x="208" y="70"/>
                  <a:pt x="208" y="70"/>
                  <a:pt x="208" y="70"/>
                </a:cubicBezTo>
                <a:cubicBezTo>
                  <a:pt x="222" y="70"/>
                  <a:pt x="222" y="70"/>
                  <a:pt x="222" y="70"/>
                </a:cubicBezTo>
                <a:cubicBezTo>
                  <a:pt x="222" y="121"/>
                  <a:pt x="222" y="121"/>
                  <a:pt x="222" y="121"/>
                </a:cubicBezTo>
                <a:cubicBezTo>
                  <a:pt x="241" y="121"/>
                  <a:pt x="241" y="121"/>
                  <a:pt x="241" y="121"/>
                </a:cubicBezTo>
                <a:lnTo>
                  <a:pt x="241" y="133"/>
                </a:lnTo>
                <a:close/>
                <a:moveTo>
                  <a:pt x="73" y="70"/>
                </a:moveTo>
                <a:cubicBezTo>
                  <a:pt x="86" y="70"/>
                  <a:pt x="86" y="70"/>
                  <a:pt x="86" y="70"/>
                </a:cubicBezTo>
                <a:cubicBezTo>
                  <a:pt x="86" y="133"/>
                  <a:pt x="86" y="133"/>
                  <a:pt x="86" y="133"/>
                </a:cubicBezTo>
                <a:cubicBezTo>
                  <a:pt x="73" y="133"/>
                  <a:pt x="73" y="133"/>
                  <a:pt x="73" y="133"/>
                </a:cubicBezTo>
                <a:cubicBezTo>
                  <a:pt x="73" y="133"/>
                  <a:pt x="73" y="133"/>
                  <a:pt x="73" y="133"/>
                </a:cubicBezTo>
                <a:cubicBezTo>
                  <a:pt x="73" y="131"/>
                  <a:pt x="57" y="104"/>
                  <a:pt x="53" y="96"/>
                </a:cubicBezTo>
                <a:cubicBezTo>
                  <a:pt x="53" y="133"/>
                  <a:pt x="53" y="133"/>
                  <a:pt x="53" y="133"/>
                </a:cubicBezTo>
                <a:cubicBezTo>
                  <a:pt x="40" y="133"/>
                  <a:pt x="40" y="133"/>
                  <a:pt x="40" y="133"/>
                </a:cubicBezTo>
                <a:cubicBezTo>
                  <a:pt x="40" y="70"/>
                  <a:pt x="40" y="70"/>
                  <a:pt x="40" y="70"/>
                </a:cubicBezTo>
                <a:cubicBezTo>
                  <a:pt x="54" y="70"/>
                  <a:pt x="54" y="70"/>
                  <a:pt x="54" y="70"/>
                </a:cubicBezTo>
                <a:cubicBezTo>
                  <a:pt x="54" y="70"/>
                  <a:pt x="54" y="70"/>
                  <a:pt x="54" y="70"/>
                </a:cubicBezTo>
                <a:cubicBezTo>
                  <a:pt x="55" y="71"/>
                  <a:pt x="69" y="97"/>
                  <a:pt x="73" y="106"/>
                </a:cubicBezTo>
                <a:lnTo>
                  <a:pt x="73" y="70"/>
                </a:lnTo>
                <a:close/>
                <a:moveTo>
                  <a:pt x="166" y="134"/>
                </a:moveTo>
                <a:cubicBezTo>
                  <a:pt x="152" y="134"/>
                  <a:pt x="144" y="126"/>
                  <a:pt x="144" y="111"/>
                </a:cubicBezTo>
                <a:cubicBezTo>
                  <a:pt x="144" y="70"/>
                  <a:pt x="144" y="70"/>
                  <a:pt x="144" y="70"/>
                </a:cubicBezTo>
                <a:cubicBezTo>
                  <a:pt x="158" y="70"/>
                  <a:pt x="158" y="70"/>
                  <a:pt x="158" y="70"/>
                </a:cubicBezTo>
                <a:cubicBezTo>
                  <a:pt x="158" y="110"/>
                  <a:pt x="158" y="110"/>
                  <a:pt x="158" y="110"/>
                </a:cubicBezTo>
                <a:cubicBezTo>
                  <a:pt x="158" y="119"/>
                  <a:pt x="161" y="122"/>
                  <a:pt x="167" y="122"/>
                </a:cubicBezTo>
                <a:cubicBezTo>
                  <a:pt x="172" y="122"/>
                  <a:pt x="175" y="118"/>
                  <a:pt x="175" y="110"/>
                </a:cubicBezTo>
                <a:cubicBezTo>
                  <a:pt x="175" y="70"/>
                  <a:pt x="175" y="70"/>
                  <a:pt x="175" y="70"/>
                </a:cubicBezTo>
                <a:cubicBezTo>
                  <a:pt x="188" y="70"/>
                  <a:pt x="188" y="70"/>
                  <a:pt x="188" y="70"/>
                </a:cubicBezTo>
                <a:cubicBezTo>
                  <a:pt x="188" y="111"/>
                  <a:pt x="188" y="111"/>
                  <a:pt x="188" y="111"/>
                </a:cubicBezTo>
                <a:cubicBezTo>
                  <a:pt x="188" y="126"/>
                  <a:pt x="181" y="134"/>
                  <a:pt x="166" y="134"/>
                </a:cubicBezTo>
                <a:close/>
                <a:moveTo>
                  <a:pt x="259" y="199"/>
                </a:moveTo>
                <a:cubicBezTo>
                  <a:pt x="267" y="206"/>
                  <a:pt x="267" y="206"/>
                  <a:pt x="267" y="206"/>
                </a:cubicBezTo>
                <a:cubicBezTo>
                  <a:pt x="267" y="206"/>
                  <a:pt x="267" y="206"/>
                  <a:pt x="267" y="206"/>
                </a:cubicBezTo>
                <a:cubicBezTo>
                  <a:pt x="263" y="213"/>
                  <a:pt x="257" y="216"/>
                  <a:pt x="249" y="216"/>
                </a:cubicBezTo>
                <a:cubicBezTo>
                  <a:pt x="236" y="216"/>
                  <a:pt x="229" y="207"/>
                  <a:pt x="229" y="192"/>
                </a:cubicBezTo>
                <a:cubicBezTo>
                  <a:pt x="229" y="174"/>
                  <a:pt x="239" y="168"/>
                  <a:pt x="249" y="168"/>
                </a:cubicBezTo>
                <a:cubicBezTo>
                  <a:pt x="261" y="168"/>
                  <a:pt x="267" y="177"/>
                  <a:pt x="267" y="193"/>
                </a:cubicBezTo>
                <a:cubicBezTo>
                  <a:pt x="267" y="196"/>
                  <a:pt x="267" y="196"/>
                  <a:pt x="267" y="196"/>
                </a:cubicBezTo>
                <a:cubicBezTo>
                  <a:pt x="242" y="196"/>
                  <a:pt x="242" y="196"/>
                  <a:pt x="242" y="196"/>
                </a:cubicBezTo>
                <a:cubicBezTo>
                  <a:pt x="243" y="202"/>
                  <a:pt x="245" y="205"/>
                  <a:pt x="250" y="205"/>
                </a:cubicBezTo>
                <a:cubicBezTo>
                  <a:pt x="254" y="205"/>
                  <a:pt x="257" y="202"/>
                  <a:pt x="259" y="200"/>
                </a:cubicBezTo>
                <a:lnTo>
                  <a:pt x="259" y="199"/>
                </a:lnTo>
                <a:close/>
                <a:moveTo>
                  <a:pt x="242" y="187"/>
                </a:moveTo>
                <a:cubicBezTo>
                  <a:pt x="255" y="187"/>
                  <a:pt x="255" y="187"/>
                  <a:pt x="255" y="187"/>
                </a:cubicBezTo>
                <a:cubicBezTo>
                  <a:pt x="254" y="179"/>
                  <a:pt x="250" y="179"/>
                  <a:pt x="249" y="179"/>
                </a:cubicBezTo>
                <a:cubicBezTo>
                  <a:pt x="245" y="179"/>
                  <a:pt x="243" y="182"/>
                  <a:pt x="242" y="187"/>
                </a:cubicBezTo>
                <a:close/>
                <a:moveTo>
                  <a:pt x="416" y="92"/>
                </a:moveTo>
                <a:cubicBezTo>
                  <a:pt x="420" y="96"/>
                  <a:pt x="422" y="102"/>
                  <a:pt x="422" y="110"/>
                </a:cubicBezTo>
                <a:cubicBezTo>
                  <a:pt x="422" y="128"/>
                  <a:pt x="412" y="134"/>
                  <a:pt x="402" y="134"/>
                </a:cubicBezTo>
                <a:cubicBezTo>
                  <a:pt x="392" y="134"/>
                  <a:pt x="382" y="128"/>
                  <a:pt x="382" y="110"/>
                </a:cubicBezTo>
                <a:cubicBezTo>
                  <a:pt x="382" y="102"/>
                  <a:pt x="384" y="96"/>
                  <a:pt x="388" y="92"/>
                </a:cubicBezTo>
                <a:cubicBezTo>
                  <a:pt x="392" y="88"/>
                  <a:pt x="396" y="86"/>
                  <a:pt x="402" y="86"/>
                </a:cubicBezTo>
                <a:cubicBezTo>
                  <a:pt x="408" y="86"/>
                  <a:pt x="413" y="88"/>
                  <a:pt x="416" y="92"/>
                </a:cubicBezTo>
                <a:close/>
                <a:moveTo>
                  <a:pt x="409" y="110"/>
                </a:moveTo>
                <a:cubicBezTo>
                  <a:pt x="409" y="99"/>
                  <a:pt x="405" y="97"/>
                  <a:pt x="402" y="97"/>
                </a:cubicBezTo>
                <a:cubicBezTo>
                  <a:pt x="398" y="97"/>
                  <a:pt x="396" y="101"/>
                  <a:pt x="396" y="110"/>
                </a:cubicBezTo>
                <a:cubicBezTo>
                  <a:pt x="396" y="122"/>
                  <a:pt x="399" y="123"/>
                  <a:pt x="402" y="123"/>
                </a:cubicBezTo>
                <a:cubicBezTo>
                  <a:pt x="407" y="123"/>
                  <a:pt x="409" y="119"/>
                  <a:pt x="409" y="110"/>
                </a:cubicBezTo>
                <a:close/>
                <a:moveTo>
                  <a:pt x="410" y="180"/>
                </a:moveTo>
                <a:cubicBezTo>
                  <a:pt x="410" y="215"/>
                  <a:pt x="410" y="215"/>
                  <a:pt x="410" y="215"/>
                </a:cubicBezTo>
                <a:cubicBezTo>
                  <a:pt x="397" y="215"/>
                  <a:pt x="397" y="215"/>
                  <a:pt x="397" y="215"/>
                </a:cubicBezTo>
                <a:cubicBezTo>
                  <a:pt x="397" y="184"/>
                  <a:pt x="397" y="184"/>
                  <a:pt x="397" y="184"/>
                </a:cubicBezTo>
                <a:cubicBezTo>
                  <a:pt x="397" y="180"/>
                  <a:pt x="395" y="180"/>
                  <a:pt x="393" y="180"/>
                </a:cubicBezTo>
                <a:cubicBezTo>
                  <a:pt x="391" y="180"/>
                  <a:pt x="389" y="181"/>
                  <a:pt x="386" y="183"/>
                </a:cubicBezTo>
                <a:cubicBezTo>
                  <a:pt x="386" y="215"/>
                  <a:pt x="386" y="215"/>
                  <a:pt x="386" y="215"/>
                </a:cubicBezTo>
                <a:cubicBezTo>
                  <a:pt x="373" y="215"/>
                  <a:pt x="373" y="215"/>
                  <a:pt x="373" y="215"/>
                </a:cubicBezTo>
                <a:cubicBezTo>
                  <a:pt x="373" y="152"/>
                  <a:pt x="373" y="152"/>
                  <a:pt x="373" y="152"/>
                </a:cubicBezTo>
                <a:cubicBezTo>
                  <a:pt x="386" y="150"/>
                  <a:pt x="386" y="150"/>
                  <a:pt x="386" y="150"/>
                </a:cubicBezTo>
                <a:cubicBezTo>
                  <a:pt x="386" y="174"/>
                  <a:pt x="386" y="174"/>
                  <a:pt x="386" y="174"/>
                </a:cubicBezTo>
                <a:cubicBezTo>
                  <a:pt x="389" y="171"/>
                  <a:pt x="393" y="168"/>
                  <a:pt x="399" y="168"/>
                </a:cubicBezTo>
                <a:cubicBezTo>
                  <a:pt x="406" y="168"/>
                  <a:pt x="410" y="172"/>
                  <a:pt x="410" y="180"/>
                </a:cubicBezTo>
                <a:close/>
                <a:moveTo>
                  <a:pt x="511" y="124"/>
                </a:moveTo>
                <a:cubicBezTo>
                  <a:pt x="511" y="124"/>
                  <a:pt x="511" y="124"/>
                  <a:pt x="511" y="124"/>
                </a:cubicBezTo>
                <a:cubicBezTo>
                  <a:pt x="507" y="131"/>
                  <a:pt x="501" y="134"/>
                  <a:pt x="493" y="134"/>
                </a:cubicBezTo>
                <a:cubicBezTo>
                  <a:pt x="480" y="134"/>
                  <a:pt x="473" y="125"/>
                  <a:pt x="473" y="110"/>
                </a:cubicBezTo>
                <a:cubicBezTo>
                  <a:pt x="473" y="92"/>
                  <a:pt x="484" y="86"/>
                  <a:pt x="493" y="86"/>
                </a:cubicBezTo>
                <a:cubicBezTo>
                  <a:pt x="505" y="86"/>
                  <a:pt x="511" y="95"/>
                  <a:pt x="511" y="111"/>
                </a:cubicBezTo>
                <a:cubicBezTo>
                  <a:pt x="511" y="114"/>
                  <a:pt x="511" y="114"/>
                  <a:pt x="511" y="114"/>
                </a:cubicBezTo>
                <a:cubicBezTo>
                  <a:pt x="486" y="114"/>
                  <a:pt x="486" y="114"/>
                  <a:pt x="486" y="114"/>
                </a:cubicBezTo>
                <a:cubicBezTo>
                  <a:pt x="487" y="120"/>
                  <a:pt x="489" y="123"/>
                  <a:pt x="494" y="123"/>
                </a:cubicBezTo>
                <a:cubicBezTo>
                  <a:pt x="498" y="123"/>
                  <a:pt x="501" y="120"/>
                  <a:pt x="503" y="118"/>
                </a:cubicBezTo>
                <a:cubicBezTo>
                  <a:pt x="503" y="117"/>
                  <a:pt x="503" y="117"/>
                  <a:pt x="503" y="117"/>
                </a:cubicBezTo>
                <a:lnTo>
                  <a:pt x="511" y="124"/>
                </a:lnTo>
                <a:close/>
                <a:moveTo>
                  <a:pt x="487" y="105"/>
                </a:moveTo>
                <a:cubicBezTo>
                  <a:pt x="499" y="105"/>
                  <a:pt x="499" y="105"/>
                  <a:pt x="499" y="105"/>
                </a:cubicBezTo>
                <a:cubicBezTo>
                  <a:pt x="498" y="97"/>
                  <a:pt x="494" y="97"/>
                  <a:pt x="493" y="97"/>
                </a:cubicBezTo>
                <a:cubicBezTo>
                  <a:pt x="489" y="97"/>
                  <a:pt x="487" y="100"/>
                  <a:pt x="487" y="105"/>
                </a:cubicBezTo>
                <a:close/>
                <a:moveTo>
                  <a:pt x="467" y="98"/>
                </a:moveTo>
                <a:cubicBezTo>
                  <a:pt x="467" y="133"/>
                  <a:pt x="467" y="133"/>
                  <a:pt x="467" y="133"/>
                </a:cubicBezTo>
                <a:cubicBezTo>
                  <a:pt x="453" y="133"/>
                  <a:pt x="453" y="133"/>
                  <a:pt x="453" y="133"/>
                </a:cubicBezTo>
                <a:cubicBezTo>
                  <a:pt x="453" y="102"/>
                  <a:pt x="453" y="102"/>
                  <a:pt x="453" y="102"/>
                </a:cubicBezTo>
                <a:cubicBezTo>
                  <a:pt x="453" y="98"/>
                  <a:pt x="452" y="98"/>
                  <a:pt x="450" y="98"/>
                </a:cubicBezTo>
                <a:cubicBezTo>
                  <a:pt x="448" y="98"/>
                  <a:pt x="445" y="99"/>
                  <a:pt x="443" y="102"/>
                </a:cubicBezTo>
                <a:cubicBezTo>
                  <a:pt x="443" y="133"/>
                  <a:pt x="443" y="133"/>
                  <a:pt x="443" y="133"/>
                </a:cubicBezTo>
                <a:cubicBezTo>
                  <a:pt x="429" y="133"/>
                  <a:pt x="429" y="133"/>
                  <a:pt x="429" y="133"/>
                </a:cubicBezTo>
                <a:cubicBezTo>
                  <a:pt x="429" y="87"/>
                  <a:pt x="429" y="87"/>
                  <a:pt x="429" y="87"/>
                </a:cubicBezTo>
                <a:cubicBezTo>
                  <a:pt x="443" y="87"/>
                  <a:pt x="443" y="87"/>
                  <a:pt x="443" y="87"/>
                </a:cubicBezTo>
                <a:cubicBezTo>
                  <a:pt x="443" y="92"/>
                  <a:pt x="443" y="92"/>
                  <a:pt x="443" y="92"/>
                </a:cubicBezTo>
                <a:cubicBezTo>
                  <a:pt x="445" y="89"/>
                  <a:pt x="450" y="86"/>
                  <a:pt x="455" y="86"/>
                </a:cubicBezTo>
                <a:cubicBezTo>
                  <a:pt x="463" y="86"/>
                  <a:pt x="467" y="90"/>
                  <a:pt x="467" y="98"/>
                </a:cubicBezTo>
                <a:close/>
                <a:moveTo>
                  <a:pt x="357" y="169"/>
                </a:moveTo>
                <a:cubicBezTo>
                  <a:pt x="366" y="169"/>
                  <a:pt x="366" y="169"/>
                  <a:pt x="366" y="169"/>
                </a:cubicBezTo>
                <a:cubicBezTo>
                  <a:pt x="366" y="179"/>
                  <a:pt x="366" y="179"/>
                  <a:pt x="366" y="179"/>
                </a:cubicBezTo>
                <a:cubicBezTo>
                  <a:pt x="357" y="179"/>
                  <a:pt x="357" y="179"/>
                  <a:pt x="357" y="179"/>
                </a:cubicBezTo>
                <a:cubicBezTo>
                  <a:pt x="357" y="200"/>
                  <a:pt x="357" y="200"/>
                  <a:pt x="357" y="200"/>
                </a:cubicBezTo>
                <a:cubicBezTo>
                  <a:pt x="357" y="204"/>
                  <a:pt x="358" y="205"/>
                  <a:pt x="361" y="205"/>
                </a:cubicBezTo>
                <a:cubicBezTo>
                  <a:pt x="363" y="205"/>
                  <a:pt x="364" y="205"/>
                  <a:pt x="365" y="205"/>
                </a:cubicBezTo>
                <a:cubicBezTo>
                  <a:pt x="366" y="204"/>
                  <a:pt x="366" y="204"/>
                  <a:pt x="366" y="204"/>
                </a:cubicBezTo>
                <a:cubicBezTo>
                  <a:pt x="366" y="215"/>
                  <a:pt x="366" y="215"/>
                  <a:pt x="366" y="215"/>
                </a:cubicBezTo>
                <a:cubicBezTo>
                  <a:pt x="365" y="215"/>
                  <a:pt x="365" y="215"/>
                  <a:pt x="365" y="215"/>
                </a:cubicBezTo>
                <a:cubicBezTo>
                  <a:pt x="364" y="215"/>
                  <a:pt x="360" y="215"/>
                  <a:pt x="357" y="215"/>
                </a:cubicBezTo>
                <a:cubicBezTo>
                  <a:pt x="347" y="215"/>
                  <a:pt x="343" y="212"/>
                  <a:pt x="343" y="203"/>
                </a:cubicBezTo>
                <a:cubicBezTo>
                  <a:pt x="343" y="179"/>
                  <a:pt x="343" y="179"/>
                  <a:pt x="343" y="179"/>
                </a:cubicBezTo>
                <a:cubicBezTo>
                  <a:pt x="337" y="179"/>
                  <a:pt x="337" y="179"/>
                  <a:pt x="337" y="179"/>
                </a:cubicBezTo>
                <a:cubicBezTo>
                  <a:pt x="337" y="169"/>
                  <a:pt x="337" y="169"/>
                  <a:pt x="337" y="169"/>
                </a:cubicBezTo>
                <a:cubicBezTo>
                  <a:pt x="343" y="169"/>
                  <a:pt x="343" y="169"/>
                  <a:pt x="343" y="169"/>
                </a:cubicBezTo>
                <a:cubicBezTo>
                  <a:pt x="343" y="156"/>
                  <a:pt x="343" y="156"/>
                  <a:pt x="343" y="156"/>
                </a:cubicBezTo>
                <a:cubicBezTo>
                  <a:pt x="357" y="154"/>
                  <a:pt x="357" y="154"/>
                  <a:pt x="357" y="154"/>
                </a:cubicBezTo>
                <a:lnTo>
                  <a:pt x="357" y="169"/>
                </a:lnTo>
                <a:close/>
                <a:moveTo>
                  <a:pt x="332" y="98"/>
                </a:moveTo>
                <a:cubicBezTo>
                  <a:pt x="332" y="133"/>
                  <a:pt x="332" y="133"/>
                  <a:pt x="332" y="133"/>
                </a:cubicBezTo>
                <a:cubicBezTo>
                  <a:pt x="318" y="133"/>
                  <a:pt x="318" y="133"/>
                  <a:pt x="318" y="133"/>
                </a:cubicBezTo>
                <a:cubicBezTo>
                  <a:pt x="318" y="102"/>
                  <a:pt x="318" y="102"/>
                  <a:pt x="318" y="102"/>
                </a:cubicBezTo>
                <a:cubicBezTo>
                  <a:pt x="318" y="98"/>
                  <a:pt x="316" y="98"/>
                  <a:pt x="315" y="98"/>
                </a:cubicBezTo>
                <a:cubicBezTo>
                  <a:pt x="313" y="98"/>
                  <a:pt x="310" y="99"/>
                  <a:pt x="307" y="102"/>
                </a:cubicBezTo>
                <a:cubicBezTo>
                  <a:pt x="307" y="133"/>
                  <a:pt x="307" y="133"/>
                  <a:pt x="307" y="133"/>
                </a:cubicBezTo>
                <a:cubicBezTo>
                  <a:pt x="294" y="133"/>
                  <a:pt x="294" y="133"/>
                  <a:pt x="294" y="133"/>
                </a:cubicBezTo>
                <a:cubicBezTo>
                  <a:pt x="294" y="87"/>
                  <a:pt x="294" y="87"/>
                  <a:pt x="294" y="87"/>
                </a:cubicBezTo>
                <a:cubicBezTo>
                  <a:pt x="307" y="87"/>
                  <a:pt x="307" y="87"/>
                  <a:pt x="307" y="87"/>
                </a:cubicBezTo>
                <a:cubicBezTo>
                  <a:pt x="307" y="92"/>
                  <a:pt x="307" y="92"/>
                  <a:pt x="307" y="92"/>
                </a:cubicBezTo>
                <a:cubicBezTo>
                  <a:pt x="310" y="89"/>
                  <a:pt x="315" y="86"/>
                  <a:pt x="320" y="86"/>
                </a:cubicBezTo>
                <a:cubicBezTo>
                  <a:pt x="328" y="86"/>
                  <a:pt x="332" y="90"/>
                  <a:pt x="332" y="98"/>
                </a:cubicBezTo>
                <a:close/>
                <a:moveTo>
                  <a:pt x="272" y="132"/>
                </a:moveTo>
                <a:cubicBezTo>
                  <a:pt x="272" y="131"/>
                  <a:pt x="271" y="130"/>
                  <a:pt x="271" y="128"/>
                </a:cubicBezTo>
                <a:cubicBezTo>
                  <a:pt x="268" y="132"/>
                  <a:pt x="264" y="133"/>
                  <a:pt x="259" y="133"/>
                </a:cubicBezTo>
                <a:cubicBezTo>
                  <a:pt x="251" y="133"/>
                  <a:pt x="247" y="129"/>
                  <a:pt x="247" y="121"/>
                </a:cubicBezTo>
                <a:cubicBezTo>
                  <a:pt x="247" y="112"/>
                  <a:pt x="255" y="106"/>
                  <a:pt x="271" y="103"/>
                </a:cubicBezTo>
                <a:cubicBezTo>
                  <a:pt x="271" y="102"/>
                  <a:pt x="271" y="102"/>
                  <a:pt x="271" y="102"/>
                </a:cubicBezTo>
                <a:cubicBezTo>
                  <a:pt x="271" y="98"/>
                  <a:pt x="270" y="97"/>
                  <a:pt x="267" y="97"/>
                </a:cubicBezTo>
                <a:cubicBezTo>
                  <a:pt x="263" y="97"/>
                  <a:pt x="258" y="100"/>
                  <a:pt x="256" y="102"/>
                </a:cubicBezTo>
                <a:cubicBezTo>
                  <a:pt x="255" y="102"/>
                  <a:pt x="255" y="102"/>
                  <a:pt x="255" y="102"/>
                </a:cubicBezTo>
                <a:cubicBezTo>
                  <a:pt x="249" y="94"/>
                  <a:pt x="249" y="94"/>
                  <a:pt x="249" y="94"/>
                </a:cubicBezTo>
                <a:cubicBezTo>
                  <a:pt x="249" y="93"/>
                  <a:pt x="249" y="93"/>
                  <a:pt x="249" y="93"/>
                </a:cubicBezTo>
                <a:cubicBezTo>
                  <a:pt x="255" y="89"/>
                  <a:pt x="262" y="86"/>
                  <a:pt x="270" y="86"/>
                </a:cubicBezTo>
                <a:cubicBezTo>
                  <a:pt x="280" y="86"/>
                  <a:pt x="285" y="91"/>
                  <a:pt x="285" y="102"/>
                </a:cubicBezTo>
                <a:cubicBezTo>
                  <a:pt x="285" y="121"/>
                  <a:pt x="285" y="121"/>
                  <a:pt x="285" y="121"/>
                </a:cubicBezTo>
                <a:cubicBezTo>
                  <a:pt x="285" y="127"/>
                  <a:pt x="285" y="130"/>
                  <a:pt x="286" y="132"/>
                </a:cubicBezTo>
                <a:cubicBezTo>
                  <a:pt x="286" y="133"/>
                  <a:pt x="286" y="133"/>
                  <a:pt x="286" y="133"/>
                </a:cubicBezTo>
                <a:cubicBezTo>
                  <a:pt x="272" y="133"/>
                  <a:pt x="272" y="133"/>
                  <a:pt x="272" y="133"/>
                </a:cubicBezTo>
                <a:lnTo>
                  <a:pt x="272" y="132"/>
                </a:lnTo>
                <a:close/>
                <a:moveTo>
                  <a:pt x="271" y="111"/>
                </a:moveTo>
                <a:cubicBezTo>
                  <a:pt x="262" y="113"/>
                  <a:pt x="261" y="116"/>
                  <a:pt x="261" y="119"/>
                </a:cubicBezTo>
                <a:cubicBezTo>
                  <a:pt x="261" y="121"/>
                  <a:pt x="262" y="123"/>
                  <a:pt x="264" y="123"/>
                </a:cubicBezTo>
                <a:cubicBezTo>
                  <a:pt x="267" y="123"/>
                  <a:pt x="269" y="122"/>
                  <a:pt x="271" y="120"/>
                </a:cubicBezTo>
                <a:lnTo>
                  <a:pt x="271" y="111"/>
                </a:lnTo>
                <a:close/>
                <a:moveTo>
                  <a:pt x="310" y="214"/>
                </a:moveTo>
                <a:cubicBezTo>
                  <a:pt x="311" y="215"/>
                  <a:pt x="311" y="215"/>
                  <a:pt x="311" y="215"/>
                </a:cubicBezTo>
                <a:cubicBezTo>
                  <a:pt x="297" y="215"/>
                  <a:pt x="297" y="215"/>
                  <a:pt x="297" y="215"/>
                </a:cubicBezTo>
                <a:cubicBezTo>
                  <a:pt x="297" y="214"/>
                  <a:pt x="297" y="214"/>
                  <a:pt x="297" y="214"/>
                </a:cubicBezTo>
                <a:cubicBezTo>
                  <a:pt x="296" y="213"/>
                  <a:pt x="296" y="212"/>
                  <a:pt x="296" y="210"/>
                </a:cubicBezTo>
                <a:cubicBezTo>
                  <a:pt x="293" y="214"/>
                  <a:pt x="289" y="215"/>
                  <a:pt x="283" y="215"/>
                </a:cubicBezTo>
                <a:cubicBezTo>
                  <a:pt x="276" y="215"/>
                  <a:pt x="272" y="211"/>
                  <a:pt x="272" y="203"/>
                </a:cubicBezTo>
                <a:cubicBezTo>
                  <a:pt x="272" y="194"/>
                  <a:pt x="280" y="188"/>
                  <a:pt x="296" y="185"/>
                </a:cubicBezTo>
                <a:cubicBezTo>
                  <a:pt x="296" y="183"/>
                  <a:pt x="296" y="183"/>
                  <a:pt x="296" y="183"/>
                </a:cubicBezTo>
                <a:cubicBezTo>
                  <a:pt x="296" y="180"/>
                  <a:pt x="295" y="179"/>
                  <a:pt x="292" y="179"/>
                </a:cubicBezTo>
                <a:cubicBezTo>
                  <a:pt x="287" y="179"/>
                  <a:pt x="283" y="182"/>
                  <a:pt x="280" y="184"/>
                </a:cubicBezTo>
                <a:cubicBezTo>
                  <a:pt x="280" y="184"/>
                  <a:pt x="280" y="184"/>
                  <a:pt x="280" y="184"/>
                </a:cubicBezTo>
                <a:cubicBezTo>
                  <a:pt x="273" y="176"/>
                  <a:pt x="273" y="176"/>
                  <a:pt x="273" y="176"/>
                </a:cubicBezTo>
                <a:cubicBezTo>
                  <a:pt x="274" y="175"/>
                  <a:pt x="274" y="175"/>
                  <a:pt x="274" y="175"/>
                </a:cubicBezTo>
                <a:cubicBezTo>
                  <a:pt x="279" y="171"/>
                  <a:pt x="286" y="168"/>
                  <a:pt x="294" y="168"/>
                </a:cubicBezTo>
                <a:cubicBezTo>
                  <a:pt x="305" y="168"/>
                  <a:pt x="309" y="173"/>
                  <a:pt x="309" y="183"/>
                </a:cubicBezTo>
                <a:cubicBezTo>
                  <a:pt x="309" y="203"/>
                  <a:pt x="309" y="203"/>
                  <a:pt x="309" y="203"/>
                </a:cubicBezTo>
                <a:cubicBezTo>
                  <a:pt x="309" y="209"/>
                  <a:pt x="310" y="212"/>
                  <a:pt x="310" y="214"/>
                </a:cubicBezTo>
                <a:close/>
                <a:moveTo>
                  <a:pt x="296" y="193"/>
                </a:moveTo>
                <a:cubicBezTo>
                  <a:pt x="286" y="195"/>
                  <a:pt x="285" y="198"/>
                  <a:pt x="285" y="201"/>
                </a:cubicBezTo>
                <a:cubicBezTo>
                  <a:pt x="285" y="203"/>
                  <a:pt x="286" y="205"/>
                  <a:pt x="289" y="205"/>
                </a:cubicBezTo>
                <a:cubicBezTo>
                  <a:pt x="291" y="205"/>
                  <a:pt x="294" y="204"/>
                  <a:pt x="296" y="201"/>
                </a:cubicBezTo>
                <a:lnTo>
                  <a:pt x="296" y="193"/>
                </a:lnTo>
                <a:close/>
                <a:moveTo>
                  <a:pt x="318" y="159"/>
                </a:moveTo>
                <a:cubicBezTo>
                  <a:pt x="332" y="157"/>
                  <a:pt x="332" y="157"/>
                  <a:pt x="332" y="157"/>
                </a:cubicBezTo>
                <a:cubicBezTo>
                  <a:pt x="332" y="215"/>
                  <a:pt x="332" y="215"/>
                  <a:pt x="332" y="215"/>
                </a:cubicBezTo>
                <a:cubicBezTo>
                  <a:pt x="318" y="215"/>
                  <a:pt x="318" y="215"/>
                  <a:pt x="318" y="215"/>
                </a:cubicBezTo>
                <a:lnTo>
                  <a:pt x="318" y="159"/>
                </a:lnTo>
                <a:close/>
                <a:moveTo>
                  <a:pt x="208" y="153"/>
                </a:moveTo>
                <a:cubicBezTo>
                  <a:pt x="222" y="153"/>
                  <a:pt x="222" y="153"/>
                  <a:pt x="222" y="153"/>
                </a:cubicBezTo>
                <a:cubicBezTo>
                  <a:pt x="222" y="215"/>
                  <a:pt x="222" y="215"/>
                  <a:pt x="222" y="215"/>
                </a:cubicBezTo>
                <a:cubicBezTo>
                  <a:pt x="208" y="215"/>
                  <a:pt x="208" y="215"/>
                  <a:pt x="208" y="215"/>
                </a:cubicBezTo>
                <a:cubicBezTo>
                  <a:pt x="208" y="188"/>
                  <a:pt x="208" y="188"/>
                  <a:pt x="208" y="188"/>
                </a:cubicBezTo>
                <a:cubicBezTo>
                  <a:pt x="188" y="188"/>
                  <a:pt x="188" y="188"/>
                  <a:pt x="188" y="188"/>
                </a:cubicBezTo>
                <a:cubicBezTo>
                  <a:pt x="188" y="215"/>
                  <a:pt x="188" y="215"/>
                  <a:pt x="188" y="215"/>
                </a:cubicBezTo>
                <a:cubicBezTo>
                  <a:pt x="174" y="215"/>
                  <a:pt x="174" y="215"/>
                  <a:pt x="174" y="215"/>
                </a:cubicBezTo>
                <a:cubicBezTo>
                  <a:pt x="174" y="153"/>
                  <a:pt x="174" y="153"/>
                  <a:pt x="174" y="153"/>
                </a:cubicBezTo>
                <a:cubicBezTo>
                  <a:pt x="188" y="153"/>
                  <a:pt x="188" y="153"/>
                  <a:pt x="188" y="153"/>
                </a:cubicBezTo>
                <a:cubicBezTo>
                  <a:pt x="188" y="176"/>
                  <a:pt x="188" y="176"/>
                  <a:pt x="188" y="176"/>
                </a:cubicBezTo>
                <a:cubicBezTo>
                  <a:pt x="208" y="176"/>
                  <a:pt x="208" y="176"/>
                  <a:pt x="208" y="176"/>
                </a:cubicBezTo>
                <a:lnTo>
                  <a:pt x="208" y="153"/>
                </a:lnTo>
                <a:close/>
                <a:moveTo>
                  <a:pt x="342" y="130"/>
                </a:moveTo>
                <a:cubicBezTo>
                  <a:pt x="340" y="129"/>
                  <a:pt x="339" y="127"/>
                  <a:pt x="339" y="124"/>
                </a:cubicBezTo>
                <a:cubicBezTo>
                  <a:pt x="339" y="122"/>
                  <a:pt x="341" y="118"/>
                  <a:pt x="345" y="116"/>
                </a:cubicBezTo>
                <a:cubicBezTo>
                  <a:pt x="341" y="113"/>
                  <a:pt x="339" y="108"/>
                  <a:pt x="339" y="103"/>
                </a:cubicBezTo>
                <a:cubicBezTo>
                  <a:pt x="339" y="93"/>
                  <a:pt x="346" y="86"/>
                  <a:pt x="357" y="86"/>
                </a:cubicBezTo>
                <a:cubicBezTo>
                  <a:pt x="362" y="86"/>
                  <a:pt x="367" y="88"/>
                  <a:pt x="370" y="90"/>
                </a:cubicBezTo>
                <a:cubicBezTo>
                  <a:pt x="372" y="88"/>
                  <a:pt x="376" y="86"/>
                  <a:pt x="379" y="86"/>
                </a:cubicBezTo>
                <a:cubicBezTo>
                  <a:pt x="380" y="86"/>
                  <a:pt x="380" y="86"/>
                  <a:pt x="380" y="86"/>
                </a:cubicBezTo>
                <a:cubicBezTo>
                  <a:pt x="380" y="98"/>
                  <a:pt x="380" y="98"/>
                  <a:pt x="380" y="98"/>
                </a:cubicBezTo>
                <a:cubicBezTo>
                  <a:pt x="379" y="98"/>
                  <a:pt x="379" y="98"/>
                  <a:pt x="379" y="98"/>
                </a:cubicBezTo>
                <a:cubicBezTo>
                  <a:pt x="378" y="98"/>
                  <a:pt x="376" y="98"/>
                  <a:pt x="374" y="98"/>
                </a:cubicBezTo>
                <a:cubicBezTo>
                  <a:pt x="375" y="100"/>
                  <a:pt x="375" y="101"/>
                  <a:pt x="375" y="103"/>
                </a:cubicBezTo>
                <a:cubicBezTo>
                  <a:pt x="375" y="113"/>
                  <a:pt x="368" y="120"/>
                  <a:pt x="357" y="120"/>
                </a:cubicBezTo>
                <a:cubicBezTo>
                  <a:pt x="355" y="120"/>
                  <a:pt x="353" y="119"/>
                  <a:pt x="351" y="119"/>
                </a:cubicBezTo>
                <a:cubicBezTo>
                  <a:pt x="351" y="120"/>
                  <a:pt x="351" y="120"/>
                  <a:pt x="351" y="120"/>
                </a:cubicBezTo>
                <a:cubicBezTo>
                  <a:pt x="351" y="121"/>
                  <a:pt x="351" y="122"/>
                  <a:pt x="354" y="122"/>
                </a:cubicBezTo>
                <a:cubicBezTo>
                  <a:pt x="360" y="123"/>
                  <a:pt x="360" y="123"/>
                  <a:pt x="360" y="123"/>
                </a:cubicBezTo>
                <a:cubicBezTo>
                  <a:pt x="374" y="124"/>
                  <a:pt x="379" y="127"/>
                  <a:pt x="379" y="135"/>
                </a:cubicBezTo>
                <a:cubicBezTo>
                  <a:pt x="379" y="144"/>
                  <a:pt x="370" y="149"/>
                  <a:pt x="356" y="149"/>
                </a:cubicBezTo>
                <a:cubicBezTo>
                  <a:pt x="342" y="149"/>
                  <a:pt x="336" y="146"/>
                  <a:pt x="336" y="139"/>
                </a:cubicBezTo>
                <a:cubicBezTo>
                  <a:pt x="336" y="135"/>
                  <a:pt x="338" y="132"/>
                  <a:pt x="342" y="130"/>
                </a:cubicBezTo>
                <a:close/>
                <a:moveTo>
                  <a:pt x="352" y="103"/>
                </a:moveTo>
                <a:cubicBezTo>
                  <a:pt x="352" y="106"/>
                  <a:pt x="352" y="111"/>
                  <a:pt x="357" y="111"/>
                </a:cubicBezTo>
                <a:cubicBezTo>
                  <a:pt x="360" y="111"/>
                  <a:pt x="362" y="108"/>
                  <a:pt x="362" y="103"/>
                </a:cubicBezTo>
                <a:cubicBezTo>
                  <a:pt x="362" y="100"/>
                  <a:pt x="361" y="96"/>
                  <a:pt x="357" y="96"/>
                </a:cubicBezTo>
                <a:cubicBezTo>
                  <a:pt x="352" y="96"/>
                  <a:pt x="352" y="101"/>
                  <a:pt x="352" y="103"/>
                </a:cubicBezTo>
                <a:close/>
                <a:moveTo>
                  <a:pt x="348" y="137"/>
                </a:moveTo>
                <a:cubicBezTo>
                  <a:pt x="348" y="140"/>
                  <a:pt x="350" y="142"/>
                  <a:pt x="357" y="142"/>
                </a:cubicBezTo>
                <a:cubicBezTo>
                  <a:pt x="363" y="142"/>
                  <a:pt x="366" y="140"/>
                  <a:pt x="366" y="137"/>
                </a:cubicBezTo>
                <a:cubicBezTo>
                  <a:pt x="366" y="135"/>
                  <a:pt x="366" y="134"/>
                  <a:pt x="358" y="134"/>
                </a:cubicBezTo>
                <a:cubicBezTo>
                  <a:pt x="351" y="133"/>
                  <a:pt x="351" y="133"/>
                  <a:pt x="351" y="133"/>
                </a:cubicBezTo>
                <a:cubicBezTo>
                  <a:pt x="351" y="133"/>
                  <a:pt x="350" y="133"/>
                  <a:pt x="350" y="133"/>
                </a:cubicBezTo>
                <a:cubicBezTo>
                  <a:pt x="349" y="134"/>
                  <a:pt x="348" y="136"/>
                  <a:pt x="348" y="137"/>
                </a:cubicBezTo>
                <a:close/>
              </a:path>
            </a:pathLst>
          </a:custGeom>
          <a:solidFill>
            <a:schemeClr val="tx2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351"/>
          </a:p>
        </p:txBody>
      </p:sp>
    </p:spTree>
    <p:extLst>
      <p:ext uri="{BB962C8B-B14F-4D97-AF65-F5344CB8AC3E}">
        <p14:creationId xmlns:p14="http://schemas.microsoft.com/office/powerpoint/2010/main" val="1009804930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769949" y="6551759"/>
            <a:ext cx="3387817" cy="123111"/>
          </a:xfrm>
          <a:prstGeom prst="rect">
            <a:avLst/>
          </a:prstGeom>
        </p:spPr>
        <p:txBody>
          <a:bodyPr vert="horz" wrap="square" lIns="0" tIns="0" rIns="0" bIns="0" rtlCol="0" anchor="ctr">
            <a:spAutoFit/>
          </a:bodyPr>
          <a:lstStyle>
            <a:lvl1pPr algn="l">
              <a:defRPr sz="800"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Division Name or Footer</a:t>
            </a:r>
          </a:p>
        </p:txBody>
      </p:sp>
      <p:sp>
        <p:nvSpPr>
          <p:cNvPr id="15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202" y="6544227"/>
            <a:ext cx="254719" cy="123111"/>
          </a:xfrm>
          <a:prstGeom prst="rect">
            <a:avLst/>
          </a:prstGeom>
        </p:spPr>
        <p:txBody>
          <a:bodyPr vert="horz" wrap="square" lIns="0" tIns="0" rIns="0" bIns="0" rtlCol="0" anchor="ctr">
            <a:spAutoFit/>
          </a:bodyPr>
          <a:lstStyle>
            <a:lvl1pPr algn="l">
              <a:defRPr sz="800">
                <a:solidFill>
                  <a:schemeClr val="tx1"/>
                </a:solidFill>
              </a:defRPr>
            </a:lvl1pPr>
          </a:lstStyle>
          <a:p>
            <a:fld id="{7FEEEA1A-CB49-3744-AA40-B896987410F9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18" name="Title Placeholder 1"/>
          <p:cNvSpPr>
            <a:spLocks noGrp="1"/>
          </p:cNvSpPr>
          <p:nvPr>
            <p:ph type="title"/>
          </p:nvPr>
        </p:nvSpPr>
        <p:spPr>
          <a:xfrm>
            <a:off x="457199" y="761455"/>
            <a:ext cx="8229600" cy="313932"/>
          </a:xfrm>
          <a:prstGeom prst="rect">
            <a:avLst/>
          </a:prstGeom>
        </p:spPr>
        <p:txBody>
          <a:bodyPr vert="horz" lIns="0" tIns="0" rIns="0" bIns="0" rtlCol="0" anchor="b" anchorCtr="0">
            <a:noAutofit/>
          </a:bodyPr>
          <a:lstStyle/>
          <a:p>
            <a:pPr lvl="0"/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9" name="Content Placeholder 3"/>
          <p:cNvSpPr>
            <a:spLocks noGrp="1"/>
          </p:cNvSpPr>
          <p:nvPr>
            <p:ph sz="quarter" idx="10"/>
          </p:nvPr>
        </p:nvSpPr>
        <p:spPr>
          <a:xfrm>
            <a:off x="457199" y="1562100"/>
            <a:ext cx="3895344" cy="44958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10" name="Content Placeholder 3"/>
          <p:cNvSpPr>
            <a:spLocks noGrp="1"/>
          </p:cNvSpPr>
          <p:nvPr>
            <p:ph sz="quarter" idx="11"/>
          </p:nvPr>
        </p:nvSpPr>
        <p:spPr>
          <a:xfrm>
            <a:off x="4791456" y="1562100"/>
            <a:ext cx="3895344" cy="44958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21472903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14" name="Rectangle 25"/>
          <p:cNvSpPr>
            <a:spLocks noChangeAspect="1"/>
          </p:cNvSpPr>
          <p:nvPr/>
        </p:nvSpPr>
        <p:spPr>
          <a:xfrm rot="10800000">
            <a:off x="0" y="0"/>
            <a:ext cx="9144000" cy="1910293"/>
          </a:xfrm>
          <a:custGeom>
            <a:avLst/>
            <a:gdLst/>
            <a:ahLst/>
            <a:cxnLst/>
            <a:rect l="l" t="t" r="r" b="b"/>
            <a:pathLst>
              <a:path w="9144000" h="1432720">
                <a:moveTo>
                  <a:pt x="9144000" y="1432720"/>
                </a:moveTo>
                <a:lnTo>
                  <a:pt x="0" y="143272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rgbClr val="2D2D2D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2378355"/>
            <a:ext cx="5943600" cy="2493165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30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PRESENTATION</a:t>
            </a:r>
            <a:br>
              <a:rPr lang="en-US" dirty="0"/>
            </a:br>
            <a:r>
              <a:rPr lang="en-US" dirty="0"/>
              <a:t>TITLE HER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685800" y="5311621"/>
            <a:ext cx="5943600" cy="1063779"/>
          </a:xfrm>
        </p:spPr>
        <p:txBody>
          <a:bodyPr anchor="t" anchorCtr="0">
            <a:normAutofit/>
          </a:bodyPr>
          <a:lstStyle>
            <a:lvl1pPr marL="0" indent="0" algn="l">
              <a:spcBef>
                <a:spcPts val="0"/>
              </a:spcBef>
              <a:buNone/>
              <a:defRPr sz="1400" baseline="0">
                <a:solidFill>
                  <a:schemeClr val="bg1"/>
                </a:solidFill>
                <a:latin typeface="+mn-lt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presentation subtitle or date</a:t>
            </a:r>
          </a:p>
        </p:txBody>
      </p:sp>
      <p:sp>
        <p:nvSpPr>
          <p:cNvPr id="8" name="Text Placeholder 18"/>
          <p:cNvSpPr>
            <a:spLocks noGrp="1"/>
          </p:cNvSpPr>
          <p:nvPr>
            <p:ph type="body" sz="quarter" idx="11" hasCustomPrompt="1"/>
          </p:nvPr>
        </p:nvSpPr>
        <p:spPr>
          <a:xfrm>
            <a:off x="4570413" y="621792"/>
            <a:ext cx="4116387" cy="748912"/>
          </a:xfrm>
        </p:spPr>
        <p:txBody>
          <a:bodyPr>
            <a:normAutofit/>
          </a:bodyPr>
          <a:lstStyle>
            <a:lvl1pPr algn="r">
              <a:spcBef>
                <a:spcPts val="0"/>
              </a:spcBef>
              <a:defRPr sz="1400" baseline="0">
                <a:solidFill>
                  <a:srgbClr val="FFFFFF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Division Name</a:t>
            </a: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7089" y="404121"/>
            <a:ext cx="1360263" cy="731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35872016"/>
      </p:ext>
    </p:extLst>
  </p:cSld>
  <p:clrMapOvr>
    <a:masterClrMapping/>
  </p:clrMapOvr>
  <p:hf hdr="0" dt="0"/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837348"/>
            <a:ext cx="3886200" cy="4295968"/>
          </a:xfrm>
        </p:spPr>
        <p:txBody>
          <a:bodyPr vert="horz" lIns="0" tIns="0" rIns="0" bIns="0" rtlCol="0">
            <a:noAutofit/>
          </a:bodyPr>
          <a:lstStyle>
            <a:lvl1pPr>
              <a:defRPr lang="en-US" dirty="0"/>
            </a:lvl1pPr>
            <a:lvl2pPr>
              <a:defRPr lang="en-US" dirty="0"/>
            </a:lvl2pPr>
            <a:lvl3pPr>
              <a:defRPr lang="en-US" dirty="0"/>
            </a:lvl3pPr>
            <a:lvl4pPr>
              <a:defRPr lang="en-US" dirty="0"/>
            </a:lvl4pPr>
            <a:lvl5pPr>
              <a:defRPr lang="en-US" dirty="0"/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9" name="Text Placeholder 11"/>
          <p:cNvSpPr>
            <a:spLocks noGrp="1"/>
          </p:cNvSpPr>
          <p:nvPr>
            <p:ph type="body" sz="quarter" idx="13"/>
          </p:nvPr>
        </p:nvSpPr>
        <p:spPr>
          <a:xfrm>
            <a:off x="457200" y="1346337"/>
            <a:ext cx="3886200" cy="406265"/>
          </a:xfrm>
        </p:spPr>
        <p:txBody>
          <a:bodyPr anchor="b" anchorCtr="0">
            <a:noAutofit/>
          </a:bodyPr>
          <a:lstStyle>
            <a:lvl1pPr marL="0" indent="0">
              <a:lnSpc>
                <a:spcPct val="90000"/>
              </a:lnSpc>
              <a:buNone/>
              <a:defRPr sz="1800" b="1"/>
            </a:lvl1pPr>
            <a:lvl2pPr marL="230182" indent="0">
              <a:buNone/>
              <a:defRPr/>
            </a:lvl2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20" name="Text Placeholder 11"/>
          <p:cNvSpPr>
            <a:spLocks noGrp="1"/>
          </p:cNvSpPr>
          <p:nvPr>
            <p:ph type="body" sz="quarter" idx="14"/>
          </p:nvPr>
        </p:nvSpPr>
        <p:spPr>
          <a:xfrm>
            <a:off x="4800600" y="1346337"/>
            <a:ext cx="3886200" cy="406265"/>
          </a:xfrm>
        </p:spPr>
        <p:txBody>
          <a:bodyPr anchor="b" anchorCtr="0">
            <a:noAutofit/>
          </a:bodyPr>
          <a:lstStyle>
            <a:lvl1pPr marL="0" indent="0">
              <a:lnSpc>
                <a:spcPct val="90000"/>
              </a:lnSpc>
              <a:buNone/>
              <a:defRPr sz="1800" b="1"/>
            </a:lvl1pPr>
            <a:lvl2pPr marL="230182" indent="0">
              <a:buNone/>
              <a:defRPr/>
            </a:lvl2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21" name="Content Placeholder 2"/>
          <p:cNvSpPr>
            <a:spLocks noGrp="1"/>
          </p:cNvSpPr>
          <p:nvPr>
            <p:ph sz="half" idx="15"/>
          </p:nvPr>
        </p:nvSpPr>
        <p:spPr>
          <a:xfrm>
            <a:off x="4800600" y="1837348"/>
            <a:ext cx="3886200" cy="4295968"/>
          </a:xfrm>
        </p:spPr>
        <p:txBody>
          <a:bodyPr vert="horz" lIns="0" tIns="0" rIns="0" bIns="0" rtlCol="0">
            <a:noAutofit/>
          </a:bodyPr>
          <a:lstStyle>
            <a:lvl1pPr>
              <a:defRPr lang="en-US"/>
            </a:lvl1pPr>
            <a:lvl2pPr>
              <a:defRPr lang="en-US"/>
            </a:lvl2pPr>
            <a:lvl3pPr>
              <a:defRPr lang="en-US"/>
            </a:lvl3pPr>
            <a:lvl4pPr>
              <a:defRPr lang="en-US"/>
            </a:lvl4pPr>
            <a:lvl5pPr>
              <a:defRPr lang="en-US" dirty="0"/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2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769949" y="6551759"/>
            <a:ext cx="3387817" cy="123111"/>
          </a:xfrm>
          <a:prstGeom prst="rect">
            <a:avLst/>
          </a:prstGeom>
        </p:spPr>
        <p:txBody>
          <a:bodyPr vert="horz" wrap="square" lIns="0" tIns="0" rIns="0" bIns="0" rtlCol="0" anchor="ctr">
            <a:spAutoFit/>
          </a:bodyPr>
          <a:lstStyle>
            <a:lvl1pPr algn="l">
              <a:defRPr sz="800"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Division Name or Footer</a:t>
            </a:r>
          </a:p>
        </p:txBody>
      </p:sp>
      <p:sp>
        <p:nvSpPr>
          <p:cNvPr id="2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202" y="6544227"/>
            <a:ext cx="254719" cy="123111"/>
          </a:xfrm>
          <a:prstGeom prst="rect">
            <a:avLst/>
          </a:prstGeom>
        </p:spPr>
        <p:txBody>
          <a:bodyPr vert="horz" wrap="square" lIns="0" tIns="0" rIns="0" bIns="0" rtlCol="0" anchor="ctr">
            <a:spAutoFit/>
          </a:bodyPr>
          <a:lstStyle>
            <a:lvl1pPr algn="l">
              <a:defRPr sz="800">
                <a:solidFill>
                  <a:schemeClr val="tx1"/>
                </a:solidFill>
              </a:defRPr>
            </a:lvl1pPr>
          </a:lstStyle>
          <a:p>
            <a:fld id="{7FEEEA1A-CB49-3744-AA40-B896987410F9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27" name="Title Placeholder 1"/>
          <p:cNvSpPr>
            <a:spLocks noGrp="1"/>
          </p:cNvSpPr>
          <p:nvPr>
            <p:ph type="title"/>
          </p:nvPr>
        </p:nvSpPr>
        <p:spPr>
          <a:xfrm>
            <a:off x="457199" y="761455"/>
            <a:ext cx="8229600" cy="313932"/>
          </a:xfrm>
          <a:prstGeom prst="rect">
            <a:avLst/>
          </a:prstGeom>
        </p:spPr>
        <p:txBody>
          <a:bodyPr vert="horz" lIns="0" tIns="0" rIns="0" bIns="0" rtlCol="0" anchor="b" anchorCtr="0">
            <a:noAutofit/>
          </a:bodyPr>
          <a:lstStyle/>
          <a:p>
            <a:pPr lvl="0"/>
            <a:r>
              <a:rPr lang="en-US"/>
              <a:t>Click to edit Master 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44209338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Content with Caption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 userDrawn="1"/>
        </p:nvSpPr>
        <p:spPr>
          <a:xfrm>
            <a:off x="0" y="-20491"/>
            <a:ext cx="5088731" cy="6878491"/>
          </a:xfrm>
          <a:prstGeom prst="rect">
            <a:avLst/>
          </a:prstGeom>
          <a:solidFill>
            <a:schemeClr val="tx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10" name="Title 1"/>
          <p:cNvSpPr>
            <a:spLocks noGrp="1"/>
          </p:cNvSpPr>
          <p:nvPr>
            <p:ph type="title"/>
          </p:nvPr>
        </p:nvSpPr>
        <p:spPr>
          <a:xfrm>
            <a:off x="457202" y="1162324"/>
            <a:ext cx="4087733" cy="348813"/>
          </a:xfrm>
        </p:spPr>
        <p:txBody>
          <a:bodyPr vert="horz" lIns="0" tIns="0" rIns="0" bIns="0" rtlCol="0" anchor="b" anchorCtr="0">
            <a:noAutofit/>
          </a:bodyPr>
          <a:lstStyle>
            <a:lvl1pPr>
              <a:defRPr lang="en-US" sz="2000" b="1" i="0" kern="1200" cap="none" dirty="0">
                <a:solidFill>
                  <a:schemeClr val="bg1"/>
                </a:solidFill>
                <a:latin typeface="+mj-lt"/>
                <a:ea typeface="+mj-ea"/>
                <a:cs typeface="+mj-cs"/>
              </a:defRPr>
            </a:lvl1pPr>
          </a:lstStyle>
          <a:p>
            <a:pPr lvl="0" algn="l" defTabSz="342891" rtl="0" eaLnBrk="1" latinLnBrk="0" hangingPunct="1">
              <a:lnSpc>
                <a:spcPct val="85000"/>
              </a:lnSpc>
              <a:spcBef>
                <a:spcPct val="0"/>
              </a:spcBef>
              <a:buNone/>
            </a:pPr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3" name="Content Placeholder 12"/>
          <p:cNvSpPr>
            <a:spLocks noGrp="1"/>
          </p:cNvSpPr>
          <p:nvPr>
            <p:ph sz="quarter" idx="11"/>
          </p:nvPr>
        </p:nvSpPr>
        <p:spPr>
          <a:xfrm>
            <a:off x="457202" y="1655064"/>
            <a:ext cx="4087913" cy="4407408"/>
          </a:xfrm>
        </p:spPr>
        <p:txBody>
          <a:bodyPr/>
          <a:lstStyle>
            <a:lvl1pPr>
              <a:lnSpc>
                <a:spcPct val="100000"/>
              </a:lnSpc>
              <a:buClr>
                <a:schemeClr val="bg1"/>
              </a:buClr>
              <a:defRPr>
                <a:solidFill>
                  <a:schemeClr val="bg1"/>
                </a:solidFill>
              </a:defRPr>
            </a:lvl1pPr>
            <a:lvl2pPr>
              <a:lnSpc>
                <a:spcPct val="100000"/>
              </a:lnSpc>
              <a:buClr>
                <a:schemeClr val="bg1"/>
              </a:buClr>
              <a:defRPr>
                <a:solidFill>
                  <a:schemeClr val="bg1"/>
                </a:solidFill>
              </a:defRPr>
            </a:lvl2pPr>
            <a:lvl3pPr>
              <a:lnSpc>
                <a:spcPct val="100000"/>
              </a:lnSpc>
              <a:buClr>
                <a:schemeClr val="bg1"/>
              </a:buClr>
              <a:defRPr>
                <a:solidFill>
                  <a:schemeClr val="bg1"/>
                </a:solidFill>
              </a:defRPr>
            </a:lvl3pPr>
            <a:lvl4pPr>
              <a:lnSpc>
                <a:spcPct val="100000"/>
              </a:lnSpc>
              <a:buClr>
                <a:schemeClr val="bg1"/>
              </a:buClr>
              <a:defRPr>
                <a:solidFill>
                  <a:schemeClr val="bg1"/>
                </a:solidFill>
              </a:defRPr>
            </a:lvl4pPr>
            <a:lvl5pPr>
              <a:lnSpc>
                <a:spcPct val="100000"/>
              </a:lnSpc>
              <a:buClr>
                <a:schemeClr val="bg1"/>
              </a:buCl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4" name="Content Placeholder 12"/>
          <p:cNvSpPr>
            <a:spLocks noGrp="1"/>
          </p:cNvSpPr>
          <p:nvPr>
            <p:ph sz="quarter" idx="12" hasCustomPrompt="1"/>
          </p:nvPr>
        </p:nvSpPr>
        <p:spPr>
          <a:xfrm>
            <a:off x="5232082" y="4076701"/>
            <a:ext cx="3454719" cy="1955800"/>
          </a:xfrm>
        </p:spPr>
        <p:txBody>
          <a:bodyPr/>
          <a:lstStyle>
            <a:lvl1pPr marL="0" indent="0">
              <a:buNone/>
              <a:defRPr sz="1200" b="1">
                <a:solidFill>
                  <a:schemeClr val="tx1"/>
                </a:solidFill>
              </a:defRPr>
            </a:lvl1pPr>
            <a:lvl2pPr marL="0" indent="0">
              <a:buNone/>
              <a:defRPr sz="1200">
                <a:solidFill>
                  <a:schemeClr val="tx1"/>
                </a:solidFill>
              </a:defRPr>
            </a:lvl2pPr>
            <a:lvl3pPr marL="228594" indent="-228594">
              <a:buFont typeface="Arial" panose="020B0604020202020204" pitchFamily="34" charset="0"/>
              <a:buChar char="•"/>
              <a:defRPr sz="1200">
                <a:solidFill>
                  <a:schemeClr val="tx1"/>
                </a:solidFill>
              </a:defRPr>
            </a:lvl3pPr>
            <a:lvl4pPr marL="466332" indent="-223833">
              <a:buFont typeface="Arial" panose="020B0604020202020204" pitchFamily="34" charset="0"/>
              <a:buChar char="–"/>
              <a:defRPr sz="1200">
                <a:solidFill>
                  <a:schemeClr val="tx1"/>
                </a:solidFill>
              </a:defRPr>
            </a:lvl4pPr>
            <a:lvl5pPr marL="685783">
              <a:defRPr sz="1200">
                <a:solidFill>
                  <a:schemeClr val="tx1"/>
                </a:solidFill>
              </a:defRPr>
            </a:lvl5pPr>
          </a:lstStyle>
          <a:p>
            <a:pPr lvl="0"/>
            <a:r>
              <a:rPr lang="en-US" dirty="0"/>
              <a:t>Caption for content above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2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769949" y="6551759"/>
            <a:ext cx="3387817" cy="123111"/>
          </a:xfrm>
          <a:prstGeom prst="rect">
            <a:avLst/>
          </a:prstGeom>
        </p:spPr>
        <p:txBody>
          <a:bodyPr vert="horz" wrap="square" lIns="0" tIns="0" rIns="0" bIns="0" rtlCol="0" anchor="ctr">
            <a:spAutoFit/>
          </a:bodyPr>
          <a:lstStyle>
            <a:lvl1pPr algn="l">
              <a:defRPr sz="800">
                <a:solidFill>
                  <a:schemeClr val="bg1"/>
                </a:solidFill>
              </a:defRPr>
            </a:lvl1pPr>
          </a:lstStyle>
          <a:p>
            <a:r>
              <a:rPr lang="en-US"/>
              <a:t>Division Name or Footer</a:t>
            </a:r>
            <a:endParaRPr lang="en-US" dirty="0"/>
          </a:p>
        </p:txBody>
      </p:sp>
      <p:sp>
        <p:nvSpPr>
          <p:cNvPr id="15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202" y="6544227"/>
            <a:ext cx="254719" cy="123111"/>
          </a:xfrm>
          <a:prstGeom prst="rect">
            <a:avLst/>
          </a:prstGeom>
        </p:spPr>
        <p:txBody>
          <a:bodyPr vert="horz" wrap="square" lIns="0" tIns="0" rIns="0" bIns="0" rtlCol="0" anchor="ctr">
            <a:spAutoFit/>
          </a:bodyPr>
          <a:lstStyle>
            <a:lvl1pPr algn="l">
              <a:defRPr sz="800">
                <a:solidFill>
                  <a:schemeClr val="bg1"/>
                </a:solidFill>
              </a:defRPr>
            </a:lvl1pPr>
          </a:lstStyle>
          <a:p>
            <a:fld id="{7FEEEA1A-CB49-3744-AA40-B896987410F9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16" name="Freeform 5"/>
          <p:cNvSpPr>
            <a:spLocks noEditPoints="1"/>
          </p:cNvSpPr>
          <p:nvPr userDrawn="1"/>
        </p:nvSpPr>
        <p:spPr bwMode="auto">
          <a:xfrm>
            <a:off x="7919867" y="6350476"/>
            <a:ext cx="766764" cy="334835"/>
          </a:xfrm>
          <a:custGeom>
            <a:avLst/>
            <a:gdLst>
              <a:gd name="T0" fmla="*/ 32 w 511"/>
              <a:gd name="T1" fmla="*/ 39 h 221"/>
              <a:gd name="T2" fmla="*/ 106 w 511"/>
              <a:gd name="T3" fmla="*/ 0 h 221"/>
              <a:gd name="T4" fmla="*/ 188 w 511"/>
              <a:gd name="T5" fmla="*/ 44 h 221"/>
              <a:gd name="T6" fmla="*/ 139 w 511"/>
              <a:gd name="T7" fmla="*/ 208 h 221"/>
              <a:gd name="T8" fmla="*/ 161 w 511"/>
              <a:gd name="T9" fmla="*/ 194 h 221"/>
              <a:gd name="T10" fmla="*/ 2 w 511"/>
              <a:gd name="T11" fmla="*/ 101 h 221"/>
              <a:gd name="T12" fmla="*/ 91 w 511"/>
              <a:gd name="T13" fmla="*/ 70 h 221"/>
              <a:gd name="T14" fmla="*/ 123 w 511"/>
              <a:gd name="T15" fmla="*/ 108 h 221"/>
              <a:gd name="T16" fmla="*/ 208 w 511"/>
              <a:gd name="T17" fmla="*/ 70 h 221"/>
              <a:gd name="T18" fmla="*/ 73 w 511"/>
              <a:gd name="T19" fmla="*/ 70 h 221"/>
              <a:gd name="T20" fmla="*/ 53 w 511"/>
              <a:gd name="T21" fmla="*/ 96 h 221"/>
              <a:gd name="T22" fmla="*/ 54 w 511"/>
              <a:gd name="T23" fmla="*/ 70 h 221"/>
              <a:gd name="T24" fmla="*/ 144 w 511"/>
              <a:gd name="T25" fmla="*/ 70 h 221"/>
              <a:gd name="T26" fmla="*/ 175 w 511"/>
              <a:gd name="T27" fmla="*/ 70 h 221"/>
              <a:gd name="T28" fmla="*/ 267 w 511"/>
              <a:gd name="T29" fmla="*/ 206 h 221"/>
              <a:gd name="T30" fmla="*/ 267 w 511"/>
              <a:gd name="T31" fmla="*/ 193 h 221"/>
              <a:gd name="T32" fmla="*/ 259 w 511"/>
              <a:gd name="T33" fmla="*/ 199 h 221"/>
              <a:gd name="T34" fmla="*/ 416 w 511"/>
              <a:gd name="T35" fmla="*/ 92 h 221"/>
              <a:gd name="T36" fmla="*/ 402 w 511"/>
              <a:gd name="T37" fmla="*/ 86 h 221"/>
              <a:gd name="T38" fmla="*/ 402 w 511"/>
              <a:gd name="T39" fmla="*/ 123 h 221"/>
              <a:gd name="T40" fmla="*/ 397 w 511"/>
              <a:gd name="T41" fmla="*/ 184 h 221"/>
              <a:gd name="T42" fmla="*/ 373 w 511"/>
              <a:gd name="T43" fmla="*/ 152 h 221"/>
              <a:gd name="T44" fmla="*/ 511 w 511"/>
              <a:gd name="T45" fmla="*/ 124 h 221"/>
              <a:gd name="T46" fmla="*/ 511 w 511"/>
              <a:gd name="T47" fmla="*/ 111 h 221"/>
              <a:gd name="T48" fmla="*/ 503 w 511"/>
              <a:gd name="T49" fmla="*/ 117 h 221"/>
              <a:gd name="T50" fmla="*/ 487 w 511"/>
              <a:gd name="T51" fmla="*/ 105 h 221"/>
              <a:gd name="T52" fmla="*/ 450 w 511"/>
              <a:gd name="T53" fmla="*/ 98 h 221"/>
              <a:gd name="T54" fmla="*/ 443 w 511"/>
              <a:gd name="T55" fmla="*/ 87 h 221"/>
              <a:gd name="T56" fmla="*/ 366 w 511"/>
              <a:gd name="T57" fmla="*/ 169 h 221"/>
              <a:gd name="T58" fmla="*/ 365 w 511"/>
              <a:gd name="T59" fmla="*/ 205 h 221"/>
              <a:gd name="T60" fmla="*/ 343 w 511"/>
              <a:gd name="T61" fmla="*/ 203 h 221"/>
              <a:gd name="T62" fmla="*/ 343 w 511"/>
              <a:gd name="T63" fmla="*/ 156 h 221"/>
              <a:gd name="T64" fmla="*/ 318 w 511"/>
              <a:gd name="T65" fmla="*/ 133 h 221"/>
              <a:gd name="T66" fmla="*/ 294 w 511"/>
              <a:gd name="T67" fmla="*/ 133 h 221"/>
              <a:gd name="T68" fmla="*/ 332 w 511"/>
              <a:gd name="T69" fmla="*/ 98 h 221"/>
              <a:gd name="T70" fmla="*/ 271 w 511"/>
              <a:gd name="T71" fmla="*/ 103 h 221"/>
              <a:gd name="T72" fmla="*/ 249 w 511"/>
              <a:gd name="T73" fmla="*/ 94 h 221"/>
              <a:gd name="T74" fmla="*/ 286 w 511"/>
              <a:gd name="T75" fmla="*/ 132 h 221"/>
              <a:gd name="T76" fmla="*/ 261 w 511"/>
              <a:gd name="T77" fmla="*/ 119 h 221"/>
              <a:gd name="T78" fmla="*/ 311 w 511"/>
              <a:gd name="T79" fmla="*/ 215 h 221"/>
              <a:gd name="T80" fmla="*/ 272 w 511"/>
              <a:gd name="T81" fmla="*/ 203 h 221"/>
              <a:gd name="T82" fmla="*/ 280 w 511"/>
              <a:gd name="T83" fmla="*/ 184 h 221"/>
              <a:gd name="T84" fmla="*/ 309 w 511"/>
              <a:gd name="T85" fmla="*/ 203 h 221"/>
              <a:gd name="T86" fmla="*/ 296 w 511"/>
              <a:gd name="T87" fmla="*/ 201 h 221"/>
              <a:gd name="T88" fmla="*/ 318 w 511"/>
              <a:gd name="T89" fmla="*/ 215 h 221"/>
              <a:gd name="T90" fmla="*/ 208 w 511"/>
              <a:gd name="T91" fmla="*/ 215 h 221"/>
              <a:gd name="T92" fmla="*/ 174 w 511"/>
              <a:gd name="T93" fmla="*/ 153 h 221"/>
              <a:gd name="T94" fmla="*/ 342 w 511"/>
              <a:gd name="T95" fmla="*/ 130 h 221"/>
              <a:gd name="T96" fmla="*/ 370 w 511"/>
              <a:gd name="T97" fmla="*/ 90 h 221"/>
              <a:gd name="T98" fmla="*/ 374 w 511"/>
              <a:gd name="T99" fmla="*/ 98 h 221"/>
              <a:gd name="T100" fmla="*/ 354 w 511"/>
              <a:gd name="T101" fmla="*/ 122 h 221"/>
              <a:gd name="T102" fmla="*/ 342 w 511"/>
              <a:gd name="T103" fmla="*/ 130 h 221"/>
              <a:gd name="T104" fmla="*/ 352 w 511"/>
              <a:gd name="T105" fmla="*/ 103 h 221"/>
              <a:gd name="T106" fmla="*/ 351 w 511"/>
              <a:gd name="T107" fmla="*/ 133 h 2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</a:cxnLst>
            <a:rect l="0" t="0" r="r" b="b"/>
            <a:pathLst>
              <a:path w="511" h="221">
                <a:moveTo>
                  <a:pt x="188" y="44"/>
                </a:moveTo>
                <a:cubicBezTo>
                  <a:pt x="188" y="44"/>
                  <a:pt x="187" y="44"/>
                  <a:pt x="186" y="43"/>
                </a:cubicBezTo>
                <a:cubicBezTo>
                  <a:pt x="185" y="42"/>
                  <a:pt x="179" y="36"/>
                  <a:pt x="169" y="30"/>
                </a:cubicBezTo>
                <a:cubicBezTo>
                  <a:pt x="159" y="24"/>
                  <a:pt x="137" y="13"/>
                  <a:pt x="107" y="13"/>
                </a:cubicBezTo>
                <a:cubicBezTo>
                  <a:pt x="71" y="13"/>
                  <a:pt x="47" y="27"/>
                  <a:pt x="32" y="39"/>
                </a:cubicBezTo>
                <a:cubicBezTo>
                  <a:pt x="18" y="51"/>
                  <a:pt x="11" y="65"/>
                  <a:pt x="11" y="66"/>
                </a:cubicBezTo>
                <a:cubicBezTo>
                  <a:pt x="11" y="66"/>
                  <a:pt x="11" y="66"/>
                  <a:pt x="10" y="66"/>
                </a:cubicBezTo>
                <a:cubicBezTo>
                  <a:pt x="10" y="66"/>
                  <a:pt x="10" y="66"/>
                  <a:pt x="10" y="66"/>
                </a:cubicBezTo>
                <a:cubicBezTo>
                  <a:pt x="11" y="65"/>
                  <a:pt x="17" y="49"/>
                  <a:pt x="30" y="35"/>
                </a:cubicBezTo>
                <a:cubicBezTo>
                  <a:pt x="43" y="20"/>
                  <a:pt x="69" y="0"/>
                  <a:pt x="106" y="0"/>
                </a:cubicBezTo>
                <a:cubicBezTo>
                  <a:pt x="142" y="0"/>
                  <a:pt x="165" y="19"/>
                  <a:pt x="173" y="26"/>
                </a:cubicBezTo>
                <a:cubicBezTo>
                  <a:pt x="180" y="33"/>
                  <a:pt x="186" y="41"/>
                  <a:pt x="187" y="42"/>
                </a:cubicBezTo>
                <a:cubicBezTo>
                  <a:pt x="188" y="43"/>
                  <a:pt x="188" y="44"/>
                  <a:pt x="188" y="44"/>
                </a:cubicBezTo>
                <a:cubicBezTo>
                  <a:pt x="188" y="44"/>
                  <a:pt x="188" y="44"/>
                  <a:pt x="188" y="44"/>
                </a:cubicBezTo>
                <a:cubicBezTo>
                  <a:pt x="188" y="44"/>
                  <a:pt x="188" y="44"/>
                  <a:pt x="188" y="44"/>
                </a:cubicBezTo>
                <a:close/>
                <a:moveTo>
                  <a:pt x="1" y="101"/>
                </a:moveTo>
                <a:cubicBezTo>
                  <a:pt x="1" y="101"/>
                  <a:pt x="1" y="101"/>
                  <a:pt x="1" y="102"/>
                </a:cubicBezTo>
                <a:cubicBezTo>
                  <a:pt x="1" y="103"/>
                  <a:pt x="0" y="117"/>
                  <a:pt x="3" y="134"/>
                </a:cubicBezTo>
                <a:cubicBezTo>
                  <a:pt x="8" y="157"/>
                  <a:pt x="22" y="186"/>
                  <a:pt x="54" y="203"/>
                </a:cubicBezTo>
                <a:cubicBezTo>
                  <a:pt x="87" y="221"/>
                  <a:pt x="120" y="216"/>
                  <a:pt x="139" y="208"/>
                </a:cubicBezTo>
                <a:cubicBezTo>
                  <a:pt x="153" y="202"/>
                  <a:pt x="157" y="198"/>
                  <a:pt x="159" y="196"/>
                </a:cubicBezTo>
                <a:cubicBezTo>
                  <a:pt x="160" y="196"/>
                  <a:pt x="161" y="195"/>
                  <a:pt x="161" y="195"/>
                </a:cubicBezTo>
                <a:cubicBezTo>
                  <a:pt x="162" y="194"/>
                  <a:pt x="162" y="194"/>
                  <a:pt x="162" y="194"/>
                </a:cubicBezTo>
                <a:cubicBezTo>
                  <a:pt x="162" y="194"/>
                  <a:pt x="162" y="194"/>
                  <a:pt x="162" y="194"/>
                </a:cubicBezTo>
                <a:cubicBezTo>
                  <a:pt x="162" y="194"/>
                  <a:pt x="162" y="194"/>
                  <a:pt x="161" y="194"/>
                </a:cubicBezTo>
                <a:cubicBezTo>
                  <a:pt x="160" y="195"/>
                  <a:pt x="146" y="201"/>
                  <a:pt x="129" y="203"/>
                </a:cubicBezTo>
                <a:cubicBezTo>
                  <a:pt x="111" y="205"/>
                  <a:pt x="87" y="204"/>
                  <a:pt x="62" y="191"/>
                </a:cubicBezTo>
                <a:cubicBezTo>
                  <a:pt x="36" y="178"/>
                  <a:pt x="19" y="158"/>
                  <a:pt x="10" y="139"/>
                </a:cubicBezTo>
                <a:cubicBezTo>
                  <a:pt x="1" y="120"/>
                  <a:pt x="2" y="103"/>
                  <a:pt x="2" y="102"/>
                </a:cubicBezTo>
                <a:cubicBezTo>
                  <a:pt x="2" y="101"/>
                  <a:pt x="2" y="101"/>
                  <a:pt x="2" y="101"/>
                </a:cubicBezTo>
                <a:cubicBezTo>
                  <a:pt x="2" y="101"/>
                  <a:pt x="2" y="101"/>
                  <a:pt x="2" y="101"/>
                </a:cubicBezTo>
                <a:cubicBezTo>
                  <a:pt x="2" y="101"/>
                  <a:pt x="1" y="101"/>
                  <a:pt x="1" y="101"/>
                </a:cubicBezTo>
                <a:close/>
                <a:moveTo>
                  <a:pt x="108" y="133"/>
                </a:moveTo>
                <a:cubicBezTo>
                  <a:pt x="108" y="108"/>
                  <a:pt x="108" y="108"/>
                  <a:pt x="108" y="108"/>
                </a:cubicBezTo>
                <a:cubicBezTo>
                  <a:pt x="91" y="70"/>
                  <a:pt x="91" y="70"/>
                  <a:pt x="91" y="70"/>
                </a:cubicBezTo>
                <a:cubicBezTo>
                  <a:pt x="105" y="70"/>
                  <a:pt x="105" y="70"/>
                  <a:pt x="105" y="70"/>
                </a:cubicBezTo>
                <a:cubicBezTo>
                  <a:pt x="116" y="95"/>
                  <a:pt x="116" y="95"/>
                  <a:pt x="116" y="95"/>
                </a:cubicBezTo>
                <a:cubicBezTo>
                  <a:pt x="127" y="70"/>
                  <a:pt x="127" y="70"/>
                  <a:pt x="127" y="70"/>
                </a:cubicBezTo>
                <a:cubicBezTo>
                  <a:pt x="140" y="70"/>
                  <a:pt x="140" y="70"/>
                  <a:pt x="140" y="70"/>
                </a:cubicBezTo>
                <a:cubicBezTo>
                  <a:pt x="123" y="108"/>
                  <a:pt x="123" y="108"/>
                  <a:pt x="123" y="108"/>
                </a:cubicBezTo>
                <a:cubicBezTo>
                  <a:pt x="123" y="133"/>
                  <a:pt x="123" y="133"/>
                  <a:pt x="123" y="133"/>
                </a:cubicBezTo>
                <a:lnTo>
                  <a:pt x="108" y="133"/>
                </a:lnTo>
                <a:close/>
                <a:moveTo>
                  <a:pt x="241" y="133"/>
                </a:moveTo>
                <a:cubicBezTo>
                  <a:pt x="208" y="133"/>
                  <a:pt x="208" y="133"/>
                  <a:pt x="208" y="133"/>
                </a:cubicBezTo>
                <a:cubicBezTo>
                  <a:pt x="208" y="70"/>
                  <a:pt x="208" y="70"/>
                  <a:pt x="208" y="70"/>
                </a:cubicBezTo>
                <a:cubicBezTo>
                  <a:pt x="222" y="70"/>
                  <a:pt x="222" y="70"/>
                  <a:pt x="222" y="70"/>
                </a:cubicBezTo>
                <a:cubicBezTo>
                  <a:pt x="222" y="121"/>
                  <a:pt x="222" y="121"/>
                  <a:pt x="222" y="121"/>
                </a:cubicBezTo>
                <a:cubicBezTo>
                  <a:pt x="241" y="121"/>
                  <a:pt x="241" y="121"/>
                  <a:pt x="241" y="121"/>
                </a:cubicBezTo>
                <a:lnTo>
                  <a:pt x="241" y="133"/>
                </a:lnTo>
                <a:close/>
                <a:moveTo>
                  <a:pt x="73" y="70"/>
                </a:moveTo>
                <a:cubicBezTo>
                  <a:pt x="86" y="70"/>
                  <a:pt x="86" y="70"/>
                  <a:pt x="86" y="70"/>
                </a:cubicBezTo>
                <a:cubicBezTo>
                  <a:pt x="86" y="133"/>
                  <a:pt x="86" y="133"/>
                  <a:pt x="86" y="133"/>
                </a:cubicBezTo>
                <a:cubicBezTo>
                  <a:pt x="73" y="133"/>
                  <a:pt x="73" y="133"/>
                  <a:pt x="73" y="133"/>
                </a:cubicBezTo>
                <a:cubicBezTo>
                  <a:pt x="73" y="133"/>
                  <a:pt x="73" y="133"/>
                  <a:pt x="73" y="133"/>
                </a:cubicBezTo>
                <a:cubicBezTo>
                  <a:pt x="73" y="131"/>
                  <a:pt x="57" y="104"/>
                  <a:pt x="53" y="96"/>
                </a:cubicBezTo>
                <a:cubicBezTo>
                  <a:pt x="53" y="133"/>
                  <a:pt x="53" y="133"/>
                  <a:pt x="53" y="133"/>
                </a:cubicBezTo>
                <a:cubicBezTo>
                  <a:pt x="40" y="133"/>
                  <a:pt x="40" y="133"/>
                  <a:pt x="40" y="133"/>
                </a:cubicBezTo>
                <a:cubicBezTo>
                  <a:pt x="40" y="70"/>
                  <a:pt x="40" y="70"/>
                  <a:pt x="40" y="70"/>
                </a:cubicBezTo>
                <a:cubicBezTo>
                  <a:pt x="54" y="70"/>
                  <a:pt x="54" y="70"/>
                  <a:pt x="54" y="70"/>
                </a:cubicBezTo>
                <a:cubicBezTo>
                  <a:pt x="54" y="70"/>
                  <a:pt x="54" y="70"/>
                  <a:pt x="54" y="70"/>
                </a:cubicBezTo>
                <a:cubicBezTo>
                  <a:pt x="55" y="71"/>
                  <a:pt x="69" y="97"/>
                  <a:pt x="73" y="106"/>
                </a:cubicBezTo>
                <a:lnTo>
                  <a:pt x="73" y="70"/>
                </a:lnTo>
                <a:close/>
                <a:moveTo>
                  <a:pt x="166" y="134"/>
                </a:moveTo>
                <a:cubicBezTo>
                  <a:pt x="152" y="134"/>
                  <a:pt x="144" y="126"/>
                  <a:pt x="144" y="111"/>
                </a:cubicBezTo>
                <a:cubicBezTo>
                  <a:pt x="144" y="70"/>
                  <a:pt x="144" y="70"/>
                  <a:pt x="144" y="70"/>
                </a:cubicBezTo>
                <a:cubicBezTo>
                  <a:pt x="158" y="70"/>
                  <a:pt x="158" y="70"/>
                  <a:pt x="158" y="70"/>
                </a:cubicBezTo>
                <a:cubicBezTo>
                  <a:pt x="158" y="110"/>
                  <a:pt x="158" y="110"/>
                  <a:pt x="158" y="110"/>
                </a:cubicBezTo>
                <a:cubicBezTo>
                  <a:pt x="158" y="119"/>
                  <a:pt x="161" y="122"/>
                  <a:pt x="167" y="122"/>
                </a:cubicBezTo>
                <a:cubicBezTo>
                  <a:pt x="172" y="122"/>
                  <a:pt x="175" y="118"/>
                  <a:pt x="175" y="110"/>
                </a:cubicBezTo>
                <a:cubicBezTo>
                  <a:pt x="175" y="70"/>
                  <a:pt x="175" y="70"/>
                  <a:pt x="175" y="70"/>
                </a:cubicBezTo>
                <a:cubicBezTo>
                  <a:pt x="188" y="70"/>
                  <a:pt x="188" y="70"/>
                  <a:pt x="188" y="70"/>
                </a:cubicBezTo>
                <a:cubicBezTo>
                  <a:pt x="188" y="111"/>
                  <a:pt x="188" y="111"/>
                  <a:pt x="188" y="111"/>
                </a:cubicBezTo>
                <a:cubicBezTo>
                  <a:pt x="188" y="126"/>
                  <a:pt x="181" y="134"/>
                  <a:pt x="166" y="134"/>
                </a:cubicBezTo>
                <a:close/>
                <a:moveTo>
                  <a:pt x="259" y="199"/>
                </a:moveTo>
                <a:cubicBezTo>
                  <a:pt x="267" y="206"/>
                  <a:pt x="267" y="206"/>
                  <a:pt x="267" y="206"/>
                </a:cubicBezTo>
                <a:cubicBezTo>
                  <a:pt x="267" y="206"/>
                  <a:pt x="267" y="206"/>
                  <a:pt x="267" y="206"/>
                </a:cubicBezTo>
                <a:cubicBezTo>
                  <a:pt x="263" y="213"/>
                  <a:pt x="257" y="216"/>
                  <a:pt x="249" y="216"/>
                </a:cubicBezTo>
                <a:cubicBezTo>
                  <a:pt x="236" y="216"/>
                  <a:pt x="229" y="207"/>
                  <a:pt x="229" y="192"/>
                </a:cubicBezTo>
                <a:cubicBezTo>
                  <a:pt x="229" y="174"/>
                  <a:pt x="239" y="168"/>
                  <a:pt x="249" y="168"/>
                </a:cubicBezTo>
                <a:cubicBezTo>
                  <a:pt x="261" y="168"/>
                  <a:pt x="267" y="177"/>
                  <a:pt x="267" y="193"/>
                </a:cubicBezTo>
                <a:cubicBezTo>
                  <a:pt x="267" y="196"/>
                  <a:pt x="267" y="196"/>
                  <a:pt x="267" y="196"/>
                </a:cubicBezTo>
                <a:cubicBezTo>
                  <a:pt x="242" y="196"/>
                  <a:pt x="242" y="196"/>
                  <a:pt x="242" y="196"/>
                </a:cubicBezTo>
                <a:cubicBezTo>
                  <a:pt x="243" y="202"/>
                  <a:pt x="245" y="205"/>
                  <a:pt x="250" y="205"/>
                </a:cubicBezTo>
                <a:cubicBezTo>
                  <a:pt x="254" y="205"/>
                  <a:pt x="257" y="202"/>
                  <a:pt x="259" y="200"/>
                </a:cubicBezTo>
                <a:lnTo>
                  <a:pt x="259" y="199"/>
                </a:lnTo>
                <a:close/>
                <a:moveTo>
                  <a:pt x="242" y="187"/>
                </a:moveTo>
                <a:cubicBezTo>
                  <a:pt x="255" y="187"/>
                  <a:pt x="255" y="187"/>
                  <a:pt x="255" y="187"/>
                </a:cubicBezTo>
                <a:cubicBezTo>
                  <a:pt x="254" y="179"/>
                  <a:pt x="250" y="179"/>
                  <a:pt x="249" y="179"/>
                </a:cubicBezTo>
                <a:cubicBezTo>
                  <a:pt x="245" y="179"/>
                  <a:pt x="243" y="182"/>
                  <a:pt x="242" y="187"/>
                </a:cubicBezTo>
                <a:close/>
                <a:moveTo>
                  <a:pt x="416" y="92"/>
                </a:moveTo>
                <a:cubicBezTo>
                  <a:pt x="420" y="96"/>
                  <a:pt x="422" y="102"/>
                  <a:pt x="422" y="110"/>
                </a:cubicBezTo>
                <a:cubicBezTo>
                  <a:pt x="422" y="128"/>
                  <a:pt x="412" y="134"/>
                  <a:pt x="402" y="134"/>
                </a:cubicBezTo>
                <a:cubicBezTo>
                  <a:pt x="392" y="134"/>
                  <a:pt x="382" y="128"/>
                  <a:pt x="382" y="110"/>
                </a:cubicBezTo>
                <a:cubicBezTo>
                  <a:pt x="382" y="102"/>
                  <a:pt x="384" y="96"/>
                  <a:pt x="388" y="92"/>
                </a:cubicBezTo>
                <a:cubicBezTo>
                  <a:pt x="392" y="88"/>
                  <a:pt x="396" y="86"/>
                  <a:pt x="402" y="86"/>
                </a:cubicBezTo>
                <a:cubicBezTo>
                  <a:pt x="408" y="86"/>
                  <a:pt x="413" y="88"/>
                  <a:pt x="416" y="92"/>
                </a:cubicBezTo>
                <a:close/>
                <a:moveTo>
                  <a:pt x="409" y="110"/>
                </a:moveTo>
                <a:cubicBezTo>
                  <a:pt x="409" y="99"/>
                  <a:pt x="405" y="97"/>
                  <a:pt x="402" y="97"/>
                </a:cubicBezTo>
                <a:cubicBezTo>
                  <a:pt x="398" y="97"/>
                  <a:pt x="396" y="101"/>
                  <a:pt x="396" y="110"/>
                </a:cubicBezTo>
                <a:cubicBezTo>
                  <a:pt x="396" y="122"/>
                  <a:pt x="399" y="123"/>
                  <a:pt x="402" y="123"/>
                </a:cubicBezTo>
                <a:cubicBezTo>
                  <a:pt x="407" y="123"/>
                  <a:pt x="409" y="119"/>
                  <a:pt x="409" y="110"/>
                </a:cubicBezTo>
                <a:close/>
                <a:moveTo>
                  <a:pt x="410" y="180"/>
                </a:moveTo>
                <a:cubicBezTo>
                  <a:pt x="410" y="215"/>
                  <a:pt x="410" y="215"/>
                  <a:pt x="410" y="215"/>
                </a:cubicBezTo>
                <a:cubicBezTo>
                  <a:pt x="397" y="215"/>
                  <a:pt x="397" y="215"/>
                  <a:pt x="397" y="215"/>
                </a:cubicBezTo>
                <a:cubicBezTo>
                  <a:pt x="397" y="184"/>
                  <a:pt x="397" y="184"/>
                  <a:pt x="397" y="184"/>
                </a:cubicBezTo>
                <a:cubicBezTo>
                  <a:pt x="397" y="180"/>
                  <a:pt x="395" y="180"/>
                  <a:pt x="393" y="180"/>
                </a:cubicBezTo>
                <a:cubicBezTo>
                  <a:pt x="391" y="180"/>
                  <a:pt x="389" y="181"/>
                  <a:pt x="386" y="183"/>
                </a:cubicBezTo>
                <a:cubicBezTo>
                  <a:pt x="386" y="215"/>
                  <a:pt x="386" y="215"/>
                  <a:pt x="386" y="215"/>
                </a:cubicBezTo>
                <a:cubicBezTo>
                  <a:pt x="373" y="215"/>
                  <a:pt x="373" y="215"/>
                  <a:pt x="373" y="215"/>
                </a:cubicBezTo>
                <a:cubicBezTo>
                  <a:pt x="373" y="152"/>
                  <a:pt x="373" y="152"/>
                  <a:pt x="373" y="152"/>
                </a:cubicBezTo>
                <a:cubicBezTo>
                  <a:pt x="386" y="150"/>
                  <a:pt x="386" y="150"/>
                  <a:pt x="386" y="150"/>
                </a:cubicBezTo>
                <a:cubicBezTo>
                  <a:pt x="386" y="174"/>
                  <a:pt x="386" y="174"/>
                  <a:pt x="386" y="174"/>
                </a:cubicBezTo>
                <a:cubicBezTo>
                  <a:pt x="389" y="171"/>
                  <a:pt x="393" y="168"/>
                  <a:pt x="399" y="168"/>
                </a:cubicBezTo>
                <a:cubicBezTo>
                  <a:pt x="406" y="168"/>
                  <a:pt x="410" y="172"/>
                  <a:pt x="410" y="180"/>
                </a:cubicBezTo>
                <a:close/>
                <a:moveTo>
                  <a:pt x="511" y="124"/>
                </a:moveTo>
                <a:cubicBezTo>
                  <a:pt x="511" y="124"/>
                  <a:pt x="511" y="124"/>
                  <a:pt x="511" y="124"/>
                </a:cubicBezTo>
                <a:cubicBezTo>
                  <a:pt x="507" y="131"/>
                  <a:pt x="501" y="134"/>
                  <a:pt x="493" y="134"/>
                </a:cubicBezTo>
                <a:cubicBezTo>
                  <a:pt x="480" y="134"/>
                  <a:pt x="473" y="125"/>
                  <a:pt x="473" y="110"/>
                </a:cubicBezTo>
                <a:cubicBezTo>
                  <a:pt x="473" y="92"/>
                  <a:pt x="484" y="86"/>
                  <a:pt x="493" y="86"/>
                </a:cubicBezTo>
                <a:cubicBezTo>
                  <a:pt x="505" y="86"/>
                  <a:pt x="511" y="95"/>
                  <a:pt x="511" y="111"/>
                </a:cubicBezTo>
                <a:cubicBezTo>
                  <a:pt x="511" y="114"/>
                  <a:pt x="511" y="114"/>
                  <a:pt x="511" y="114"/>
                </a:cubicBezTo>
                <a:cubicBezTo>
                  <a:pt x="486" y="114"/>
                  <a:pt x="486" y="114"/>
                  <a:pt x="486" y="114"/>
                </a:cubicBezTo>
                <a:cubicBezTo>
                  <a:pt x="487" y="120"/>
                  <a:pt x="489" y="123"/>
                  <a:pt x="494" y="123"/>
                </a:cubicBezTo>
                <a:cubicBezTo>
                  <a:pt x="498" y="123"/>
                  <a:pt x="501" y="120"/>
                  <a:pt x="503" y="118"/>
                </a:cubicBezTo>
                <a:cubicBezTo>
                  <a:pt x="503" y="117"/>
                  <a:pt x="503" y="117"/>
                  <a:pt x="503" y="117"/>
                </a:cubicBezTo>
                <a:lnTo>
                  <a:pt x="511" y="124"/>
                </a:lnTo>
                <a:close/>
                <a:moveTo>
                  <a:pt x="487" y="105"/>
                </a:moveTo>
                <a:cubicBezTo>
                  <a:pt x="499" y="105"/>
                  <a:pt x="499" y="105"/>
                  <a:pt x="499" y="105"/>
                </a:cubicBezTo>
                <a:cubicBezTo>
                  <a:pt x="498" y="97"/>
                  <a:pt x="494" y="97"/>
                  <a:pt x="493" y="97"/>
                </a:cubicBezTo>
                <a:cubicBezTo>
                  <a:pt x="489" y="97"/>
                  <a:pt x="487" y="100"/>
                  <a:pt x="487" y="105"/>
                </a:cubicBezTo>
                <a:close/>
                <a:moveTo>
                  <a:pt x="467" y="98"/>
                </a:moveTo>
                <a:cubicBezTo>
                  <a:pt x="467" y="133"/>
                  <a:pt x="467" y="133"/>
                  <a:pt x="467" y="133"/>
                </a:cubicBezTo>
                <a:cubicBezTo>
                  <a:pt x="453" y="133"/>
                  <a:pt x="453" y="133"/>
                  <a:pt x="453" y="133"/>
                </a:cubicBezTo>
                <a:cubicBezTo>
                  <a:pt x="453" y="102"/>
                  <a:pt x="453" y="102"/>
                  <a:pt x="453" y="102"/>
                </a:cubicBezTo>
                <a:cubicBezTo>
                  <a:pt x="453" y="98"/>
                  <a:pt x="452" y="98"/>
                  <a:pt x="450" y="98"/>
                </a:cubicBezTo>
                <a:cubicBezTo>
                  <a:pt x="448" y="98"/>
                  <a:pt x="445" y="99"/>
                  <a:pt x="443" y="102"/>
                </a:cubicBezTo>
                <a:cubicBezTo>
                  <a:pt x="443" y="133"/>
                  <a:pt x="443" y="133"/>
                  <a:pt x="443" y="133"/>
                </a:cubicBezTo>
                <a:cubicBezTo>
                  <a:pt x="429" y="133"/>
                  <a:pt x="429" y="133"/>
                  <a:pt x="429" y="133"/>
                </a:cubicBezTo>
                <a:cubicBezTo>
                  <a:pt x="429" y="87"/>
                  <a:pt x="429" y="87"/>
                  <a:pt x="429" y="87"/>
                </a:cubicBezTo>
                <a:cubicBezTo>
                  <a:pt x="443" y="87"/>
                  <a:pt x="443" y="87"/>
                  <a:pt x="443" y="87"/>
                </a:cubicBezTo>
                <a:cubicBezTo>
                  <a:pt x="443" y="92"/>
                  <a:pt x="443" y="92"/>
                  <a:pt x="443" y="92"/>
                </a:cubicBezTo>
                <a:cubicBezTo>
                  <a:pt x="445" y="89"/>
                  <a:pt x="450" y="86"/>
                  <a:pt x="455" y="86"/>
                </a:cubicBezTo>
                <a:cubicBezTo>
                  <a:pt x="463" y="86"/>
                  <a:pt x="467" y="90"/>
                  <a:pt x="467" y="98"/>
                </a:cubicBezTo>
                <a:close/>
                <a:moveTo>
                  <a:pt x="357" y="169"/>
                </a:moveTo>
                <a:cubicBezTo>
                  <a:pt x="366" y="169"/>
                  <a:pt x="366" y="169"/>
                  <a:pt x="366" y="169"/>
                </a:cubicBezTo>
                <a:cubicBezTo>
                  <a:pt x="366" y="179"/>
                  <a:pt x="366" y="179"/>
                  <a:pt x="366" y="179"/>
                </a:cubicBezTo>
                <a:cubicBezTo>
                  <a:pt x="357" y="179"/>
                  <a:pt x="357" y="179"/>
                  <a:pt x="357" y="179"/>
                </a:cubicBezTo>
                <a:cubicBezTo>
                  <a:pt x="357" y="200"/>
                  <a:pt x="357" y="200"/>
                  <a:pt x="357" y="200"/>
                </a:cubicBezTo>
                <a:cubicBezTo>
                  <a:pt x="357" y="204"/>
                  <a:pt x="358" y="205"/>
                  <a:pt x="361" y="205"/>
                </a:cubicBezTo>
                <a:cubicBezTo>
                  <a:pt x="363" y="205"/>
                  <a:pt x="364" y="205"/>
                  <a:pt x="365" y="205"/>
                </a:cubicBezTo>
                <a:cubicBezTo>
                  <a:pt x="366" y="204"/>
                  <a:pt x="366" y="204"/>
                  <a:pt x="366" y="204"/>
                </a:cubicBezTo>
                <a:cubicBezTo>
                  <a:pt x="366" y="215"/>
                  <a:pt x="366" y="215"/>
                  <a:pt x="366" y="215"/>
                </a:cubicBezTo>
                <a:cubicBezTo>
                  <a:pt x="365" y="215"/>
                  <a:pt x="365" y="215"/>
                  <a:pt x="365" y="215"/>
                </a:cubicBezTo>
                <a:cubicBezTo>
                  <a:pt x="364" y="215"/>
                  <a:pt x="360" y="215"/>
                  <a:pt x="357" y="215"/>
                </a:cubicBezTo>
                <a:cubicBezTo>
                  <a:pt x="347" y="215"/>
                  <a:pt x="343" y="212"/>
                  <a:pt x="343" y="203"/>
                </a:cubicBezTo>
                <a:cubicBezTo>
                  <a:pt x="343" y="179"/>
                  <a:pt x="343" y="179"/>
                  <a:pt x="343" y="179"/>
                </a:cubicBezTo>
                <a:cubicBezTo>
                  <a:pt x="337" y="179"/>
                  <a:pt x="337" y="179"/>
                  <a:pt x="337" y="179"/>
                </a:cubicBezTo>
                <a:cubicBezTo>
                  <a:pt x="337" y="169"/>
                  <a:pt x="337" y="169"/>
                  <a:pt x="337" y="169"/>
                </a:cubicBezTo>
                <a:cubicBezTo>
                  <a:pt x="343" y="169"/>
                  <a:pt x="343" y="169"/>
                  <a:pt x="343" y="169"/>
                </a:cubicBezTo>
                <a:cubicBezTo>
                  <a:pt x="343" y="156"/>
                  <a:pt x="343" y="156"/>
                  <a:pt x="343" y="156"/>
                </a:cubicBezTo>
                <a:cubicBezTo>
                  <a:pt x="357" y="154"/>
                  <a:pt x="357" y="154"/>
                  <a:pt x="357" y="154"/>
                </a:cubicBezTo>
                <a:lnTo>
                  <a:pt x="357" y="169"/>
                </a:lnTo>
                <a:close/>
                <a:moveTo>
                  <a:pt x="332" y="98"/>
                </a:moveTo>
                <a:cubicBezTo>
                  <a:pt x="332" y="133"/>
                  <a:pt x="332" y="133"/>
                  <a:pt x="332" y="133"/>
                </a:cubicBezTo>
                <a:cubicBezTo>
                  <a:pt x="318" y="133"/>
                  <a:pt x="318" y="133"/>
                  <a:pt x="318" y="133"/>
                </a:cubicBezTo>
                <a:cubicBezTo>
                  <a:pt x="318" y="102"/>
                  <a:pt x="318" y="102"/>
                  <a:pt x="318" y="102"/>
                </a:cubicBezTo>
                <a:cubicBezTo>
                  <a:pt x="318" y="98"/>
                  <a:pt x="316" y="98"/>
                  <a:pt x="315" y="98"/>
                </a:cubicBezTo>
                <a:cubicBezTo>
                  <a:pt x="313" y="98"/>
                  <a:pt x="310" y="99"/>
                  <a:pt x="307" y="102"/>
                </a:cubicBezTo>
                <a:cubicBezTo>
                  <a:pt x="307" y="133"/>
                  <a:pt x="307" y="133"/>
                  <a:pt x="307" y="133"/>
                </a:cubicBezTo>
                <a:cubicBezTo>
                  <a:pt x="294" y="133"/>
                  <a:pt x="294" y="133"/>
                  <a:pt x="294" y="133"/>
                </a:cubicBezTo>
                <a:cubicBezTo>
                  <a:pt x="294" y="87"/>
                  <a:pt x="294" y="87"/>
                  <a:pt x="294" y="87"/>
                </a:cubicBezTo>
                <a:cubicBezTo>
                  <a:pt x="307" y="87"/>
                  <a:pt x="307" y="87"/>
                  <a:pt x="307" y="87"/>
                </a:cubicBezTo>
                <a:cubicBezTo>
                  <a:pt x="307" y="92"/>
                  <a:pt x="307" y="92"/>
                  <a:pt x="307" y="92"/>
                </a:cubicBezTo>
                <a:cubicBezTo>
                  <a:pt x="310" y="89"/>
                  <a:pt x="315" y="86"/>
                  <a:pt x="320" y="86"/>
                </a:cubicBezTo>
                <a:cubicBezTo>
                  <a:pt x="328" y="86"/>
                  <a:pt x="332" y="90"/>
                  <a:pt x="332" y="98"/>
                </a:cubicBezTo>
                <a:close/>
                <a:moveTo>
                  <a:pt x="272" y="132"/>
                </a:moveTo>
                <a:cubicBezTo>
                  <a:pt x="272" y="131"/>
                  <a:pt x="271" y="130"/>
                  <a:pt x="271" y="128"/>
                </a:cubicBezTo>
                <a:cubicBezTo>
                  <a:pt x="268" y="132"/>
                  <a:pt x="264" y="133"/>
                  <a:pt x="259" y="133"/>
                </a:cubicBezTo>
                <a:cubicBezTo>
                  <a:pt x="251" y="133"/>
                  <a:pt x="247" y="129"/>
                  <a:pt x="247" y="121"/>
                </a:cubicBezTo>
                <a:cubicBezTo>
                  <a:pt x="247" y="112"/>
                  <a:pt x="255" y="106"/>
                  <a:pt x="271" y="103"/>
                </a:cubicBezTo>
                <a:cubicBezTo>
                  <a:pt x="271" y="102"/>
                  <a:pt x="271" y="102"/>
                  <a:pt x="271" y="102"/>
                </a:cubicBezTo>
                <a:cubicBezTo>
                  <a:pt x="271" y="98"/>
                  <a:pt x="270" y="97"/>
                  <a:pt x="267" y="97"/>
                </a:cubicBezTo>
                <a:cubicBezTo>
                  <a:pt x="263" y="97"/>
                  <a:pt x="258" y="100"/>
                  <a:pt x="256" y="102"/>
                </a:cubicBezTo>
                <a:cubicBezTo>
                  <a:pt x="255" y="102"/>
                  <a:pt x="255" y="102"/>
                  <a:pt x="255" y="102"/>
                </a:cubicBezTo>
                <a:cubicBezTo>
                  <a:pt x="249" y="94"/>
                  <a:pt x="249" y="94"/>
                  <a:pt x="249" y="94"/>
                </a:cubicBezTo>
                <a:cubicBezTo>
                  <a:pt x="249" y="93"/>
                  <a:pt x="249" y="93"/>
                  <a:pt x="249" y="93"/>
                </a:cubicBezTo>
                <a:cubicBezTo>
                  <a:pt x="255" y="89"/>
                  <a:pt x="262" y="86"/>
                  <a:pt x="270" y="86"/>
                </a:cubicBezTo>
                <a:cubicBezTo>
                  <a:pt x="280" y="86"/>
                  <a:pt x="285" y="91"/>
                  <a:pt x="285" y="102"/>
                </a:cubicBezTo>
                <a:cubicBezTo>
                  <a:pt x="285" y="121"/>
                  <a:pt x="285" y="121"/>
                  <a:pt x="285" y="121"/>
                </a:cubicBezTo>
                <a:cubicBezTo>
                  <a:pt x="285" y="127"/>
                  <a:pt x="285" y="130"/>
                  <a:pt x="286" y="132"/>
                </a:cubicBezTo>
                <a:cubicBezTo>
                  <a:pt x="286" y="133"/>
                  <a:pt x="286" y="133"/>
                  <a:pt x="286" y="133"/>
                </a:cubicBezTo>
                <a:cubicBezTo>
                  <a:pt x="272" y="133"/>
                  <a:pt x="272" y="133"/>
                  <a:pt x="272" y="133"/>
                </a:cubicBezTo>
                <a:lnTo>
                  <a:pt x="272" y="132"/>
                </a:lnTo>
                <a:close/>
                <a:moveTo>
                  <a:pt x="271" y="111"/>
                </a:moveTo>
                <a:cubicBezTo>
                  <a:pt x="262" y="113"/>
                  <a:pt x="261" y="116"/>
                  <a:pt x="261" y="119"/>
                </a:cubicBezTo>
                <a:cubicBezTo>
                  <a:pt x="261" y="121"/>
                  <a:pt x="262" y="123"/>
                  <a:pt x="264" y="123"/>
                </a:cubicBezTo>
                <a:cubicBezTo>
                  <a:pt x="267" y="123"/>
                  <a:pt x="269" y="122"/>
                  <a:pt x="271" y="120"/>
                </a:cubicBezTo>
                <a:lnTo>
                  <a:pt x="271" y="111"/>
                </a:lnTo>
                <a:close/>
                <a:moveTo>
                  <a:pt x="310" y="214"/>
                </a:moveTo>
                <a:cubicBezTo>
                  <a:pt x="311" y="215"/>
                  <a:pt x="311" y="215"/>
                  <a:pt x="311" y="215"/>
                </a:cubicBezTo>
                <a:cubicBezTo>
                  <a:pt x="297" y="215"/>
                  <a:pt x="297" y="215"/>
                  <a:pt x="297" y="215"/>
                </a:cubicBezTo>
                <a:cubicBezTo>
                  <a:pt x="297" y="214"/>
                  <a:pt x="297" y="214"/>
                  <a:pt x="297" y="214"/>
                </a:cubicBezTo>
                <a:cubicBezTo>
                  <a:pt x="296" y="213"/>
                  <a:pt x="296" y="212"/>
                  <a:pt x="296" y="210"/>
                </a:cubicBezTo>
                <a:cubicBezTo>
                  <a:pt x="293" y="214"/>
                  <a:pt x="289" y="215"/>
                  <a:pt x="283" y="215"/>
                </a:cubicBezTo>
                <a:cubicBezTo>
                  <a:pt x="276" y="215"/>
                  <a:pt x="272" y="211"/>
                  <a:pt x="272" y="203"/>
                </a:cubicBezTo>
                <a:cubicBezTo>
                  <a:pt x="272" y="194"/>
                  <a:pt x="280" y="188"/>
                  <a:pt x="296" y="185"/>
                </a:cubicBezTo>
                <a:cubicBezTo>
                  <a:pt x="296" y="183"/>
                  <a:pt x="296" y="183"/>
                  <a:pt x="296" y="183"/>
                </a:cubicBezTo>
                <a:cubicBezTo>
                  <a:pt x="296" y="180"/>
                  <a:pt x="295" y="179"/>
                  <a:pt x="292" y="179"/>
                </a:cubicBezTo>
                <a:cubicBezTo>
                  <a:pt x="287" y="179"/>
                  <a:pt x="283" y="182"/>
                  <a:pt x="280" y="184"/>
                </a:cubicBezTo>
                <a:cubicBezTo>
                  <a:pt x="280" y="184"/>
                  <a:pt x="280" y="184"/>
                  <a:pt x="280" y="184"/>
                </a:cubicBezTo>
                <a:cubicBezTo>
                  <a:pt x="273" y="176"/>
                  <a:pt x="273" y="176"/>
                  <a:pt x="273" y="176"/>
                </a:cubicBezTo>
                <a:cubicBezTo>
                  <a:pt x="274" y="175"/>
                  <a:pt x="274" y="175"/>
                  <a:pt x="274" y="175"/>
                </a:cubicBezTo>
                <a:cubicBezTo>
                  <a:pt x="279" y="171"/>
                  <a:pt x="286" y="168"/>
                  <a:pt x="294" y="168"/>
                </a:cubicBezTo>
                <a:cubicBezTo>
                  <a:pt x="305" y="168"/>
                  <a:pt x="309" y="173"/>
                  <a:pt x="309" y="183"/>
                </a:cubicBezTo>
                <a:cubicBezTo>
                  <a:pt x="309" y="203"/>
                  <a:pt x="309" y="203"/>
                  <a:pt x="309" y="203"/>
                </a:cubicBezTo>
                <a:cubicBezTo>
                  <a:pt x="309" y="209"/>
                  <a:pt x="310" y="212"/>
                  <a:pt x="310" y="214"/>
                </a:cubicBezTo>
                <a:close/>
                <a:moveTo>
                  <a:pt x="296" y="193"/>
                </a:moveTo>
                <a:cubicBezTo>
                  <a:pt x="286" y="195"/>
                  <a:pt x="285" y="198"/>
                  <a:pt x="285" y="201"/>
                </a:cubicBezTo>
                <a:cubicBezTo>
                  <a:pt x="285" y="203"/>
                  <a:pt x="286" y="205"/>
                  <a:pt x="289" y="205"/>
                </a:cubicBezTo>
                <a:cubicBezTo>
                  <a:pt x="291" y="205"/>
                  <a:pt x="294" y="204"/>
                  <a:pt x="296" y="201"/>
                </a:cubicBezTo>
                <a:lnTo>
                  <a:pt x="296" y="193"/>
                </a:lnTo>
                <a:close/>
                <a:moveTo>
                  <a:pt x="318" y="159"/>
                </a:moveTo>
                <a:cubicBezTo>
                  <a:pt x="332" y="157"/>
                  <a:pt x="332" y="157"/>
                  <a:pt x="332" y="157"/>
                </a:cubicBezTo>
                <a:cubicBezTo>
                  <a:pt x="332" y="215"/>
                  <a:pt x="332" y="215"/>
                  <a:pt x="332" y="215"/>
                </a:cubicBezTo>
                <a:cubicBezTo>
                  <a:pt x="318" y="215"/>
                  <a:pt x="318" y="215"/>
                  <a:pt x="318" y="215"/>
                </a:cubicBezTo>
                <a:lnTo>
                  <a:pt x="318" y="159"/>
                </a:lnTo>
                <a:close/>
                <a:moveTo>
                  <a:pt x="208" y="153"/>
                </a:moveTo>
                <a:cubicBezTo>
                  <a:pt x="222" y="153"/>
                  <a:pt x="222" y="153"/>
                  <a:pt x="222" y="153"/>
                </a:cubicBezTo>
                <a:cubicBezTo>
                  <a:pt x="222" y="215"/>
                  <a:pt x="222" y="215"/>
                  <a:pt x="222" y="215"/>
                </a:cubicBezTo>
                <a:cubicBezTo>
                  <a:pt x="208" y="215"/>
                  <a:pt x="208" y="215"/>
                  <a:pt x="208" y="215"/>
                </a:cubicBezTo>
                <a:cubicBezTo>
                  <a:pt x="208" y="188"/>
                  <a:pt x="208" y="188"/>
                  <a:pt x="208" y="188"/>
                </a:cubicBezTo>
                <a:cubicBezTo>
                  <a:pt x="188" y="188"/>
                  <a:pt x="188" y="188"/>
                  <a:pt x="188" y="188"/>
                </a:cubicBezTo>
                <a:cubicBezTo>
                  <a:pt x="188" y="215"/>
                  <a:pt x="188" y="215"/>
                  <a:pt x="188" y="215"/>
                </a:cubicBezTo>
                <a:cubicBezTo>
                  <a:pt x="174" y="215"/>
                  <a:pt x="174" y="215"/>
                  <a:pt x="174" y="215"/>
                </a:cubicBezTo>
                <a:cubicBezTo>
                  <a:pt x="174" y="153"/>
                  <a:pt x="174" y="153"/>
                  <a:pt x="174" y="153"/>
                </a:cubicBezTo>
                <a:cubicBezTo>
                  <a:pt x="188" y="153"/>
                  <a:pt x="188" y="153"/>
                  <a:pt x="188" y="153"/>
                </a:cubicBezTo>
                <a:cubicBezTo>
                  <a:pt x="188" y="176"/>
                  <a:pt x="188" y="176"/>
                  <a:pt x="188" y="176"/>
                </a:cubicBezTo>
                <a:cubicBezTo>
                  <a:pt x="208" y="176"/>
                  <a:pt x="208" y="176"/>
                  <a:pt x="208" y="176"/>
                </a:cubicBezTo>
                <a:lnTo>
                  <a:pt x="208" y="153"/>
                </a:lnTo>
                <a:close/>
                <a:moveTo>
                  <a:pt x="342" y="130"/>
                </a:moveTo>
                <a:cubicBezTo>
                  <a:pt x="340" y="129"/>
                  <a:pt x="339" y="127"/>
                  <a:pt x="339" y="124"/>
                </a:cubicBezTo>
                <a:cubicBezTo>
                  <a:pt x="339" y="122"/>
                  <a:pt x="341" y="118"/>
                  <a:pt x="345" y="116"/>
                </a:cubicBezTo>
                <a:cubicBezTo>
                  <a:pt x="341" y="113"/>
                  <a:pt x="339" y="108"/>
                  <a:pt x="339" y="103"/>
                </a:cubicBezTo>
                <a:cubicBezTo>
                  <a:pt x="339" y="93"/>
                  <a:pt x="346" y="86"/>
                  <a:pt x="357" y="86"/>
                </a:cubicBezTo>
                <a:cubicBezTo>
                  <a:pt x="362" y="86"/>
                  <a:pt x="367" y="88"/>
                  <a:pt x="370" y="90"/>
                </a:cubicBezTo>
                <a:cubicBezTo>
                  <a:pt x="372" y="88"/>
                  <a:pt x="376" y="86"/>
                  <a:pt x="379" y="86"/>
                </a:cubicBezTo>
                <a:cubicBezTo>
                  <a:pt x="380" y="86"/>
                  <a:pt x="380" y="86"/>
                  <a:pt x="380" y="86"/>
                </a:cubicBezTo>
                <a:cubicBezTo>
                  <a:pt x="380" y="98"/>
                  <a:pt x="380" y="98"/>
                  <a:pt x="380" y="98"/>
                </a:cubicBezTo>
                <a:cubicBezTo>
                  <a:pt x="379" y="98"/>
                  <a:pt x="379" y="98"/>
                  <a:pt x="379" y="98"/>
                </a:cubicBezTo>
                <a:cubicBezTo>
                  <a:pt x="378" y="98"/>
                  <a:pt x="376" y="98"/>
                  <a:pt x="374" y="98"/>
                </a:cubicBezTo>
                <a:cubicBezTo>
                  <a:pt x="375" y="100"/>
                  <a:pt x="375" y="101"/>
                  <a:pt x="375" y="103"/>
                </a:cubicBezTo>
                <a:cubicBezTo>
                  <a:pt x="375" y="113"/>
                  <a:pt x="368" y="120"/>
                  <a:pt x="357" y="120"/>
                </a:cubicBezTo>
                <a:cubicBezTo>
                  <a:pt x="355" y="120"/>
                  <a:pt x="353" y="119"/>
                  <a:pt x="351" y="119"/>
                </a:cubicBezTo>
                <a:cubicBezTo>
                  <a:pt x="351" y="120"/>
                  <a:pt x="351" y="120"/>
                  <a:pt x="351" y="120"/>
                </a:cubicBezTo>
                <a:cubicBezTo>
                  <a:pt x="351" y="121"/>
                  <a:pt x="351" y="122"/>
                  <a:pt x="354" y="122"/>
                </a:cubicBezTo>
                <a:cubicBezTo>
                  <a:pt x="360" y="123"/>
                  <a:pt x="360" y="123"/>
                  <a:pt x="360" y="123"/>
                </a:cubicBezTo>
                <a:cubicBezTo>
                  <a:pt x="374" y="124"/>
                  <a:pt x="379" y="127"/>
                  <a:pt x="379" y="135"/>
                </a:cubicBezTo>
                <a:cubicBezTo>
                  <a:pt x="379" y="144"/>
                  <a:pt x="370" y="149"/>
                  <a:pt x="356" y="149"/>
                </a:cubicBezTo>
                <a:cubicBezTo>
                  <a:pt x="342" y="149"/>
                  <a:pt x="336" y="146"/>
                  <a:pt x="336" y="139"/>
                </a:cubicBezTo>
                <a:cubicBezTo>
                  <a:pt x="336" y="135"/>
                  <a:pt x="338" y="132"/>
                  <a:pt x="342" y="130"/>
                </a:cubicBezTo>
                <a:close/>
                <a:moveTo>
                  <a:pt x="352" y="103"/>
                </a:moveTo>
                <a:cubicBezTo>
                  <a:pt x="352" y="106"/>
                  <a:pt x="352" y="111"/>
                  <a:pt x="357" y="111"/>
                </a:cubicBezTo>
                <a:cubicBezTo>
                  <a:pt x="360" y="111"/>
                  <a:pt x="362" y="108"/>
                  <a:pt x="362" y="103"/>
                </a:cubicBezTo>
                <a:cubicBezTo>
                  <a:pt x="362" y="100"/>
                  <a:pt x="361" y="96"/>
                  <a:pt x="357" y="96"/>
                </a:cubicBezTo>
                <a:cubicBezTo>
                  <a:pt x="352" y="96"/>
                  <a:pt x="352" y="101"/>
                  <a:pt x="352" y="103"/>
                </a:cubicBezTo>
                <a:close/>
                <a:moveTo>
                  <a:pt x="348" y="137"/>
                </a:moveTo>
                <a:cubicBezTo>
                  <a:pt x="348" y="140"/>
                  <a:pt x="350" y="142"/>
                  <a:pt x="357" y="142"/>
                </a:cubicBezTo>
                <a:cubicBezTo>
                  <a:pt x="363" y="142"/>
                  <a:pt x="366" y="140"/>
                  <a:pt x="366" y="137"/>
                </a:cubicBezTo>
                <a:cubicBezTo>
                  <a:pt x="366" y="135"/>
                  <a:pt x="366" y="134"/>
                  <a:pt x="358" y="134"/>
                </a:cubicBezTo>
                <a:cubicBezTo>
                  <a:pt x="351" y="133"/>
                  <a:pt x="351" y="133"/>
                  <a:pt x="351" y="133"/>
                </a:cubicBezTo>
                <a:cubicBezTo>
                  <a:pt x="351" y="133"/>
                  <a:pt x="350" y="133"/>
                  <a:pt x="350" y="133"/>
                </a:cubicBezTo>
                <a:cubicBezTo>
                  <a:pt x="349" y="134"/>
                  <a:pt x="348" y="136"/>
                  <a:pt x="348" y="137"/>
                </a:cubicBezTo>
                <a:close/>
              </a:path>
            </a:pathLst>
          </a:custGeom>
          <a:solidFill>
            <a:schemeClr val="tx2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351"/>
          </a:p>
        </p:txBody>
      </p:sp>
      <p:sp>
        <p:nvSpPr>
          <p:cNvPr id="19" name="Picture Placeholder 6"/>
          <p:cNvSpPr>
            <a:spLocks noGrp="1"/>
          </p:cNvSpPr>
          <p:nvPr>
            <p:ph type="pic" sz="quarter" idx="10"/>
          </p:nvPr>
        </p:nvSpPr>
        <p:spPr>
          <a:xfrm>
            <a:off x="5067208" y="-970"/>
            <a:ext cx="4076792" cy="3759696"/>
          </a:xfrm>
          <a:custGeom>
            <a:avLst/>
            <a:gdLst>
              <a:gd name="connsiteX0" fmla="*/ 0 w 4035853"/>
              <a:gd name="connsiteY0" fmla="*/ 0 h 2697096"/>
              <a:gd name="connsiteX1" fmla="*/ 4035853 w 4035853"/>
              <a:gd name="connsiteY1" fmla="*/ 0 h 2697096"/>
              <a:gd name="connsiteX2" fmla="*/ 4035853 w 4035853"/>
              <a:gd name="connsiteY2" fmla="*/ 2697096 h 2697096"/>
              <a:gd name="connsiteX3" fmla="*/ 0 w 4035853"/>
              <a:gd name="connsiteY3" fmla="*/ 2697096 h 2697096"/>
              <a:gd name="connsiteX4" fmla="*/ 0 w 4035853"/>
              <a:gd name="connsiteY4" fmla="*/ 0 h 2697096"/>
              <a:gd name="connsiteX0" fmla="*/ 0 w 4035853"/>
              <a:gd name="connsiteY0" fmla="*/ 0 h 2700356"/>
              <a:gd name="connsiteX1" fmla="*/ 4035853 w 4035853"/>
              <a:gd name="connsiteY1" fmla="*/ 0 h 2700356"/>
              <a:gd name="connsiteX2" fmla="*/ 4035853 w 4035853"/>
              <a:gd name="connsiteY2" fmla="*/ 2697096 h 2700356"/>
              <a:gd name="connsiteX3" fmla="*/ 323823 w 4035853"/>
              <a:gd name="connsiteY3" fmla="*/ 2700356 h 2700356"/>
              <a:gd name="connsiteX4" fmla="*/ 0 w 4035853"/>
              <a:gd name="connsiteY4" fmla="*/ 2697096 h 2700356"/>
              <a:gd name="connsiteX5" fmla="*/ 0 w 4035853"/>
              <a:gd name="connsiteY5" fmla="*/ 0 h 2700356"/>
              <a:gd name="connsiteX0" fmla="*/ 0 w 4035853"/>
              <a:gd name="connsiteY0" fmla="*/ 0 h 2700356"/>
              <a:gd name="connsiteX1" fmla="*/ 4035853 w 4035853"/>
              <a:gd name="connsiteY1" fmla="*/ 0 h 2700356"/>
              <a:gd name="connsiteX2" fmla="*/ 4035853 w 4035853"/>
              <a:gd name="connsiteY2" fmla="*/ 2697096 h 2700356"/>
              <a:gd name="connsiteX3" fmla="*/ 323823 w 4035853"/>
              <a:gd name="connsiteY3" fmla="*/ 2700356 h 2700356"/>
              <a:gd name="connsiteX4" fmla="*/ 0 w 4035853"/>
              <a:gd name="connsiteY4" fmla="*/ 2697096 h 2700356"/>
              <a:gd name="connsiteX5" fmla="*/ 0 w 4035853"/>
              <a:gd name="connsiteY5" fmla="*/ 0 h 2700356"/>
              <a:gd name="connsiteX0" fmla="*/ 0 w 4035853"/>
              <a:gd name="connsiteY0" fmla="*/ 0 h 2700356"/>
              <a:gd name="connsiteX1" fmla="*/ 4035853 w 4035853"/>
              <a:gd name="connsiteY1" fmla="*/ 0 h 2700356"/>
              <a:gd name="connsiteX2" fmla="*/ 4035853 w 4035853"/>
              <a:gd name="connsiteY2" fmla="*/ 2697096 h 2700356"/>
              <a:gd name="connsiteX3" fmla="*/ 612823 w 4035853"/>
              <a:gd name="connsiteY3" fmla="*/ 2689412 h 2700356"/>
              <a:gd name="connsiteX4" fmla="*/ 323823 w 4035853"/>
              <a:gd name="connsiteY4" fmla="*/ 2700356 h 2700356"/>
              <a:gd name="connsiteX5" fmla="*/ 0 w 4035853"/>
              <a:gd name="connsiteY5" fmla="*/ 2697096 h 2700356"/>
              <a:gd name="connsiteX6" fmla="*/ 0 w 4035853"/>
              <a:gd name="connsiteY6" fmla="*/ 0 h 2700356"/>
              <a:gd name="connsiteX0" fmla="*/ 0 w 4035853"/>
              <a:gd name="connsiteY0" fmla="*/ 0 h 2700356"/>
              <a:gd name="connsiteX1" fmla="*/ 4035853 w 4035853"/>
              <a:gd name="connsiteY1" fmla="*/ 0 h 2700356"/>
              <a:gd name="connsiteX2" fmla="*/ 4035853 w 4035853"/>
              <a:gd name="connsiteY2" fmla="*/ 2697096 h 2700356"/>
              <a:gd name="connsiteX3" fmla="*/ 612823 w 4035853"/>
              <a:gd name="connsiteY3" fmla="*/ 2689412 h 2700356"/>
              <a:gd name="connsiteX4" fmla="*/ 323823 w 4035853"/>
              <a:gd name="connsiteY4" fmla="*/ 2700356 h 2700356"/>
              <a:gd name="connsiteX5" fmla="*/ 0 w 4035853"/>
              <a:gd name="connsiteY5" fmla="*/ 2697096 h 2700356"/>
              <a:gd name="connsiteX6" fmla="*/ 0 w 4035853"/>
              <a:gd name="connsiteY6" fmla="*/ 0 h 2700356"/>
              <a:gd name="connsiteX0" fmla="*/ 0 w 4035853"/>
              <a:gd name="connsiteY0" fmla="*/ 0 h 2700356"/>
              <a:gd name="connsiteX1" fmla="*/ 4035853 w 4035853"/>
              <a:gd name="connsiteY1" fmla="*/ 0 h 2700356"/>
              <a:gd name="connsiteX2" fmla="*/ 4035853 w 4035853"/>
              <a:gd name="connsiteY2" fmla="*/ 2697096 h 2700356"/>
              <a:gd name="connsiteX3" fmla="*/ 612823 w 4035853"/>
              <a:gd name="connsiteY3" fmla="*/ 2689412 h 2700356"/>
              <a:gd name="connsiteX4" fmla="*/ 323823 w 4035853"/>
              <a:gd name="connsiteY4" fmla="*/ 2700356 h 2700356"/>
              <a:gd name="connsiteX5" fmla="*/ 0 w 4035853"/>
              <a:gd name="connsiteY5" fmla="*/ 2697096 h 2700356"/>
              <a:gd name="connsiteX6" fmla="*/ 0 w 4035853"/>
              <a:gd name="connsiteY6" fmla="*/ 0 h 2700356"/>
              <a:gd name="connsiteX0" fmla="*/ 0 w 4035853"/>
              <a:gd name="connsiteY0" fmla="*/ 0 h 2700645"/>
              <a:gd name="connsiteX1" fmla="*/ 4035853 w 4035853"/>
              <a:gd name="connsiteY1" fmla="*/ 0 h 2700645"/>
              <a:gd name="connsiteX2" fmla="*/ 4035853 w 4035853"/>
              <a:gd name="connsiteY2" fmla="*/ 2697096 h 2700645"/>
              <a:gd name="connsiteX3" fmla="*/ 612823 w 4035853"/>
              <a:gd name="connsiteY3" fmla="*/ 2689412 h 2700645"/>
              <a:gd name="connsiteX4" fmla="*/ 323823 w 4035853"/>
              <a:gd name="connsiteY4" fmla="*/ 2700356 h 2700645"/>
              <a:gd name="connsiteX5" fmla="*/ 0 w 4035853"/>
              <a:gd name="connsiteY5" fmla="*/ 2697096 h 2700645"/>
              <a:gd name="connsiteX6" fmla="*/ 0 w 4035853"/>
              <a:gd name="connsiteY6" fmla="*/ 0 h 2700645"/>
              <a:gd name="connsiteX0" fmla="*/ 0 w 4035853"/>
              <a:gd name="connsiteY0" fmla="*/ 0 h 2700645"/>
              <a:gd name="connsiteX1" fmla="*/ 4035853 w 4035853"/>
              <a:gd name="connsiteY1" fmla="*/ 0 h 2700645"/>
              <a:gd name="connsiteX2" fmla="*/ 4035853 w 4035853"/>
              <a:gd name="connsiteY2" fmla="*/ 2697096 h 2700645"/>
              <a:gd name="connsiteX3" fmla="*/ 612823 w 4035853"/>
              <a:gd name="connsiteY3" fmla="*/ 2689412 h 2700645"/>
              <a:gd name="connsiteX4" fmla="*/ 171423 w 4035853"/>
              <a:gd name="connsiteY4" fmla="*/ 2700356 h 2700645"/>
              <a:gd name="connsiteX5" fmla="*/ 0 w 4035853"/>
              <a:gd name="connsiteY5" fmla="*/ 2697096 h 2700645"/>
              <a:gd name="connsiteX6" fmla="*/ 0 w 4035853"/>
              <a:gd name="connsiteY6" fmla="*/ 0 h 2700645"/>
              <a:gd name="connsiteX0" fmla="*/ 0 w 4035853"/>
              <a:gd name="connsiteY0" fmla="*/ 0 h 2700645"/>
              <a:gd name="connsiteX1" fmla="*/ 4035853 w 4035853"/>
              <a:gd name="connsiteY1" fmla="*/ 0 h 2700645"/>
              <a:gd name="connsiteX2" fmla="*/ 4035853 w 4035853"/>
              <a:gd name="connsiteY2" fmla="*/ 2697096 h 2700645"/>
              <a:gd name="connsiteX3" fmla="*/ 612823 w 4035853"/>
              <a:gd name="connsiteY3" fmla="*/ 2689412 h 2700645"/>
              <a:gd name="connsiteX4" fmla="*/ 171423 w 4035853"/>
              <a:gd name="connsiteY4" fmla="*/ 2700356 h 2700645"/>
              <a:gd name="connsiteX5" fmla="*/ 0 w 4035853"/>
              <a:gd name="connsiteY5" fmla="*/ 2697096 h 2700645"/>
              <a:gd name="connsiteX6" fmla="*/ 0 w 4035853"/>
              <a:gd name="connsiteY6" fmla="*/ 0 h 2700645"/>
              <a:gd name="connsiteX0" fmla="*/ 0 w 4035853"/>
              <a:gd name="connsiteY0" fmla="*/ 0 h 2700356"/>
              <a:gd name="connsiteX1" fmla="*/ 4035853 w 4035853"/>
              <a:gd name="connsiteY1" fmla="*/ 0 h 2700356"/>
              <a:gd name="connsiteX2" fmla="*/ 4035853 w 4035853"/>
              <a:gd name="connsiteY2" fmla="*/ 2697096 h 2700356"/>
              <a:gd name="connsiteX3" fmla="*/ 612823 w 4035853"/>
              <a:gd name="connsiteY3" fmla="*/ 2689412 h 2700356"/>
              <a:gd name="connsiteX4" fmla="*/ 171423 w 4035853"/>
              <a:gd name="connsiteY4" fmla="*/ 2700356 h 2700356"/>
              <a:gd name="connsiteX5" fmla="*/ 0 w 4035853"/>
              <a:gd name="connsiteY5" fmla="*/ 2697096 h 2700356"/>
              <a:gd name="connsiteX6" fmla="*/ 0 w 4035853"/>
              <a:gd name="connsiteY6" fmla="*/ 0 h 2700356"/>
              <a:gd name="connsiteX0" fmla="*/ 0 w 4035853"/>
              <a:gd name="connsiteY0" fmla="*/ 0 h 2697975"/>
              <a:gd name="connsiteX1" fmla="*/ 4035853 w 4035853"/>
              <a:gd name="connsiteY1" fmla="*/ 0 h 2697975"/>
              <a:gd name="connsiteX2" fmla="*/ 4035853 w 4035853"/>
              <a:gd name="connsiteY2" fmla="*/ 2697096 h 2697975"/>
              <a:gd name="connsiteX3" fmla="*/ 612823 w 4035853"/>
              <a:gd name="connsiteY3" fmla="*/ 2689412 h 2697975"/>
              <a:gd name="connsiteX4" fmla="*/ 171423 w 4035853"/>
              <a:gd name="connsiteY4" fmla="*/ 2697975 h 2697975"/>
              <a:gd name="connsiteX5" fmla="*/ 0 w 4035853"/>
              <a:gd name="connsiteY5" fmla="*/ 2697096 h 2697975"/>
              <a:gd name="connsiteX6" fmla="*/ 0 w 4035853"/>
              <a:gd name="connsiteY6" fmla="*/ 0 h 2697975"/>
              <a:gd name="connsiteX0" fmla="*/ 0 w 4035853"/>
              <a:gd name="connsiteY0" fmla="*/ 0 h 2698065"/>
              <a:gd name="connsiteX1" fmla="*/ 4035853 w 4035853"/>
              <a:gd name="connsiteY1" fmla="*/ 0 h 2698065"/>
              <a:gd name="connsiteX2" fmla="*/ 4035853 w 4035853"/>
              <a:gd name="connsiteY2" fmla="*/ 2697096 h 2698065"/>
              <a:gd name="connsiteX3" fmla="*/ 612823 w 4035853"/>
              <a:gd name="connsiteY3" fmla="*/ 2689412 h 2698065"/>
              <a:gd name="connsiteX4" fmla="*/ 171423 w 4035853"/>
              <a:gd name="connsiteY4" fmla="*/ 2697975 h 2698065"/>
              <a:gd name="connsiteX5" fmla="*/ 0 w 4035853"/>
              <a:gd name="connsiteY5" fmla="*/ 2697096 h 2698065"/>
              <a:gd name="connsiteX6" fmla="*/ 0 w 4035853"/>
              <a:gd name="connsiteY6" fmla="*/ 0 h 2698065"/>
              <a:gd name="connsiteX0" fmla="*/ 0 w 4035853"/>
              <a:gd name="connsiteY0" fmla="*/ 0 h 2697975"/>
              <a:gd name="connsiteX1" fmla="*/ 4035853 w 4035853"/>
              <a:gd name="connsiteY1" fmla="*/ 0 h 2697975"/>
              <a:gd name="connsiteX2" fmla="*/ 4035853 w 4035853"/>
              <a:gd name="connsiteY2" fmla="*/ 2697096 h 2697975"/>
              <a:gd name="connsiteX3" fmla="*/ 581867 w 4035853"/>
              <a:gd name="connsiteY3" fmla="*/ 2696556 h 2697975"/>
              <a:gd name="connsiteX4" fmla="*/ 171423 w 4035853"/>
              <a:gd name="connsiteY4" fmla="*/ 2697975 h 2697975"/>
              <a:gd name="connsiteX5" fmla="*/ 0 w 4035853"/>
              <a:gd name="connsiteY5" fmla="*/ 2697096 h 2697975"/>
              <a:gd name="connsiteX6" fmla="*/ 0 w 4035853"/>
              <a:gd name="connsiteY6" fmla="*/ 0 h 2697975"/>
              <a:gd name="connsiteX0" fmla="*/ 0 w 4035853"/>
              <a:gd name="connsiteY0" fmla="*/ 0 h 2697975"/>
              <a:gd name="connsiteX1" fmla="*/ 4035853 w 4035853"/>
              <a:gd name="connsiteY1" fmla="*/ 0 h 2697975"/>
              <a:gd name="connsiteX2" fmla="*/ 4035853 w 4035853"/>
              <a:gd name="connsiteY2" fmla="*/ 2697096 h 2697975"/>
              <a:gd name="connsiteX3" fmla="*/ 581867 w 4035853"/>
              <a:gd name="connsiteY3" fmla="*/ 2696556 h 2697975"/>
              <a:gd name="connsiteX4" fmla="*/ 171423 w 4035853"/>
              <a:gd name="connsiteY4" fmla="*/ 2697975 h 2697975"/>
              <a:gd name="connsiteX5" fmla="*/ 0 w 4035853"/>
              <a:gd name="connsiteY5" fmla="*/ 2697096 h 2697975"/>
              <a:gd name="connsiteX6" fmla="*/ 0 w 4035853"/>
              <a:gd name="connsiteY6" fmla="*/ 0 h 2697975"/>
              <a:gd name="connsiteX0" fmla="*/ 0 w 4035853"/>
              <a:gd name="connsiteY0" fmla="*/ 0 h 2698071"/>
              <a:gd name="connsiteX1" fmla="*/ 4035853 w 4035853"/>
              <a:gd name="connsiteY1" fmla="*/ 0 h 2698071"/>
              <a:gd name="connsiteX2" fmla="*/ 4035853 w 4035853"/>
              <a:gd name="connsiteY2" fmla="*/ 2697096 h 2698071"/>
              <a:gd name="connsiteX3" fmla="*/ 438992 w 4035853"/>
              <a:gd name="connsiteY3" fmla="*/ 2696556 h 2698071"/>
              <a:gd name="connsiteX4" fmla="*/ 171423 w 4035853"/>
              <a:gd name="connsiteY4" fmla="*/ 2697975 h 2698071"/>
              <a:gd name="connsiteX5" fmla="*/ 0 w 4035853"/>
              <a:gd name="connsiteY5" fmla="*/ 2697096 h 2698071"/>
              <a:gd name="connsiteX6" fmla="*/ 0 w 4035853"/>
              <a:gd name="connsiteY6" fmla="*/ 0 h 2698071"/>
              <a:gd name="connsiteX0" fmla="*/ 0 w 4035853"/>
              <a:gd name="connsiteY0" fmla="*/ 0 h 2698071"/>
              <a:gd name="connsiteX1" fmla="*/ 4035853 w 4035853"/>
              <a:gd name="connsiteY1" fmla="*/ 0 h 2698071"/>
              <a:gd name="connsiteX2" fmla="*/ 4035853 w 4035853"/>
              <a:gd name="connsiteY2" fmla="*/ 2697096 h 2698071"/>
              <a:gd name="connsiteX3" fmla="*/ 441373 w 4035853"/>
              <a:gd name="connsiteY3" fmla="*/ 2696556 h 2698071"/>
              <a:gd name="connsiteX4" fmla="*/ 171423 w 4035853"/>
              <a:gd name="connsiteY4" fmla="*/ 2697975 h 2698071"/>
              <a:gd name="connsiteX5" fmla="*/ 0 w 4035853"/>
              <a:gd name="connsiteY5" fmla="*/ 2697096 h 2698071"/>
              <a:gd name="connsiteX6" fmla="*/ 0 w 4035853"/>
              <a:gd name="connsiteY6" fmla="*/ 0 h 2698071"/>
              <a:gd name="connsiteX0" fmla="*/ 0 w 4035853"/>
              <a:gd name="connsiteY0" fmla="*/ 0 h 2700356"/>
              <a:gd name="connsiteX1" fmla="*/ 4035853 w 4035853"/>
              <a:gd name="connsiteY1" fmla="*/ 0 h 2700356"/>
              <a:gd name="connsiteX2" fmla="*/ 4035853 w 4035853"/>
              <a:gd name="connsiteY2" fmla="*/ 2697096 h 2700356"/>
              <a:gd name="connsiteX3" fmla="*/ 441373 w 4035853"/>
              <a:gd name="connsiteY3" fmla="*/ 2696556 h 2700356"/>
              <a:gd name="connsiteX4" fmla="*/ 173804 w 4035853"/>
              <a:gd name="connsiteY4" fmla="*/ 2700356 h 2700356"/>
              <a:gd name="connsiteX5" fmla="*/ 0 w 4035853"/>
              <a:gd name="connsiteY5" fmla="*/ 2697096 h 2700356"/>
              <a:gd name="connsiteX6" fmla="*/ 0 w 4035853"/>
              <a:gd name="connsiteY6" fmla="*/ 0 h 2700356"/>
              <a:gd name="connsiteX0" fmla="*/ 0 w 4035853"/>
              <a:gd name="connsiteY0" fmla="*/ 0 h 2700356"/>
              <a:gd name="connsiteX1" fmla="*/ 4035853 w 4035853"/>
              <a:gd name="connsiteY1" fmla="*/ 0 h 2700356"/>
              <a:gd name="connsiteX2" fmla="*/ 4035853 w 4035853"/>
              <a:gd name="connsiteY2" fmla="*/ 2697096 h 2700356"/>
              <a:gd name="connsiteX3" fmla="*/ 441373 w 4035853"/>
              <a:gd name="connsiteY3" fmla="*/ 2696556 h 2700356"/>
              <a:gd name="connsiteX4" fmla="*/ 173804 w 4035853"/>
              <a:gd name="connsiteY4" fmla="*/ 2700356 h 2700356"/>
              <a:gd name="connsiteX5" fmla="*/ 0 w 4035853"/>
              <a:gd name="connsiteY5" fmla="*/ 2697096 h 2700356"/>
              <a:gd name="connsiteX6" fmla="*/ 0 w 4035853"/>
              <a:gd name="connsiteY6" fmla="*/ 0 h 2700356"/>
              <a:gd name="connsiteX0" fmla="*/ 0 w 4035853"/>
              <a:gd name="connsiteY0" fmla="*/ 0 h 2700356"/>
              <a:gd name="connsiteX1" fmla="*/ 4035853 w 4035853"/>
              <a:gd name="connsiteY1" fmla="*/ 0 h 2700356"/>
              <a:gd name="connsiteX2" fmla="*/ 4035853 w 4035853"/>
              <a:gd name="connsiteY2" fmla="*/ 2697096 h 2700356"/>
              <a:gd name="connsiteX3" fmla="*/ 441373 w 4035853"/>
              <a:gd name="connsiteY3" fmla="*/ 2696556 h 2700356"/>
              <a:gd name="connsiteX4" fmla="*/ 173804 w 4035853"/>
              <a:gd name="connsiteY4" fmla="*/ 2700356 h 2700356"/>
              <a:gd name="connsiteX5" fmla="*/ 0 w 4035853"/>
              <a:gd name="connsiteY5" fmla="*/ 2697096 h 2700356"/>
              <a:gd name="connsiteX6" fmla="*/ 0 w 4035853"/>
              <a:gd name="connsiteY6" fmla="*/ 0 h 2700356"/>
              <a:gd name="connsiteX0" fmla="*/ 0 w 4035853"/>
              <a:gd name="connsiteY0" fmla="*/ 0 h 2700356"/>
              <a:gd name="connsiteX1" fmla="*/ 4035853 w 4035853"/>
              <a:gd name="connsiteY1" fmla="*/ 0 h 2700356"/>
              <a:gd name="connsiteX2" fmla="*/ 4035853 w 4035853"/>
              <a:gd name="connsiteY2" fmla="*/ 2697096 h 2700356"/>
              <a:gd name="connsiteX3" fmla="*/ 441373 w 4035853"/>
              <a:gd name="connsiteY3" fmla="*/ 2696556 h 2700356"/>
              <a:gd name="connsiteX4" fmla="*/ 164279 w 4035853"/>
              <a:gd name="connsiteY4" fmla="*/ 2700356 h 2700356"/>
              <a:gd name="connsiteX5" fmla="*/ 0 w 4035853"/>
              <a:gd name="connsiteY5" fmla="*/ 2697096 h 2700356"/>
              <a:gd name="connsiteX6" fmla="*/ 0 w 4035853"/>
              <a:gd name="connsiteY6" fmla="*/ 0 h 2700356"/>
              <a:gd name="connsiteX0" fmla="*/ 0 w 4035853"/>
              <a:gd name="connsiteY0" fmla="*/ 0 h 2700357"/>
              <a:gd name="connsiteX1" fmla="*/ 4035853 w 4035853"/>
              <a:gd name="connsiteY1" fmla="*/ 0 h 2700357"/>
              <a:gd name="connsiteX2" fmla="*/ 4035853 w 4035853"/>
              <a:gd name="connsiteY2" fmla="*/ 2697096 h 2700357"/>
              <a:gd name="connsiteX3" fmla="*/ 434229 w 4035853"/>
              <a:gd name="connsiteY3" fmla="*/ 2696556 h 2700357"/>
              <a:gd name="connsiteX4" fmla="*/ 164279 w 4035853"/>
              <a:gd name="connsiteY4" fmla="*/ 2700356 h 2700357"/>
              <a:gd name="connsiteX5" fmla="*/ 0 w 4035853"/>
              <a:gd name="connsiteY5" fmla="*/ 2697096 h 2700357"/>
              <a:gd name="connsiteX6" fmla="*/ 0 w 4035853"/>
              <a:gd name="connsiteY6" fmla="*/ 0 h 2700357"/>
              <a:gd name="connsiteX0" fmla="*/ 0 w 4035853"/>
              <a:gd name="connsiteY0" fmla="*/ 0 h 2701319"/>
              <a:gd name="connsiteX1" fmla="*/ 4035853 w 4035853"/>
              <a:gd name="connsiteY1" fmla="*/ 0 h 2701319"/>
              <a:gd name="connsiteX2" fmla="*/ 4035853 w 4035853"/>
              <a:gd name="connsiteY2" fmla="*/ 2697096 h 2701319"/>
              <a:gd name="connsiteX3" fmla="*/ 431848 w 4035853"/>
              <a:gd name="connsiteY3" fmla="*/ 2701319 h 2701319"/>
              <a:gd name="connsiteX4" fmla="*/ 164279 w 4035853"/>
              <a:gd name="connsiteY4" fmla="*/ 2700356 h 2701319"/>
              <a:gd name="connsiteX5" fmla="*/ 0 w 4035853"/>
              <a:gd name="connsiteY5" fmla="*/ 2697096 h 2701319"/>
              <a:gd name="connsiteX6" fmla="*/ 0 w 4035853"/>
              <a:gd name="connsiteY6" fmla="*/ 0 h 2701319"/>
              <a:gd name="connsiteX0" fmla="*/ 0 w 4035853"/>
              <a:gd name="connsiteY0" fmla="*/ 0 h 2701319"/>
              <a:gd name="connsiteX1" fmla="*/ 4035853 w 4035853"/>
              <a:gd name="connsiteY1" fmla="*/ 0 h 2701319"/>
              <a:gd name="connsiteX2" fmla="*/ 4035853 w 4035853"/>
              <a:gd name="connsiteY2" fmla="*/ 2697096 h 2701319"/>
              <a:gd name="connsiteX3" fmla="*/ 431848 w 4035853"/>
              <a:gd name="connsiteY3" fmla="*/ 2701319 h 2701319"/>
              <a:gd name="connsiteX4" fmla="*/ 311945 w 4035853"/>
              <a:gd name="connsiteY4" fmla="*/ 2697956 h 2701319"/>
              <a:gd name="connsiteX5" fmla="*/ 164279 w 4035853"/>
              <a:gd name="connsiteY5" fmla="*/ 2700356 h 2701319"/>
              <a:gd name="connsiteX6" fmla="*/ 0 w 4035853"/>
              <a:gd name="connsiteY6" fmla="*/ 2697096 h 2701319"/>
              <a:gd name="connsiteX7" fmla="*/ 0 w 4035853"/>
              <a:gd name="connsiteY7" fmla="*/ 0 h 2701319"/>
              <a:gd name="connsiteX0" fmla="*/ 0 w 4035853"/>
              <a:gd name="connsiteY0" fmla="*/ 0 h 2943225"/>
              <a:gd name="connsiteX1" fmla="*/ 4035853 w 4035853"/>
              <a:gd name="connsiteY1" fmla="*/ 0 h 2943225"/>
              <a:gd name="connsiteX2" fmla="*/ 4035853 w 4035853"/>
              <a:gd name="connsiteY2" fmla="*/ 2697096 h 2943225"/>
              <a:gd name="connsiteX3" fmla="*/ 431848 w 4035853"/>
              <a:gd name="connsiteY3" fmla="*/ 2701319 h 2943225"/>
              <a:gd name="connsiteX4" fmla="*/ 307182 w 4035853"/>
              <a:gd name="connsiteY4" fmla="*/ 2943225 h 2943225"/>
              <a:gd name="connsiteX5" fmla="*/ 164279 w 4035853"/>
              <a:gd name="connsiteY5" fmla="*/ 2700356 h 2943225"/>
              <a:gd name="connsiteX6" fmla="*/ 0 w 4035853"/>
              <a:gd name="connsiteY6" fmla="*/ 2697096 h 2943225"/>
              <a:gd name="connsiteX7" fmla="*/ 0 w 4035853"/>
              <a:gd name="connsiteY7" fmla="*/ 0 h 2943225"/>
              <a:gd name="connsiteX0" fmla="*/ 0 w 4035853"/>
              <a:gd name="connsiteY0" fmla="*/ 0 h 2943225"/>
              <a:gd name="connsiteX1" fmla="*/ 4035853 w 4035853"/>
              <a:gd name="connsiteY1" fmla="*/ 0 h 2943225"/>
              <a:gd name="connsiteX2" fmla="*/ 4035853 w 4035853"/>
              <a:gd name="connsiteY2" fmla="*/ 2697096 h 2943225"/>
              <a:gd name="connsiteX3" fmla="*/ 431848 w 4035853"/>
              <a:gd name="connsiteY3" fmla="*/ 2701319 h 2943225"/>
              <a:gd name="connsiteX4" fmla="*/ 307182 w 4035853"/>
              <a:gd name="connsiteY4" fmla="*/ 2943225 h 2943225"/>
              <a:gd name="connsiteX5" fmla="*/ 164279 w 4035853"/>
              <a:gd name="connsiteY5" fmla="*/ 2700356 h 2943225"/>
              <a:gd name="connsiteX6" fmla="*/ 0 w 4035853"/>
              <a:gd name="connsiteY6" fmla="*/ 2697096 h 2943225"/>
              <a:gd name="connsiteX7" fmla="*/ 0 w 4035853"/>
              <a:gd name="connsiteY7" fmla="*/ 0 h 2943225"/>
              <a:gd name="connsiteX0" fmla="*/ 0 w 4035853"/>
              <a:gd name="connsiteY0" fmla="*/ 0 h 2943225"/>
              <a:gd name="connsiteX1" fmla="*/ 4035853 w 4035853"/>
              <a:gd name="connsiteY1" fmla="*/ 0 h 2943225"/>
              <a:gd name="connsiteX2" fmla="*/ 4035853 w 4035853"/>
              <a:gd name="connsiteY2" fmla="*/ 2697096 h 2943225"/>
              <a:gd name="connsiteX3" fmla="*/ 431848 w 4035853"/>
              <a:gd name="connsiteY3" fmla="*/ 2701319 h 2943225"/>
              <a:gd name="connsiteX4" fmla="*/ 307182 w 4035853"/>
              <a:gd name="connsiteY4" fmla="*/ 2943225 h 2943225"/>
              <a:gd name="connsiteX5" fmla="*/ 164279 w 4035853"/>
              <a:gd name="connsiteY5" fmla="*/ 2700356 h 2943225"/>
              <a:gd name="connsiteX6" fmla="*/ 0 w 4035853"/>
              <a:gd name="connsiteY6" fmla="*/ 2697096 h 2943225"/>
              <a:gd name="connsiteX7" fmla="*/ 0 w 4035853"/>
              <a:gd name="connsiteY7" fmla="*/ 0 h 2943225"/>
              <a:gd name="connsiteX0" fmla="*/ 0 w 4035853"/>
              <a:gd name="connsiteY0" fmla="*/ 0 h 2943225"/>
              <a:gd name="connsiteX1" fmla="*/ 4035853 w 4035853"/>
              <a:gd name="connsiteY1" fmla="*/ 0 h 2943225"/>
              <a:gd name="connsiteX2" fmla="*/ 4035853 w 4035853"/>
              <a:gd name="connsiteY2" fmla="*/ 2697096 h 2943225"/>
              <a:gd name="connsiteX3" fmla="*/ 431848 w 4035853"/>
              <a:gd name="connsiteY3" fmla="*/ 2701319 h 2943225"/>
              <a:gd name="connsiteX4" fmla="*/ 307182 w 4035853"/>
              <a:gd name="connsiteY4" fmla="*/ 2943225 h 2943225"/>
              <a:gd name="connsiteX5" fmla="*/ 164279 w 4035853"/>
              <a:gd name="connsiteY5" fmla="*/ 2700356 h 2943225"/>
              <a:gd name="connsiteX6" fmla="*/ 0 w 4035853"/>
              <a:gd name="connsiteY6" fmla="*/ 2697096 h 2943225"/>
              <a:gd name="connsiteX7" fmla="*/ 0 w 4035853"/>
              <a:gd name="connsiteY7" fmla="*/ 0 h 2943225"/>
              <a:gd name="connsiteX0" fmla="*/ 0 w 4035853"/>
              <a:gd name="connsiteY0" fmla="*/ 0 h 2943225"/>
              <a:gd name="connsiteX1" fmla="*/ 4035853 w 4035853"/>
              <a:gd name="connsiteY1" fmla="*/ 0 h 2943225"/>
              <a:gd name="connsiteX2" fmla="*/ 4035853 w 4035853"/>
              <a:gd name="connsiteY2" fmla="*/ 2697096 h 2943225"/>
              <a:gd name="connsiteX3" fmla="*/ 431848 w 4035853"/>
              <a:gd name="connsiteY3" fmla="*/ 2701319 h 2943225"/>
              <a:gd name="connsiteX4" fmla="*/ 307182 w 4035853"/>
              <a:gd name="connsiteY4" fmla="*/ 2943225 h 2943225"/>
              <a:gd name="connsiteX5" fmla="*/ 164279 w 4035853"/>
              <a:gd name="connsiteY5" fmla="*/ 2700356 h 2943225"/>
              <a:gd name="connsiteX6" fmla="*/ 0 w 4035853"/>
              <a:gd name="connsiteY6" fmla="*/ 2697096 h 2943225"/>
              <a:gd name="connsiteX7" fmla="*/ 0 w 4035853"/>
              <a:gd name="connsiteY7" fmla="*/ 0 h 2943225"/>
              <a:gd name="connsiteX0" fmla="*/ 0 w 4035853"/>
              <a:gd name="connsiteY0" fmla="*/ 0 h 2936082"/>
              <a:gd name="connsiteX1" fmla="*/ 4035853 w 4035853"/>
              <a:gd name="connsiteY1" fmla="*/ 0 h 2936082"/>
              <a:gd name="connsiteX2" fmla="*/ 4035853 w 4035853"/>
              <a:gd name="connsiteY2" fmla="*/ 2697096 h 2936082"/>
              <a:gd name="connsiteX3" fmla="*/ 431848 w 4035853"/>
              <a:gd name="connsiteY3" fmla="*/ 2701319 h 2936082"/>
              <a:gd name="connsiteX4" fmla="*/ 302420 w 4035853"/>
              <a:gd name="connsiteY4" fmla="*/ 2936082 h 2936082"/>
              <a:gd name="connsiteX5" fmla="*/ 164279 w 4035853"/>
              <a:gd name="connsiteY5" fmla="*/ 2700356 h 2936082"/>
              <a:gd name="connsiteX6" fmla="*/ 0 w 4035853"/>
              <a:gd name="connsiteY6" fmla="*/ 2697096 h 2936082"/>
              <a:gd name="connsiteX7" fmla="*/ 0 w 4035853"/>
              <a:gd name="connsiteY7" fmla="*/ 0 h 2936082"/>
              <a:gd name="connsiteX0" fmla="*/ 0 w 4035853"/>
              <a:gd name="connsiteY0" fmla="*/ 0 h 2936082"/>
              <a:gd name="connsiteX1" fmla="*/ 4035853 w 4035853"/>
              <a:gd name="connsiteY1" fmla="*/ 0 h 2936082"/>
              <a:gd name="connsiteX2" fmla="*/ 4035853 w 4035853"/>
              <a:gd name="connsiteY2" fmla="*/ 2697096 h 2936082"/>
              <a:gd name="connsiteX3" fmla="*/ 431848 w 4035853"/>
              <a:gd name="connsiteY3" fmla="*/ 2701319 h 2936082"/>
              <a:gd name="connsiteX4" fmla="*/ 302420 w 4035853"/>
              <a:gd name="connsiteY4" fmla="*/ 2936082 h 2936082"/>
              <a:gd name="connsiteX5" fmla="*/ 164279 w 4035853"/>
              <a:gd name="connsiteY5" fmla="*/ 2700356 h 2936082"/>
              <a:gd name="connsiteX6" fmla="*/ 0 w 4035853"/>
              <a:gd name="connsiteY6" fmla="*/ 2697096 h 2936082"/>
              <a:gd name="connsiteX7" fmla="*/ 0 w 4035853"/>
              <a:gd name="connsiteY7" fmla="*/ 0 h 2936082"/>
              <a:gd name="connsiteX0" fmla="*/ 0 w 4035853"/>
              <a:gd name="connsiteY0" fmla="*/ 0 h 2936082"/>
              <a:gd name="connsiteX1" fmla="*/ 4035853 w 4035853"/>
              <a:gd name="connsiteY1" fmla="*/ 0 h 2936082"/>
              <a:gd name="connsiteX2" fmla="*/ 4035853 w 4035853"/>
              <a:gd name="connsiteY2" fmla="*/ 2697096 h 2936082"/>
              <a:gd name="connsiteX3" fmla="*/ 431848 w 4035853"/>
              <a:gd name="connsiteY3" fmla="*/ 2701319 h 2936082"/>
              <a:gd name="connsiteX4" fmla="*/ 302420 w 4035853"/>
              <a:gd name="connsiteY4" fmla="*/ 2936082 h 2936082"/>
              <a:gd name="connsiteX5" fmla="*/ 164279 w 4035853"/>
              <a:gd name="connsiteY5" fmla="*/ 2700356 h 2936082"/>
              <a:gd name="connsiteX6" fmla="*/ 0 w 4035853"/>
              <a:gd name="connsiteY6" fmla="*/ 2697096 h 2936082"/>
              <a:gd name="connsiteX7" fmla="*/ 0 w 4035853"/>
              <a:gd name="connsiteY7" fmla="*/ 0 h 2936082"/>
              <a:gd name="connsiteX0" fmla="*/ 0 w 4035853"/>
              <a:gd name="connsiteY0" fmla="*/ 0 h 2936085"/>
              <a:gd name="connsiteX1" fmla="*/ 4035853 w 4035853"/>
              <a:gd name="connsiteY1" fmla="*/ 0 h 2936085"/>
              <a:gd name="connsiteX2" fmla="*/ 4035853 w 4035853"/>
              <a:gd name="connsiteY2" fmla="*/ 2697096 h 2936085"/>
              <a:gd name="connsiteX3" fmla="*/ 431848 w 4035853"/>
              <a:gd name="connsiteY3" fmla="*/ 2701319 h 2936085"/>
              <a:gd name="connsiteX4" fmla="*/ 302420 w 4035853"/>
              <a:gd name="connsiteY4" fmla="*/ 2936082 h 2936085"/>
              <a:gd name="connsiteX5" fmla="*/ 166660 w 4035853"/>
              <a:gd name="connsiteY5" fmla="*/ 2695594 h 2936085"/>
              <a:gd name="connsiteX6" fmla="*/ 0 w 4035853"/>
              <a:gd name="connsiteY6" fmla="*/ 2697096 h 2936085"/>
              <a:gd name="connsiteX7" fmla="*/ 0 w 4035853"/>
              <a:gd name="connsiteY7" fmla="*/ 0 h 2936085"/>
              <a:gd name="connsiteX0" fmla="*/ 0 w 4035853"/>
              <a:gd name="connsiteY0" fmla="*/ 0 h 2936085"/>
              <a:gd name="connsiteX1" fmla="*/ 4035853 w 4035853"/>
              <a:gd name="connsiteY1" fmla="*/ 0 h 2936085"/>
              <a:gd name="connsiteX2" fmla="*/ 4035853 w 4035853"/>
              <a:gd name="connsiteY2" fmla="*/ 2697096 h 2936085"/>
              <a:gd name="connsiteX3" fmla="*/ 431848 w 4035853"/>
              <a:gd name="connsiteY3" fmla="*/ 2701319 h 2936085"/>
              <a:gd name="connsiteX4" fmla="*/ 302420 w 4035853"/>
              <a:gd name="connsiteY4" fmla="*/ 2936082 h 2936085"/>
              <a:gd name="connsiteX5" fmla="*/ 166660 w 4035853"/>
              <a:gd name="connsiteY5" fmla="*/ 2695594 h 2936085"/>
              <a:gd name="connsiteX6" fmla="*/ 0 w 4035853"/>
              <a:gd name="connsiteY6" fmla="*/ 2697096 h 2936085"/>
              <a:gd name="connsiteX7" fmla="*/ 0 w 4035853"/>
              <a:gd name="connsiteY7" fmla="*/ 0 h 2936085"/>
              <a:gd name="connsiteX0" fmla="*/ 0 w 4035853"/>
              <a:gd name="connsiteY0" fmla="*/ 0 h 2936085"/>
              <a:gd name="connsiteX1" fmla="*/ 4035853 w 4035853"/>
              <a:gd name="connsiteY1" fmla="*/ 0 h 2936085"/>
              <a:gd name="connsiteX2" fmla="*/ 4035853 w 4035853"/>
              <a:gd name="connsiteY2" fmla="*/ 2697096 h 2936085"/>
              <a:gd name="connsiteX3" fmla="*/ 431848 w 4035853"/>
              <a:gd name="connsiteY3" fmla="*/ 2701319 h 2936085"/>
              <a:gd name="connsiteX4" fmla="*/ 302420 w 4035853"/>
              <a:gd name="connsiteY4" fmla="*/ 2936082 h 2936085"/>
              <a:gd name="connsiteX5" fmla="*/ 166660 w 4035853"/>
              <a:gd name="connsiteY5" fmla="*/ 2695594 h 2936085"/>
              <a:gd name="connsiteX6" fmla="*/ 0 w 4035853"/>
              <a:gd name="connsiteY6" fmla="*/ 2697096 h 2936085"/>
              <a:gd name="connsiteX7" fmla="*/ 0 w 4035853"/>
              <a:gd name="connsiteY7" fmla="*/ 0 h 2936085"/>
              <a:gd name="connsiteX0" fmla="*/ 0 w 4035853"/>
              <a:gd name="connsiteY0" fmla="*/ 0 h 2936090"/>
              <a:gd name="connsiteX1" fmla="*/ 4035853 w 4035853"/>
              <a:gd name="connsiteY1" fmla="*/ 0 h 2936090"/>
              <a:gd name="connsiteX2" fmla="*/ 4035853 w 4035853"/>
              <a:gd name="connsiteY2" fmla="*/ 2697096 h 2936090"/>
              <a:gd name="connsiteX3" fmla="*/ 431848 w 4035853"/>
              <a:gd name="connsiteY3" fmla="*/ 2701319 h 2936090"/>
              <a:gd name="connsiteX4" fmla="*/ 302420 w 4035853"/>
              <a:gd name="connsiteY4" fmla="*/ 2936082 h 2936090"/>
              <a:gd name="connsiteX5" fmla="*/ 166660 w 4035853"/>
              <a:gd name="connsiteY5" fmla="*/ 2695594 h 2936090"/>
              <a:gd name="connsiteX6" fmla="*/ 0 w 4035853"/>
              <a:gd name="connsiteY6" fmla="*/ 2697096 h 2936090"/>
              <a:gd name="connsiteX7" fmla="*/ 0 w 4035853"/>
              <a:gd name="connsiteY7" fmla="*/ 0 h 2936090"/>
              <a:gd name="connsiteX0" fmla="*/ 0 w 4035853"/>
              <a:gd name="connsiteY0" fmla="*/ 0 h 2936082"/>
              <a:gd name="connsiteX1" fmla="*/ 4035853 w 4035853"/>
              <a:gd name="connsiteY1" fmla="*/ 0 h 2936082"/>
              <a:gd name="connsiteX2" fmla="*/ 4035853 w 4035853"/>
              <a:gd name="connsiteY2" fmla="*/ 2697096 h 2936082"/>
              <a:gd name="connsiteX3" fmla="*/ 431848 w 4035853"/>
              <a:gd name="connsiteY3" fmla="*/ 2696556 h 2936082"/>
              <a:gd name="connsiteX4" fmla="*/ 302420 w 4035853"/>
              <a:gd name="connsiteY4" fmla="*/ 2936082 h 2936082"/>
              <a:gd name="connsiteX5" fmla="*/ 166660 w 4035853"/>
              <a:gd name="connsiteY5" fmla="*/ 2695594 h 2936082"/>
              <a:gd name="connsiteX6" fmla="*/ 0 w 4035853"/>
              <a:gd name="connsiteY6" fmla="*/ 2697096 h 2936082"/>
              <a:gd name="connsiteX7" fmla="*/ 0 w 4035853"/>
              <a:gd name="connsiteY7" fmla="*/ 0 h 2936082"/>
              <a:gd name="connsiteX0" fmla="*/ 0 w 4035853"/>
              <a:gd name="connsiteY0" fmla="*/ 0 h 2967038"/>
              <a:gd name="connsiteX1" fmla="*/ 4035853 w 4035853"/>
              <a:gd name="connsiteY1" fmla="*/ 0 h 2967038"/>
              <a:gd name="connsiteX2" fmla="*/ 4035853 w 4035853"/>
              <a:gd name="connsiteY2" fmla="*/ 2697096 h 2967038"/>
              <a:gd name="connsiteX3" fmla="*/ 431848 w 4035853"/>
              <a:gd name="connsiteY3" fmla="*/ 2696556 h 2967038"/>
              <a:gd name="connsiteX4" fmla="*/ 300039 w 4035853"/>
              <a:gd name="connsiteY4" fmla="*/ 2967038 h 2967038"/>
              <a:gd name="connsiteX5" fmla="*/ 166660 w 4035853"/>
              <a:gd name="connsiteY5" fmla="*/ 2695594 h 2967038"/>
              <a:gd name="connsiteX6" fmla="*/ 0 w 4035853"/>
              <a:gd name="connsiteY6" fmla="*/ 2697096 h 2967038"/>
              <a:gd name="connsiteX7" fmla="*/ 0 w 4035853"/>
              <a:gd name="connsiteY7" fmla="*/ 0 h 2967038"/>
              <a:gd name="connsiteX0" fmla="*/ 0 w 4035853"/>
              <a:gd name="connsiteY0" fmla="*/ 0 h 2933700"/>
              <a:gd name="connsiteX1" fmla="*/ 4035853 w 4035853"/>
              <a:gd name="connsiteY1" fmla="*/ 0 h 2933700"/>
              <a:gd name="connsiteX2" fmla="*/ 4035853 w 4035853"/>
              <a:gd name="connsiteY2" fmla="*/ 2697096 h 2933700"/>
              <a:gd name="connsiteX3" fmla="*/ 431848 w 4035853"/>
              <a:gd name="connsiteY3" fmla="*/ 2696556 h 2933700"/>
              <a:gd name="connsiteX4" fmla="*/ 302420 w 4035853"/>
              <a:gd name="connsiteY4" fmla="*/ 2933700 h 2933700"/>
              <a:gd name="connsiteX5" fmla="*/ 166660 w 4035853"/>
              <a:gd name="connsiteY5" fmla="*/ 2695594 h 2933700"/>
              <a:gd name="connsiteX6" fmla="*/ 0 w 4035853"/>
              <a:gd name="connsiteY6" fmla="*/ 2697096 h 2933700"/>
              <a:gd name="connsiteX7" fmla="*/ 0 w 4035853"/>
              <a:gd name="connsiteY7" fmla="*/ 0 h 2933700"/>
              <a:gd name="connsiteX0" fmla="*/ 0 w 4035853"/>
              <a:gd name="connsiteY0" fmla="*/ 0 h 2933700"/>
              <a:gd name="connsiteX1" fmla="*/ 4035853 w 4035853"/>
              <a:gd name="connsiteY1" fmla="*/ 0 h 2933700"/>
              <a:gd name="connsiteX2" fmla="*/ 4035853 w 4035853"/>
              <a:gd name="connsiteY2" fmla="*/ 2697096 h 2933700"/>
              <a:gd name="connsiteX3" fmla="*/ 431848 w 4035853"/>
              <a:gd name="connsiteY3" fmla="*/ 2696556 h 2933700"/>
              <a:gd name="connsiteX4" fmla="*/ 302420 w 4035853"/>
              <a:gd name="connsiteY4" fmla="*/ 2933700 h 2933700"/>
              <a:gd name="connsiteX5" fmla="*/ 166660 w 4035853"/>
              <a:gd name="connsiteY5" fmla="*/ 2695594 h 2933700"/>
              <a:gd name="connsiteX6" fmla="*/ 0 w 4035853"/>
              <a:gd name="connsiteY6" fmla="*/ 2697096 h 2933700"/>
              <a:gd name="connsiteX7" fmla="*/ 0 w 4035853"/>
              <a:gd name="connsiteY7" fmla="*/ 0 h 2933700"/>
              <a:gd name="connsiteX0" fmla="*/ 0 w 4035853"/>
              <a:gd name="connsiteY0" fmla="*/ 0 h 2933700"/>
              <a:gd name="connsiteX1" fmla="*/ 4035853 w 4035853"/>
              <a:gd name="connsiteY1" fmla="*/ 0 h 2933700"/>
              <a:gd name="connsiteX2" fmla="*/ 4035853 w 4035853"/>
              <a:gd name="connsiteY2" fmla="*/ 2697096 h 2933700"/>
              <a:gd name="connsiteX3" fmla="*/ 431848 w 4035853"/>
              <a:gd name="connsiteY3" fmla="*/ 2696556 h 2933700"/>
              <a:gd name="connsiteX4" fmla="*/ 302420 w 4035853"/>
              <a:gd name="connsiteY4" fmla="*/ 2933700 h 2933700"/>
              <a:gd name="connsiteX5" fmla="*/ 154811 w 4035853"/>
              <a:gd name="connsiteY5" fmla="*/ 2695594 h 2933700"/>
              <a:gd name="connsiteX6" fmla="*/ 0 w 4035853"/>
              <a:gd name="connsiteY6" fmla="*/ 2697096 h 2933700"/>
              <a:gd name="connsiteX7" fmla="*/ 0 w 4035853"/>
              <a:gd name="connsiteY7" fmla="*/ 0 h 2933700"/>
              <a:gd name="connsiteX0" fmla="*/ 0 w 4035853"/>
              <a:gd name="connsiteY0" fmla="*/ 0 h 2947646"/>
              <a:gd name="connsiteX1" fmla="*/ 4035853 w 4035853"/>
              <a:gd name="connsiteY1" fmla="*/ 0 h 2947646"/>
              <a:gd name="connsiteX2" fmla="*/ 4035853 w 4035853"/>
              <a:gd name="connsiteY2" fmla="*/ 2697096 h 2947646"/>
              <a:gd name="connsiteX3" fmla="*/ 431848 w 4035853"/>
              <a:gd name="connsiteY3" fmla="*/ 2696556 h 2947646"/>
              <a:gd name="connsiteX4" fmla="*/ 341259 w 4035853"/>
              <a:gd name="connsiteY4" fmla="*/ 2895599 h 2947646"/>
              <a:gd name="connsiteX5" fmla="*/ 302420 w 4035853"/>
              <a:gd name="connsiteY5" fmla="*/ 2933700 h 2947646"/>
              <a:gd name="connsiteX6" fmla="*/ 154811 w 4035853"/>
              <a:gd name="connsiteY6" fmla="*/ 2695594 h 2947646"/>
              <a:gd name="connsiteX7" fmla="*/ 0 w 4035853"/>
              <a:gd name="connsiteY7" fmla="*/ 2697096 h 2947646"/>
              <a:gd name="connsiteX8" fmla="*/ 0 w 4035853"/>
              <a:gd name="connsiteY8" fmla="*/ 0 h 2947646"/>
              <a:gd name="connsiteX0" fmla="*/ 0 w 4035853"/>
              <a:gd name="connsiteY0" fmla="*/ 0 h 2947646"/>
              <a:gd name="connsiteX1" fmla="*/ 4035853 w 4035853"/>
              <a:gd name="connsiteY1" fmla="*/ 0 h 2947646"/>
              <a:gd name="connsiteX2" fmla="*/ 4035853 w 4035853"/>
              <a:gd name="connsiteY2" fmla="*/ 2697096 h 2947646"/>
              <a:gd name="connsiteX3" fmla="*/ 431848 w 4035853"/>
              <a:gd name="connsiteY3" fmla="*/ 2696556 h 2947646"/>
              <a:gd name="connsiteX4" fmla="*/ 341259 w 4035853"/>
              <a:gd name="connsiteY4" fmla="*/ 2895599 h 2947646"/>
              <a:gd name="connsiteX5" fmla="*/ 302420 w 4035853"/>
              <a:gd name="connsiteY5" fmla="*/ 2933700 h 2947646"/>
              <a:gd name="connsiteX6" fmla="*/ 154811 w 4035853"/>
              <a:gd name="connsiteY6" fmla="*/ 2695594 h 2947646"/>
              <a:gd name="connsiteX7" fmla="*/ 0 w 4035853"/>
              <a:gd name="connsiteY7" fmla="*/ 2697096 h 2947646"/>
              <a:gd name="connsiteX8" fmla="*/ 0 w 4035853"/>
              <a:gd name="connsiteY8" fmla="*/ 0 h 2947646"/>
              <a:gd name="connsiteX0" fmla="*/ 0 w 4035853"/>
              <a:gd name="connsiteY0" fmla="*/ 0 h 2933799"/>
              <a:gd name="connsiteX1" fmla="*/ 4035853 w 4035853"/>
              <a:gd name="connsiteY1" fmla="*/ 0 h 2933799"/>
              <a:gd name="connsiteX2" fmla="*/ 4035853 w 4035853"/>
              <a:gd name="connsiteY2" fmla="*/ 2697096 h 2933799"/>
              <a:gd name="connsiteX3" fmla="*/ 431848 w 4035853"/>
              <a:gd name="connsiteY3" fmla="*/ 2696556 h 2933799"/>
              <a:gd name="connsiteX4" fmla="*/ 341259 w 4035853"/>
              <a:gd name="connsiteY4" fmla="*/ 2895599 h 2933799"/>
              <a:gd name="connsiteX5" fmla="*/ 302420 w 4035853"/>
              <a:gd name="connsiteY5" fmla="*/ 2933700 h 2933799"/>
              <a:gd name="connsiteX6" fmla="*/ 272534 w 4035853"/>
              <a:gd name="connsiteY6" fmla="*/ 2893218 h 2933799"/>
              <a:gd name="connsiteX7" fmla="*/ 154811 w 4035853"/>
              <a:gd name="connsiteY7" fmla="*/ 2695594 h 2933799"/>
              <a:gd name="connsiteX8" fmla="*/ 0 w 4035853"/>
              <a:gd name="connsiteY8" fmla="*/ 2697096 h 2933799"/>
              <a:gd name="connsiteX9" fmla="*/ 0 w 4035853"/>
              <a:gd name="connsiteY9" fmla="*/ 0 h 2933799"/>
              <a:gd name="connsiteX0" fmla="*/ 0 w 4035853"/>
              <a:gd name="connsiteY0" fmla="*/ 0 h 2933799"/>
              <a:gd name="connsiteX1" fmla="*/ 4035853 w 4035853"/>
              <a:gd name="connsiteY1" fmla="*/ 0 h 2933799"/>
              <a:gd name="connsiteX2" fmla="*/ 4035853 w 4035853"/>
              <a:gd name="connsiteY2" fmla="*/ 2697096 h 2933799"/>
              <a:gd name="connsiteX3" fmla="*/ 431848 w 4035853"/>
              <a:gd name="connsiteY3" fmla="*/ 2696556 h 2933799"/>
              <a:gd name="connsiteX4" fmla="*/ 341259 w 4035853"/>
              <a:gd name="connsiteY4" fmla="*/ 2895599 h 2933799"/>
              <a:gd name="connsiteX5" fmla="*/ 302420 w 4035853"/>
              <a:gd name="connsiteY5" fmla="*/ 2933700 h 2933799"/>
              <a:gd name="connsiteX6" fmla="*/ 260684 w 4035853"/>
              <a:gd name="connsiteY6" fmla="*/ 2893218 h 2933799"/>
              <a:gd name="connsiteX7" fmla="*/ 154811 w 4035853"/>
              <a:gd name="connsiteY7" fmla="*/ 2695594 h 2933799"/>
              <a:gd name="connsiteX8" fmla="*/ 0 w 4035853"/>
              <a:gd name="connsiteY8" fmla="*/ 2697096 h 2933799"/>
              <a:gd name="connsiteX9" fmla="*/ 0 w 4035853"/>
              <a:gd name="connsiteY9" fmla="*/ 0 h 2933799"/>
              <a:gd name="connsiteX0" fmla="*/ 0 w 4035853"/>
              <a:gd name="connsiteY0" fmla="*/ 0 h 2933799"/>
              <a:gd name="connsiteX1" fmla="*/ 4035853 w 4035853"/>
              <a:gd name="connsiteY1" fmla="*/ 0 h 2933799"/>
              <a:gd name="connsiteX2" fmla="*/ 4035853 w 4035853"/>
              <a:gd name="connsiteY2" fmla="*/ 2697096 h 2933799"/>
              <a:gd name="connsiteX3" fmla="*/ 431848 w 4035853"/>
              <a:gd name="connsiteY3" fmla="*/ 2696556 h 2933799"/>
              <a:gd name="connsiteX4" fmla="*/ 341259 w 4035853"/>
              <a:gd name="connsiteY4" fmla="*/ 2895599 h 2933799"/>
              <a:gd name="connsiteX5" fmla="*/ 302420 w 4035853"/>
              <a:gd name="connsiteY5" fmla="*/ 2933700 h 2933799"/>
              <a:gd name="connsiteX6" fmla="*/ 260684 w 4035853"/>
              <a:gd name="connsiteY6" fmla="*/ 2893218 h 2933799"/>
              <a:gd name="connsiteX7" fmla="*/ 154811 w 4035853"/>
              <a:gd name="connsiteY7" fmla="*/ 2695594 h 2933799"/>
              <a:gd name="connsiteX8" fmla="*/ 0 w 4035853"/>
              <a:gd name="connsiteY8" fmla="*/ 2697096 h 2933799"/>
              <a:gd name="connsiteX9" fmla="*/ 0 w 4035853"/>
              <a:gd name="connsiteY9" fmla="*/ 0 h 2933799"/>
              <a:gd name="connsiteX0" fmla="*/ 0 w 4035853"/>
              <a:gd name="connsiteY0" fmla="*/ 0 h 2940861"/>
              <a:gd name="connsiteX1" fmla="*/ 4035853 w 4035853"/>
              <a:gd name="connsiteY1" fmla="*/ 0 h 2940861"/>
              <a:gd name="connsiteX2" fmla="*/ 4035853 w 4035853"/>
              <a:gd name="connsiteY2" fmla="*/ 2697096 h 2940861"/>
              <a:gd name="connsiteX3" fmla="*/ 431848 w 4035853"/>
              <a:gd name="connsiteY3" fmla="*/ 2696556 h 2940861"/>
              <a:gd name="connsiteX4" fmla="*/ 341259 w 4035853"/>
              <a:gd name="connsiteY4" fmla="*/ 2895599 h 2940861"/>
              <a:gd name="connsiteX5" fmla="*/ 295311 w 4035853"/>
              <a:gd name="connsiteY5" fmla="*/ 2940844 h 2940861"/>
              <a:gd name="connsiteX6" fmla="*/ 260684 w 4035853"/>
              <a:gd name="connsiteY6" fmla="*/ 2893218 h 2940861"/>
              <a:gd name="connsiteX7" fmla="*/ 154811 w 4035853"/>
              <a:gd name="connsiteY7" fmla="*/ 2695594 h 2940861"/>
              <a:gd name="connsiteX8" fmla="*/ 0 w 4035853"/>
              <a:gd name="connsiteY8" fmla="*/ 2697096 h 2940861"/>
              <a:gd name="connsiteX9" fmla="*/ 0 w 4035853"/>
              <a:gd name="connsiteY9" fmla="*/ 0 h 2940861"/>
              <a:gd name="connsiteX0" fmla="*/ 0 w 4035853"/>
              <a:gd name="connsiteY0" fmla="*/ 0 h 2940861"/>
              <a:gd name="connsiteX1" fmla="*/ 4035853 w 4035853"/>
              <a:gd name="connsiteY1" fmla="*/ 0 h 2940861"/>
              <a:gd name="connsiteX2" fmla="*/ 4035853 w 4035853"/>
              <a:gd name="connsiteY2" fmla="*/ 2697096 h 2940861"/>
              <a:gd name="connsiteX3" fmla="*/ 431848 w 4035853"/>
              <a:gd name="connsiteY3" fmla="*/ 2696556 h 2940861"/>
              <a:gd name="connsiteX4" fmla="*/ 334149 w 4035853"/>
              <a:gd name="connsiteY4" fmla="*/ 2895599 h 2940861"/>
              <a:gd name="connsiteX5" fmla="*/ 295311 w 4035853"/>
              <a:gd name="connsiteY5" fmla="*/ 2940844 h 2940861"/>
              <a:gd name="connsiteX6" fmla="*/ 260684 w 4035853"/>
              <a:gd name="connsiteY6" fmla="*/ 2893218 h 2940861"/>
              <a:gd name="connsiteX7" fmla="*/ 154811 w 4035853"/>
              <a:gd name="connsiteY7" fmla="*/ 2695594 h 2940861"/>
              <a:gd name="connsiteX8" fmla="*/ 0 w 4035853"/>
              <a:gd name="connsiteY8" fmla="*/ 2697096 h 2940861"/>
              <a:gd name="connsiteX9" fmla="*/ 0 w 4035853"/>
              <a:gd name="connsiteY9" fmla="*/ 0 h 2940861"/>
              <a:gd name="connsiteX0" fmla="*/ 0 w 4035853"/>
              <a:gd name="connsiteY0" fmla="*/ 0 h 2940861"/>
              <a:gd name="connsiteX1" fmla="*/ 4035853 w 4035853"/>
              <a:gd name="connsiteY1" fmla="*/ 0 h 2940861"/>
              <a:gd name="connsiteX2" fmla="*/ 4035853 w 4035853"/>
              <a:gd name="connsiteY2" fmla="*/ 2697096 h 2940861"/>
              <a:gd name="connsiteX3" fmla="*/ 431848 w 4035853"/>
              <a:gd name="connsiteY3" fmla="*/ 2696556 h 2940861"/>
              <a:gd name="connsiteX4" fmla="*/ 334149 w 4035853"/>
              <a:gd name="connsiteY4" fmla="*/ 2895599 h 2940861"/>
              <a:gd name="connsiteX5" fmla="*/ 295311 w 4035853"/>
              <a:gd name="connsiteY5" fmla="*/ 2940844 h 2940861"/>
              <a:gd name="connsiteX6" fmla="*/ 260684 w 4035853"/>
              <a:gd name="connsiteY6" fmla="*/ 2893218 h 2940861"/>
              <a:gd name="connsiteX7" fmla="*/ 154811 w 4035853"/>
              <a:gd name="connsiteY7" fmla="*/ 2695594 h 2940861"/>
              <a:gd name="connsiteX8" fmla="*/ 0 w 4035853"/>
              <a:gd name="connsiteY8" fmla="*/ 2697096 h 2940861"/>
              <a:gd name="connsiteX9" fmla="*/ 0 w 4035853"/>
              <a:gd name="connsiteY9" fmla="*/ 0 h 2940861"/>
              <a:gd name="connsiteX0" fmla="*/ 0 w 4035853"/>
              <a:gd name="connsiteY0" fmla="*/ 0 h 2941325"/>
              <a:gd name="connsiteX1" fmla="*/ 4035853 w 4035853"/>
              <a:gd name="connsiteY1" fmla="*/ 0 h 2941325"/>
              <a:gd name="connsiteX2" fmla="*/ 4035853 w 4035853"/>
              <a:gd name="connsiteY2" fmla="*/ 2697096 h 2941325"/>
              <a:gd name="connsiteX3" fmla="*/ 431848 w 4035853"/>
              <a:gd name="connsiteY3" fmla="*/ 2696556 h 2941325"/>
              <a:gd name="connsiteX4" fmla="*/ 334149 w 4035853"/>
              <a:gd name="connsiteY4" fmla="*/ 2895599 h 2941325"/>
              <a:gd name="connsiteX5" fmla="*/ 295311 w 4035853"/>
              <a:gd name="connsiteY5" fmla="*/ 2940844 h 2941325"/>
              <a:gd name="connsiteX6" fmla="*/ 260684 w 4035853"/>
              <a:gd name="connsiteY6" fmla="*/ 2893218 h 2941325"/>
              <a:gd name="connsiteX7" fmla="*/ 154811 w 4035853"/>
              <a:gd name="connsiteY7" fmla="*/ 2695594 h 2941325"/>
              <a:gd name="connsiteX8" fmla="*/ 0 w 4035853"/>
              <a:gd name="connsiteY8" fmla="*/ 2697096 h 2941325"/>
              <a:gd name="connsiteX9" fmla="*/ 0 w 4035853"/>
              <a:gd name="connsiteY9" fmla="*/ 0 h 2941325"/>
              <a:gd name="connsiteX0" fmla="*/ 0 w 4035853"/>
              <a:gd name="connsiteY0" fmla="*/ 0 h 2940861"/>
              <a:gd name="connsiteX1" fmla="*/ 4035853 w 4035853"/>
              <a:gd name="connsiteY1" fmla="*/ 0 h 2940861"/>
              <a:gd name="connsiteX2" fmla="*/ 4035853 w 4035853"/>
              <a:gd name="connsiteY2" fmla="*/ 2697096 h 2940861"/>
              <a:gd name="connsiteX3" fmla="*/ 431848 w 4035853"/>
              <a:gd name="connsiteY3" fmla="*/ 2696556 h 2940861"/>
              <a:gd name="connsiteX4" fmla="*/ 334149 w 4035853"/>
              <a:gd name="connsiteY4" fmla="*/ 2895599 h 2940861"/>
              <a:gd name="connsiteX5" fmla="*/ 295311 w 4035853"/>
              <a:gd name="connsiteY5" fmla="*/ 2940844 h 2940861"/>
              <a:gd name="connsiteX6" fmla="*/ 260684 w 4035853"/>
              <a:gd name="connsiteY6" fmla="*/ 2893218 h 2940861"/>
              <a:gd name="connsiteX7" fmla="*/ 154811 w 4035853"/>
              <a:gd name="connsiteY7" fmla="*/ 2695594 h 2940861"/>
              <a:gd name="connsiteX8" fmla="*/ 0 w 4035853"/>
              <a:gd name="connsiteY8" fmla="*/ 2697096 h 2940861"/>
              <a:gd name="connsiteX9" fmla="*/ 0 w 4035853"/>
              <a:gd name="connsiteY9" fmla="*/ 0 h 2940861"/>
              <a:gd name="connsiteX0" fmla="*/ 0 w 4035853"/>
              <a:gd name="connsiteY0" fmla="*/ 0 h 2940861"/>
              <a:gd name="connsiteX1" fmla="*/ 4035853 w 4035853"/>
              <a:gd name="connsiteY1" fmla="*/ 0 h 2940861"/>
              <a:gd name="connsiteX2" fmla="*/ 4035853 w 4035853"/>
              <a:gd name="connsiteY2" fmla="*/ 2697096 h 2940861"/>
              <a:gd name="connsiteX3" fmla="*/ 431848 w 4035853"/>
              <a:gd name="connsiteY3" fmla="*/ 2696556 h 2940861"/>
              <a:gd name="connsiteX4" fmla="*/ 334149 w 4035853"/>
              <a:gd name="connsiteY4" fmla="*/ 2895599 h 2940861"/>
              <a:gd name="connsiteX5" fmla="*/ 295311 w 4035853"/>
              <a:gd name="connsiteY5" fmla="*/ 2940844 h 2940861"/>
              <a:gd name="connsiteX6" fmla="*/ 260684 w 4035853"/>
              <a:gd name="connsiteY6" fmla="*/ 2893218 h 2940861"/>
              <a:gd name="connsiteX7" fmla="*/ 154811 w 4035853"/>
              <a:gd name="connsiteY7" fmla="*/ 2695594 h 2940861"/>
              <a:gd name="connsiteX8" fmla="*/ 0 w 4035853"/>
              <a:gd name="connsiteY8" fmla="*/ 2697096 h 2940861"/>
              <a:gd name="connsiteX9" fmla="*/ 0 w 4035853"/>
              <a:gd name="connsiteY9" fmla="*/ 0 h 2940861"/>
              <a:gd name="connsiteX0" fmla="*/ 0 w 4035853"/>
              <a:gd name="connsiteY0" fmla="*/ 0 h 2938488"/>
              <a:gd name="connsiteX1" fmla="*/ 4035853 w 4035853"/>
              <a:gd name="connsiteY1" fmla="*/ 0 h 2938488"/>
              <a:gd name="connsiteX2" fmla="*/ 4035853 w 4035853"/>
              <a:gd name="connsiteY2" fmla="*/ 2697096 h 2938488"/>
              <a:gd name="connsiteX3" fmla="*/ 431848 w 4035853"/>
              <a:gd name="connsiteY3" fmla="*/ 2696556 h 2938488"/>
              <a:gd name="connsiteX4" fmla="*/ 334149 w 4035853"/>
              <a:gd name="connsiteY4" fmla="*/ 2895599 h 2938488"/>
              <a:gd name="connsiteX5" fmla="*/ 295311 w 4035853"/>
              <a:gd name="connsiteY5" fmla="*/ 2938463 h 2938488"/>
              <a:gd name="connsiteX6" fmla="*/ 260684 w 4035853"/>
              <a:gd name="connsiteY6" fmla="*/ 2893218 h 2938488"/>
              <a:gd name="connsiteX7" fmla="*/ 154811 w 4035853"/>
              <a:gd name="connsiteY7" fmla="*/ 2695594 h 2938488"/>
              <a:gd name="connsiteX8" fmla="*/ 0 w 4035853"/>
              <a:gd name="connsiteY8" fmla="*/ 2697096 h 2938488"/>
              <a:gd name="connsiteX9" fmla="*/ 0 w 4035853"/>
              <a:gd name="connsiteY9" fmla="*/ 0 h 2938488"/>
              <a:gd name="connsiteX0" fmla="*/ 0 w 4035853"/>
              <a:gd name="connsiteY0" fmla="*/ 0 h 2938488"/>
              <a:gd name="connsiteX1" fmla="*/ 4035853 w 4035853"/>
              <a:gd name="connsiteY1" fmla="*/ 0 h 2938488"/>
              <a:gd name="connsiteX2" fmla="*/ 4035853 w 4035853"/>
              <a:gd name="connsiteY2" fmla="*/ 2697096 h 2938488"/>
              <a:gd name="connsiteX3" fmla="*/ 431848 w 4035853"/>
              <a:gd name="connsiteY3" fmla="*/ 2696556 h 2938488"/>
              <a:gd name="connsiteX4" fmla="*/ 334149 w 4035853"/>
              <a:gd name="connsiteY4" fmla="*/ 2895599 h 2938488"/>
              <a:gd name="connsiteX5" fmla="*/ 295311 w 4035853"/>
              <a:gd name="connsiteY5" fmla="*/ 2938463 h 2938488"/>
              <a:gd name="connsiteX6" fmla="*/ 260684 w 4035853"/>
              <a:gd name="connsiteY6" fmla="*/ 2893218 h 2938488"/>
              <a:gd name="connsiteX7" fmla="*/ 159550 w 4035853"/>
              <a:gd name="connsiteY7" fmla="*/ 2695594 h 2938488"/>
              <a:gd name="connsiteX8" fmla="*/ 0 w 4035853"/>
              <a:gd name="connsiteY8" fmla="*/ 2697096 h 2938488"/>
              <a:gd name="connsiteX9" fmla="*/ 0 w 4035853"/>
              <a:gd name="connsiteY9" fmla="*/ 0 h 2938488"/>
              <a:gd name="connsiteX0" fmla="*/ 0 w 4035853"/>
              <a:gd name="connsiteY0" fmla="*/ 0 h 2938488"/>
              <a:gd name="connsiteX1" fmla="*/ 4035853 w 4035853"/>
              <a:gd name="connsiteY1" fmla="*/ 0 h 2938488"/>
              <a:gd name="connsiteX2" fmla="*/ 4035853 w 4035853"/>
              <a:gd name="connsiteY2" fmla="*/ 2697096 h 2938488"/>
              <a:gd name="connsiteX3" fmla="*/ 431848 w 4035853"/>
              <a:gd name="connsiteY3" fmla="*/ 2696556 h 2938488"/>
              <a:gd name="connsiteX4" fmla="*/ 334149 w 4035853"/>
              <a:gd name="connsiteY4" fmla="*/ 2895599 h 2938488"/>
              <a:gd name="connsiteX5" fmla="*/ 295311 w 4035853"/>
              <a:gd name="connsiteY5" fmla="*/ 2938463 h 2938488"/>
              <a:gd name="connsiteX6" fmla="*/ 260684 w 4035853"/>
              <a:gd name="connsiteY6" fmla="*/ 2893218 h 2938488"/>
              <a:gd name="connsiteX7" fmla="*/ 159550 w 4035853"/>
              <a:gd name="connsiteY7" fmla="*/ 2695594 h 2938488"/>
              <a:gd name="connsiteX8" fmla="*/ 0 w 4035853"/>
              <a:gd name="connsiteY8" fmla="*/ 2697096 h 2938488"/>
              <a:gd name="connsiteX9" fmla="*/ 0 w 4035853"/>
              <a:gd name="connsiteY9" fmla="*/ 0 h 2938488"/>
              <a:gd name="connsiteX0" fmla="*/ 0 w 4035853"/>
              <a:gd name="connsiteY0" fmla="*/ 0 h 2938488"/>
              <a:gd name="connsiteX1" fmla="*/ 4035853 w 4035853"/>
              <a:gd name="connsiteY1" fmla="*/ 0 h 2938488"/>
              <a:gd name="connsiteX2" fmla="*/ 4035853 w 4035853"/>
              <a:gd name="connsiteY2" fmla="*/ 2697096 h 2938488"/>
              <a:gd name="connsiteX3" fmla="*/ 431848 w 4035853"/>
              <a:gd name="connsiteY3" fmla="*/ 2696556 h 2938488"/>
              <a:gd name="connsiteX4" fmla="*/ 334149 w 4035853"/>
              <a:gd name="connsiteY4" fmla="*/ 2895599 h 2938488"/>
              <a:gd name="connsiteX5" fmla="*/ 300051 w 4035853"/>
              <a:gd name="connsiteY5" fmla="*/ 2938463 h 2938488"/>
              <a:gd name="connsiteX6" fmla="*/ 260684 w 4035853"/>
              <a:gd name="connsiteY6" fmla="*/ 2893218 h 2938488"/>
              <a:gd name="connsiteX7" fmla="*/ 159550 w 4035853"/>
              <a:gd name="connsiteY7" fmla="*/ 2695594 h 2938488"/>
              <a:gd name="connsiteX8" fmla="*/ 0 w 4035853"/>
              <a:gd name="connsiteY8" fmla="*/ 2697096 h 2938488"/>
              <a:gd name="connsiteX9" fmla="*/ 0 w 4035853"/>
              <a:gd name="connsiteY9" fmla="*/ 0 h 2938488"/>
              <a:gd name="connsiteX0" fmla="*/ 0 w 4035853"/>
              <a:gd name="connsiteY0" fmla="*/ 0 h 2938470"/>
              <a:gd name="connsiteX1" fmla="*/ 4035853 w 4035853"/>
              <a:gd name="connsiteY1" fmla="*/ 0 h 2938470"/>
              <a:gd name="connsiteX2" fmla="*/ 4035853 w 4035853"/>
              <a:gd name="connsiteY2" fmla="*/ 2697096 h 2938470"/>
              <a:gd name="connsiteX3" fmla="*/ 431848 w 4035853"/>
              <a:gd name="connsiteY3" fmla="*/ 2696556 h 2938470"/>
              <a:gd name="connsiteX4" fmla="*/ 334149 w 4035853"/>
              <a:gd name="connsiteY4" fmla="*/ 2895599 h 2938470"/>
              <a:gd name="connsiteX5" fmla="*/ 300051 w 4035853"/>
              <a:gd name="connsiteY5" fmla="*/ 2938463 h 2938470"/>
              <a:gd name="connsiteX6" fmla="*/ 260684 w 4035853"/>
              <a:gd name="connsiteY6" fmla="*/ 2893218 h 2938470"/>
              <a:gd name="connsiteX7" fmla="*/ 159550 w 4035853"/>
              <a:gd name="connsiteY7" fmla="*/ 2695594 h 2938470"/>
              <a:gd name="connsiteX8" fmla="*/ 0 w 4035853"/>
              <a:gd name="connsiteY8" fmla="*/ 2697096 h 2938470"/>
              <a:gd name="connsiteX9" fmla="*/ 0 w 4035853"/>
              <a:gd name="connsiteY9" fmla="*/ 0 h 2938470"/>
              <a:gd name="connsiteX0" fmla="*/ 0 w 4035853"/>
              <a:gd name="connsiteY0" fmla="*/ 0 h 2938470"/>
              <a:gd name="connsiteX1" fmla="*/ 4035853 w 4035853"/>
              <a:gd name="connsiteY1" fmla="*/ 0 h 2938470"/>
              <a:gd name="connsiteX2" fmla="*/ 4035853 w 4035853"/>
              <a:gd name="connsiteY2" fmla="*/ 2697096 h 2938470"/>
              <a:gd name="connsiteX3" fmla="*/ 431848 w 4035853"/>
              <a:gd name="connsiteY3" fmla="*/ 2696556 h 2938470"/>
              <a:gd name="connsiteX4" fmla="*/ 334149 w 4035853"/>
              <a:gd name="connsiteY4" fmla="*/ 2895599 h 2938470"/>
              <a:gd name="connsiteX5" fmla="*/ 300051 w 4035853"/>
              <a:gd name="connsiteY5" fmla="*/ 2938463 h 2938470"/>
              <a:gd name="connsiteX6" fmla="*/ 260684 w 4035853"/>
              <a:gd name="connsiteY6" fmla="*/ 2893218 h 2938470"/>
              <a:gd name="connsiteX7" fmla="*/ 159550 w 4035853"/>
              <a:gd name="connsiteY7" fmla="*/ 2695594 h 2938470"/>
              <a:gd name="connsiteX8" fmla="*/ 0 w 4035853"/>
              <a:gd name="connsiteY8" fmla="*/ 2697096 h 2938470"/>
              <a:gd name="connsiteX9" fmla="*/ 0 w 4035853"/>
              <a:gd name="connsiteY9" fmla="*/ 0 h 2938470"/>
              <a:gd name="connsiteX0" fmla="*/ 0 w 4035853"/>
              <a:gd name="connsiteY0" fmla="*/ 0 h 2938470"/>
              <a:gd name="connsiteX1" fmla="*/ 4035853 w 4035853"/>
              <a:gd name="connsiteY1" fmla="*/ 0 h 2938470"/>
              <a:gd name="connsiteX2" fmla="*/ 4035853 w 4035853"/>
              <a:gd name="connsiteY2" fmla="*/ 2697096 h 2938470"/>
              <a:gd name="connsiteX3" fmla="*/ 431848 w 4035853"/>
              <a:gd name="connsiteY3" fmla="*/ 2696556 h 2938470"/>
              <a:gd name="connsiteX4" fmla="*/ 334149 w 4035853"/>
              <a:gd name="connsiteY4" fmla="*/ 2895599 h 2938470"/>
              <a:gd name="connsiteX5" fmla="*/ 300051 w 4035853"/>
              <a:gd name="connsiteY5" fmla="*/ 2938463 h 2938470"/>
              <a:gd name="connsiteX6" fmla="*/ 260684 w 4035853"/>
              <a:gd name="connsiteY6" fmla="*/ 2893218 h 2938470"/>
              <a:gd name="connsiteX7" fmla="*/ 159550 w 4035853"/>
              <a:gd name="connsiteY7" fmla="*/ 2695594 h 2938470"/>
              <a:gd name="connsiteX8" fmla="*/ 0 w 4035853"/>
              <a:gd name="connsiteY8" fmla="*/ 2697096 h 2938470"/>
              <a:gd name="connsiteX9" fmla="*/ 0 w 4035853"/>
              <a:gd name="connsiteY9" fmla="*/ 0 h 2938470"/>
              <a:gd name="connsiteX0" fmla="*/ 0 w 4035853"/>
              <a:gd name="connsiteY0" fmla="*/ 0 h 2938470"/>
              <a:gd name="connsiteX1" fmla="*/ 4035853 w 4035853"/>
              <a:gd name="connsiteY1" fmla="*/ 0 h 2938470"/>
              <a:gd name="connsiteX2" fmla="*/ 4035853 w 4035853"/>
              <a:gd name="connsiteY2" fmla="*/ 2697096 h 2938470"/>
              <a:gd name="connsiteX3" fmla="*/ 431848 w 4035853"/>
              <a:gd name="connsiteY3" fmla="*/ 2696556 h 2938470"/>
              <a:gd name="connsiteX4" fmla="*/ 334149 w 4035853"/>
              <a:gd name="connsiteY4" fmla="*/ 2895599 h 2938470"/>
              <a:gd name="connsiteX5" fmla="*/ 300051 w 4035853"/>
              <a:gd name="connsiteY5" fmla="*/ 2938463 h 2938470"/>
              <a:gd name="connsiteX6" fmla="*/ 260684 w 4035853"/>
              <a:gd name="connsiteY6" fmla="*/ 2893218 h 2938470"/>
              <a:gd name="connsiteX7" fmla="*/ 159550 w 4035853"/>
              <a:gd name="connsiteY7" fmla="*/ 2695594 h 2938470"/>
              <a:gd name="connsiteX8" fmla="*/ 0 w 4035853"/>
              <a:gd name="connsiteY8" fmla="*/ 2697096 h 2938470"/>
              <a:gd name="connsiteX9" fmla="*/ 0 w 4035853"/>
              <a:gd name="connsiteY9" fmla="*/ 0 h 2938470"/>
              <a:gd name="connsiteX0" fmla="*/ 0 w 4035853"/>
              <a:gd name="connsiteY0" fmla="*/ 0 h 2948969"/>
              <a:gd name="connsiteX1" fmla="*/ 4035853 w 4035853"/>
              <a:gd name="connsiteY1" fmla="*/ 0 h 2948969"/>
              <a:gd name="connsiteX2" fmla="*/ 4035853 w 4035853"/>
              <a:gd name="connsiteY2" fmla="*/ 2697096 h 2948969"/>
              <a:gd name="connsiteX3" fmla="*/ 431848 w 4035853"/>
              <a:gd name="connsiteY3" fmla="*/ 2696556 h 2948969"/>
              <a:gd name="connsiteX4" fmla="*/ 334149 w 4035853"/>
              <a:gd name="connsiteY4" fmla="*/ 2895599 h 2948969"/>
              <a:gd name="connsiteX5" fmla="*/ 300051 w 4035853"/>
              <a:gd name="connsiteY5" fmla="*/ 2938463 h 2948969"/>
              <a:gd name="connsiteX6" fmla="*/ 260684 w 4035853"/>
              <a:gd name="connsiteY6" fmla="*/ 2893218 h 2948969"/>
              <a:gd name="connsiteX7" fmla="*/ 159550 w 4035853"/>
              <a:gd name="connsiteY7" fmla="*/ 2695594 h 2948969"/>
              <a:gd name="connsiteX8" fmla="*/ 0 w 4035853"/>
              <a:gd name="connsiteY8" fmla="*/ 2697096 h 2948969"/>
              <a:gd name="connsiteX9" fmla="*/ 0 w 4035853"/>
              <a:gd name="connsiteY9" fmla="*/ 0 h 2948969"/>
              <a:gd name="connsiteX0" fmla="*/ 0 w 4035853"/>
              <a:gd name="connsiteY0" fmla="*/ 0 h 2938468"/>
              <a:gd name="connsiteX1" fmla="*/ 4035853 w 4035853"/>
              <a:gd name="connsiteY1" fmla="*/ 0 h 2938468"/>
              <a:gd name="connsiteX2" fmla="*/ 4035853 w 4035853"/>
              <a:gd name="connsiteY2" fmla="*/ 2697096 h 2938468"/>
              <a:gd name="connsiteX3" fmla="*/ 431848 w 4035853"/>
              <a:gd name="connsiteY3" fmla="*/ 2696556 h 2938468"/>
              <a:gd name="connsiteX4" fmla="*/ 334149 w 4035853"/>
              <a:gd name="connsiteY4" fmla="*/ 2895599 h 2938468"/>
              <a:gd name="connsiteX5" fmla="*/ 300051 w 4035853"/>
              <a:gd name="connsiteY5" fmla="*/ 2938463 h 2938468"/>
              <a:gd name="connsiteX6" fmla="*/ 260684 w 4035853"/>
              <a:gd name="connsiteY6" fmla="*/ 2893218 h 2938468"/>
              <a:gd name="connsiteX7" fmla="*/ 159550 w 4035853"/>
              <a:gd name="connsiteY7" fmla="*/ 2695594 h 2938468"/>
              <a:gd name="connsiteX8" fmla="*/ 0 w 4035853"/>
              <a:gd name="connsiteY8" fmla="*/ 2697096 h 2938468"/>
              <a:gd name="connsiteX9" fmla="*/ 0 w 4035853"/>
              <a:gd name="connsiteY9" fmla="*/ 0 h 2938468"/>
              <a:gd name="connsiteX0" fmla="*/ 0 w 4035853"/>
              <a:gd name="connsiteY0" fmla="*/ 0 h 2938468"/>
              <a:gd name="connsiteX1" fmla="*/ 4035853 w 4035853"/>
              <a:gd name="connsiteY1" fmla="*/ 0 h 2938468"/>
              <a:gd name="connsiteX2" fmla="*/ 4035853 w 4035853"/>
              <a:gd name="connsiteY2" fmla="*/ 2697096 h 2938468"/>
              <a:gd name="connsiteX3" fmla="*/ 431848 w 4035853"/>
              <a:gd name="connsiteY3" fmla="*/ 2696556 h 2938468"/>
              <a:gd name="connsiteX4" fmla="*/ 334149 w 4035853"/>
              <a:gd name="connsiteY4" fmla="*/ 2895599 h 2938468"/>
              <a:gd name="connsiteX5" fmla="*/ 300051 w 4035853"/>
              <a:gd name="connsiteY5" fmla="*/ 2938463 h 2938468"/>
              <a:gd name="connsiteX6" fmla="*/ 260684 w 4035853"/>
              <a:gd name="connsiteY6" fmla="*/ 2893218 h 2938468"/>
              <a:gd name="connsiteX7" fmla="*/ 159550 w 4035853"/>
              <a:gd name="connsiteY7" fmla="*/ 2695594 h 2938468"/>
              <a:gd name="connsiteX8" fmla="*/ 0 w 4035853"/>
              <a:gd name="connsiteY8" fmla="*/ 2697096 h 2938468"/>
              <a:gd name="connsiteX9" fmla="*/ 0 w 4035853"/>
              <a:gd name="connsiteY9" fmla="*/ 0 h 2938468"/>
              <a:gd name="connsiteX0" fmla="*/ 0 w 4035853"/>
              <a:gd name="connsiteY0" fmla="*/ 0 h 2938468"/>
              <a:gd name="connsiteX1" fmla="*/ 4035853 w 4035853"/>
              <a:gd name="connsiteY1" fmla="*/ 0 h 2938468"/>
              <a:gd name="connsiteX2" fmla="*/ 4035853 w 4035853"/>
              <a:gd name="connsiteY2" fmla="*/ 2697096 h 2938468"/>
              <a:gd name="connsiteX3" fmla="*/ 431848 w 4035853"/>
              <a:gd name="connsiteY3" fmla="*/ 2696556 h 2938468"/>
              <a:gd name="connsiteX4" fmla="*/ 334149 w 4035853"/>
              <a:gd name="connsiteY4" fmla="*/ 2895599 h 2938468"/>
              <a:gd name="connsiteX5" fmla="*/ 300051 w 4035853"/>
              <a:gd name="connsiteY5" fmla="*/ 2938463 h 2938468"/>
              <a:gd name="connsiteX6" fmla="*/ 260684 w 4035853"/>
              <a:gd name="connsiteY6" fmla="*/ 2893218 h 2938468"/>
              <a:gd name="connsiteX7" fmla="*/ 159550 w 4035853"/>
              <a:gd name="connsiteY7" fmla="*/ 2695594 h 2938468"/>
              <a:gd name="connsiteX8" fmla="*/ 0 w 4035853"/>
              <a:gd name="connsiteY8" fmla="*/ 2697096 h 2938468"/>
              <a:gd name="connsiteX9" fmla="*/ 0 w 4035853"/>
              <a:gd name="connsiteY9" fmla="*/ 0 h 2938468"/>
              <a:gd name="connsiteX0" fmla="*/ 0 w 4035853"/>
              <a:gd name="connsiteY0" fmla="*/ 0 h 2938602"/>
              <a:gd name="connsiteX1" fmla="*/ 4035853 w 4035853"/>
              <a:gd name="connsiteY1" fmla="*/ 0 h 2938602"/>
              <a:gd name="connsiteX2" fmla="*/ 4035853 w 4035853"/>
              <a:gd name="connsiteY2" fmla="*/ 2697096 h 2938602"/>
              <a:gd name="connsiteX3" fmla="*/ 431848 w 4035853"/>
              <a:gd name="connsiteY3" fmla="*/ 2696556 h 2938602"/>
              <a:gd name="connsiteX4" fmla="*/ 334149 w 4035853"/>
              <a:gd name="connsiteY4" fmla="*/ 2895599 h 2938602"/>
              <a:gd name="connsiteX5" fmla="*/ 300051 w 4035853"/>
              <a:gd name="connsiteY5" fmla="*/ 2938463 h 2938602"/>
              <a:gd name="connsiteX6" fmla="*/ 260684 w 4035853"/>
              <a:gd name="connsiteY6" fmla="*/ 2893218 h 2938602"/>
              <a:gd name="connsiteX7" fmla="*/ 159550 w 4035853"/>
              <a:gd name="connsiteY7" fmla="*/ 2695594 h 2938602"/>
              <a:gd name="connsiteX8" fmla="*/ 0 w 4035853"/>
              <a:gd name="connsiteY8" fmla="*/ 2697096 h 2938602"/>
              <a:gd name="connsiteX9" fmla="*/ 0 w 4035853"/>
              <a:gd name="connsiteY9" fmla="*/ 0 h 2938602"/>
              <a:gd name="connsiteX0" fmla="*/ 0 w 4063711"/>
              <a:gd name="connsiteY0" fmla="*/ 0 h 3787688"/>
              <a:gd name="connsiteX1" fmla="*/ 4063711 w 4063711"/>
              <a:gd name="connsiteY1" fmla="*/ 849086 h 3787688"/>
              <a:gd name="connsiteX2" fmla="*/ 4063711 w 4063711"/>
              <a:gd name="connsiteY2" fmla="*/ 3546182 h 3787688"/>
              <a:gd name="connsiteX3" fmla="*/ 459706 w 4063711"/>
              <a:gd name="connsiteY3" fmla="*/ 3545642 h 3787688"/>
              <a:gd name="connsiteX4" fmla="*/ 362007 w 4063711"/>
              <a:gd name="connsiteY4" fmla="*/ 3744685 h 3787688"/>
              <a:gd name="connsiteX5" fmla="*/ 327909 w 4063711"/>
              <a:gd name="connsiteY5" fmla="*/ 3787549 h 3787688"/>
              <a:gd name="connsiteX6" fmla="*/ 288542 w 4063711"/>
              <a:gd name="connsiteY6" fmla="*/ 3742304 h 3787688"/>
              <a:gd name="connsiteX7" fmla="*/ 187408 w 4063711"/>
              <a:gd name="connsiteY7" fmla="*/ 3544680 h 3787688"/>
              <a:gd name="connsiteX8" fmla="*/ 27858 w 4063711"/>
              <a:gd name="connsiteY8" fmla="*/ 3546182 h 3787688"/>
              <a:gd name="connsiteX9" fmla="*/ 0 w 4063711"/>
              <a:gd name="connsiteY9" fmla="*/ 0 h 3787688"/>
              <a:gd name="connsiteX0" fmla="*/ 0 w 4063711"/>
              <a:gd name="connsiteY0" fmla="*/ 0 h 3787688"/>
              <a:gd name="connsiteX1" fmla="*/ 4063711 w 4063711"/>
              <a:gd name="connsiteY1" fmla="*/ 37323 h 3787688"/>
              <a:gd name="connsiteX2" fmla="*/ 4063711 w 4063711"/>
              <a:gd name="connsiteY2" fmla="*/ 3546182 h 3787688"/>
              <a:gd name="connsiteX3" fmla="*/ 459706 w 4063711"/>
              <a:gd name="connsiteY3" fmla="*/ 3545642 h 3787688"/>
              <a:gd name="connsiteX4" fmla="*/ 362007 w 4063711"/>
              <a:gd name="connsiteY4" fmla="*/ 3744685 h 3787688"/>
              <a:gd name="connsiteX5" fmla="*/ 327909 w 4063711"/>
              <a:gd name="connsiteY5" fmla="*/ 3787549 h 3787688"/>
              <a:gd name="connsiteX6" fmla="*/ 288542 w 4063711"/>
              <a:gd name="connsiteY6" fmla="*/ 3742304 h 3787688"/>
              <a:gd name="connsiteX7" fmla="*/ 187408 w 4063711"/>
              <a:gd name="connsiteY7" fmla="*/ 3544680 h 3787688"/>
              <a:gd name="connsiteX8" fmla="*/ 27858 w 4063711"/>
              <a:gd name="connsiteY8" fmla="*/ 3546182 h 3787688"/>
              <a:gd name="connsiteX9" fmla="*/ 0 w 4063711"/>
              <a:gd name="connsiteY9" fmla="*/ 0 h 3787688"/>
              <a:gd name="connsiteX0" fmla="*/ 0 w 4045138"/>
              <a:gd name="connsiteY0" fmla="*/ 0 h 3759696"/>
              <a:gd name="connsiteX1" fmla="*/ 4045138 w 4045138"/>
              <a:gd name="connsiteY1" fmla="*/ 9331 h 3759696"/>
              <a:gd name="connsiteX2" fmla="*/ 4045138 w 4045138"/>
              <a:gd name="connsiteY2" fmla="*/ 3518190 h 3759696"/>
              <a:gd name="connsiteX3" fmla="*/ 441133 w 4045138"/>
              <a:gd name="connsiteY3" fmla="*/ 3517650 h 3759696"/>
              <a:gd name="connsiteX4" fmla="*/ 343434 w 4045138"/>
              <a:gd name="connsiteY4" fmla="*/ 3716693 h 3759696"/>
              <a:gd name="connsiteX5" fmla="*/ 309336 w 4045138"/>
              <a:gd name="connsiteY5" fmla="*/ 3759557 h 3759696"/>
              <a:gd name="connsiteX6" fmla="*/ 269969 w 4045138"/>
              <a:gd name="connsiteY6" fmla="*/ 3714312 h 3759696"/>
              <a:gd name="connsiteX7" fmla="*/ 168835 w 4045138"/>
              <a:gd name="connsiteY7" fmla="*/ 3516688 h 3759696"/>
              <a:gd name="connsiteX8" fmla="*/ 9285 w 4045138"/>
              <a:gd name="connsiteY8" fmla="*/ 3518190 h 3759696"/>
              <a:gd name="connsiteX9" fmla="*/ 0 w 4045138"/>
              <a:gd name="connsiteY9" fmla="*/ 0 h 375969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</a:cxnLst>
            <a:rect l="l" t="t" r="r" b="b"/>
            <a:pathLst>
              <a:path w="4045138" h="3759696">
                <a:moveTo>
                  <a:pt x="0" y="0"/>
                </a:moveTo>
                <a:lnTo>
                  <a:pt x="4045138" y="9331"/>
                </a:lnTo>
                <a:lnTo>
                  <a:pt x="4045138" y="3518190"/>
                </a:lnTo>
                <a:lnTo>
                  <a:pt x="441133" y="3517650"/>
                </a:lnTo>
                <a:cubicBezTo>
                  <a:pt x="407164" y="3591215"/>
                  <a:pt x="353155" y="3696220"/>
                  <a:pt x="343434" y="3716693"/>
                </a:cubicBezTo>
                <a:cubicBezTo>
                  <a:pt x="333713" y="3737166"/>
                  <a:pt x="331059" y="3757573"/>
                  <a:pt x="309336" y="3759557"/>
                </a:cubicBezTo>
                <a:cubicBezTo>
                  <a:pt x="287613" y="3761541"/>
                  <a:pt x="285091" y="3742090"/>
                  <a:pt x="269969" y="3714312"/>
                </a:cubicBezTo>
                <a:cubicBezTo>
                  <a:pt x="254847" y="3686534"/>
                  <a:pt x="195297" y="3573188"/>
                  <a:pt x="168835" y="3516688"/>
                </a:cubicBezTo>
                <a:lnTo>
                  <a:pt x="9285" y="3518190"/>
                </a:lnTo>
                <a:lnTo>
                  <a:pt x="0" y="0"/>
                </a:lnTo>
                <a:close/>
              </a:path>
            </a:pathLst>
          </a:custGeom>
        </p:spPr>
        <p:txBody>
          <a:bodyPr anchor="ctr" anchorCtr="1"/>
          <a:lstStyle>
            <a:lvl1pPr marL="0" indent="0">
              <a:buNone/>
              <a:defRPr>
                <a:solidFill>
                  <a:schemeClr val="tx1"/>
                </a:solidFill>
              </a:defRPr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76879287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hank You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 Placeholder 4"/>
          <p:cNvSpPr>
            <a:spLocks noGrp="1"/>
          </p:cNvSpPr>
          <p:nvPr>
            <p:ph type="body" sz="quarter" idx="20"/>
          </p:nvPr>
        </p:nvSpPr>
        <p:spPr>
          <a:xfrm>
            <a:off x="457200" y="1268985"/>
            <a:ext cx="8229600" cy="215444"/>
          </a:xfrm>
        </p:spPr>
        <p:txBody>
          <a:bodyPr>
            <a:noAutofit/>
          </a:bodyPr>
          <a:lstStyle>
            <a:lvl1pPr marL="0" indent="0">
              <a:buNone/>
              <a:defRPr lang="en-US" sz="14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30188" indent="0">
              <a:buNone/>
              <a:defRPr/>
            </a:lvl2pPr>
          </a:lstStyle>
          <a:p>
            <a:pPr marL="0" lvl="0" indent="0" algn="l" defTabSz="342900" rtl="0" eaLnBrk="1" latinLnBrk="0" hangingPunct="1">
              <a:lnSpc>
                <a:spcPct val="100000"/>
              </a:lnSpc>
              <a:spcBef>
                <a:spcPts val="800"/>
              </a:spcBef>
              <a:buClr>
                <a:schemeClr val="tx2"/>
              </a:buClr>
              <a:buFont typeface="Arial"/>
              <a:buNone/>
            </a:pPr>
            <a:r>
              <a:rPr lang="en-US"/>
              <a:t>Edit Master text styles</a:t>
            </a:r>
          </a:p>
        </p:txBody>
      </p:sp>
      <p:sp>
        <p:nvSpPr>
          <p:cNvPr id="9" name="Title Placeholder 1"/>
          <p:cNvSpPr>
            <a:spLocks noGrp="1"/>
          </p:cNvSpPr>
          <p:nvPr>
            <p:ph type="title"/>
          </p:nvPr>
        </p:nvSpPr>
        <p:spPr>
          <a:xfrm>
            <a:off x="457199" y="761455"/>
            <a:ext cx="8229600" cy="313932"/>
          </a:xfrm>
          <a:prstGeom prst="rect">
            <a:avLst/>
          </a:prstGeom>
        </p:spPr>
        <p:txBody>
          <a:bodyPr vert="horz" lIns="0" tIns="0" rIns="0" bIns="0" rtlCol="0" anchor="b" anchorCtr="0">
            <a:noAutofit/>
          </a:bodyPr>
          <a:lstStyle/>
          <a:p>
            <a:pPr lvl="0"/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0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769949" y="6551759"/>
            <a:ext cx="3387817" cy="123111"/>
          </a:xfrm>
          <a:prstGeom prst="rect">
            <a:avLst/>
          </a:prstGeom>
        </p:spPr>
        <p:txBody>
          <a:bodyPr vert="horz" wrap="square" lIns="0" tIns="0" rIns="0" bIns="0" rtlCol="0" anchor="ctr">
            <a:spAutoFit/>
          </a:bodyPr>
          <a:lstStyle>
            <a:lvl1pPr algn="l">
              <a:defRPr sz="800"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Division Name or Footer</a:t>
            </a:r>
          </a:p>
        </p:txBody>
      </p:sp>
      <p:sp>
        <p:nvSpPr>
          <p:cNvPr id="11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202" y="6544227"/>
            <a:ext cx="254719" cy="123111"/>
          </a:xfrm>
          <a:prstGeom prst="rect">
            <a:avLst/>
          </a:prstGeom>
        </p:spPr>
        <p:txBody>
          <a:bodyPr vert="horz" wrap="square" lIns="0" tIns="0" rIns="0" bIns="0" rtlCol="0" anchor="ctr">
            <a:spAutoFit/>
          </a:bodyPr>
          <a:lstStyle>
            <a:lvl1pPr algn="l">
              <a:defRPr sz="800">
                <a:solidFill>
                  <a:schemeClr val="tx1"/>
                </a:solidFill>
              </a:defRPr>
            </a:lvl1pPr>
          </a:lstStyle>
          <a:p>
            <a:fld id="{7FEEEA1A-CB49-3744-AA40-B896987410F9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12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781048"/>
            <a:ext cx="2481072" cy="4276852"/>
          </a:xfrm>
        </p:spPr>
        <p:txBody>
          <a:bodyPr vert="horz" lIns="0" tIns="0" rIns="0" bIns="0" rtlCol="0">
            <a:noAutofit/>
          </a:bodyPr>
          <a:lstStyle>
            <a:lvl1pPr marL="0" indent="0">
              <a:spcBef>
                <a:spcPts val="1500"/>
              </a:spcBef>
              <a:buNone/>
              <a:defRPr lang="en-US" sz="1200" b="1" dirty="0">
                <a:solidFill>
                  <a:schemeClr val="accent1"/>
                </a:solidFill>
              </a:defRPr>
            </a:lvl1pPr>
            <a:lvl2pPr marL="341313" indent="-341313">
              <a:spcBef>
                <a:spcPts val="0"/>
              </a:spcBef>
              <a:buNone/>
              <a:defRPr lang="en-US" sz="1200" dirty="0"/>
            </a:lvl2pPr>
            <a:lvl3pPr>
              <a:defRPr lang="en-US" dirty="0"/>
            </a:lvl3pPr>
            <a:lvl4pPr>
              <a:defRPr lang="en-US" dirty="0"/>
            </a:lvl4pPr>
            <a:lvl5pPr>
              <a:defRPr lang="en-US" dirty="0"/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</p:txBody>
      </p:sp>
      <p:sp>
        <p:nvSpPr>
          <p:cNvPr id="13" name="Content Placeholder 2"/>
          <p:cNvSpPr>
            <a:spLocks noGrp="1"/>
          </p:cNvSpPr>
          <p:nvPr>
            <p:ph sz="half" idx="21"/>
          </p:nvPr>
        </p:nvSpPr>
        <p:spPr>
          <a:xfrm>
            <a:off x="3200400" y="1781048"/>
            <a:ext cx="2481072" cy="4276852"/>
          </a:xfrm>
        </p:spPr>
        <p:txBody>
          <a:bodyPr vert="horz" lIns="0" tIns="0" rIns="0" bIns="0" rtlCol="0">
            <a:noAutofit/>
          </a:bodyPr>
          <a:lstStyle>
            <a:lvl1pPr marL="0" indent="0">
              <a:spcBef>
                <a:spcPts val="1500"/>
              </a:spcBef>
              <a:buNone/>
              <a:defRPr lang="en-US" sz="1200" b="1" dirty="0">
                <a:solidFill>
                  <a:schemeClr val="accent1"/>
                </a:solidFill>
              </a:defRPr>
            </a:lvl1pPr>
            <a:lvl2pPr marL="341313" indent="-341313">
              <a:spcBef>
                <a:spcPts val="0"/>
              </a:spcBef>
              <a:buNone/>
              <a:defRPr lang="en-US" sz="1200" dirty="0"/>
            </a:lvl2pPr>
            <a:lvl3pPr>
              <a:defRPr lang="en-US" dirty="0"/>
            </a:lvl3pPr>
            <a:lvl4pPr>
              <a:defRPr lang="en-US" dirty="0"/>
            </a:lvl4pPr>
            <a:lvl5pPr>
              <a:defRPr lang="en-US" dirty="0"/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</p:txBody>
      </p:sp>
      <p:sp>
        <p:nvSpPr>
          <p:cNvPr id="14" name="Content Placeholder 2"/>
          <p:cNvSpPr>
            <a:spLocks noGrp="1"/>
          </p:cNvSpPr>
          <p:nvPr>
            <p:ph sz="half" idx="22"/>
          </p:nvPr>
        </p:nvSpPr>
        <p:spPr>
          <a:xfrm>
            <a:off x="5943600" y="1781048"/>
            <a:ext cx="2481072" cy="4276852"/>
          </a:xfrm>
        </p:spPr>
        <p:txBody>
          <a:bodyPr vert="horz" lIns="0" tIns="0" rIns="0" bIns="0" rtlCol="0">
            <a:noAutofit/>
          </a:bodyPr>
          <a:lstStyle>
            <a:lvl1pPr marL="0" indent="0">
              <a:spcBef>
                <a:spcPts val="1500"/>
              </a:spcBef>
              <a:buNone/>
              <a:defRPr lang="en-US" sz="1200" b="1" dirty="0">
                <a:solidFill>
                  <a:schemeClr val="accent1"/>
                </a:solidFill>
              </a:defRPr>
            </a:lvl1pPr>
            <a:lvl2pPr marL="341313" indent="-341313">
              <a:spcBef>
                <a:spcPts val="0"/>
              </a:spcBef>
              <a:buNone/>
              <a:defRPr lang="en-US" sz="1200" dirty="0"/>
            </a:lvl2pPr>
            <a:lvl3pPr>
              <a:defRPr lang="en-US" dirty="0"/>
            </a:lvl3pPr>
            <a:lvl4pPr>
              <a:defRPr lang="en-US" dirty="0"/>
            </a:lvl4pPr>
            <a:lvl5pPr>
              <a:defRPr lang="en-US" dirty="0"/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</p:txBody>
      </p:sp>
    </p:spTree>
    <p:extLst>
      <p:ext uri="{BB962C8B-B14F-4D97-AF65-F5344CB8AC3E}">
        <p14:creationId xmlns:p14="http://schemas.microsoft.com/office/powerpoint/2010/main" val="10721112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463967"/>
            <a:ext cx="6904038" cy="1069657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8" name="Rectangle 7"/>
          <p:cNvSpPr/>
          <p:nvPr/>
        </p:nvSpPr>
        <p:spPr>
          <a:xfrm>
            <a:off x="0" y="0"/>
            <a:ext cx="9144000" cy="24384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800"/>
          </a:p>
        </p:txBody>
      </p:sp>
      <p:sp>
        <p:nvSpPr>
          <p:cNvPr id="12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1587914"/>
            <a:ext cx="6904038" cy="468708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r>
              <a:rPr lang="en-US"/>
              <a:t>Division Name or Footer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7FEEEA1A-CB49-3744-AA40-B896987410F9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55790617"/>
      </p:ext>
    </p:extLst>
  </p:cSld>
  <p:clrMapOvr>
    <a:masterClrMapping/>
  </p:clrMapOvr>
  <p:hf hdr="0" dt="0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25"/>
          <p:cNvSpPr>
            <a:spLocks noChangeAspect="1"/>
          </p:cNvSpPr>
          <p:nvPr/>
        </p:nvSpPr>
        <p:spPr>
          <a:xfrm rot="10800000">
            <a:off x="0" y="0"/>
            <a:ext cx="9144000" cy="1285453"/>
          </a:xfrm>
          <a:custGeom>
            <a:avLst/>
            <a:gdLst/>
            <a:ahLst/>
            <a:cxnLst/>
            <a:rect l="l" t="t" r="r" b="b"/>
            <a:pathLst>
              <a:path w="9144000" h="964090">
                <a:moveTo>
                  <a:pt x="9144000" y="964090"/>
                </a:moveTo>
                <a:lnTo>
                  <a:pt x="0" y="96409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1" y="1446104"/>
            <a:ext cx="6904037" cy="1072896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rgbClr val="FFFFFF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14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2595033"/>
            <a:ext cx="6904038" cy="36576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r>
              <a:rPr lang="en-US"/>
              <a:t>Division Name or Footer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7FEEEA1A-CB49-3744-AA40-B896987410F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67210573"/>
      </p:ext>
    </p:extLst>
  </p:cSld>
  <p:clrMapOvr>
    <a:masterClrMapping/>
  </p:clrMapOvr>
  <p:hf hdr="0" dt="0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25"/>
          <p:cNvSpPr>
            <a:spLocks noChangeAspect="1"/>
          </p:cNvSpPr>
          <p:nvPr/>
        </p:nvSpPr>
        <p:spPr>
          <a:xfrm rot="10800000">
            <a:off x="0" y="0"/>
            <a:ext cx="9144000" cy="3963827"/>
          </a:xfrm>
          <a:custGeom>
            <a:avLst/>
            <a:gdLst/>
            <a:ahLst/>
            <a:cxnLst/>
            <a:rect l="l" t="t" r="r" b="b"/>
            <a:pathLst>
              <a:path w="9144000" h="2972870">
                <a:moveTo>
                  <a:pt x="9144000" y="2972870"/>
                </a:moveTo>
                <a:lnTo>
                  <a:pt x="0" y="297287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2" y="609600"/>
            <a:ext cx="6904037" cy="2562829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here to write your long headline, quote, or introduction sentence in this space. </a:t>
            </a:r>
          </a:p>
        </p:txBody>
      </p:sp>
      <p:sp>
        <p:nvSpPr>
          <p:cNvPr id="13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4083051"/>
            <a:ext cx="6904038" cy="21590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r>
              <a:rPr lang="en-US"/>
              <a:t>Division Name or Footer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7FEEEA1A-CB49-3744-AA40-B896987410F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98260175"/>
      </p:ext>
    </p:extLst>
  </p:cSld>
  <p:clrMapOvr>
    <a:masterClrMapping/>
  </p:clrMapOvr>
  <p:hf hdr="0" dt="0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wo Content 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0" y="0"/>
            <a:ext cx="9144000" cy="24384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800"/>
          </a:p>
        </p:txBody>
      </p:sp>
      <p:sp>
        <p:nvSpPr>
          <p:cNvPr id="7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502907"/>
            <a:ext cx="8001000" cy="1043640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9" name="Text Placeholder 2"/>
          <p:cNvSpPr>
            <a:spLocks noGrp="1"/>
          </p:cNvSpPr>
          <p:nvPr>
            <p:ph type="body" idx="13" hasCustomPrompt="1"/>
          </p:nvPr>
        </p:nvSpPr>
        <p:spPr>
          <a:xfrm>
            <a:off x="685799" y="1706374"/>
            <a:ext cx="3811589" cy="520452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 i="0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Master text styles.</a:t>
            </a:r>
          </a:p>
        </p:txBody>
      </p:sp>
      <p:sp>
        <p:nvSpPr>
          <p:cNvPr id="10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4873715" y="1706374"/>
            <a:ext cx="3813086" cy="520452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lick to edit Master text styles.</a:t>
            </a:r>
          </a:p>
        </p:txBody>
      </p:sp>
      <p:sp>
        <p:nvSpPr>
          <p:cNvPr id="17" name="Content Placeholder 2"/>
          <p:cNvSpPr>
            <a:spLocks noGrp="1"/>
          </p:cNvSpPr>
          <p:nvPr>
            <p:ph sz="quarter" idx="16"/>
          </p:nvPr>
        </p:nvSpPr>
        <p:spPr>
          <a:xfrm>
            <a:off x="685800" y="2341033"/>
            <a:ext cx="3811588" cy="375285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9" name="Content Placeholder 2"/>
          <p:cNvSpPr>
            <a:spLocks noGrp="1"/>
          </p:cNvSpPr>
          <p:nvPr>
            <p:ph sz="quarter" idx="17"/>
          </p:nvPr>
        </p:nvSpPr>
        <p:spPr>
          <a:xfrm>
            <a:off x="4861946" y="2341033"/>
            <a:ext cx="3811588" cy="375285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2" name="Footer Placeholder 1"/>
          <p:cNvSpPr>
            <a:spLocks noGrp="1"/>
          </p:cNvSpPr>
          <p:nvPr>
            <p:ph type="ftr" sz="quarter" idx="18"/>
          </p:nvPr>
        </p:nvSpPr>
        <p:spPr/>
        <p:txBody>
          <a:bodyPr/>
          <a:lstStyle/>
          <a:p>
            <a:r>
              <a:rPr lang="en-US"/>
              <a:t>Division Name or Footer</a:t>
            </a:r>
            <a:endParaRPr lang="en-US" dirty="0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9"/>
          </p:nvPr>
        </p:nvSpPr>
        <p:spPr/>
        <p:txBody>
          <a:bodyPr/>
          <a:lstStyle/>
          <a:p>
            <a:fld id="{7FEEEA1A-CB49-3744-AA40-B896987410F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63716363"/>
      </p:ext>
    </p:extLst>
  </p:cSld>
  <p:clrMapOvr>
    <a:masterClrMapping/>
  </p:clrMapOvr>
  <p:hf hdr="0" dt="0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wo Content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25"/>
          <p:cNvSpPr>
            <a:spLocks noChangeAspect="1"/>
          </p:cNvSpPr>
          <p:nvPr/>
        </p:nvSpPr>
        <p:spPr>
          <a:xfrm rot="10800000">
            <a:off x="0" y="0"/>
            <a:ext cx="9144000" cy="1285453"/>
          </a:xfrm>
          <a:custGeom>
            <a:avLst/>
            <a:gdLst/>
            <a:ahLst/>
            <a:cxnLst/>
            <a:rect l="l" t="t" r="r" b="b"/>
            <a:pathLst>
              <a:path w="9144000" h="964090">
                <a:moveTo>
                  <a:pt x="9144000" y="964090"/>
                </a:moveTo>
                <a:lnTo>
                  <a:pt x="0" y="96409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1422907"/>
            <a:ext cx="8001000" cy="1043640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11" name="Text Placeholder 2"/>
          <p:cNvSpPr>
            <a:spLocks noGrp="1"/>
          </p:cNvSpPr>
          <p:nvPr>
            <p:ph type="body" idx="13" hasCustomPrompt="1"/>
          </p:nvPr>
        </p:nvSpPr>
        <p:spPr>
          <a:xfrm>
            <a:off x="685799" y="2626374"/>
            <a:ext cx="3811589" cy="520452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 i="0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Master text styles.</a:t>
            </a:r>
          </a:p>
        </p:txBody>
      </p:sp>
      <p:sp>
        <p:nvSpPr>
          <p:cNvPr id="12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4873715" y="2626374"/>
            <a:ext cx="3813086" cy="520452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lick to edit Master text styles.</a:t>
            </a:r>
          </a:p>
        </p:txBody>
      </p:sp>
      <p:sp>
        <p:nvSpPr>
          <p:cNvPr id="17" name="Content Placeholder 3"/>
          <p:cNvSpPr>
            <a:spLocks noGrp="1"/>
          </p:cNvSpPr>
          <p:nvPr>
            <p:ph sz="quarter" idx="16"/>
          </p:nvPr>
        </p:nvSpPr>
        <p:spPr>
          <a:xfrm>
            <a:off x="685800" y="3259667"/>
            <a:ext cx="3811588" cy="295275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8" name="Content Placeholder 3"/>
          <p:cNvSpPr>
            <a:spLocks noGrp="1"/>
          </p:cNvSpPr>
          <p:nvPr>
            <p:ph sz="quarter" idx="17"/>
          </p:nvPr>
        </p:nvSpPr>
        <p:spPr>
          <a:xfrm>
            <a:off x="4873715" y="3259667"/>
            <a:ext cx="3811588" cy="295275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8"/>
          </p:nvPr>
        </p:nvSpPr>
        <p:spPr/>
        <p:txBody>
          <a:bodyPr/>
          <a:lstStyle/>
          <a:p>
            <a:r>
              <a:rPr lang="en-US"/>
              <a:t>Division Name or Footer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9"/>
          </p:nvPr>
        </p:nvSpPr>
        <p:spPr/>
        <p:txBody>
          <a:bodyPr/>
          <a:lstStyle/>
          <a:p>
            <a:fld id="{7FEEEA1A-CB49-3744-AA40-B896987410F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4579946"/>
      </p:ext>
    </p:extLst>
  </p:cSld>
  <p:clrMapOvr>
    <a:masterClrMapping/>
  </p:clrMapOvr>
  <p:hf hdr="0" dt="0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with Image and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icture Placeholder 12"/>
          <p:cNvSpPr>
            <a:spLocks noGrp="1"/>
          </p:cNvSpPr>
          <p:nvPr>
            <p:ph type="pic" sz="quarter" idx="14"/>
          </p:nvPr>
        </p:nvSpPr>
        <p:spPr>
          <a:xfrm>
            <a:off x="5257800" y="0"/>
            <a:ext cx="3886200" cy="3429000"/>
          </a:xfrm>
          <a:custGeom>
            <a:avLst/>
            <a:gdLst/>
            <a:ahLst/>
            <a:cxnLst/>
            <a:rect l="l" t="t" r="r" b="b"/>
            <a:pathLst>
              <a:path w="3886200" h="2571750">
                <a:moveTo>
                  <a:pt x="0" y="0"/>
                </a:moveTo>
                <a:lnTo>
                  <a:pt x="3886200" y="0"/>
                </a:lnTo>
                <a:lnTo>
                  <a:pt x="3886200" y="2339180"/>
                </a:lnTo>
                <a:lnTo>
                  <a:pt x="506870" y="2339180"/>
                </a:lnTo>
                <a:lnTo>
                  <a:pt x="406031" y="2547511"/>
                </a:lnTo>
                <a:cubicBezTo>
                  <a:pt x="389676" y="2580721"/>
                  <a:pt x="368833" y="2578926"/>
                  <a:pt x="354275" y="2547511"/>
                </a:cubicBezTo>
                <a:lnTo>
                  <a:pt x="253435" y="2339180"/>
                </a:lnTo>
                <a:lnTo>
                  <a:pt x="0" y="2339180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8" name="Rectangle 7"/>
          <p:cNvSpPr/>
          <p:nvPr/>
        </p:nvSpPr>
        <p:spPr>
          <a:xfrm>
            <a:off x="0" y="0"/>
            <a:ext cx="5257800" cy="6858000"/>
          </a:xfrm>
          <a:prstGeom prst="rect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678488" y="3601209"/>
            <a:ext cx="3008313" cy="833180"/>
          </a:xfrm>
        </p:spPr>
        <p:txBody>
          <a:bodyPr anchor="b">
            <a:normAutofit/>
          </a:bodyPr>
          <a:lstStyle>
            <a:lvl1pPr algn="l">
              <a:lnSpc>
                <a:spcPct val="90000"/>
              </a:lnSpc>
              <a:defRPr sz="1600" b="1" cap="none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5678488" y="4528303"/>
            <a:ext cx="3008313" cy="1758219"/>
          </a:xfrm>
        </p:spPr>
        <p:txBody>
          <a:bodyPr>
            <a:normAutofit/>
          </a:bodyPr>
          <a:lstStyle>
            <a:lvl1pPr marL="0" indent="0">
              <a:buNone/>
              <a:defRPr sz="1000">
                <a:solidFill>
                  <a:schemeClr val="bg1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dirty="0"/>
              <a:t>Click to edit your paragraph here. </a:t>
            </a:r>
          </a:p>
        </p:txBody>
      </p:sp>
      <p:sp>
        <p:nvSpPr>
          <p:cNvPr id="11" name="Text Placeholder 10"/>
          <p:cNvSpPr>
            <a:spLocks noGrp="1"/>
          </p:cNvSpPr>
          <p:nvPr>
            <p:ph type="body" sz="quarter" idx="13" hasCustomPrompt="1"/>
          </p:nvPr>
        </p:nvSpPr>
        <p:spPr>
          <a:xfrm>
            <a:off x="685801" y="846705"/>
            <a:ext cx="3884612" cy="1722715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spcBef>
                <a:spcPts val="0"/>
              </a:spcBef>
              <a:defRPr sz="2000" b="1" i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 dirty="0"/>
              <a:t>Click to edit headline here.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5" hasCustomPrompt="1"/>
          </p:nvPr>
        </p:nvSpPr>
        <p:spPr>
          <a:xfrm>
            <a:off x="685801" y="2707218"/>
            <a:ext cx="3884613" cy="3529543"/>
          </a:xfrm>
        </p:spPr>
        <p:txBody>
          <a:bodyPr>
            <a:normAutofit/>
          </a:bodyPr>
          <a:lstStyle>
            <a:lvl1pPr>
              <a:defRPr sz="1400" baseline="0"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edit your paragraph here.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>
          <a:xfrm>
            <a:off x="1069848" y="6364224"/>
            <a:ext cx="4187952" cy="365760"/>
          </a:xfrm>
        </p:spPr>
        <p:txBody>
          <a:bodyPr/>
          <a:lstStyle/>
          <a:p>
            <a:r>
              <a:rPr lang="en-US"/>
              <a:t>Division Name or Footer</a:t>
            </a:r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7FEEEA1A-CB49-3744-AA40-B896987410F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50620775"/>
      </p:ext>
    </p:extLst>
  </p:cSld>
  <p:clrMapOvr>
    <a:masterClrMapping/>
  </p:clrMapOvr>
  <p:hf hdr="0" dt="0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with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icture Placeholder 6"/>
          <p:cNvSpPr>
            <a:spLocks noGrp="1"/>
          </p:cNvSpPr>
          <p:nvPr>
            <p:ph type="pic" sz="quarter" idx="18"/>
          </p:nvPr>
        </p:nvSpPr>
        <p:spPr>
          <a:xfrm>
            <a:off x="5257800" y="0"/>
            <a:ext cx="3886200" cy="6858000"/>
          </a:xfrm>
        </p:spPr>
        <p:txBody>
          <a:bodyPr anchor="ctr" anchorCtr="0"/>
          <a:lstStyle>
            <a:lvl1pPr algn="ctr">
              <a:defRPr/>
            </a:lvl1pPr>
          </a:lstStyle>
          <a:p>
            <a:r>
              <a:rPr lang="en-US"/>
              <a:t>Click icon to add picture</a:t>
            </a:r>
          </a:p>
        </p:txBody>
      </p:sp>
      <p:sp>
        <p:nvSpPr>
          <p:cNvPr id="8" name="Rectangle 7"/>
          <p:cNvSpPr/>
          <p:nvPr/>
        </p:nvSpPr>
        <p:spPr>
          <a:xfrm>
            <a:off x="0" y="0"/>
            <a:ext cx="5257800" cy="6858000"/>
          </a:xfrm>
          <a:prstGeom prst="rect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11" name="Text Placeholder 10"/>
          <p:cNvSpPr>
            <a:spLocks noGrp="1"/>
          </p:cNvSpPr>
          <p:nvPr>
            <p:ph type="body" sz="quarter" idx="13" hasCustomPrompt="1"/>
          </p:nvPr>
        </p:nvSpPr>
        <p:spPr>
          <a:xfrm>
            <a:off x="685801" y="846705"/>
            <a:ext cx="3884612" cy="1722715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spcBef>
                <a:spcPts val="0"/>
              </a:spcBef>
              <a:defRPr sz="2000" b="1" i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 dirty="0"/>
              <a:t>Click to edit headline here.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5" hasCustomPrompt="1"/>
          </p:nvPr>
        </p:nvSpPr>
        <p:spPr>
          <a:xfrm>
            <a:off x="685801" y="2707218"/>
            <a:ext cx="3884613" cy="3529543"/>
          </a:xfrm>
        </p:spPr>
        <p:txBody>
          <a:bodyPr>
            <a:normAutofit/>
          </a:bodyPr>
          <a:lstStyle>
            <a:lvl1pPr>
              <a:defRPr sz="1400" baseline="0"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edit your paragraph here.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>
          <a:xfrm>
            <a:off x="1069848" y="6364224"/>
            <a:ext cx="4187952" cy="365760"/>
          </a:xfrm>
        </p:spPr>
        <p:txBody>
          <a:bodyPr/>
          <a:lstStyle/>
          <a:p>
            <a:r>
              <a:rPr lang="en-US"/>
              <a:t>Division Name or Footer</a:t>
            </a:r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7FEEEA1A-CB49-3744-AA40-B896987410F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72719198"/>
      </p:ext>
    </p:extLst>
  </p:cSld>
  <p:clrMapOvr>
    <a:masterClrMapping/>
  </p:clrMapOvr>
  <p:hf hdr="0" dt="0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slideLayout" Target="../slideLayouts/slideLayout18.xml"/><Relationship Id="rId3" Type="http://schemas.openxmlformats.org/officeDocument/2006/relationships/slideLayout" Target="../slideLayouts/slideLayout3.xml"/><Relationship Id="rId21" Type="http://schemas.openxmlformats.org/officeDocument/2006/relationships/slideLayout" Target="../slideLayouts/slideLayout21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20" Type="http://schemas.openxmlformats.org/officeDocument/2006/relationships/slideLayout" Target="../slideLayouts/slideLayout20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23" Type="http://schemas.openxmlformats.org/officeDocument/2006/relationships/theme" Target="../theme/theme1.xml"/><Relationship Id="rId10" Type="http://schemas.openxmlformats.org/officeDocument/2006/relationships/slideLayout" Target="../slideLayouts/slideLayout10.xml"/><Relationship Id="rId19" Type="http://schemas.openxmlformats.org/officeDocument/2006/relationships/slideLayout" Target="../slideLayouts/slideLayout19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Relationship Id="rId22" Type="http://schemas.openxmlformats.org/officeDocument/2006/relationships/slideLayout" Target="../slideLayouts/slideLayout2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2D2D2D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5800" y="274639"/>
            <a:ext cx="8001000" cy="1143000"/>
          </a:xfrm>
          <a:prstGeom prst="rect">
            <a:avLst/>
          </a:prstGeom>
        </p:spPr>
        <p:txBody>
          <a:bodyPr vert="horz" lIns="0" tIns="0" rIns="0" bIns="0" rtlCol="0" anchor="t" anchorCtr="0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5800" y="1600201"/>
            <a:ext cx="8001000" cy="4525963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3"/>
          </p:nvPr>
        </p:nvSpPr>
        <p:spPr>
          <a:xfrm>
            <a:off x="1069848" y="6364224"/>
            <a:ext cx="6519672" cy="36576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800" b="1" i="0">
                <a:solidFill>
                  <a:schemeClr val="bg1"/>
                </a:solidFill>
                <a:latin typeface="+mn-lt"/>
                <a:ea typeface="Arial" charset="0"/>
                <a:cs typeface="Arial" charset="0"/>
              </a:defRPr>
            </a:lvl1pPr>
          </a:lstStyle>
          <a:p>
            <a:r>
              <a:rPr lang="en-US"/>
              <a:t>Division Name or Footer</a:t>
            </a: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85800" y="6364224"/>
            <a:ext cx="310896" cy="36576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800" b="0" i="0">
                <a:solidFill>
                  <a:schemeClr val="bg1"/>
                </a:solidFill>
                <a:latin typeface="+mn-lt"/>
                <a:ea typeface="Arial" charset="0"/>
                <a:cs typeface="Arial" charset="0"/>
              </a:defRPr>
            </a:lvl1pPr>
          </a:lstStyle>
          <a:p>
            <a:fld id="{7FEEEA1A-CB49-3744-AA40-B896987410F9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7" name="Rectangle 6"/>
          <p:cNvSpPr/>
          <p:nvPr userDrawn="1"/>
        </p:nvSpPr>
        <p:spPr>
          <a:xfrm>
            <a:off x="0" y="0"/>
            <a:ext cx="9144000" cy="256032"/>
          </a:xfrm>
          <a:prstGeom prst="rect">
            <a:avLst/>
          </a:prstGeom>
          <a:solidFill>
            <a:schemeClr val="tx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8" name="Freeform 5"/>
          <p:cNvSpPr>
            <a:spLocks noEditPoints="1"/>
          </p:cNvSpPr>
          <p:nvPr userDrawn="1"/>
        </p:nvSpPr>
        <p:spPr bwMode="auto">
          <a:xfrm>
            <a:off x="7919867" y="6350476"/>
            <a:ext cx="766764" cy="334835"/>
          </a:xfrm>
          <a:custGeom>
            <a:avLst/>
            <a:gdLst>
              <a:gd name="T0" fmla="*/ 32 w 511"/>
              <a:gd name="T1" fmla="*/ 39 h 221"/>
              <a:gd name="T2" fmla="*/ 106 w 511"/>
              <a:gd name="T3" fmla="*/ 0 h 221"/>
              <a:gd name="T4" fmla="*/ 188 w 511"/>
              <a:gd name="T5" fmla="*/ 44 h 221"/>
              <a:gd name="T6" fmla="*/ 139 w 511"/>
              <a:gd name="T7" fmla="*/ 208 h 221"/>
              <a:gd name="T8" fmla="*/ 161 w 511"/>
              <a:gd name="T9" fmla="*/ 194 h 221"/>
              <a:gd name="T10" fmla="*/ 2 w 511"/>
              <a:gd name="T11" fmla="*/ 101 h 221"/>
              <a:gd name="T12" fmla="*/ 91 w 511"/>
              <a:gd name="T13" fmla="*/ 70 h 221"/>
              <a:gd name="T14" fmla="*/ 123 w 511"/>
              <a:gd name="T15" fmla="*/ 108 h 221"/>
              <a:gd name="T16" fmla="*/ 208 w 511"/>
              <a:gd name="T17" fmla="*/ 70 h 221"/>
              <a:gd name="T18" fmla="*/ 73 w 511"/>
              <a:gd name="T19" fmla="*/ 70 h 221"/>
              <a:gd name="T20" fmla="*/ 53 w 511"/>
              <a:gd name="T21" fmla="*/ 96 h 221"/>
              <a:gd name="T22" fmla="*/ 54 w 511"/>
              <a:gd name="T23" fmla="*/ 70 h 221"/>
              <a:gd name="T24" fmla="*/ 144 w 511"/>
              <a:gd name="T25" fmla="*/ 70 h 221"/>
              <a:gd name="T26" fmla="*/ 175 w 511"/>
              <a:gd name="T27" fmla="*/ 70 h 221"/>
              <a:gd name="T28" fmla="*/ 267 w 511"/>
              <a:gd name="T29" fmla="*/ 206 h 221"/>
              <a:gd name="T30" fmla="*/ 267 w 511"/>
              <a:gd name="T31" fmla="*/ 193 h 221"/>
              <a:gd name="T32" fmla="*/ 259 w 511"/>
              <a:gd name="T33" fmla="*/ 199 h 221"/>
              <a:gd name="T34" fmla="*/ 416 w 511"/>
              <a:gd name="T35" fmla="*/ 92 h 221"/>
              <a:gd name="T36" fmla="*/ 402 w 511"/>
              <a:gd name="T37" fmla="*/ 86 h 221"/>
              <a:gd name="T38" fmla="*/ 402 w 511"/>
              <a:gd name="T39" fmla="*/ 123 h 221"/>
              <a:gd name="T40" fmla="*/ 397 w 511"/>
              <a:gd name="T41" fmla="*/ 184 h 221"/>
              <a:gd name="T42" fmla="*/ 373 w 511"/>
              <a:gd name="T43" fmla="*/ 152 h 221"/>
              <a:gd name="T44" fmla="*/ 511 w 511"/>
              <a:gd name="T45" fmla="*/ 124 h 221"/>
              <a:gd name="T46" fmla="*/ 511 w 511"/>
              <a:gd name="T47" fmla="*/ 111 h 221"/>
              <a:gd name="T48" fmla="*/ 503 w 511"/>
              <a:gd name="T49" fmla="*/ 117 h 221"/>
              <a:gd name="T50" fmla="*/ 487 w 511"/>
              <a:gd name="T51" fmla="*/ 105 h 221"/>
              <a:gd name="T52" fmla="*/ 450 w 511"/>
              <a:gd name="T53" fmla="*/ 98 h 221"/>
              <a:gd name="T54" fmla="*/ 443 w 511"/>
              <a:gd name="T55" fmla="*/ 87 h 221"/>
              <a:gd name="T56" fmla="*/ 366 w 511"/>
              <a:gd name="T57" fmla="*/ 169 h 221"/>
              <a:gd name="T58" fmla="*/ 365 w 511"/>
              <a:gd name="T59" fmla="*/ 205 h 221"/>
              <a:gd name="T60" fmla="*/ 343 w 511"/>
              <a:gd name="T61" fmla="*/ 203 h 221"/>
              <a:gd name="T62" fmla="*/ 343 w 511"/>
              <a:gd name="T63" fmla="*/ 156 h 221"/>
              <a:gd name="T64" fmla="*/ 318 w 511"/>
              <a:gd name="T65" fmla="*/ 133 h 221"/>
              <a:gd name="T66" fmla="*/ 294 w 511"/>
              <a:gd name="T67" fmla="*/ 133 h 221"/>
              <a:gd name="T68" fmla="*/ 332 w 511"/>
              <a:gd name="T69" fmla="*/ 98 h 221"/>
              <a:gd name="T70" fmla="*/ 271 w 511"/>
              <a:gd name="T71" fmla="*/ 103 h 221"/>
              <a:gd name="T72" fmla="*/ 249 w 511"/>
              <a:gd name="T73" fmla="*/ 94 h 221"/>
              <a:gd name="T74" fmla="*/ 286 w 511"/>
              <a:gd name="T75" fmla="*/ 132 h 221"/>
              <a:gd name="T76" fmla="*/ 261 w 511"/>
              <a:gd name="T77" fmla="*/ 119 h 221"/>
              <a:gd name="T78" fmla="*/ 311 w 511"/>
              <a:gd name="T79" fmla="*/ 215 h 221"/>
              <a:gd name="T80" fmla="*/ 272 w 511"/>
              <a:gd name="T81" fmla="*/ 203 h 221"/>
              <a:gd name="T82" fmla="*/ 280 w 511"/>
              <a:gd name="T83" fmla="*/ 184 h 221"/>
              <a:gd name="T84" fmla="*/ 309 w 511"/>
              <a:gd name="T85" fmla="*/ 203 h 221"/>
              <a:gd name="T86" fmla="*/ 296 w 511"/>
              <a:gd name="T87" fmla="*/ 201 h 221"/>
              <a:gd name="T88" fmla="*/ 318 w 511"/>
              <a:gd name="T89" fmla="*/ 215 h 221"/>
              <a:gd name="T90" fmla="*/ 208 w 511"/>
              <a:gd name="T91" fmla="*/ 215 h 221"/>
              <a:gd name="T92" fmla="*/ 174 w 511"/>
              <a:gd name="T93" fmla="*/ 153 h 221"/>
              <a:gd name="T94" fmla="*/ 342 w 511"/>
              <a:gd name="T95" fmla="*/ 130 h 221"/>
              <a:gd name="T96" fmla="*/ 370 w 511"/>
              <a:gd name="T97" fmla="*/ 90 h 221"/>
              <a:gd name="T98" fmla="*/ 374 w 511"/>
              <a:gd name="T99" fmla="*/ 98 h 221"/>
              <a:gd name="T100" fmla="*/ 354 w 511"/>
              <a:gd name="T101" fmla="*/ 122 h 221"/>
              <a:gd name="T102" fmla="*/ 342 w 511"/>
              <a:gd name="T103" fmla="*/ 130 h 221"/>
              <a:gd name="T104" fmla="*/ 352 w 511"/>
              <a:gd name="T105" fmla="*/ 103 h 221"/>
              <a:gd name="T106" fmla="*/ 351 w 511"/>
              <a:gd name="T107" fmla="*/ 133 h 2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</a:cxnLst>
            <a:rect l="0" t="0" r="r" b="b"/>
            <a:pathLst>
              <a:path w="511" h="221">
                <a:moveTo>
                  <a:pt x="188" y="44"/>
                </a:moveTo>
                <a:cubicBezTo>
                  <a:pt x="188" y="44"/>
                  <a:pt x="187" y="44"/>
                  <a:pt x="186" y="43"/>
                </a:cubicBezTo>
                <a:cubicBezTo>
                  <a:pt x="185" y="42"/>
                  <a:pt x="179" y="36"/>
                  <a:pt x="169" y="30"/>
                </a:cubicBezTo>
                <a:cubicBezTo>
                  <a:pt x="159" y="24"/>
                  <a:pt x="137" y="13"/>
                  <a:pt x="107" y="13"/>
                </a:cubicBezTo>
                <a:cubicBezTo>
                  <a:pt x="71" y="13"/>
                  <a:pt x="47" y="27"/>
                  <a:pt x="32" y="39"/>
                </a:cubicBezTo>
                <a:cubicBezTo>
                  <a:pt x="18" y="51"/>
                  <a:pt x="11" y="65"/>
                  <a:pt x="11" y="66"/>
                </a:cubicBezTo>
                <a:cubicBezTo>
                  <a:pt x="11" y="66"/>
                  <a:pt x="11" y="66"/>
                  <a:pt x="10" y="66"/>
                </a:cubicBezTo>
                <a:cubicBezTo>
                  <a:pt x="10" y="66"/>
                  <a:pt x="10" y="66"/>
                  <a:pt x="10" y="66"/>
                </a:cubicBezTo>
                <a:cubicBezTo>
                  <a:pt x="11" y="65"/>
                  <a:pt x="17" y="49"/>
                  <a:pt x="30" y="35"/>
                </a:cubicBezTo>
                <a:cubicBezTo>
                  <a:pt x="43" y="20"/>
                  <a:pt x="69" y="0"/>
                  <a:pt x="106" y="0"/>
                </a:cubicBezTo>
                <a:cubicBezTo>
                  <a:pt x="142" y="0"/>
                  <a:pt x="165" y="19"/>
                  <a:pt x="173" y="26"/>
                </a:cubicBezTo>
                <a:cubicBezTo>
                  <a:pt x="180" y="33"/>
                  <a:pt x="186" y="41"/>
                  <a:pt x="187" y="42"/>
                </a:cubicBezTo>
                <a:cubicBezTo>
                  <a:pt x="188" y="43"/>
                  <a:pt x="188" y="44"/>
                  <a:pt x="188" y="44"/>
                </a:cubicBezTo>
                <a:cubicBezTo>
                  <a:pt x="188" y="44"/>
                  <a:pt x="188" y="44"/>
                  <a:pt x="188" y="44"/>
                </a:cubicBezTo>
                <a:cubicBezTo>
                  <a:pt x="188" y="44"/>
                  <a:pt x="188" y="44"/>
                  <a:pt x="188" y="44"/>
                </a:cubicBezTo>
                <a:close/>
                <a:moveTo>
                  <a:pt x="1" y="101"/>
                </a:moveTo>
                <a:cubicBezTo>
                  <a:pt x="1" y="101"/>
                  <a:pt x="1" y="101"/>
                  <a:pt x="1" y="102"/>
                </a:cubicBezTo>
                <a:cubicBezTo>
                  <a:pt x="1" y="103"/>
                  <a:pt x="0" y="117"/>
                  <a:pt x="3" y="134"/>
                </a:cubicBezTo>
                <a:cubicBezTo>
                  <a:pt x="8" y="157"/>
                  <a:pt x="22" y="186"/>
                  <a:pt x="54" y="203"/>
                </a:cubicBezTo>
                <a:cubicBezTo>
                  <a:pt x="87" y="221"/>
                  <a:pt x="120" y="216"/>
                  <a:pt x="139" y="208"/>
                </a:cubicBezTo>
                <a:cubicBezTo>
                  <a:pt x="153" y="202"/>
                  <a:pt x="157" y="198"/>
                  <a:pt x="159" y="196"/>
                </a:cubicBezTo>
                <a:cubicBezTo>
                  <a:pt x="160" y="196"/>
                  <a:pt x="161" y="195"/>
                  <a:pt x="161" y="195"/>
                </a:cubicBezTo>
                <a:cubicBezTo>
                  <a:pt x="162" y="194"/>
                  <a:pt x="162" y="194"/>
                  <a:pt x="162" y="194"/>
                </a:cubicBezTo>
                <a:cubicBezTo>
                  <a:pt x="162" y="194"/>
                  <a:pt x="162" y="194"/>
                  <a:pt x="162" y="194"/>
                </a:cubicBezTo>
                <a:cubicBezTo>
                  <a:pt x="162" y="194"/>
                  <a:pt x="162" y="194"/>
                  <a:pt x="161" y="194"/>
                </a:cubicBezTo>
                <a:cubicBezTo>
                  <a:pt x="160" y="195"/>
                  <a:pt x="146" y="201"/>
                  <a:pt x="129" y="203"/>
                </a:cubicBezTo>
                <a:cubicBezTo>
                  <a:pt x="111" y="205"/>
                  <a:pt x="87" y="204"/>
                  <a:pt x="62" y="191"/>
                </a:cubicBezTo>
                <a:cubicBezTo>
                  <a:pt x="36" y="178"/>
                  <a:pt x="19" y="158"/>
                  <a:pt x="10" y="139"/>
                </a:cubicBezTo>
                <a:cubicBezTo>
                  <a:pt x="1" y="120"/>
                  <a:pt x="2" y="103"/>
                  <a:pt x="2" y="102"/>
                </a:cubicBezTo>
                <a:cubicBezTo>
                  <a:pt x="2" y="101"/>
                  <a:pt x="2" y="101"/>
                  <a:pt x="2" y="101"/>
                </a:cubicBezTo>
                <a:cubicBezTo>
                  <a:pt x="2" y="101"/>
                  <a:pt x="2" y="101"/>
                  <a:pt x="2" y="101"/>
                </a:cubicBezTo>
                <a:cubicBezTo>
                  <a:pt x="2" y="101"/>
                  <a:pt x="1" y="101"/>
                  <a:pt x="1" y="101"/>
                </a:cubicBezTo>
                <a:close/>
                <a:moveTo>
                  <a:pt x="108" y="133"/>
                </a:moveTo>
                <a:cubicBezTo>
                  <a:pt x="108" y="108"/>
                  <a:pt x="108" y="108"/>
                  <a:pt x="108" y="108"/>
                </a:cubicBezTo>
                <a:cubicBezTo>
                  <a:pt x="91" y="70"/>
                  <a:pt x="91" y="70"/>
                  <a:pt x="91" y="70"/>
                </a:cubicBezTo>
                <a:cubicBezTo>
                  <a:pt x="105" y="70"/>
                  <a:pt x="105" y="70"/>
                  <a:pt x="105" y="70"/>
                </a:cubicBezTo>
                <a:cubicBezTo>
                  <a:pt x="116" y="95"/>
                  <a:pt x="116" y="95"/>
                  <a:pt x="116" y="95"/>
                </a:cubicBezTo>
                <a:cubicBezTo>
                  <a:pt x="127" y="70"/>
                  <a:pt x="127" y="70"/>
                  <a:pt x="127" y="70"/>
                </a:cubicBezTo>
                <a:cubicBezTo>
                  <a:pt x="140" y="70"/>
                  <a:pt x="140" y="70"/>
                  <a:pt x="140" y="70"/>
                </a:cubicBezTo>
                <a:cubicBezTo>
                  <a:pt x="123" y="108"/>
                  <a:pt x="123" y="108"/>
                  <a:pt x="123" y="108"/>
                </a:cubicBezTo>
                <a:cubicBezTo>
                  <a:pt x="123" y="133"/>
                  <a:pt x="123" y="133"/>
                  <a:pt x="123" y="133"/>
                </a:cubicBezTo>
                <a:lnTo>
                  <a:pt x="108" y="133"/>
                </a:lnTo>
                <a:close/>
                <a:moveTo>
                  <a:pt x="241" y="133"/>
                </a:moveTo>
                <a:cubicBezTo>
                  <a:pt x="208" y="133"/>
                  <a:pt x="208" y="133"/>
                  <a:pt x="208" y="133"/>
                </a:cubicBezTo>
                <a:cubicBezTo>
                  <a:pt x="208" y="70"/>
                  <a:pt x="208" y="70"/>
                  <a:pt x="208" y="70"/>
                </a:cubicBezTo>
                <a:cubicBezTo>
                  <a:pt x="222" y="70"/>
                  <a:pt x="222" y="70"/>
                  <a:pt x="222" y="70"/>
                </a:cubicBezTo>
                <a:cubicBezTo>
                  <a:pt x="222" y="121"/>
                  <a:pt x="222" y="121"/>
                  <a:pt x="222" y="121"/>
                </a:cubicBezTo>
                <a:cubicBezTo>
                  <a:pt x="241" y="121"/>
                  <a:pt x="241" y="121"/>
                  <a:pt x="241" y="121"/>
                </a:cubicBezTo>
                <a:lnTo>
                  <a:pt x="241" y="133"/>
                </a:lnTo>
                <a:close/>
                <a:moveTo>
                  <a:pt x="73" y="70"/>
                </a:moveTo>
                <a:cubicBezTo>
                  <a:pt x="86" y="70"/>
                  <a:pt x="86" y="70"/>
                  <a:pt x="86" y="70"/>
                </a:cubicBezTo>
                <a:cubicBezTo>
                  <a:pt x="86" y="133"/>
                  <a:pt x="86" y="133"/>
                  <a:pt x="86" y="133"/>
                </a:cubicBezTo>
                <a:cubicBezTo>
                  <a:pt x="73" y="133"/>
                  <a:pt x="73" y="133"/>
                  <a:pt x="73" y="133"/>
                </a:cubicBezTo>
                <a:cubicBezTo>
                  <a:pt x="73" y="133"/>
                  <a:pt x="73" y="133"/>
                  <a:pt x="73" y="133"/>
                </a:cubicBezTo>
                <a:cubicBezTo>
                  <a:pt x="73" y="131"/>
                  <a:pt x="57" y="104"/>
                  <a:pt x="53" y="96"/>
                </a:cubicBezTo>
                <a:cubicBezTo>
                  <a:pt x="53" y="133"/>
                  <a:pt x="53" y="133"/>
                  <a:pt x="53" y="133"/>
                </a:cubicBezTo>
                <a:cubicBezTo>
                  <a:pt x="40" y="133"/>
                  <a:pt x="40" y="133"/>
                  <a:pt x="40" y="133"/>
                </a:cubicBezTo>
                <a:cubicBezTo>
                  <a:pt x="40" y="70"/>
                  <a:pt x="40" y="70"/>
                  <a:pt x="40" y="70"/>
                </a:cubicBezTo>
                <a:cubicBezTo>
                  <a:pt x="54" y="70"/>
                  <a:pt x="54" y="70"/>
                  <a:pt x="54" y="70"/>
                </a:cubicBezTo>
                <a:cubicBezTo>
                  <a:pt x="54" y="70"/>
                  <a:pt x="54" y="70"/>
                  <a:pt x="54" y="70"/>
                </a:cubicBezTo>
                <a:cubicBezTo>
                  <a:pt x="55" y="71"/>
                  <a:pt x="69" y="97"/>
                  <a:pt x="73" y="106"/>
                </a:cubicBezTo>
                <a:lnTo>
                  <a:pt x="73" y="70"/>
                </a:lnTo>
                <a:close/>
                <a:moveTo>
                  <a:pt x="166" y="134"/>
                </a:moveTo>
                <a:cubicBezTo>
                  <a:pt x="152" y="134"/>
                  <a:pt x="144" y="126"/>
                  <a:pt x="144" y="111"/>
                </a:cubicBezTo>
                <a:cubicBezTo>
                  <a:pt x="144" y="70"/>
                  <a:pt x="144" y="70"/>
                  <a:pt x="144" y="70"/>
                </a:cubicBezTo>
                <a:cubicBezTo>
                  <a:pt x="158" y="70"/>
                  <a:pt x="158" y="70"/>
                  <a:pt x="158" y="70"/>
                </a:cubicBezTo>
                <a:cubicBezTo>
                  <a:pt x="158" y="110"/>
                  <a:pt x="158" y="110"/>
                  <a:pt x="158" y="110"/>
                </a:cubicBezTo>
                <a:cubicBezTo>
                  <a:pt x="158" y="119"/>
                  <a:pt x="161" y="122"/>
                  <a:pt x="167" y="122"/>
                </a:cubicBezTo>
                <a:cubicBezTo>
                  <a:pt x="172" y="122"/>
                  <a:pt x="175" y="118"/>
                  <a:pt x="175" y="110"/>
                </a:cubicBezTo>
                <a:cubicBezTo>
                  <a:pt x="175" y="70"/>
                  <a:pt x="175" y="70"/>
                  <a:pt x="175" y="70"/>
                </a:cubicBezTo>
                <a:cubicBezTo>
                  <a:pt x="188" y="70"/>
                  <a:pt x="188" y="70"/>
                  <a:pt x="188" y="70"/>
                </a:cubicBezTo>
                <a:cubicBezTo>
                  <a:pt x="188" y="111"/>
                  <a:pt x="188" y="111"/>
                  <a:pt x="188" y="111"/>
                </a:cubicBezTo>
                <a:cubicBezTo>
                  <a:pt x="188" y="126"/>
                  <a:pt x="181" y="134"/>
                  <a:pt x="166" y="134"/>
                </a:cubicBezTo>
                <a:close/>
                <a:moveTo>
                  <a:pt x="259" y="199"/>
                </a:moveTo>
                <a:cubicBezTo>
                  <a:pt x="267" y="206"/>
                  <a:pt x="267" y="206"/>
                  <a:pt x="267" y="206"/>
                </a:cubicBezTo>
                <a:cubicBezTo>
                  <a:pt x="267" y="206"/>
                  <a:pt x="267" y="206"/>
                  <a:pt x="267" y="206"/>
                </a:cubicBezTo>
                <a:cubicBezTo>
                  <a:pt x="263" y="213"/>
                  <a:pt x="257" y="216"/>
                  <a:pt x="249" y="216"/>
                </a:cubicBezTo>
                <a:cubicBezTo>
                  <a:pt x="236" y="216"/>
                  <a:pt x="229" y="207"/>
                  <a:pt x="229" y="192"/>
                </a:cubicBezTo>
                <a:cubicBezTo>
                  <a:pt x="229" y="174"/>
                  <a:pt x="239" y="168"/>
                  <a:pt x="249" y="168"/>
                </a:cubicBezTo>
                <a:cubicBezTo>
                  <a:pt x="261" y="168"/>
                  <a:pt x="267" y="177"/>
                  <a:pt x="267" y="193"/>
                </a:cubicBezTo>
                <a:cubicBezTo>
                  <a:pt x="267" y="196"/>
                  <a:pt x="267" y="196"/>
                  <a:pt x="267" y="196"/>
                </a:cubicBezTo>
                <a:cubicBezTo>
                  <a:pt x="242" y="196"/>
                  <a:pt x="242" y="196"/>
                  <a:pt x="242" y="196"/>
                </a:cubicBezTo>
                <a:cubicBezTo>
                  <a:pt x="243" y="202"/>
                  <a:pt x="245" y="205"/>
                  <a:pt x="250" y="205"/>
                </a:cubicBezTo>
                <a:cubicBezTo>
                  <a:pt x="254" y="205"/>
                  <a:pt x="257" y="202"/>
                  <a:pt x="259" y="200"/>
                </a:cubicBezTo>
                <a:lnTo>
                  <a:pt x="259" y="199"/>
                </a:lnTo>
                <a:close/>
                <a:moveTo>
                  <a:pt x="242" y="187"/>
                </a:moveTo>
                <a:cubicBezTo>
                  <a:pt x="255" y="187"/>
                  <a:pt x="255" y="187"/>
                  <a:pt x="255" y="187"/>
                </a:cubicBezTo>
                <a:cubicBezTo>
                  <a:pt x="254" y="179"/>
                  <a:pt x="250" y="179"/>
                  <a:pt x="249" y="179"/>
                </a:cubicBezTo>
                <a:cubicBezTo>
                  <a:pt x="245" y="179"/>
                  <a:pt x="243" y="182"/>
                  <a:pt x="242" y="187"/>
                </a:cubicBezTo>
                <a:close/>
                <a:moveTo>
                  <a:pt x="416" y="92"/>
                </a:moveTo>
                <a:cubicBezTo>
                  <a:pt x="420" y="96"/>
                  <a:pt x="422" y="102"/>
                  <a:pt x="422" y="110"/>
                </a:cubicBezTo>
                <a:cubicBezTo>
                  <a:pt x="422" y="128"/>
                  <a:pt x="412" y="134"/>
                  <a:pt x="402" y="134"/>
                </a:cubicBezTo>
                <a:cubicBezTo>
                  <a:pt x="392" y="134"/>
                  <a:pt x="382" y="128"/>
                  <a:pt x="382" y="110"/>
                </a:cubicBezTo>
                <a:cubicBezTo>
                  <a:pt x="382" y="102"/>
                  <a:pt x="384" y="96"/>
                  <a:pt x="388" y="92"/>
                </a:cubicBezTo>
                <a:cubicBezTo>
                  <a:pt x="392" y="88"/>
                  <a:pt x="396" y="86"/>
                  <a:pt x="402" y="86"/>
                </a:cubicBezTo>
                <a:cubicBezTo>
                  <a:pt x="408" y="86"/>
                  <a:pt x="413" y="88"/>
                  <a:pt x="416" y="92"/>
                </a:cubicBezTo>
                <a:close/>
                <a:moveTo>
                  <a:pt x="409" y="110"/>
                </a:moveTo>
                <a:cubicBezTo>
                  <a:pt x="409" y="99"/>
                  <a:pt x="405" y="97"/>
                  <a:pt x="402" y="97"/>
                </a:cubicBezTo>
                <a:cubicBezTo>
                  <a:pt x="398" y="97"/>
                  <a:pt x="396" y="101"/>
                  <a:pt x="396" y="110"/>
                </a:cubicBezTo>
                <a:cubicBezTo>
                  <a:pt x="396" y="122"/>
                  <a:pt x="399" y="123"/>
                  <a:pt x="402" y="123"/>
                </a:cubicBezTo>
                <a:cubicBezTo>
                  <a:pt x="407" y="123"/>
                  <a:pt x="409" y="119"/>
                  <a:pt x="409" y="110"/>
                </a:cubicBezTo>
                <a:close/>
                <a:moveTo>
                  <a:pt x="410" y="180"/>
                </a:moveTo>
                <a:cubicBezTo>
                  <a:pt x="410" y="215"/>
                  <a:pt x="410" y="215"/>
                  <a:pt x="410" y="215"/>
                </a:cubicBezTo>
                <a:cubicBezTo>
                  <a:pt x="397" y="215"/>
                  <a:pt x="397" y="215"/>
                  <a:pt x="397" y="215"/>
                </a:cubicBezTo>
                <a:cubicBezTo>
                  <a:pt x="397" y="184"/>
                  <a:pt x="397" y="184"/>
                  <a:pt x="397" y="184"/>
                </a:cubicBezTo>
                <a:cubicBezTo>
                  <a:pt x="397" y="180"/>
                  <a:pt x="395" y="180"/>
                  <a:pt x="393" y="180"/>
                </a:cubicBezTo>
                <a:cubicBezTo>
                  <a:pt x="391" y="180"/>
                  <a:pt x="389" y="181"/>
                  <a:pt x="386" y="183"/>
                </a:cubicBezTo>
                <a:cubicBezTo>
                  <a:pt x="386" y="215"/>
                  <a:pt x="386" y="215"/>
                  <a:pt x="386" y="215"/>
                </a:cubicBezTo>
                <a:cubicBezTo>
                  <a:pt x="373" y="215"/>
                  <a:pt x="373" y="215"/>
                  <a:pt x="373" y="215"/>
                </a:cubicBezTo>
                <a:cubicBezTo>
                  <a:pt x="373" y="152"/>
                  <a:pt x="373" y="152"/>
                  <a:pt x="373" y="152"/>
                </a:cubicBezTo>
                <a:cubicBezTo>
                  <a:pt x="386" y="150"/>
                  <a:pt x="386" y="150"/>
                  <a:pt x="386" y="150"/>
                </a:cubicBezTo>
                <a:cubicBezTo>
                  <a:pt x="386" y="174"/>
                  <a:pt x="386" y="174"/>
                  <a:pt x="386" y="174"/>
                </a:cubicBezTo>
                <a:cubicBezTo>
                  <a:pt x="389" y="171"/>
                  <a:pt x="393" y="168"/>
                  <a:pt x="399" y="168"/>
                </a:cubicBezTo>
                <a:cubicBezTo>
                  <a:pt x="406" y="168"/>
                  <a:pt x="410" y="172"/>
                  <a:pt x="410" y="180"/>
                </a:cubicBezTo>
                <a:close/>
                <a:moveTo>
                  <a:pt x="511" y="124"/>
                </a:moveTo>
                <a:cubicBezTo>
                  <a:pt x="511" y="124"/>
                  <a:pt x="511" y="124"/>
                  <a:pt x="511" y="124"/>
                </a:cubicBezTo>
                <a:cubicBezTo>
                  <a:pt x="507" y="131"/>
                  <a:pt x="501" y="134"/>
                  <a:pt x="493" y="134"/>
                </a:cubicBezTo>
                <a:cubicBezTo>
                  <a:pt x="480" y="134"/>
                  <a:pt x="473" y="125"/>
                  <a:pt x="473" y="110"/>
                </a:cubicBezTo>
                <a:cubicBezTo>
                  <a:pt x="473" y="92"/>
                  <a:pt x="484" y="86"/>
                  <a:pt x="493" y="86"/>
                </a:cubicBezTo>
                <a:cubicBezTo>
                  <a:pt x="505" y="86"/>
                  <a:pt x="511" y="95"/>
                  <a:pt x="511" y="111"/>
                </a:cubicBezTo>
                <a:cubicBezTo>
                  <a:pt x="511" y="114"/>
                  <a:pt x="511" y="114"/>
                  <a:pt x="511" y="114"/>
                </a:cubicBezTo>
                <a:cubicBezTo>
                  <a:pt x="486" y="114"/>
                  <a:pt x="486" y="114"/>
                  <a:pt x="486" y="114"/>
                </a:cubicBezTo>
                <a:cubicBezTo>
                  <a:pt x="487" y="120"/>
                  <a:pt x="489" y="123"/>
                  <a:pt x="494" y="123"/>
                </a:cubicBezTo>
                <a:cubicBezTo>
                  <a:pt x="498" y="123"/>
                  <a:pt x="501" y="120"/>
                  <a:pt x="503" y="118"/>
                </a:cubicBezTo>
                <a:cubicBezTo>
                  <a:pt x="503" y="117"/>
                  <a:pt x="503" y="117"/>
                  <a:pt x="503" y="117"/>
                </a:cubicBezTo>
                <a:lnTo>
                  <a:pt x="511" y="124"/>
                </a:lnTo>
                <a:close/>
                <a:moveTo>
                  <a:pt x="487" y="105"/>
                </a:moveTo>
                <a:cubicBezTo>
                  <a:pt x="499" y="105"/>
                  <a:pt x="499" y="105"/>
                  <a:pt x="499" y="105"/>
                </a:cubicBezTo>
                <a:cubicBezTo>
                  <a:pt x="498" y="97"/>
                  <a:pt x="494" y="97"/>
                  <a:pt x="493" y="97"/>
                </a:cubicBezTo>
                <a:cubicBezTo>
                  <a:pt x="489" y="97"/>
                  <a:pt x="487" y="100"/>
                  <a:pt x="487" y="105"/>
                </a:cubicBezTo>
                <a:close/>
                <a:moveTo>
                  <a:pt x="467" y="98"/>
                </a:moveTo>
                <a:cubicBezTo>
                  <a:pt x="467" y="133"/>
                  <a:pt x="467" y="133"/>
                  <a:pt x="467" y="133"/>
                </a:cubicBezTo>
                <a:cubicBezTo>
                  <a:pt x="453" y="133"/>
                  <a:pt x="453" y="133"/>
                  <a:pt x="453" y="133"/>
                </a:cubicBezTo>
                <a:cubicBezTo>
                  <a:pt x="453" y="102"/>
                  <a:pt x="453" y="102"/>
                  <a:pt x="453" y="102"/>
                </a:cubicBezTo>
                <a:cubicBezTo>
                  <a:pt x="453" y="98"/>
                  <a:pt x="452" y="98"/>
                  <a:pt x="450" y="98"/>
                </a:cubicBezTo>
                <a:cubicBezTo>
                  <a:pt x="448" y="98"/>
                  <a:pt x="445" y="99"/>
                  <a:pt x="443" y="102"/>
                </a:cubicBezTo>
                <a:cubicBezTo>
                  <a:pt x="443" y="133"/>
                  <a:pt x="443" y="133"/>
                  <a:pt x="443" y="133"/>
                </a:cubicBezTo>
                <a:cubicBezTo>
                  <a:pt x="429" y="133"/>
                  <a:pt x="429" y="133"/>
                  <a:pt x="429" y="133"/>
                </a:cubicBezTo>
                <a:cubicBezTo>
                  <a:pt x="429" y="87"/>
                  <a:pt x="429" y="87"/>
                  <a:pt x="429" y="87"/>
                </a:cubicBezTo>
                <a:cubicBezTo>
                  <a:pt x="443" y="87"/>
                  <a:pt x="443" y="87"/>
                  <a:pt x="443" y="87"/>
                </a:cubicBezTo>
                <a:cubicBezTo>
                  <a:pt x="443" y="92"/>
                  <a:pt x="443" y="92"/>
                  <a:pt x="443" y="92"/>
                </a:cubicBezTo>
                <a:cubicBezTo>
                  <a:pt x="445" y="89"/>
                  <a:pt x="450" y="86"/>
                  <a:pt x="455" y="86"/>
                </a:cubicBezTo>
                <a:cubicBezTo>
                  <a:pt x="463" y="86"/>
                  <a:pt x="467" y="90"/>
                  <a:pt x="467" y="98"/>
                </a:cubicBezTo>
                <a:close/>
                <a:moveTo>
                  <a:pt x="357" y="169"/>
                </a:moveTo>
                <a:cubicBezTo>
                  <a:pt x="366" y="169"/>
                  <a:pt x="366" y="169"/>
                  <a:pt x="366" y="169"/>
                </a:cubicBezTo>
                <a:cubicBezTo>
                  <a:pt x="366" y="179"/>
                  <a:pt x="366" y="179"/>
                  <a:pt x="366" y="179"/>
                </a:cubicBezTo>
                <a:cubicBezTo>
                  <a:pt x="357" y="179"/>
                  <a:pt x="357" y="179"/>
                  <a:pt x="357" y="179"/>
                </a:cubicBezTo>
                <a:cubicBezTo>
                  <a:pt x="357" y="200"/>
                  <a:pt x="357" y="200"/>
                  <a:pt x="357" y="200"/>
                </a:cubicBezTo>
                <a:cubicBezTo>
                  <a:pt x="357" y="204"/>
                  <a:pt x="358" y="205"/>
                  <a:pt x="361" y="205"/>
                </a:cubicBezTo>
                <a:cubicBezTo>
                  <a:pt x="363" y="205"/>
                  <a:pt x="364" y="205"/>
                  <a:pt x="365" y="205"/>
                </a:cubicBezTo>
                <a:cubicBezTo>
                  <a:pt x="366" y="204"/>
                  <a:pt x="366" y="204"/>
                  <a:pt x="366" y="204"/>
                </a:cubicBezTo>
                <a:cubicBezTo>
                  <a:pt x="366" y="215"/>
                  <a:pt x="366" y="215"/>
                  <a:pt x="366" y="215"/>
                </a:cubicBezTo>
                <a:cubicBezTo>
                  <a:pt x="365" y="215"/>
                  <a:pt x="365" y="215"/>
                  <a:pt x="365" y="215"/>
                </a:cubicBezTo>
                <a:cubicBezTo>
                  <a:pt x="364" y="215"/>
                  <a:pt x="360" y="215"/>
                  <a:pt x="357" y="215"/>
                </a:cubicBezTo>
                <a:cubicBezTo>
                  <a:pt x="347" y="215"/>
                  <a:pt x="343" y="212"/>
                  <a:pt x="343" y="203"/>
                </a:cubicBezTo>
                <a:cubicBezTo>
                  <a:pt x="343" y="179"/>
                  <a:pt x="343" y="179"/>
                  <a:pt x="343" y="179"/>
                </a:cubicBezTo>
                <a:cubicBezTo>
                  <a:pt x="337" y="179"/>
                  <a:pt x="337" y="179"/>
                  <a:pt x="337" y="179"/>
                </a:cubicBezTo>
                <a:cubicBezTo>
                  <a:pt x="337" y="169"/>
                  <a:pt x="337" y="169"/>
                  <a:pt x="337" y="169"/>
                </a:cubicBezTo>
                <a:cubicBezTo>
                  <a:pt x="343" y="169"/>
                  <a:pt x="343" y="169"/>
                  <a:pt x="343" y="169"/>
                </a:cubicBezTo>
                <a:cubicBezTo>
                  <a:pt x="343" y="156"/>
                  <a:pt x="343" y="156"/>
                  <a:pt x="343" y="156"/>
                </a:cubicBezTo>
                <a:cubicBezTo>
                  <a:pt x="357" y="154"/>
                  <a:pt x="357" y="154"/>
                  <a:pt x="357" y="154"/>
                </a:cubicBezTo>
                <a:lnTo>
                  <a:pt x="357" y="169"/>
                </a:lnTo>
                <a:close/>
                <a:moveTo>
                  <a:pt x="332" y="98"/>
                </a:moveTo>
                <a:cubicBezTo>
                  <a:pt x="332" y="133"/>
                  <a:pt x="332" y="133"/>
                  <a:pt x="332" y="133"/>
                </a:cubicBezTo>
                <a:cubicBezTo>
                  <a:pt x="318" y="133"/>
                  <a:pt x="318" y="133"/>
                  <a:pt x="318" y="133"/>
                </a:cubicBezTo>
                <a:cubicBezTo>
                  <a:pt x="318" y="102"/>
                  <a:pt x="318" y="102"/>
                  <a:pt x="318" y="102"/>
                </a:cubicBezTo>
                <a:cubicBezTo>
                  <a:pt x="318" y="98"/>
                  <a:pt x="316" y="98"/>
                  <a:pt x="315" y="98"/>
                </a:cubicBezTo>
                <a:cubicBezTo>
                  <a:pt x="313" y="98"/>
                  <a:pt x="310" y="99"/>
                  <a:pt x="307" y="102"/>
                </a:cubicBezTo>
                <a:cubicBezTo>
                  <a:pt x="307" y="133"/>
                  <a:pt x="307" y="133"/>
                  <a:pt x="307" y="133"/>
                </a:cubicBezTo>
                <a:cubicBezTo>
                  <a:pt x="294" y="133"/>
                  <a:pt x="294" y="133"/>
                  <a:pt x="294" y="133"/>
                </a:cubicBezTo>
                <a:cubicBezTo>
                  <a:pt x="294" y="87"/>
                  <a:pt x="294" y="87"/>
                  <a:pt x="294" y="87"/>
                </a:cubicBezTo>
                <a:cubicBezTo>
                  <a:pt x="307" y="87"/>
                  <a:pt x="307" y="87"/>
                  <a:pt x="307" y="87"/>
                </a:cubicBezTo>
                <a:cubicBezTo>
                  <a:pt x="307" y="92"/>
                  <a:pt x="307" y="92"/>
                  <a:pt x="307" y="92"/>
                </a:cubicBezTo>
                <a:cubicBezTo>
                  <a:pt x="310" y="89"/>
                  <a:pt x="315" y="86"/>
                  <a:pt x="320" y="86"/>
                </a:cubicBezTo>
                <a:cubicBezTo>
                  <a:pt x="328" y="86"/>
                  <a:pt x="332" y="90"/>
                  <a:pt x="332" y="98"/>
                </a:cubicBezTo>
                <a:close/>
                <a:moveTo>
                  <a:pt x="272" y="132"/>
                </a:moveTo>
                <a:cubicBezTo>
                  <a:pt x="272" y="131"/>
                  <a:pt x="271" y="130"/>
                  <a:pt x="271" y="128"/>
                </a:cubicBezTo>
                <a:cubicBezTo>
                  <a:pt x="268" y="132"/>
                  <a:pt x="264" y="133"/>
                  <a:pt x="259" y="133"/>
                </a:cubicBezTo>
                <a:cubicBezTo>
                  <a:pt x="251" y="133"/>
                  <a:pt x="247" y="129"/>
                  <a:pt x="247" y="121"/>
                </a:cubicBezTo>
                <a:cubicBezTo>
                  <a:pt x="247" y="112"/>
                  <a:pt x="255" y="106"/>
                  <a:pt x="271" y="103"/>
                </a:cubicBezTo>
                <a:cubicBezTo>
                  <a:pt x="271" y="102"/>
                  <a:pt x="271" y="102"/>
                  <a:pt x="271" y="102"/>
                </a:cubicBezTo>
                <a:cubicBezTo>
                  <a:pt x="271" y="98"/>
                  <a:pt x="270" y="97"/>
                  <a:pt x="267" y="97"/>
                </a:cubicBezTo>
                <a:cubicBezTo>
                  <a:pt x="263" y="97"/>
                  <a:pt x="258" y="100"/>
                  <a:pt x="256" y="102"/>
                </a:cubicBezTo>
                <a:cubicBezTo>
                  <a:pt x="255" y="102"/>
                  <a:pt x="255" y="102"/>
                  <a:pt x="255" y="102"/>
                </a:cubicBezTo>
                <a:cubicBezTo>
                  <a:pt x="249" y="94"/>
                  <a:pt x="249" y="94"/>
                  <a:pt x="249" y="94"/>
                </a:cubicBezTo>
                <a:cubicBezTo>
                  <a:pt x="249" y="93"/>
                  <a:pt x="249" y="93"/>
                  <a:pt x="249" y="93"/>
                </a:cubicBezTo>
                <a:cubicBezTo>
                  <a:pt x="255" y="89"/>
                  <a:pt x="262" y="86"/>
                  <a:pt x="270" y="86"/>
                </a:cubicBezTo>
                <a:cubicBezTo>
                  <a:pt x="280" y="86"/>
                  <a:pt x="285" y="91"/>
                  <a:pt x="285" y="102"/>
                </a:cubicBezTo>
                <a:cubicBezTo>
                  <a:pt x="285" y="121"/>
                  <a:pt x="285" y="121"/>
                  <a:pt x="285" y="121"/>
                </a:cubicBezTo>
                <a:cubicBezTo>
                  <a:pt x="285" y="127"/>
                  <a:pt x="285" y="130"/>
                  <a:pt x="286" y="132"/>
                </a:cubicBezTo>
                <a:cubicBezTo>
                  <a:pt x="286" y="133"/>
                  <a:pt x="286" y="133"/>
                  <a:pt x="286" y="133"/>
                </a:cubicBezTo>
                <a:cubicBezTo>
                  <a:pt x="272" y="133"/>
                  <a:pt x="272" y="133"/>
                  <a:pt x="272" y="133"/>
                </a:cubicBezTo>
                <a:lnTo>
                  <a:pt x="272" y="132"/>
                </a:lnTo>
                <a:close/>
                <a:moveTo>
                  <a:pt x="271" y="111"/>
                </a:moveTo>
                <a:cubicBezTo>
                  <a:pt x="262" y="113"/>
                  <a:pt x="261" y="116"/>
                  <a:pt x="261" y="119"/>
                </a:cubicBezTo>
                <a:cubicBezTo>
                  <a:pt x="261" y="121"/>
                  <a:pt x="262" y="123"/>
                  <a:pt x="264" y="123"/>
                </a:cubicBezTo>
                <a:cubicBezTo>
                  <a:pt x="267" y="123"/>
                  <a:pt x="269" y="122"/>
                  <a:pt x="271" y="120"/>
                </a:cubicBezTo>
                <a:lnTo>
                  <a:pt x="271" y="111"/>
                </a:lnTo>
                <a:close/>
                <a:moveTo>
                  <a:pt x="310" y="214"/>
                </a:moveTo>
                <a:cubicBezTo>
                  <a:pt x="311" y="215"/>
                  <a:pt x="311" y="215"/>
                  <a:pt x="311" y="215"/>
                </a:cubicBezTo>
                <a:cubicBezTo>
                  <a:pt x="297" y="215"/>
                  <a:pt x="297" y="215"/>
                  <a:pt x="297" y="215"/>
                </a:cubicBezTo>
                <a:cubicBezTo>
                  <a:pt x="297" y="214"/>
                  <a:pt x="297" y="214"/>
                  <a:pt x="297" y="214"/>
                </a:cubicBezTo>
                <a:cubicBezTo>
                  <a:pt x="296" y="213"/>
                  <a:pt x="296" y="212"/>
                  <a:pt x="296" y="210"/>
                </a:cubicBezTo>
                <a:cubicBezTo>
                  <a:pt x="293" y="214"/>
                  <a:pt x="289" y="215"/>
                  <a:pt x="283" y="215"/>
                </a:cubicBezTo>
                <a:cubicBezTo>
                  <a:pt x="276" y="215"/>
                  <a:pt x="272" y="211"/>
                  <a:pt x="272" y="203"/>
                </a:cubicBezTo>
                <a:cubicBezTo>
                  <a:pt x="272" y="194"/>
                  <a:pt x="280" y="188"/>
                  <a:pt x="296" y="185"/>
                </a:cubicBezTo>
                <a:cubicBezTo>
                  <a:pt x="296" y="183"/>
                  <a:pt x="296" y="183"/>
                  <a:pt x="296" y="183"/>
                </a:cubicBezTo>
                <a:cubicBezTo>
                  <a:pt x="296" y="180"/>
                  <a:pt x="295" y="179"/>
                  <a:pt x="292" y="179"/>
                </a:cubicBezTo>
                <a:cubicBezTo>
                  <a:pt x="287" y="179"/>
                  <a:pt x="283" y="182"/>
                  <a:pt x="280" y="184"/>
                </a:cubicBezTo>
                <a:cubicBezTo>
                  <a:pt x="280" y="184"/>
                  <a:pt x="280" y="184"/>
                  <a:pt x="280" y="184"/>
                </a:cubicBezTo>
                <a:cubicBezTo>
                  <a:pt x="273" y="176"/>
                  <a:pt x="273" y="176"/>
                  <a:pt x="273" y="176"/>
                </a:cubicBezTo>
                <a:cubicBezTo>
                  <a:pt x="274" y="175"/>
                  <a:pt x="274" y="175"/>
                  <a:pt x="274" y="175"/>
                </a:cubicBezTo>
                <a:cubicBezTo>
                  <a:pt x="279" y="171"/>
                  <a:pt x="286" y="168"/>
                  <a:pt x="294" y="168"/>
                </a:cubicBezTo>
                <a:cubicBezTo>
                  <a:pt x="305" y="168"/>
                  <a:pt x="309" y="173"/>
                  <a:pt x="309" y="183"/>
                </a:cubicBezTo>
                <a:cubicBezTo>
                  <a:pt x="309" y="203"/>
                  <a:pt x="309" y="203"/>
                  <a:pt x="309" y="203"/>
                </a:cubicBezTo>
                <a:cubicBezTo>
                  <a:pt x="309" y="209"/>
                  <a:pt x="310" y="212"/>
                  <a:pt x="310" y="214"/>
                </a:cubicBezTo>
                <a:close/>
                <a:moveTo>
                  <a:pt x="296" y="193"/>
                </a:moveTo>
                <a:cubicBezTo>
                  <a:pt x="286" y="195"/>
                  <a:pt x="285" y="198"/>
                  <a:pt x="285" y="201"/>
                </a:cubicBezTo>
                <a:cubicBezTo>
                  <a:pt x="285" y="203"/>
                  <a:pt x="286" y="205"/>
                  <a:pt x="289" y="205"/>
                </a:cubicBezTo>
                <a:cubicBezTo>
                  <a:pt x="291" y="205"/>
                  <a:pt x="294" y="204"/>
                  <a:pt x="296" y="201"/>
                </a:cubicBezTo>
                <a:lnTo>
                  <a:pt x="296" y="193"/>
                </a:lnTo>
                <a:close/>
                <a:moveTo>
                  <a:pt x="318" y="159"/>
                </a:moveTo>
                <a:cubicBezTo>
                  <a:pt x="332" y="157"/>
                  <a:pt x="332" y="157"/>
                  <a:pt x="332" y="157"/>
                </a:cubicBezTo>
                <a:cubicBezTo>
                  <a:pt x="332" y="215"/>
                  <a:pt x="332" y="215"/>
                  <a:pt x="332" y="215"/>
                </a:cubicBezTo>
                <a:cubicBezTo>
                  <a:pt x="318" y="215"/>
                  <a:pt x="318" y="215"/>
                  <a:pt x="318" y="215"/>
                </a:cubicBezTo>
                <a:lnTo>
                  <a:pt x="318" y="159"/>
                </a:lnTo>
                <a:close/>
                <a:moveTo>
                  <a:pt x="208" y="153"/>
                </a:moveTo>
                <a:cubicBezTo>
                  <a:pt x="222" y="153"/>
                  <a:pt x="222" y="153"/>
                  <a:pt x="222" y="153"/>
                </a:cubicBezTo>
                <a:cubicBezTo>
                  <a:pt x="222" y="215"/>
                  <a:pt x="222" y="215"/>
                  <a:pt x="222" y="215"/>
                </a:cubicBezTo>
                <a:cubicBezTo>
                  <a:pt x="208" y="215"/>
                  <a:pt x="208" y="215"/>
                  <a:pt x="208" y="215"/>
                </a:cubicBezTo>
                <a:cubicBezTo>
                  <a:pt x="208" y="188"/>
                  <a:pt x="208" y="188"/>
                  <a:pt x="208" y="188"/>
                </a:cubicBezTo>
                <a:cubicBezTo>
                  <a:pt x="188" y="188"/>
                  <a:pt x="188" y="188"/>
                  <a:pt x="188" y="188"/>
                </a:cubicBezTo>
                <a:cubicBezTo>
                  <a:pt x="188" y="215"/>
                  <a:pt x="188" y="215"/>
                  <a:pt x="188" y="215"/>
                </a:cubicBezTo>
                <a:cubicBezTo>
                  <a:pt x="174" y="215"/>
                  <a:pt x="174" y="215"/>
                  <a:pt x="174" y="215"/>
                </a:cubicBezTo>
                <a:cubicBezTo>
                  <a:pt x="174" y="153"/>
                  <a:pt x="174" y="153"/>
                  <a:pt x="174" y="153"/>
                </a:cubicBezTo>
                <a:cubicBezTo>
                  <a:pt x="188" y="153"/>
                  <a:pt x="188" y="153"/>
                  <a:pt x="188" y="153"/>
                </a:cubicBezTo>
                <a:cubicBezTo>
                  <a:pt x="188" y="176"/>
                  <a:pt x="188" y="176"/>
                  <a:pt x="188" y="176"/>
                </a:cubicBezTo>
                <a:cubicBezTo>
                  <a:pt x="208" y="176"/>
                  <a:pt x="208" y="176"/>
                  <a:pt x="208" y="176"/>
                </a:cubicBezTo>
                <a:lnTo>
                  <a:pt x="208" y="153"/>
                </a:lnTo>
                <a:close/>
                <a:moveTo>
                  <a:pt x="342" y="130"/>
                </a:moveTo>
                <a:cubicBezTo>
                  <a:pt x="340" y="129"/>
                  <a:pt x="339" y="127"/>
                  <a:pt x="339" y="124"/>
                </a:cubicBezTo>
                <a:cubicBezTo>
                  <a:pt x="339" y="122"/>
                  <a:pt x="341" y="118"/>
                  <a:pt x="345" y="116"/>
                </a:cubicBezTo>
                <a:cubicBezTo>
                  <a:pt x="341" y="113"/>
                  <a:pt x="339" y="108"/>
                  <a:pt x="339" y="103"/>
                </a:cubicBezTo>
                <a:cubicBezTo>
                  <a:pt x="339" y="93"/>
                  <a:pt x="346" y="86"/>
                  <a:pt x="357" y="86"/>
                </a:cubicBezTo>
                <a:cubicBezTo>
                  <a:pt x="362" y="86"/>
                  <a:pt x="367" y="88"/>
                  <a:pt x="370" y="90"/>
                </a:cubicBezTo>
                <a:cubicBezTo>
                  <a:pt x="372" y="88"/>
                  <a:pt x="376" y="86"/>
                  <a:pt x="379" y="86"/>
                </a:cubicBezTo>
                <a:cubicBezTo>
                  <a:pt x="380" y="86"/>
                  <a:pt x="380" y="86"/>
                  <a:pt x="380" y="86"/>
                </a:cubicBezTo>
                <a:cubicBezTo>
                  <a:pt x="380" y="98"/>
                  <a:pt x="380" y="98"/>
                  <a:pt x="380" y="98"/>
                </a:cubicBezTo>
                <a:cubicBezTo>
                  <a:pt x="379" y="98"/>
                  <a:pt x="379" y="98"/>
                  <a:pt x="379" y="98"/>
                </a:cubicBezTo>
                <a:cubicBezTo>
                  <a:pt x="378" y="98"/>
                  <a:pt x="376" y="98"/>
                  <a:pt x="374" y="98"/>
                </a:cubicBezTo>
                <a:cubicBezTo>
                  <a:pt x="375" y="100"/>
                  <a:pt x="375" y="101"/>
                  <a:pt x="375" y="103"/>
                </a:cubicBezTo>
                <a:cubicBezTo>
                  <a:pt x="375" y="113"/>
                  <a:pt x="368" y="120"/>
                  <a:pt x="357" y="120"/>
                </a:cubicBezTo>
                <a:cubicBezTo>
                  <a:pt x="355" y="120"/>
                  <a:pt x="353" y="119"/>
                  <a:pt x="351" y="119"/>
                </a:cubicBezTo>
                <a:cubicBezTo>
                  <a:pt x="351" y="120"/>
                  <a:pt x="351" y="120"/>
                  <a:pt x="351" y="120"/>
                </a:cubicBezTo>
                <a:cubicBezTo>
                  <a:pt x="351" y="121"/>
                  <a:pt x="351" y="122"/>
                  <a:pt x="354" y="122"/>
                </a:cubicBezTo>
                <a:cubicBezTo>
                  <a:pt x="360" y="123"/>
                  <a:pt x="360" y="123"/>
                  <a:pt x="360" y="123"/>
                </a:cubicBezTo>
                <a:cubicBezTo>
                  <a:pt x="374" y="124"/>
                  <a:pt x="379" y="127"/>
                  <a:pt x="379" y="135"/>
                </a:cubicBezTo>
                <a:cubicBezTo>
                  <a:pt x="379" y="144"/>
                  <a:pt x="370" y="149"/>
                  <a:pt x="356" y="149"/>
                </a:cubicBezTo>
                <a:cubicBezTo>
                  <a:pt x="342" y="149"/>
                  <a:pt x="336" y="146"/>
                  <a:pt x="336" y="139"/>
                </a:cubicBezTo>
                <a:cubicBezTo>
                  <a:pt x="336" y="135"/>
                  <a:pt x="338" y="132"/>
                  <a:pt x="342" y="130"/>
                </a:cubicBezTo>
                <a:close/>
                <a:moveTo>
                  <a:pt x="352" y="103"/>
                </a:moveTo>
                <a:cubicBezTo>
                  <a:pt x="352" y="106"/>
                  <a:pt x="352" y="111"/>
                  <a:pt x="357" y="111"/>
                </a:cubicBezTo>
                <a:cubicBezTo>
                  <a:pt x="360" y="111"/>
                  <a:pt x="362" y="108"/>
                  <a:pt x="362" y="103"/>
                </a:cubicBezTo>
                <a:cubicBezTo>
                  <a:pt x="362" y="100"/>
                  <a:pt x="361" y="96"/>
                  <a:pt x="357" y="96"/>
                </a:cubicBezTo>
                <a:cubicBezTo>
                  <a:pt x="352" y="96"/>
                  <a:pt x="352" y="101"/>
                  <a:pt x="352" y="103"/>
                </a:cubicBezTo>
                <a:close/>
                <a:moveTo>
                  <a:pt x="348" y="137"/>
                </a:moveTo>
                <a:cubicBezTo>
                  <a:pt x="348" y="140"/>
                  <a:pt x="350" y="142"/>
                  <a:pt x="357" y="142"/>
                </a:cubicBezTo>
                <a:cubicBezTo>
                  <a:pt x="363" y="142"/>
                  <a:pt x="366" y="140"/>
                  <a:pt x="366" y="137"/>
                </a:cubicBezTo>
                <a:cubicBezTo>
                  <a:pt x="366" y="135"/>
                  <a:pt x="366" y="134"/>
                  <a:pt x="358" y="134"/>
                </a:cubicBezTo>
                <a:cubicBezTo>
                  <a:pt x="351" y="133"/>
                  <a:pt x="351" y="133"/>
                  <a:pt x="351" y="133"/>
                </a:cubicBezTo>
                <a:cubicBezTo>
                  <a:pt x="351" y="133"/>
                  <a:pt x="350" y="133"/>
                  <a:pt x="350" y="133"/>
                </a:cubicBezTo>
                <a:cubicBezTo>
                  <a:pt x="349" y="134"/>
                  <a:pt x="348" y="136"/>
                  <a:pt x="348" y="137"/>
                </a:cubicBezTo>
                <a:close/>
              </a:path>
            </a:pathLst>
          </a:custGeom>
          <a:solidFill>
            <a:schemeClr val="tx2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351"/>
          </a:p>
        </p:txBody>
      </p:sp>
    </p:spTree>
    <p:extLst>
      <p:ext uri="{BB962C8B-B14F-4D97-AF65-F5344CB8AC3E}">
        <p14:creationId xmlns:p14="http://schemas.microsoft.com/office/powerpoint/2010/main" val="16121168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7" r:id="rId1"/>
    <p:sldLayoutId id="2147483708" r:id="rId2"/>
    <p:sldLayoutId id="2147483709" r:id="rId3"/>
    <p:sldLayoutId id="2147483710" r:id="rId4"/>
    <p:sldLayoutId id="2147483711" r:id="rId5"/>
    <p:sldLayoutId id="2147483712" r:id="rId6"/>
    <p:sldLayoutId id="2147483713" r:id="rId7"/>
    <p:sldLayoutId id="2147483714" r:id="rId8"/>
    <p:sldLayoutId id="2147483715" r:id="rId9"/>
    <p:sldLayoutId id="2147483716" r:id="rId10"/>
    <p:sldLayoutId id="2147483717" r:id="rId11"/>
    <p:sldLayoutId id="2147483718" r:id="rId12"/>
    <p:sldLayoutId id="2147483719" r:id="rId13"/>
    <p:sldLayoutId id="2147483720" r:id="rId14"/>
    <p:sldLayoutId id="2147483721" r:id="rId15"/>
    <p:sldLayoutId id="2147483722" r:id="rId16"/>
    <p:sldLayoutId id="2147483723" r:id="rId17"/>
    <p:sldLayoutId id="2147483651" r:id="rId18"/>
    <p:sldLayoutId id="2147483652" r:id="rId19"/>
    <p:sldLayoutId id="2147483653" r:id="rId20"/>
    <p:sldLayoutId id="2147483686" r:id="rId21"/>
    <p:sldLayoutId id="2147483687" r:id="rId22"/>
  </p:sldLayoutIdLst>
  <p:hf hdr="0" dt="0"/>
  <p:txStyles>
    <p:titleStyle>
      <a:lvl1pPr algn="l" defTabSz="457200" rtl="0" eaLnBrk="1" latinLnBrk="0" hangingPunct="1">
        <a:lnSpc>
          <a:spcPct val="90000"/>
        </a:lnSpc>
        <a:spcBef>
          <a:spcPct val="0"/>
        </a:spcBef>
        <a:buNone/>
        <a:defRPr sz="3000" b="1" i="0" kern="1200" cap="all" baseline="0">
          <a:solidFill>
            <a:schemeClr val="bg1"/>
          </a:solidFill>
          <a:latin typeface="+mj-lt"/>
          <a:ea typeface="+mj-ea"/>
          <a:cs typeface="+mj-cs"/>
        </a:defRPr>
      </a:lvl1pPr>
    </p:titleStyle>
    <p:bodyStyle>
      <a:lvl1pPr marL="0" indent="0" algn="l" defTabSz="457200" rtl="0" eaLnBrk="1" latinLnBrk="0" hangingPunct="1">
        <a:lnSpc>
          <a:spcPct val="125000"/>
        </a:lnSpc>
        <a:spcBef>
          <a:spcPts val="1200"/>
        </a:spcBef>
        <a:buFontTx/>
        <a:buNone/>
        <a:defRPr sz="1400" kern="1200" baseline="0">
          <a:solidFill>
            <a:srgbClr val="FFFFFF"/>
          </a:solidFill>
          <a:latin typeface="+mn-lt"/>
          <a:ea typeface="+mn-ea"/>
          <a:cs typeface="+mn-cs"/>
        </a:defRPr>
      </a:lvl1pPr>
      <a:lvl2pPr marL="502920" indent="-228600" algn="l" defTabSz="457200" rtl="0" eaLnBrk="1" latinLnBrk="0" hangingPunct="1">
        <a:lnSpc>
          <a:spcPct val="125000"/>
        </a:lnSpc>
        <a:spcBef>
          <a:spcPts val="1200"/>
        </a:spcBef>
        <a:buSzPct val="100000"/>
        <a:buFont typeface="Arial"/>
        <a:buChar char="•"/>
        <a:defRPr sz="1400" kern="1200" baseline="0">
          <a:solidFill>
            <a:srgbClr val="FFFFFF"/>
          </a:solidFill>
          <a:latin typeface="+mn-lt"/>
          <a:ea typeface="+mn-ea"/>
          <a:cs typeface="+mn-cs"/>
        </a:defRPr>
      </a:lvl2pPr>
      <a:lvl3pPr marL="777240" indent="-228600" algn="l" defTabSz="457200" rtl="0" eaLnBrk="1" latinLnBrk="0" hangingPunct="1">
        <a:lnSpc>
          <a:spcPct val="125000"/>
        </a:lnSpc>
        <a:spcBef>
          <a:spcPts val="1200"/>
        </a:spcBef>
        <a:buFont typeface="Lucida Grande"/>
        <a:buChar char="·"/>
        <a:defRPr sz="1400" kern="1200" baseline="0">
          <a:solidFill>
            <a:srgbClr val="FFFFFF"/>
          </a:solidFill>
          <a:latin typeface="+mn-lt"/>
          <a:ea typeface="+mn-ea"/>
          <a:cs typeface="+mn-cs"/>
        </a:defRPr>
      </a:lvl3pPr>
      <a:lvl4pPr marL="1143000" indent="-228600" algn="l" defTabSz="457200" rtl="0" eaLnBrk="1" latinLnBrk="0" hangingPunct="1">
        <a:lnSpc>
          <a:spcPct val="125000"/>
        </a:lnSpc>
        <a:spcBef>
          <a:spcPts val="1200"/>
        </a:spcBef>
        <a:buFont typeface="Arial"/>
        <a:buChar char="–"/>
        <a:defRPr sz="1000" kern="1200" baseline="0">
          <a:solidFill>
            <a:srgbClr val="FFFFFF"/>
          </a:solidFill>
          <a:latin typeface="+mn-lt"/>
          <a:ea typeface="+mn-ea"/>
          <a:cs typeface="+mn-cs"/>
        </a:defRPr>
      </a:lvl4pPr>
      <a:lvl5pPr marL="1371600" indent="-228600" algn="l" defTabSz="457200" rtl="0" eaLnBrk="1" latinLnBrk="0" hangingPunct="1">
        <a:lnSpc>
          <a:spcPct val="125000"/>
        </a:lnSpc>
        <a:spcBef>
          <a:spcPts val="1200"/>
        </a:spcBef>
        <a:buFont typeface="Arial"/>
        <a:buChar char="»"/>
        <a:defRPr sz="1000" kern="1200" baseline="0">
          <a:solidFill>
            <a:srgbClr val="FFFFFF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orient="horz" pos="1104" userDrawn="1">
          <p15:clr>
            <a:srgbClr val="F26B43"/>
          </p15:clr>
        </p15:guide>
        <p15:guide id="2" pos="5472" userDrawn="1">
          <p15:clr>
            <a:srgbClr val="F26B43"/>
          </p15:clr>
        </p15:guide>
        <p15:guide id="3" orient="horz" pos="480" userDrawn="1">
          <p15:clr>
            <a:srgbClr val="F26B43"/>
          </p15:clr>
        </p15:guide>
        <p15:guide id="4" pos="288" userDrawn="1">
          <p15:clr>
            <a:srgbClr val="F26B43"/>
          </p15:clr>
        </p15:guide>
        <p15:guide id="5" orient="horz" pos="3816" userDrawn="1">
          <p15:clr>
            <a:srgbClr val="F26B43"/>
          </p15:clr>
        </p15:guide>
        <p15:guide id="6" orient="horz" pos="2160" userDrawn="1">
          <p15:clr>
            <a:srgbClr val="F26B43"/>
          </p15:clr>
        </p15:guide>
        <p15:guide id="7" orient="horz" pos="984" userDrawn="1">
          <p15:clr>
            <a:srgbClr val="F26B43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15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15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15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15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5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5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6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5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5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5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5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0007C8-113F-4643-835C-074C8DF879DF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>
                <a:ea typeface="+mj-lt"/>
                <a:cs typeface="+mj-lt"/>
              </a:rPr>
              <a:t>Emergency Department Observation Unit Management of Alcohol Withdrawal</a:t>
            </a:r>
            <a:endParaRPr lang="en-US" dirty="0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32D06D2-CCA4-4762-91F8-44FD44AC4CDC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/>
        <p:txBody>
          <a:bodyPr vert="horz" lIns="0" tIns="0" rIns="0" bIns="0" rtlCol="0" anchor="t">
            <a:normAutofit/>
          </a:bodyPr>
          <a:lstStyle/>
          <a:p>
            <a:r>
              <a:rPr lang="en-US" dirty="0">
                <a:cs typeface="Arial"/>
              </a:rPr>
              <a:t>Division of Observation Medicine</a:t>
            </a:r>
            <a:endParaRPr lang="en-US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BD2068B4-4A03-A04B-80B4-E2EF9301681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93027" y="5753608"/>
            <a:ext cx="1422400" cy="482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3355964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Footer Placeholder 5"/>
          <p:cNvSpPr>
            <a:spLocks noGrp="1"/>
          </p:cNvSpPr>
          <p:nvPr>
            <p:ph type="ftr" sz="quarter" idx="3"/>
          </p:nvPr>
        </p:nvSpPr>
        <p:spPr/>
        <p:txBody>
          <a:bodyPr/>
          <a:lstStyle/>
          <a:p>
            <a:r>
              <a:rPr lang="en-US" dirty="0"/>
              <a:t>NYU Perelman Department of Emergency Medicine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7FEEEA1A-CB49-3744-AA40-B896987410F9}" type="slidenum">
              <a:rPr lang="en-US" smtClean="0"/>
              <a:pPr/>
              <a:t>10</a:t>
            </a:fld>
            <a:endParaRPr lang="en-US" dirty="0"/>
          </a:p>
        </p:txBody>
      </p:sp>
      <p:sp>
        <p:nvSpPr>
          <p:cNvPr id="14" name="Content Placeholder 13"/>
          <p:cNvSpPr>
            <a:spLocks noGrp="1"/>
          </p:cNvSpPr>
          <p:nvPr>
            <p:ph sz="quarter" idx="10"/>
          </p:nvPr>
        </p:nvSpPr>
        <p:spPr>
          <a:xfrm>
            <a:off x="457199" y="1237516"/>
            <a:ext cx="8229599" cy="5138346"/>
          </a:xfrm>
        </p:spPr>
        <p:txBody>
          <a:bodyPr vert="horz" lIns="0" tIns="0" rIns="0" bIns="0" rtlCol="0" anchor="t">
            <a:normAutofit fontScale="77500" lnSpcReduction="20000"/>
          </a:bodyPr>
          <a:lstStyle/>
          <a:p>
            <a:r>
              <a:rPr lang="en-US" dirty="0"/>
              <a:t>Preferred agent – Chlordiazepoxide (Librium): Initial dose: 25-100 mg</a:t>
            </a:r>
            <a:endParaRPr lang="en-US" sz="1800" dirty="0"/>
          </a:p>
          <a:p>
            <a:pPr lvl="2"/>
            <a:r>
              <a:rPr lang="en-US" dirty="0"/>
              <a:t>Repeat CIWA </a:t>
            </a:r>
            <a:r>
              <a:rPr lang="en-US" b="1" dirty="0"/>
              <a:t>60 mins</a:t>
            </a:r>
            <a:r>
              <a:rPr lang="en-US" dirty="0"/>
              <a:t> after PO Librium, give additional dose if CIWA still &gt;8</a:t>
            </a:r>
            <a:endParaRPr lang="en-US" sz="1400" dirty="0"/>
          </a:p>
          <a:p>
            <a:pPr lvl="2"/>
            <a:r>
              <a:rPr lang="en-US" dirty="0"/>
              <a:t>If 300mg within 3 hours has been reached, consult medical toxicology and consider escalation to higher level of care</a:t>
            </a:r>
            <a:endParaRPr lang="en-US" sz="1400" dirty="0"/>
          </a:p>
          <a:p>
            <a:r>
              <a:rPr lang="en-US" dirty="0"/>
              <a:t>Alternative agent – Diazepam (Valium): Initial dose: 10 mg IV</a:t>
            </a:r>
            <a:endParaRPr lang="en-US" sz="1800" dirty="0"/>
          </a:p>
          <a:p>
            <a:pPr lvl="2"/>
            <a:r>
              <a:rPr lang="en-US" dirty="0"/>
              <a:t>Use diazepam IV if patient is NPO, cannot tolerate PO, or CIWA &gt;15</a:t>
            </a:r>
            <a:endParaRPr lang="en-US" sz="1400" dirty="0"/>
          </a:p>
          <a:p>
            <a:pPr lvl="2"/>
            <a:r>
              <a:rPr lang="en-US" dirty="0"/>
              <a:t>Repeat CIWA </a:t>
            </a:r>
            <a:r>
              <a:rPr lang="en-US" b="1" dirty="0"/>
              <a:t>30 mins</a:t>
            </a:r>
            <a:r>
              <a:rPr lang="en-US" dirty="0"/>
              <a:t> after IV valium</a:t>
            </a:r>
            <a:endParaRPr lang="en-US" sz="1400" dirty="0"/>
          </a:p>
          <a:p>
            <a:pPr lvl="3"/>
            <a:r>
              <a:rPr lang="en-US" sz="1400" dirty="0"/>
              <a:t>Give additional dose if CIWA still &gt;15</a:t>
            </a:r>
          </a:p>
          <a:p>
            <a:pPr lvl="3"/>
            <a:r>
              <a:rPr lang="en-US" sz="1400" dirty="0"/>
              <a:t>If CIWA is &gt;8 but &lt;15, can transition to oral Librium</a:t>
            </a:r>
          </a:p>
          <a:p>
            <a:pPr lvl="2"/>
            <a:r>
              <a:rPr lang="en-US" dirty="0"/>
              <a:t>If 30 mg within 3 hours has been reached, continue symptom-triggered therapy and consult Medical Toxicology</a:t>
            </a:r>
            <a:endParaRPr lang="en-US" sz="1400" dirty="0"/>
          </a:p>
          <a:p>
            <a:r>
              <a:rPr lang="en-US" dirty="0"/>
              <a:t>Alternative agent – lorazepam (Ativan): initial dose 0.5-2mg PO or IV (PO preferred)</a:t>
            </a:r>
            <a:endParaRPr lang="en-US" sz="1800" dirty="0"/>
          </a:p>
          <a:p>
            <a:pPr lvl="2"/>
            <a:r>
              <a:rPr lang="en-US" dirty="0"/>
              <a:t>For use in severe hepatic dysfunction only</a:t>
            </a:r>
            <a:endParaRPr lang="en-US" sz="1400" dirty="0"/>
          </a:p>
          <a:p>
            <a:pPr lvl="2"/>
            <a:r>
              <a:rPr lang="en-US" dirty="0"/>
              <a:t>Repeat CIWA </a:t>
            </a:r>
            <a:r>
              <a:rPr lang="en-US" b="1" dirty="0"/>
              <a:t>30 mins</a:t>
            </a:r>
            <a:r>
              <a:rPr lang="en-US" dirty="0"/>
              <a:t> after IV lorazepam</a:t>
            </a:r>
            <a:endParaRPr lang="en-US" sz="1400" dirty="0"/>
          </a:p>
          <a:p>
            <a:pPr lvl="2"/>
            <a:r>
              <a:rPr lang="en-US" dirty="0"/>
              <a:t>See below for lorazepam escalation guidelines</a:t>
            </a:r>
            <a:endParaRPr lang="en-US" sz="1400" dirty="0"/>
          </a:p>
          <a:p>
            <a:r>
              <a:rPr lang="en-US" b="1" dirty="0"/>
              <a:t>Avoid</a:t>
            </a:r>
            <a:r>
              <a:rPr lang="en-US" dirty="0"/>
              <a:t> fixed-dose benzodiazepine therapy</a:t>
            </a:r>
          </a:p>
          <a:p>
            <a:r>
              <a:rPr lang="en-US" dirty="0"/>
              <a:t>Once CIWA-</a:t>
            </a:r>
            <a:r>
              <a:rPr lang="en-US" dirty="0" err="1"/>
              <a:t>Ar</a:t>
            </a:r>
            <a:r>
              <a:rPr lang="en-US" dirty="0"/>
              <a:t> &lt;8, repeat every 6 hours</a:t>
            </a:r>
            <a:endParaRPr lang="en-US" dirty="0">
              <a:cs typeface="Arial"/>
            </a:endParaRPr>
          </a:p>
        </p:txBody>
      </p:sp>
      <p:sp>
        <p:nvSpPr>
          <p:cNvPr id="9" name="Title 8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Management of Mild AWS in the ED Observation Unit</a:t>
            </a:r>
          </a:p>
        </p:txBody>
      </p:sp>
    </p:spTree>
    <p:extLst>
      <p:ext uri="{BB962C8B-B14F-4D97-AF65-F5344CB8AC3E}">
        <p14:creationId xmlns:p14="http://schemas.microsoft.com/office/powerpoint/2010/main" val="160425645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Footer Placeholder 5"/>
          <p:cNvSpPr>
            <a:spLocks noGrp="1"/>
          </p:cNvSpPr>
          <p:nvPr>
            <p:ph type="ftr" sz="quarter" idx="3"/>
          </p:nvPr>
        </p:nvSpPr>
        <p:spPr/>
        <p:txBody>
          <a:bodyPr/>
          <a:lstStyle/>
          <a:p>
            <a:r>
              <a:rPr lang="en-US" dirty="0"/>
              <a:t>NYU Perelman Department of Emergency Medicine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7FEEEA1A-CB49-3744-AA40-B896987410F9}" type="slidenum">
              <a:rPr lang="en-US" smtClean="0"/>
              <a:pPr/>
              <a:t>11</a:t>
            </a:fld>
            <a:endParaRPr lang="en-US" dirty="0"/>
          </a:p>
        </p:txBody>
      </p:sp>
      <p:sp>
        <p:nvSpPr>
          <p:cNvPr id="14" name="Content Placeholder 13"/>
          <p:cNvSpPr>
            <a:spLocks noGrp="1"/>
          </p:cNvSpPr>
          <p:nvPr>
            <p:ph sz="quarter" idx="10"/>
          </p:nvPr>
        </p:nvSpPr>
        <p:spPr/>
        <p:txBody>
          <a:bodyPr vert="horz" lIns="0" tIns="0" rIns="0" bIns="0" rtlCol="0" anchor="t">
            <a:normAutofit fontScale="85000" lnSpcReduction="20000"/>
          </a:bodyPr>
          <a:lstStyle/>
          <a:p>
            <a:r>
              <a:rPr lang="en-US" dirty="0"/>
              <a:t>Admit to inpatient if:</a:t>
            </a:r>
          </a:p>
          <a:p>
            <a:pPr lvl="1"/>
            <a:r>
              <a:rPr lang="en-US" dirty="0"/>
              <a:t>Unstable vital signs</a:t>
            </a:r>
            <a:endParaRPr lang="en-US" dirty="0">
              <a:cs typeface="Arial"/>
            </a:endParaRPr>
          </a:p>
          <a:p>
            <a:pPr lvl="1"/>
            <a:r>
              <a:rPr lang="en-US" dirty="0"/>
              <a:t>Seizure</a:t>
            </a:r>
            <a:endParaRPr lang="en-US" dirty="0">
              <a:cs typeface="Arial"/>
            </a:endParaRPr>
          </a:p>
          <a:p>
            <a:pPr lvl="1"/>
            <a:r>
              <a:rPr lang="en-US" dirty="0"/>
              <a:t>Delirium</a:t>
            </a:r>
            <a:endParaRPr lang="en-US" dirty="0">
              <a:cs typeface="Arial"/>
            </a:endParaRPr>
          </a:p>
          <a:p>
            <a:pPr lvl="1"/>
            <a:r>
              <a:rPr lang="en-US" dirty="0">
                <a:cs typeface="Arial"/>
              </a:rPr>
              <a:t>Worsening mental status</a:t>
            </a:r>
            <a:endParaRPr lang="en-US" dirty="0"/>
          </a:p>
          <a:p>
            <a:pPr lvl="1"/>
            <a:r>
              <a:rPr lang="en-US" dirty="0"/>
              <a:t>Worsening medical co-morbidities</a:t>
            </a:r>
            <a:endParaRPr lang="en-US" dirty="0">
              <a:cs typeface="Arial"/>
            </a:endParaRPr>
          </a:p>
          <a:p>
            <a:pPr lvl="1"/>
            <a:r>
              <a:rPr lang="en-US" dirty="0"/>
              <a:t>Need for more frequent assessment than q4 hours</a:t>
            </a:r>
          </a:p>
          <a:p>
            <a:pPr lvl="1"/>
            <a:r>
              <a:rPr lang="en-US" dirty="0"/>
              <a:t>Need for IV therapy for symptom control if CIWA-</a:t>
            </a:r>
            <a:r>
              <a:rPr lang="en-US" dirty="0" err="1"/>
              <a:t>Ar</a:t>
            </a:r>
            <a:r>
              <a:rPr lang="en-US" dirty="0"/>
              <a:t> remains above 15 after treatment</a:t>
            </a:r>
          </a:p>
          <a:p>
            <a:pPr lvl="1"/>
            <a:r>
              <a:rPr lang="en-US" dirty="0"/>
              <a:t>Symptoms remain present for greater than 24-48 hours</a:t>
            </a:r>
          </a:p>
          <a:p>
            <a:pPr lvl="1"/>
            <a:r>
              <a:rPr lang="en-US" dirty="0">
                <a:ea typeface="+mn-lt"/>
                <a:cs typeface="+mn-lt"/>
              </a:rPr>
              <a:t>Meet criteria for resistant alcohol withdrawal (admit to ICU)</a:t>
            </a:r>
          </a:p>
          <a:p>
            <a:pPr lvl="2"/>
            <a:r>
              <a:rPr lang="en-US" dirty="0">
                <a:ea typeface="+mn-lt"/>
                <a:cs typeface="+mn-lt"/>
              </a:rPr>
              <a:t>Persistent CIWA &gt;25</a:t>
            </a:r>
          </a:p>
          <a:p>
            <a:pPr lvl="2"/>
            <a:r>
              <a:rPr lang="en-US" dirty="0">
                <a:ea typeface="+mn-lt"/>
                <a:cs typeface="+mn-lt"/>
              </a:rPr>
              <a:t>Use of &gt;200mg of diazepam or 30mg of lorazepam in first 3 hours</a:t>
            </a:r>
          </a:p>
          <a:p>
            <a:pPr lvl="2"/>
            <a:r>
              <a:rPr lang="en-US" dirty="0">
                <a:ea typeface="+mn-lt"/>
                <a:cs typeface="+mn-lt"/>
              </a:rPr>
              <a:t>Use of &gt;400mg of diazepam or 60mg of lorazepam in first 8 hours</a:t>
            </a:r>
            <a:endParaRPr lang="en-US" dirty="0"/>
          </a:p>
        </p:txBody>
      </p:sp>
      <p:sp>
        <p:nvSpPr>
          <p:cNvPr id="9" name="Title 8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nsideration of Escalation in Level of Care</a:t>
            </a:r>
          </a:p>
        </p:txBody>
      </p:sp>
    </p:spTree>
    <p:extLst>
      <p:ext uri="{BB962C8B-B14F-4D97-AF65-F5344CB8AC3E}">
        <p14:creationId xmlns:p14="http://schemas.microsoft.com/office/powerpoint/2010/main" val="77206754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1"/>
          <p:cNvSpPr>
            <a:spLocks noGrp="1"/>
          </p:cNvSpPr>
          <p:nvPr>
            <p:ph type="ftr" sz="quarter" idx="3"/>
          </p:nvPr>
        </p:nvSpPr>
        <p:spPr/>
        <p:txBody>
          <a:bodyPr/>
          <a:lstStyle/>
          <a:p>
            <a:r>
              <a:rPr lang="en-US" dirty="0"/>
              <a:t>NYU Perelman Department of Emergency Medicine</a:t>
            </a:r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7FEEEA1A-CB49-3744-AA40-B896987410F9}" type="slidenum">
              <a:rPr lang="en-US" smtClean="0"/>
              <a:pPr/>
              <a:t>12</a:t>
            </a:fld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quarter" idx="10"/>
          </p:nvPr>
        </p:nvSpPr>
        <p:spPr/>
        <p:txBody>
          <a:bodyPr vert="horz" lIns="0" tIns="0" rIns="0" bIns="0" rtlCol="0" anchor="t">
            <a:normAutofit/>
          </a:bodyPr>
          <a:lstStyle/>
          <a:p>
            <a:r>
              <a:rPr lang="en-US" dirty="0"/>
              <a:t>Cases of mixed withdrawal such as alcohol withdrawal with additional benzodiazepine, opioid, or antihypertensive withdrawal</a:t>
            </a:r>
          </a:p>
          <a:p>
            <a:r>
              <a:rPr lang="en-US" dirty="0"/>
              <a:t>Unplanned escalation of care to ICU/Step Down unit setting</a:t>
            </a:r>
          </a:p>
          <a:p>
            <a:r>
              <a:rPr lang="en-US" dirty="0"/>
              <a:t>Patient requiring:</a:t>
            </a:r>
          </a:p>
          <a:p>
            <a:pPr lvl="1"/>
            <a:r>
              <a:rPr lang="en-US" dirty="0"/>
              <a:t>&gt;300mg of oral chlordiazepoxide within 3 hours</a:t>
            </a:r>
          </a:p>
          <a:p>
            <a:pPr lvl="1"/>
            <a:r>
              <a:rPr lang="en-US" dirty="0"/>
              <a:t>Three consecutive hourly doses of diazepam</a:t>
            </a:r>
          </a:p>
          <a:p>
            <a:pPr lvl="1"/>
            <a:r>
              <a:rPr lang="en-US" dirty="0"/>
              <a:t>Need for a second treatment agent</a:t>
            </a:r>
          </a:p>
        </p:txBody>
      </p:sp>
      <p:sp>
        <p:nvSpPr>
          <p:cNvPr id="5" name="Title 4"/>
          <p:cNvSpPr>
            <a:spLocks noGrp="1"/>
          </p:cNvSpPr>
          <p:nvPr>
            <p:ph type="title"/>
          </p:nvPr>
        </p:nvSpPr>
        <p:spPr>
          <a:xfrm>
            <a:off x="395692" y="1038235"/>
            <a:ext cx="8229600" cy="313932"/>
          </a:xfrm>
        </p:spPr>
        <p:txBody>
          <a:bodyPr/>
          <a:lstStyle/>
          <a:p>
            <a:r>
              <a:rPr lang="en-US" dirty="0"/>
              <a:t>Indication for Toxicology Consultation</a:t>
            </a:r>
          </a:p>
        </p:txBody>
      </p:sp>
    </p:spTree>
    <p:extLst>
      <p:ext uri="{BB962C8B-B14F-4D97-AF65-F5344CB8AC3E}">
        <p14:creationId xmlns:p14="http://schemas.microsoft.com/office/powerpoint/2010/main" val="131805908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Footer Placeholder 5"/>
          <p:cNvSpPr>
            <a:spLocks noGrp="1"/>
          </p:cNvSpPr>
          <p:nvPr>
            <p:ph type="ftr" sz="quarter" idx="3"/>
          </p:nvPr>
        </p:nvSpPr>
        <p:spPr/>
        <p:txBody>
          <a:bodyPr/>
          <a:lstStyle/>
          <a:p>
            <a:r>
              <a:rPr lang="en-US" dirty="0"/>
              <a:t>NYU Perelman Department of Emergency Medicine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7FEEEA1A-CB49-3744-AA40-B896987410F9}" type="slidenum">
              <a:rPr lang="en-US" smtClean="0"/>
              <a:pPr/>
              <a:t>13</a:t>
            </a:fld>
            <a:endParaRPr lang="en-US" dirty="0"/>
          </a:p>
        </p:txBody>
      </p:sp>
      <p:sp>
        <p:nvSpPr>
          <p:cNvPr id="14" name="Content Placeholder 13"/>
          <p:cNvSpPr>
            <a:spLocks noGrp="1"/>
          </p:cNvSpPr>
          <p:nvPr>
            <p:ph sz="quarter" idx="10"/>
          </p:nvPr>
        </p:nvSpPr>
        <p:spPr/>
        <p:txBody>
          <a:bodyPr vert="horz" lIns="0" tIns="0" rIns="0" bIns="0" rtlCol="0" anchor="t">
            <a:normAutofit/>
          </a:bodyPr>
          <a:lstStyle/>
          <a:p>
            <a:r>
              <a:rPr lang="en-US" dirty="0"/>
              <a:t>Once CIWA-</a:t>
            </a:r>
            <a:r>
              <a:rPr lang="en-US" dirty="0" err="1"/>
              <a:t>Ar</a:t>
            </a:r>
            <a:r>
              <a:rPr lang="en-US" dirty="0"/>
              <a:t> &lt;8 twice, at least 8 hours apart</a:t>
            </a:r>
          </a:p>
          <a:p>
            <a:r>
              <a:rPr lang="en-US" dirty="0">
                <a:cs typeface="Arial"/>
              </a:rPr>
              <a:t>Acute, co-morbid conditions resolved</a:t>
            </a:r>
          </a:p>
          <a:p>
            <a:r>
              <a:rPr lang="en-US" dirty="0"/>
              <a:t>Social work evaluation and consultation to provide information about appropriate aftercare options</a:t>
            </a:r>
          </a:p>
          <a:p>
            <a:endParaRPr lang="en-US" dirty="0">
              <a:cs typeface="Arial"/>
            </a:endParaRPr>
          </a:p>
          <a:p>
            <a:endParaRPr lang="en-US" dirty="0">
              <a:cs typeface="Arial"/>
            </a:endParaRPr>
          </a:p>
        </p:txBody>
      </p:sp>
      <p:sp>
        <p:nvSpPr>
          <p:cNvPr id="9" name="Title 8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reatment Endpoint</a:t>
            </a:r>
          </a:p>
        </p:txBody>
      </p:sp>
    </p:spTree>
    <p:extLst>
      <p:ext uri="{BB962C8B-B14F-4D97-AF65-F5344CB8AC3E}">
        <p14:creationId xmlns:p14="http://schemas.microsoft.com/office/powerpoint/2010/main" val="47265492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Footer Placeholder 5"/>
          <p:cNvSpPr>
            <a:spLocks noGrp="1"/>
          </p:cNvSpPr>
          <p:nvPr>
            <p:ph type="ftr" sz="quarter" idx="3"/>
          </p:nvPr>
        </p:nvSpPr>
        <p:spPr/>
        <p:txBody>
          <a:bodyPr/>
          <a:lstStyle/>
          <a:p>
            <a:r>
              <a:rPr lang="en-US" dirty="0"/>
              <a:t>NYU Perelman Department of Emergency Medicine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7FEEEA1A-CB49-3744-AA40-B896987410F9}" type="slidenum">
              <a:rPr lang="en-US" smtClean="0"/>
              <a:pPr/>
              <a:t>14</a:t>
            </a:fld>
            <a:endParaRPr lang="en-US" dirty="0"/>
          </a:p>
        </p:txBody>
      </p:sp>
      <p:sp>
        <p:nvSpPr>
          <p:cNvPr id="14" name="Content Placeholder 13"/>
          <p:cNvSpPr>
            <a:spLocks noGrp="1"/>
          </p:cNvSpPr>
          <p:nvPr>
            <p:ph sz="quarter" idx="10"/>
          </p:nvPr>
        </p:nvSpPr>
        <p:spPr/>
        <p:txBody>
          <a:bodyPr vert="horz" lIns="0" tIns="0" rIns="0" bIns="0" rtlCol="0" anchor="t">
            <a:normAutofit fontScale="92500"/>
          </a:bodyPr>
          <a:lstStyle/>
          <a:p>
            <a:r>
              <a:rPr lang="en-US" sz="1000" dirty="0"/>
              <a:t>1.</a:t>
            </a:r>
            <a:r>
              <a:rPr lang="en-US" sz="1000" dirty="0">
                <a:ea typeface="+mn-lt"/>
                <a:cs typeface="+mn-lt"/>
              </a:rPr>
              <a:t>Grant BF, Goldstein RB, Saha TD, et al. Epidemiology of DSM-5 Alcohol Use Disorder: Results From the National Epidemiologic Survey on Alcohol and Related Conditions III. </a:t>
            </a:r>
            <a:r>
              <a:rPr lang="en-US" sz="1000" i="1" dirty="0">
                <a:ea typeface="+mn-lt"/>
                <a:cs typeface="+mn-lt"/>
              </a:rPr>
              <a:t>JAMA Psychiatry</a:t>
            </a:r>
            <a:r>
              <a:rPr lang="en-US" sz="1000" dirty="0">
                <a:ea typeface="+mn-lt"/>
                <a:cs typeface="+mn-lt"/>
              </a:rPr>
              <a:t>. 2015;72(8):757-766.</a:t>
            </a:r>
            <a:endParaRPr lang="en-US" sz="1000" dirty="0">
              <a:cs typeface="Arial"/>
            </a:endParaRPr>
          </a:p>
          <a:p>
            <a:r>
              <a:rPr lang="en-US" sz="1000" dirty="0">
                <a:cs typeface="Arial"/>
              </a:rPr>
              <a:t>2. </a:t>
            </a:r>
            <a:r>
              <a:rPr lang="en-US" sz="1000" dirty="0">
                <a:ea typeface="+mn-lt"/>
                <a:cs typeface="+mn-lt"/>
              </a:rPr>
              <a:t>Goodson CM, Clark BJ, Douglas IS. Predictors of severe alcohol withdrawal syndrome: a systematic review and meta-analysis. </a:t>
            </a:r>
            <a:r>
              <a:rPr lang="en-US" sz="1000" i="1" dirty="0">
                <a:ea typeface="+mn-lt"/>
                <a:cs typeface="+mn-lt"/>
              </a:rPr>
              <a:t>Alcohol Clin Exp Res</a:t>
            </a:r>
            <a:r>
              <a:rPr lang="en-US" sz="1000" dirty="0">
                <a:ea typeface="+mn-lt"/>
                <a:cs typeface="+mn-lt"/>
              </a:rPr>
              <a:t>. 2014;38(10):2664-2677.</a:t>
            </a:r>
            <a:endParaRPr lang="en-US" sz="1000" dirty="0"/>
          </a:p>
          <a:p>
            <a:r>
              <a:rPr lang="en-US" sz="1000" dirty="0"/>
              <a:t>3.</a:t>
            </a:r>
            <a:r>
              <a:rPr lang="en-US" sz="1000" dirty="0">
                <a:ea typeface="+mn-lt"/>
                <a:cs typeface="+mn-lt"/>
              </a:rPr>
              <a:t>Pecoraro A, Ewen E, Horton T, et al. Using the AUDIT-PC to predict alcohol withdrawal in hospitalized patients. </a:t>
            </a:r>
            <a:r>
              <a:rPr lang="en-US" sz="1000" i="1" dirty="0">
                <a:ea typeface="+mn-lt"/>
                <a:cs typeface="+mn-lt"/>
              </a:rPr>
              <a:t>J Gen Intern Med</a:t>
            </a:r>
            <a:r>
              <a:rPr lang="en-US" sz="1000" dirty="0">
                <a:ea typeface="+mn-lt"/>
                <a:cs typeface="+mn-lt"/>
              </a:rPr>
              <a:t>. 2014;29(1):34-40.</a:t>
            </a:r>
            <a:endParaRPr lang="en-US" sz="1000" dirty="0">
              <a:cs typeface="Arial"/>
            </a:endParaRPr>
          </a:p>
          <a:p>
            <a:r>
              <a:rPr lang="en-US" sz="1000" dirty="0">
                <a:cs typeface="Arial"/>
              </a:rPr>
              <a:t>4. </a:t>
            </a:r>
            <a:r>
              <a:rPr lang="en-US" sz="1000" dirty="0">
                <a:ea typeface="+mn-lt"/>
                <a:cs typeface="+mn-lt"/>
              </a:rPr>
              <a:t>Turner RC, Lichstein PR, Peden JG Jr, Busher JT, Waivers LE. Alcohol withdrawal syndromes: a review of pathophysiology, clinical presentation, and treatment. </a:t>
            </a:r>
            <a:r>
              <a:rPr lang="en-US" sz="1000" i="1" dirty="0">
                <a:ea typeface="+mn-lt"/>
                <a:cs typeface="+mn-lt"/>
              </a:rPr>
              <a:t>J Gen Intern Med</a:t>
            </a:r>
            <a:r>
              <a:rPr lang="en-US" sz="1000" dirty="0">
                <a:ea typeface="+mn-lt"/>
                <a:cs typeface="+mn-lt"/>
              </a:rPr>
              <a:t>. 1989;4(5):432-444.</a:t>
            </a:r>
            <a:endParaRPr lang="en-US" sz="1000" dirty="0"/>
          </a:p>
          <a:p>
            <a:r>
              <a:rPr lang="en-US" sz="1000" dirty="0">
                <a:cs typeface="Arial"/>
              </a:rPr>
              <a:t>5. </a:t>
            </a:r>
            <a:r>
              <a:rPr lang="en-US" sz="1000" dirty="0">
                <a:ea typeface="+mn-lt"/>
                <a:cs typeface="+mn-lt"/>
              </a:rPr>
              <a:t>Mayo-Smith MF. Pharmacological management of alcohol withdrawal. A meta-analysis and evidence-based practice guideline. American Society of Addiction Medicine Working Group on Pharmacological Management of Alcohol Withdrawal. </a:t>
            </a:r>
            <a:r>
              <a:rPr lang="en-US" sz="1000" i="1" dirty="0">
                <a:ea typeface="+mn-lt"/>
                <a:cs typeface="+mn-lt"/>
              </a:rPr>
              <a:t>JAMA</a:t>
            </a:r>
            <a:r>
              <a:rPr lang="en-US" sz="1000" dirty="0">
                <a:ea typeface="+mn-lt"/>
                <a:cs typeface="+mn-lt"/>
              </a:rPr>
              <a:t>. 1997;278(2):144-151.</a:t>
            </a:r>
            <a:endParaRPr lang="en-US" sz="1000" dirty="0"/>
          </a:p>
          <a:p>
            <a:r>
              <a:rPr lang="en-US" sz="1000" dirty="0">
                <a:cs typeface="Arial"/>
              </a:rPr>
              <a:t>6. </a:t>
            </a:r>
            <a:r>
              <a:rPr lang="en-US" sz="1000" dirty="0">
                <a:ea typeface="+mn-lt"/>
                <a:cs typeface="+mn-lt"/>
              </a:rPr>
              <a:t>Isbell H, Fraser H, Wilker A, Belleville R, Eisenman, AJ. An experimental study of the etiology of rum fits and delirium tremens. </a:t>
            </a:r>
            <a:r>
              <a:rPr lang="en-US" sz="1000" i="1" dirty="0">
                <a:ea typeface="+mn-lt"/>
                <a:cs typeface="+mn-lt"/>
              </a:rPr>
              <a:t>Q J Stud Alcohol</a:t>
            </a:r>
            <a:r>
              <a:rPr lang="en-US" sz="1000" dirty="0">
                <a:ea typeface="+mn-lt"/>
                <a:cs typeface="+mn-lt"/>
              </a:rPr>
              <a:t>. 1955;16(1):1-33.</a:t>
            </a:r>
            <a:endParaRPr lang="en-US" sz="1000" dirty="0"/>
          </a:p>
          <a:p>
            <a:r>
              <a:rPr lang="en-US" sz="1000" dirty="0">
                <a:cs typeface="Arial"/>
              </a:rPr>
              <a:t>7. </a:t>
            </a:r>
            <a:r>
              <a:rPr lang="en-US" sz="1000" dirty="0">
                <a:ea typeface="+mn-lt"/>
                <a:cs typeface="+mn-lt"/>
              </a:rPr>
              <a:t>Daeppen JB, Gache P, Landry U, et al. Symptom-triggered vs fixed-schedule doses of benzodiazepine for alcohol withdrawal: a randomized treatment trial. </a:t>
            </a:r>
            <a:r>
              <a:rPr lang="en-US" sz="1000" i="1" dirty="0">
                <a:ea typeface="+mn-lt"/>
                <a:cs typeface="+mn-lt"/>
              </a:rPr>
              <a:t>Arch Intern Med</a:t>
            </a:r>
            <a:r>
              <a:rPr lang="en-US" sz="1000" dirty="0">
                <a:ea typeface="+mn-lt"/>
                <a:cs typeface="+mn-lt"/>
              </a:rPr>
              <a:t>. 2002;162(10):1117-1121.</a:t>
            </a:r>
            <a:endParaRPr lang="en-US" sz="1000" dirty="0"/>
          </a:p>
          <a:p>
            <a:r>
              <a:rPr lang="en-US" sz="1000" dirty="0">
                <a:cs typeface="Arial"/>
              </a:rPr>
              <a:t>8. </a:t>
            </a:r>
            <a:r>
              <a:rPr lang="en-US" sz="1000" dirty="0">
                <a:ea typeface="+mn-lt"/>
                <a:cs typeface="+mn-lt"/>
              </a:rPr>
              <a:t>Sullivan JT, Sykora K, Schneiderman J, Naranjo CA, Sellers EM. Assessment of alcohol withdrawal: the revised clinical institute withdrawal assessment for alcohol scale (CIWA-Ar). </a:t>
            </a:r>
            <a:r>
              <a:rPr lang="en-US" sz="1000" i="1" dirty="0">
                <a:ea typeface="+mn-lt"/>
                <a:cs typeface="+mn-lt"/>
              </a:rPr>
              <a:t>Br J Addic</a:t>
            </a:r>
            <a:r>
              <a:rPr lang="en-US" sz="1000" dirty="0">
                <a:ea typeface="+mn-lt"/>
                <a:cs typeface="+mn-lt"/>
              </a:rPr>
              <a:t>t. 1989 Nov;84(11):1353-7. </a:t>
            </a:r>
          </a:p>
          <a:p>
            <a:r>
              <a:rPr lang="en-US" sz="1000" dirty="0">
                <a:cs typeface="Arial"/>
              </a:rPr>
              <a:t>9. </a:t>
            </a:r>
            <a:r>
              <a:rPr lang="en-US" sz="1000" dirty="0">
                <a:ea typeface="+mn-lt"/>
                <a:cs typeface="+mn-lt"/>
              </a:rPr>
              <a:t>Cassidy EM, O'Sullivan I, Bradshaw P, Islam T, Onovo C. Symptom-triggered benzodiazepine therapy for alcohol withdrawal syndrome in the emergency department: a comparison with the standard fixed dose benzodiazepine regimen. </a:t>
            </a:r>
            <a:r>
              <a:rPr lang="en-US" sz="1000" i="1" dirty="0">
                <a:ea typeface="+mn-lt"/>
                <a:cs typeface="+mn-lt"/>
              </a:rPr>
              <a:t>Emerg Med J</a:t>
            </a:r>
            <a:r>
              <a:rPr lang="en-US" sz="1000" dirty="0">
                <a:ea typeface="+mn-lt"/>
                <a:cs typeface="+mn-lt"/>
              </a:rPr>
              <a:t>. 2012;29(10):802-804.</a:t>
            </a:r>
            <a:endParaRPr lang="en-US" sz="1000" dirty="0">
              <a:cs typeface="Arial"/>
            </a:endParaRPr>
          </a:p>
          <a:p>
            <a:r>
              <a:rPr lang="en-US" sz="1000" dirty="0">
                <a:cs typeface="Arial"/>
              </a:rPr>
              <a:t>10. </a:t>
            </a:r>
            <a:r>
              <a:rPr lang="en-US" sz="1000" dirty="0">
                <a:ea typeface="+mn-lt"/>
                <a:cs typeface="+mn-lt"/>
              </a:rPr>
              <a:t>Kosten TR, O'Connor PG. Management of drug and alcohol withdrawal. </a:t>
            </a:r>
            <a:r>
              <a:rPr lang="en-US" sz="1000" i="1" dirty="0">
                <a:ea typeface="+mn-lt"/>
                <a:cs typeface="+mn-lt"/>
              </a:rPr>
              <a:t>N Engl J Me</a:t>
            </a:r>
            <a:r>
              <a:rPr lang="en-US" sz="1000" dirty="0">
                <a:ea typeface="+mn-lt"/>
                <a:cs typeface="+mn-lt"/>
              </a:rPr>
              <a:t>d. 2003 May 1;348(18):1786-95.</a:t>
            </a:r>
            <a:endParaRPr lang="en-US" sz="1000" dirty="0"/>
          </a:p>
          <a:p>
            <a:pPr marL="0" indent="0">
              <a:buNone/>
            </a:pPr>
            <a:endParaRPr lang="en-US" sz="1000" dirty="0"/>
          </a:p>
          <a:p>
            <a:pPr marL="0" indent="0">
              <a:buNone/>
            </a:pPr>
            <a:endParaRPr lang="en-US" sz="1000" dirty="0"/>
          </a:p>
        </p:txBody>
      </p:sp>
      <p:sp>
        <p:nvSpPr>
          <p:cNvPr id="9" name="Title 8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References</a:t>
            </a:r>
          </a:p>
        </p:txBody>
      </p:sp>
    </p:spTree>
    <p:extLst>
      <p:ext uri="{BB962C8B-B14F-4D97-AF65-F5344CB8AC3E}">
        <p14:creationId xmlns:p14="http://schemas.microsoft.com/office/powerpoint/2010/main" val="4325627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Footer Placeholder 5"/>
          <p:cNvSpPr>
            <a:spLocks noGrp="1"/>
          </p:cNvSpPr>
          <p:nvPr>
            <p:ph type="ftr" sz="quarter" idx="3"/>
          </p:nvPr>
        </p:nvSpPr>
        <p:spPr/>
        <p:txBody>
          <a:bodyPr/>
          <a:lstStyle/>
          <a:p>
            <a:r>
              <a:rPr lang="en-US" dirty="0"/>
              <a:t>NYU Perelman Department of Emergency Medicine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7FEEEA1A-CB49-3744-AA40-B896987410F9}" type="slidenum">
              <a:rPr lang="en-US" smtClean="0"/>
              <a:pPr/>
              <a:t>2</a:t>
            </a:fld>
            <a:endParaRPr lang="en-US" dirty="0"/>
          </a:p>
        </p:txBody>
      </p:sp>
      <p:sp>
        <p:nvSpPr>
          <p:cNvPr id="14" name="Content Placeholder 13"/>
          <p:cNvSpPr>
            <a:spLocks noGrp="1"/>
          </p:cNvSpPr>
          <p:nvPr>
            <p:ph sz="quarter" idx="10"/>
          </p:nvPr>
        </p:nvSpPr>
        <p:spPr/>
        <p:txBody>
          <a:bodyPr/>
          <a:lstStyle/>
          <a:p>
            <a:r>
              <a:rPr lang="en-US" dirty="0"/>
              <a:t>Prevalence of alcohol abuse and dependence in hospitalized patients is estimated at nearly 40%</a:t>
            </a:r>
          </a:p>
          <a:p>
            <a:pPr lvl="1"/>
            <a:r>
              <a:rPr lang="en-US" dirty="0"/>
              <a:t>Approximately 50% of patients with alcohol use disorder experience withdrawal when they stop or reduce drinking</a:t>
            </a:r>
          </a:p>
          <a:p>
            <a:r>
              <a:rPr lang="en-US" dirty="0"/>
              <a:t>Alcohol withdrawal usually mild but up to 20% of patients can exhibit symptoms of severe withdrawal including hallucinosis, seizures and delirium tremens</a:t>
            </a:r>
          </a:p>
          <a:p>
            <a:pPr lvl="1"/>
            <a:r>
              <a:rPr lang="en-US" dirty="0"/>
              <a:t>Development of alcohol withdrawal can lead to significant morbidity and mortality and increased length of stay for patients admitted to the hospital</a:t>
            </a:r>
          </a:p>
        </p:txBody>
      </p:sp>
      <p:sp>
        <p:nvSpPr>
          <p:cNvPr id="9" name="Title 8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pidemiology of Alcohol Withdrawal</a:t>
            </a:r>
          </a:p>
        </p:txBody>
      </p:sp>
    </p:spTree>
    <p:extLst>
      <p:ext uri="{BB962C8B-B14F-4D97-AF65-F5344CB8AC3E}">
        <p14:creationId xmlns:p14="http://schemas.microsoft.com/office/powerpoint/2010/main" val="7289429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Footer Placeholder 5"/>
          <p:cNvSpPr>
            <a:spLocks noGrp="1"/>
          </p:cNvSpPr>
          <p:nvPr>
            <p:ph type="ftr" sz="quarter" idx="3"/>
          </p:nvPr>
        </p:nvSpPr>
        <p:spPr/>
        <p:txBody>
          <a:bodyPr/>
          <a:lstStyle/>
          <a:p>
            <a:r>
              <a:rPr lang="en-US" dirty="0"/>
              <a:t>NYU Perelman Department of Emergency Medicine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7FEEEA1A-CB49-3744-AA40-B896987410F9}" type="slidenum">
              <a:rPr lang="en-US" smtClean="0"/>
              <a:pPr/>
              <a:t>3</a:t>
            </a:fld>
            <a:endParaRPr lang="en-US" dirty="0"/>
          </a:p>
        </p:txBody>
      </p:sp>
      <p:sp>
        <p:nvSpPr>
          <p:cNvPr id="14" name="Content Placeholder 13"/>
          <p:cNvSpPr>
            <a:spLocks noGrp="1"/>
          </p:cNvSpPr>
          <p:nvPr>
            <p:ph sz="quarter" idx="10"/>
          </p:nvPr>
        </p:nvSpPr>
        <p:spPr/>
        <p:txBody>
          <a:bodyPr/>
          <a:lstStyle/>
          <a:p>
            <a:r>
              <a:rPr lang="en-US" dirty="0"/>
              <a:t>Without intervention, symptoms of ETOH withdrawal usually start within 6 to 24 hours of last drink or drastic reduction in drinking</a:t>
            </a:r>
          </a:p>
          <a:p>
            <a:pPr lvl="1"/>
            <a:r>
              <a:rPr lang="en-US" dirty="0"/>
              <a:t>If symptoms are not present at 24 hours then alcohol withdrawal is unlikely to develop</a:t>
            </a:r>
          </a:p>
          <a:p>
            <a:pPr lvl="1"/>
            <a:r>
              <a:rPr lang="en-US" dirty="0"/>
              <a:t>Symptoms may emerge even before blood alcohol levels have reached zero</a:t>
            </a:r>
          </a:p>
        </p:txBody>
      </p:sp>
      <p:sp>
        <p:nvSpPr>
          <p:cNvPr id="9" name="Title 8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athophysiology of Alcohol Withdrawal</a:t>
            </a:r>
          </a:p>
        </p:txBody>
      </p:sp>
    </p:spTree>
    <p:extLst>
      <p:ext uri="{BB962C8B-B14F-4D97-AF65-F5344CB8AC3E}">
        <p14:creationId xmlns:p14="http://schemas.microsoft.com/office/powerpoint/2010/main" val="253592312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Table Placeholder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98764506"/>
              </p:ext>
            </p:extLst>
          </p:nvPr>
        </p:nvGraphicFramePr>
        <p:xfrm>
          <a:off x="457198" y="1562100"/>
          <a:ext cx="8362606" cy="256540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78753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82692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4814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endParaRPr lang="en-US" sz="1100" cap="all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cap="all" dirty="0"/>
                        <a:t>Clinical</a:t>
                      </a:r>
                      <a:r>
                        <a:rPr lang="en-US" sz="1000" cap="all" baseline="0" dirty="0"/>
                        <a:t> Manifestations</a:t>
                      </a:r>
                      <a:endParaRPr lang="en-US" sz="1000" cap="all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cap="all" dirty="0"/>
                        <a:t>Onset After</a:t>
                      </a:r>
                      <a:r>
                        <a:rPr lang="en-US" sz="1000" cap="all" baseline="0" dirty="0"/>
                        <a:t> Last Drink</a:t>
                      </a:r>
                    </a:p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cap="all" baseline="0" dirty="0"/>
                        <a:t>(Hours)</a:t>
                      </a:r>
                      <a:endParaRPr lang="en-US" sz="1000" cap="all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0839">
                <a:tc>
                  <a:txBody>
                    <a:bodyPr/>
                    <a:lstStyle/>
                    <a:p>
                      <a:r>
                        <a:rPr lang="en-US" sz="1100" cap="all" dirty="0"/>
                        <a:t>Mild</a:t>
                      </a:r>
                      <a:r>
                        <a:rPr lang="en-US" sz="1100" cap="all" baseline="0" dirty="0"/>
                        <a:t> Withdrawal</a:t>
                      </a:r>
                      <a:endParaRPr lang="en-US" sz="1100" cap="all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Nausea</a:t>
                      </a:r>
                      <a:r>
                        <a:rPr lang="en-US" sz="1000" baseline="0" dirty="0"/>
                        <a:t>, vomiting, tachycardia, hypertension, tremor, agitation, restlessness, diaphoresis, anxiety, headache, hyperactive reflexes</a:t>
                      </a:r>
                      <a:endParaRPr lang="en-US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6-36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kern="1200" cap="all" dirty="0"/>
                        <a:t>Withdrawal</a:t>
                      </a:r>
                      <a:r>
                        <a:rPr lang="en-US" sz="1100" kern="1200" cap="all" baseline="0" dirty="0"/>
                        <a:t> Seizures</a:t>
                      </a:r>
                      <a:endParaRPr lang="en-US" sz="1100" kern="1200" cap="all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Seen</a:t>
                      </a:r>
                      <a:r>
                        <a:rPr lang="en-US" sz="1000" baseline="0" dirty="0"/>
                        <a:t> in 10-30% of patients with ETOH withdrawal, usually generalized tonic clonic, rarely progresses to status epilepticus</a:t>
                      </a:r>
                      <a:endParaRPr lang="en-US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6-48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cap="all" dirty="0">
                          <a:solidFill>
                            <a:schemeClr val="bg1"/>
                          </a:solidFill>
                        </a:rPr>
                        <a:t>Alcohol Hallucinosi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>
                          <a:solidFill>
                            <a:schemeClr val="bg1"/>
                          </a:solidFill>
                        </a:rPr>
                        <a:t>Most commonly</a:t>
                      </a:r>
                      <a:r>
                        <a:rPr lang="en-US" sz="1000" baseline="0" dirty="0">
                          <a:solidFill>
                            <a:schemeClr val="bg1"/>
                          </a:solidFill>
                        </a:rPr>
                        <a:t> tactile, less commonly visual  or auditory</a:t>
                      </a:r>
                      <a:endParaRPr lang="en-US" sz="1000" dirty="0">
                        <a:solidFill>
                          <a:schemeClr val="bg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12-48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cap="all" dirty="0"/>
                        <a:t>Withdrawal</a:t>
                      </a:r>
                      <a:r>
                        <a:rPr lang="en-US" sz="1100" cap="all" baseline="0" dirty="0"/>
                        <a:t> Delirium</a:t>
                      </a:r>
                      <a:endParaRPr lang="en-US" sz="1100" cap="all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Seen</a:t>
                      </a:r>
                      <a:r>
                        <a:rPr lang="en-US" sz="1000" baseline="0" dirty="0"/>
                        <a:t> in 1-4% of hospitalized patients with ETOH withdrawal, includes s</a:t>
                      </a:r>
                      <a:r>
                        <a:rPr lang="en-US" sz="1000" dirty="0"/>
                        <a:t>ignificant</a:t>
                      </a:r>
                      <a:r>
                        <a:rPr lang="en-US" sz="1000" baseline="0" dirty="0"/>
                        <a:t> alteration in attention and cognition, associated with extreme agitation and autonomic instability including fever, tachycardia, hypertension, diaphoresis</a:t>
                      </a:r>
                      <a:endParaRPr lang="en-US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48-96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sp>
        <p:nvSpPr>
          <p:cNvPr id="4" name="Footer Placeholder 3"/>
          <p:cNvSpPr>
            <a:spLocks noGrp="1"/>
          </p:cNvSpPr>
          <p:nvPr>
            <p:ph type="ftr" sz="quarter" idx="3"/>
          </p:nvPr>
        </p:nvSpPr>
        <p:spPr/>
        <p:txBody>
          <a:bodyPr/>
          <a:lstStyle/>
          <a:p>
            <a:r>
              <a:rPr lang="en-US" dirty="0"/>
              <a:t>NYU Perelman Department of Emergency Medicine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ED7E567B-70F4-744D-B8D4-735662645214}" type="slidenum">
              <a:rPr lang="en-US" smtClean="0"/>
              <a:pPr/>
              <a:t>4</a:t>
            </a:fld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nical Presentation and Course</a:t>
            </a:r>
          </a:p>
        </p:txBody>
      </p:sp>
    </p:spTree>
    <p:extLst>
      <p:ext uri="{BB962C8B-B14F-4D97-AF65-F5344CB8AC3E}">
        <p14:creationId xmlns:p14="http://schemas.microsoft.com/office/powerpoint/2010/main" val="81082305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Footer Placeholder 5"/>
          <p:cNvSpPr>
            <a:spLocks noGrp="1"/>
          </p:cNvSpPr>
          <p:nvPr>
            <p:ph type="ftr" sz="quarter" idx="3"/>
          </p:nvPr>
        </p:nvSpPr>
        <p:spPr/>
        <p:txBody>
          <a:bodyPr/>
          <a:lstStyle/>
          <a:p>
            <a:r>
              <a:rPr lang="en-US" dirty="0"/>
              <a:t>NYU Perelman Department of Emergency Medicine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7FEEEA1A-CB49-3744-AA40-B896987410F9}" type="slidenum">
              <a:rPr lang="en-US" smtClean="0"/>
              <a:pPr/>
              <a:t>5</a:t>
            </a:fld>
            <a:endParaRPr lang="en-US" dirty="0"/>
          </a:p>
        </p:txBody>
      </p:sp>
      <p:sp>
        <p:nvSpPr>
          <p:cNvPr id="14" name="Content Placeholder 13"/>
          <p:cNvSpPr>
            <a:spLocks noGrp="1"/>
          </p:cNvSpPr>
          <p:nvPr>
            <p:ph sz="quarter" idx="10"/>
          </p:nvPr>
        </p:nvSpPr>
        <p:spPr/>
        <p:txBody>
          <a:bodyPr vert="horz" lIns="0" tIns="0" rIns="0" bIns="0" rtlCol="0" anchor="t">
            <a:norm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All patients with concern for alcohol withdrawal syndrome (AWS) should be evaluated for comorbid illness (ie, Why did the patient stop drinking?  Why couldn't the patient access alcohol?)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Determination of severity of alcohol withdrawal should be performed using the Clinical Institute Withdrawal Assessment for Alcohol (CIWA-</a:t>
            </a:r>
            <a:r>
              <a:rPr lang="en-US" dirty="0" err="1"/>
              <a:t>Ar</a:t>
            </a:r>
            <a:r>
              <a:rPr lang="en-US" dirty="0"/>
              <a:t>) as soon as signs and symptoms are identified</a:t>
            </a:r>
            <a:endParaRPr lang="en-US" dirty="0">
              <a:cs typeface="Arial"/>
            </a:endParaRPr>
          </a:p>
        </p:txBody>
      </p:sp>
      <p:sp>
        <p:nvSpPr>
          <p:cNvPr id="9" name="Title 8"/>
          <p:cNvSpPr>
            <a:spLocks noGrp="1"/>
          </p:cNvSpPr>
          <p:nvPr>
            <p:ph type="title"/>
          </p:nvPr>
        </p:nvSpPr>
        <p:spPr>
          <a:xfrm>
            <a:off x="457199" y="956226"/>
            <a:ext cx="8229600" cy="313932"/>
          </a:xfrm>
        </p:spPr>
        <p:txBody>
          <a:bodyPr/>
          <a:lstStyle/>
          <a:p>
            <a:r>
              <a:rPr lang="en-US" dirty="0"/>
              <a:t>Initial Approach and Risk Stratification</a:t>
            </a:r>
          </a:p>
        </p:txBody>
      </p:sp>
    </p:spTree>
    <p:extLst>
      <p:ext uri="{BB962C8B-B14F-4D97-AF65-F5344CB8AC3E}">
        <p14:creationId xmlns:p14="http://schemas.microsoft.com/office/powerpoint/2010/main" val="375875573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1"/>
          <p:cNvSpPr>
            <a:spLocks noGrp="1"/>
          </p:cNvSpPr>
          <p:nvPr>
            <p:ph type="ftr" sz="quarter" idx="3"/>
          </p:nvPr>
        </p:nvSpPr>
        <p:spPr/>
        <p:txBody>
          <a:bodyPr/>
          <a:lstStyle/>
          <a:p>
            <a:r>
              <a:rPr lang="en-US" dirty="0"/>
              <a:t>NYU Perelman Department of </a:t>
            </a:r>
            <a:r>
              <a:rPr lang="en-US"/>
              <a:t>Emergency Medicine</a:t>
            </a:r>
            <a:endParaRPr lang="en-US" dirty="0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7FEEEA1A-CB49-3744-AA40-B896987410F9}" type="slidenum">
              <a:rPr lang="en-US" smtClean="0"/>
              <a:pPr/>
              <a:t>6</a:t>
            </a:fld>
            <a:endParaRPr lang="en-US" dirty="0"/>
          </a:p>
        </p:txBody>
      </p:sp>
      <p:graphicFrame>
        <p:nvGraphicFramePr>
          <p:cNvPr id="6" name="Content Placeholder 5"/>
          <p:cNvGraphicFramePr>
            <a:graphicFrameLocks noGrp="1"/>
          </p:cNvGraphicFramePr>
          <p:nvPr>
            <p:ph sz="quarter" idx="10"/>
            <p:extLst>
              <p:ext uri="{D42A27DB-BD31-4B8C-83A1-F6EECF244321}">
                <p14:modId xmlns:p14="http://schemas.microsoft.com/office/powerpoint/2010/main" val="3139081629"/>
              </p:ext>
            </p:extLst>
          </p:nvPr>
        </p:nvGraphicFramePr>
        <p:xfrm>
          <a:off x="457202" y="1437612"/>
          <a:ext cx="8229600" cy="25654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47649">
                  <a:extLst>
                    <a:ext uri="{9D8B030D-6E8A-4147-A177-3AD203B41FA5}">
                      <a16:colId xmlns:a16="http://schemas.microsoft.com/office/drawing/2014/main" val="1752508164"/>
                    </a:ext>
                  </a:extLst>
                </a:gridCol>
                <a:gridCol w="1197033">
                  <a:extLst>
                    <a:ext uri="{9D8B030D-6E8A-4147-A177-3AD203B41FA5}">
                      <a16:colId xmlns:a16="http://schemas.microsoft.com/office/drawing/2014/main" val="1671557179"/>
                    </a:ext>
                  </a:extLst>
                </a:gridCol>
                <a:gridCol w="3682538">
                  <a:extLst>
                    <a:ext uri="{9D8B030D-6E8A-4147-A177-3AD203B41FA5}">
                      <a16:colId xmlns:a16="http://schemas.microsoft.com/office/drawing/2014/main" val="941245999"/>
                    </a:ext>
                  </a:extLst>
                </a:gridCol>
                <a:gridCol w="2402380">
                  <a:extLst>
                    <a:ext uri="{9D8B030D-6E8A-4147-A177-3AD203B41FA5}">
                      <a16:colId xmlns:a16="http://schemas.microsoft.com/office/drawing/2014/main" val="4138337315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Scor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Severit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Clinical</a:t>
                      </a:r>
                      <a:r>
                        <a:rPr lang="en-US" baseline="0" dirty="0"/>
                        <a:t> Findings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Vital Sign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288248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8-1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Mil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Tongue fasciculation,</a:t>
                      </a:r>
                      <a:r>
                        <a:rPr lang="en-US" baseline="0" dirty="0"/>
                        <a:t> diaphoresis, anxiety, insomnia, nausea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Heart Rate 80-100, Blood</a:t>
                      </a:r>
                      <a:r>
                        <a:rPr lang="en-US" baseline="0" dirty="0"/>
                        <a:t> pressure 120-140/90-100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48449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16-2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Moderat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Gross tremor, psychomotor agita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34289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/>
                        <a:t>HR 100-120, BP 140-160/90-10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6572667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&gt;2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Sever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Autonomic instability, seizure, hallucinations, deliriu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34289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/>
                        <a:t>HR &gt;120, BP&gt;160/90-10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10352482"/>
                  </a:ext>
                </a:extLst>
              </a:tr>
            </a:tbl>
          </a:graphicData>
        </a:graphic>
      </p:graphicFrame>
      <p:sp>
        <p:nvSpPr>
          <p:cNvPr id="5" name="Title 4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IWA-</a:t>
            </a:r>
            <a:r>
              <a:rPr lang="en-US" dirty="0" err="1"/>
              <a:t>Ar</a:t>
            </a:r>
            <a:r>
              <a:rPr lang="en-US" dirty="0"/>
              <a:t> Scoring</a:t>
            </a:r>
          </a:p>
        </p:txBody>
      </p:sp>
    </p:spTree>
    <p:extLst>
      <p:ext uri="{BB962C8B-B14F-4D97-AF65-F5344CB8AC3E}">
        <p14:creationId xmlns:p14="http://schemas.microsoft.com/office/powerpoint/2010/main" val="36440548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Footer Placeholder 5"/>
          <p:cNvSpPr>
            <a:spLocks noGrp="1"/>
          </p:cNvSpPr>
          <p:nvPr>
            <p:ph type="ftr" sz="quarter" idx="3"/>
          </p:nvPr>
        </p:nvSpPr>
        <p:spPr/>
        <p:txBody>
          <a:bodyPr/>
          <a:lstStyle/>
          <a:p>
            <a:r>
              <a:rPr lang="en-US" dirty="0"/>
              <a:t>NYU Perelman Department of Emergency Medicine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7FEEEA1A-CB49-3744-AA40-B896987410F9}" type="slidenum">
              <a:rPr lang="en-US" smtClean="0"/>
              <a:pPr/>
              <a:t>7</a:t>
            </a:fld>
            <a:endParaRPr lang="en-US" dirty="0"/>
          </a:p>
        </p:txBody>
      </p:sp>
      <p:sp>
        <p:nvSpPr>
          <p:cNvPr id="14" name="Content Placeholder 13"/>
          <p:cNvSpPr>
            <a:spLocks noGrp="1"/>
          </p:cNvSpPr>
          <p:nvPr>
            <p:ph sz="quarter" idx="10"/>
          </p:nvPr>
        </p:nvSpPr>
        <p:spPr/>
        <p:txBody>
          <a:bodyPr vert="horz" lIns="0" tIns="0" rIns="0" bIns="0" rtlCol="0" anchor="t">
            <a:normAutofit fontScale="92500"/>
          </a:bodyPr>
          <a:lstStyle/>
          <a:p>
            <a:r>
              <a:rPr lang="en-US" dirty="0"/>
              <a:t>Patients with a history of severe AWS (intubation, seizures, delirium tremens) and active medical illness at admission are at increased risk of developing more severe AWS</a:t>
            </a:r>
          </a:p>
          <a:p>
            <a:r>
              <a:rPr lang="en-US" dirty="0"/>
              <a:t>CIWA-</a:t>
            </a:r>
            <a:r>
              <a:rPr lang="en-US" dirty="0" err="1"/>
              <a:t>Ar</a:t>
            </a:r>
            <a:r>
              <a:rPr lang="en-US" dirty="0"/>
              <a:t> score should be used in combination with current blood alcohol level to inform triage decisions</a:t>
            </a:r>
          </a:p>
          <a:p>
            <a:r>
              <a:rPr lang="en-US" dirty="0"/>
              <a:t>Patients who can be considered for acceptance into ED observation unit include:</a:t>
            </a:r>
          </a:p>
          <a:p>
            <a:pPr lvl="1"/>
            <a:r>
              <a:rPr lang="en-US" dirty="0"/>
              <a:t>Patients with mild to moderate alcohol withdrawal who are stable after appropriate ED initial management</a:t>
            </a:r>
          </a:p>
          <a:p>
            <a:pPr lvl="1"/>
            <a:r>
              <a:rPr lang="en-US" dirty="0"/>
              <a:t>CIWA 8-16</a:t>
            </a:r>
            <a:endParaRPr lang="en-US" dirty="0">
              <a:cs typeface="Arial"/>
            </a:endParaRPr>
          </a:p>
          <a:p>
            <a:pPr lvl="1"/>
            <a:r>
              <a:rPr lang="en-US" dirty="0"/>
              <a:t>Blood Alcohol Content (BAC) &lt;100 mg/dL </a:t>
            </a:r>
          </a:p>
          <a:p>
            <a:pPr lvl="1"/>
            <a:r>
              <a:rPr lang="en-US" dirty="0"/>
              <a:t>ED dosage of:</a:t>
            </a:r>
          </a:p>
          <a:p>
            <a:pPr lvl="2"/>
            <a:r>
              <a:rPr lang="en-US" dirty="0"/>
              <a:t> &lt;40mg of diazepam over 1 hour and/or &lt; 80mg over 6 hours</a:t>
            </a:r>
          </a:p>
          <a:p>
            <a:pPr lvl="2"/>
            <a:r>
              <a:rPr lang="en-US" dirty="0"/>
              <a:t>&lt;100mg of Librium in 1 hour and/or &lt;300mg over 3 hours</a:t>
            </a:r>
          </a:p>
          <a:p>
            <a:pPr lvl="1"/>
            <a:r>
              <a:rPr lang="en-US" dirty="0"/>
              <a:t>Patients with low-acuity medical co morbidities</a:t>
            </a:r>
            <a:endParaRPr lang="en-US" dirty="0">
              <a:cs typeface="Arial"/>
            </a:endParaRPr>
          </a:p>
          <a:p>
            <a:endParaRPr lang="en-US" dirty="0"/>
          </a:p>
        </p:txBody>
      </p:sp>
      <p:sp>
        <p:nvSpPr>
          <p:cNvPr id="9" name="Title 8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riage Decision</a:t>
            </a:r>
          </a:p>
        </p:txBody>
      </p:sp>
    </p:spTree>
    <p:extLst>
      <p:ext uri="{BB962C8B-B14F-4D97-AF65-F5344CB8AC3E}">
        <p14:creationId xmlns:p14="http://schemas.microsoft.com/office/powerpoint/2010/main" val="314954682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Footer Placeholder 5"/>
          <p:cNvSpPr>
            <a:spLocks noGrp="1"/>
          </p:cNvSpPr>
          <p:nvPr>
            <p:ph type="ftr" sz="quarter" idx="3"/>
          </p:nvPr>
        </p:nvSpPr>
        <p:spPr/>
        <p:txBody>
          <a:bodyPr/>
          <a:lstStyle/>
          <a:p>
            <a:r>
              <a:rPr lang="en-US" dirty="0"/>
              <a:t>NYU Perelman Department of Emergency Medicine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7FEEEA1A-CB49-3744-AA40-B896987410F9}" type="slidenum">
              <a:rPr lang="en-US" smtClean="0"/>
              <a:pPr/>
              <a:t>8</a:t>
            </a:fld>
            <a:endParaRPr lang="en-US" dirty="0"/>
          </a:p>
        </p:txBody>
      </p:sp>
      <p:sp>
        <p:nvSpPr>
          <p:cNvPr id="14" name="Content Placeholder 13"/>
          <p:cNvSpPr>
            <a:spLocks noGrp="1"/>
          </p:cNvSpPr>
          <p:nvPr>
            <p:ph sz="quarter" idx="10"/>
          </p:nvPr>
        </p:nvSpPr>
        <p:spPr/>
        <p:txBody>
          <a:bodyPr vert="horz" lIns="0" tIns="0" rIns="0" bIns="0" rtlCol="0" anchor="t">
            <a:normAutofit fontScale="92500" lnSpcReduction="20000"/>
          </a:bodyPr>
          <a:lstStyle/>
          <a:p>
            <a:r>
              <a:rPr lang="en-US" dirty="0"/>
              <a:t>Indications for early consultation of critical care on identification of AWS include</a:t>
            </a:r>
          </a:p>
          <a:p>
            <a:pPr lvl="1"/>
            <a:r>
              <a:rPr lang="en-US" dirty="0"/>
              <a:t>Patients with </a:t>
            </a:r>
          </a:p>
          <a:p>
            <a:pPr lvl="2"/>
            <a:r>
              <a:rPr lang="en-US" dirty="0"/>
              <a:t>Depressed mental status or airway/respiratory concerns</a:t>
            </a:r>
            <a:endParaRPr lang="en-US" dirty="0">
              <a:cs typeface="Arial"/>
            </a:endParaRPr>
          </a:p>
          <a:p>
            <a:pPr lvl="2"/>
            <a:r>
              <a:rPr lang="en-US" dirty="0"/>
              <a:t>Patients with alcohol withdrawal seizures</a:t>
            </a:r>
          </a:p>
          <a:p>
            <a:pPr lvl="2"/>
            <a:r>
              <a:rPr lang="en-US" dirty="0"/>
              <a:t>Significant co-morbid medical conditions including alcohol ketoacidosis, cardiopulmonary disease, uncontrolled diabetes, pancreatitis, sepsis, hepatic dysfunction</a:t>
            </a:r>
            <a:endParaRPr lang="en-US" dirty="0">
              <a:cs typeface="Arial"/>
            </a:endParaRPr>
          </a:p>
          <a:p>
            <a:pPr lvl="1"/>
            <a:r>
              <a:rPr lang="en-US" dirty="0"/>
              <a:t>CIWA-</a:t>
            </a:r>
            <a:r>
              <a:rPr lang="en-US" dirty="0" err="1"/>
              <a:t>Ar</a:t>
            </a:r>
            <a:r>
              <a:rPr lang="en-US" dirty="0"/>
              <a:t> &gt;20</a:t>
            </a:r>
          </a:p>
          <a:p>
            <a:pPr lvl="1"/>
            <a:r>
              <a:rPr lang="en-US" dirty="0"/>
              <a:t>BAC &gt;100 mg/dl</a:t>
            </a:r>
          </a:p>
          <a:p>
            <a:pPr lvl="1"/>
            <a:r>
              <a:rPr lang="en-US" dirty="0"/>
              <a:t>Patients with initial ED dosing of:</a:t>
            </a:r>
          </a:p>
          <a:p>
            <a:pPr lvl="2"/>
            <a:r>
              <a:rPr lang="en-US" dirty="0"/>
              <a:t>IV diazepam &gt;40 mg in 1 hour and/or &gt;80mg in 6 hours</a:t>
            </a:r>
            <a:endParaRPr lang="en-US" dirty="0">
              <a:cs typeface="Arial"/>
            </a:endParaRPr>
          </a:p>
          <a:p>
            <a:pPr lvl="2"/>
            <a:r>
              <a:rPr lang="en-US" dirty="0"/>
              <a:t>PO chlordiazepoxide &gt;100mg in 1 hour and/or &gt;300mg in 3 hours</a:t>
            </a:r>
            <a:endParaRPr lang="en-US" dirty="0">
              <a:cs typeface="Arial"/>
            </a:endParaRPr>
          </a:p>
          <a:p>
            <a:pPr lvl="1"/>
            <a:r>
              <a:rPr lang="en-US" dirty="0"/>
              <a:t>Patients with unchanged or worsening CIWA-</a:t>
            </a:r>
            <a:r>
              <a:rPr lang="en-US" dirty="0" err="1"/>
              <a:t>Ar</a:t>
            </a:r>
            <a:r>
              <a:rPr lang="en-US" dirty="0"/>
              <a:t> despite ED interventions</a:t>
            </a:r>
          </a:p>
          <a:p>
            <a:pPr lvl="1"/>
            <a:r>
              <a:rPr lang="en-US" dirty="0"/>
              <a:t>PO intolerance</a:t>
            </a:r>
          </a:p>
        </p:txBody>
      </p:sp>
      <p:sp>
        <p:nvSpPr>
          <p:cNvPr id="9" name="Title 8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ritical Care Indications</a:t>
            </a:r>
          </a:p>
        </p:txBody>
      </p:sp>
    </p:spTree>
    <p:extLst>
      <p:ext uri="{BB962C8B-B14F-4D97-AF65-F5344CB8AC3E}">
        <p14:creationId xmlns:p14="http://schemas.microsoft.com/office/powerpoint/2010/main" val="100203872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Footer Placeholder 5"/>
          <p:cNvSpPr>
            <a:spLocks noGrp="1"/>
          </p:cNvSpPr>
          <p:nvPr>
            <p:ph type="ftr" sz="quarter" idx="3"/>
          </p:nvPr>
        </p:nvSpPr>
        <p:spPr/>
        <p:txBody>
          <a:bodyPr/>
          <a:lstStyle/>
          <a:p>
            <a:r>
              <a:rPr lang="en-US" dirty="0"/>
              <a:t>NYU Perelman Department of Emergency Medicine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7FEEEA1A-CB49-3744-AA40-B896987410F9}" type="slidenum">
              <a:rPr lang="en-US" smtClean="0"/>
              <a:pPr/>
              <a:t>9</a:t>
            </a:fld>
            <a:endParaRPr lang="en-US" dirty="0"/>
          </a:p>
        </p:txBody>
      </p:sp>
      <p:sp>
        <p:nvSpPr>
          <p:cNvPr id="14" name="Content Placeholder 13"/>
          <p:cNvSpPr>
            <a:spLocks noGrp="1"/>
          </p:cNvSpPr>
          <p:nvPr>
            <p:ph sz="quarter" idx="10"/>
          </p:nvPr>
        </p:nvSpPr>
        <p:spPr/>
        <p:txBody>
          <a:bodyPr vert="horz" lIns="0" tIns="0" rIns="0" bIns="0" rtlCol="0" anchor="t">
            <a:normAutofit/>
          </a:bodyPr>
          <a:lstStyle/>
          <a:p>
            <a:r>
              <a:rPr lang="en-US" dirty="0"/>
              <a:t>Symptom-triggered therapy is recommended</a:t>
            </a:r>
          </a:p>
          <a:p>
            <a:pPr lvl="1"/>
            <a:r>
              <a:rPr lang="en-US" dirty="0"/>
              <a:t>More labor intensive than standing doses</a:t>
            </a:r>
            <a:endParaRPr lang="en-US" dirty="0">
              <a:cs typeface="Arial"/>
            </a:endParaRPr>
          </a:p>
          <a:p>
            <a:pPr lvl="1"/>
            <a:r>
              <a:rPr lang="en-US" dirty="0"/>
              <a:t>Improved outcomes in terms of complications, total dosage of medication, length of stay</a:t>
            </a:r>
            <a:endParaRPr lang="en-US" dirty="0">
              <a:cs typeface="Arial"/>
            </a:endParaRPr>
          </a:p>
          <a:p>
            <a:r>
              <a:rPr lang="en-US" dirty="0"/>
              <a:t>Oral therapy is preferred </a:t>
            </a:r>
            <a:endParaRPr lang="en-US">
              <a:cs typeface="Arial"/>
            </a:endParaRPr>
          </a:p>
          <a:p>
            <a:pPr lvl="1"/>
            <a:r>
              <a:rPr lang="en-US" dirty="0"/>
              <a:t>IV therapy may be indicated as initial dose</a:t>
            </a:r>
          </a:p>
          <a:p>
            <a:r>
              <a:rPr lang="en-US" dirty="0"/>
              <a:t>Recommendation is for use of chlordiazepoxide (slow onset of action, long duration of effect) for oral therapy and diazepam (rapid onset of action, long acting metabolites) for IV use</a:t>
            </a:r>
          </a:p>
          <a:p>
            <a:pPr lvl="1"/>
            <a:r>
              <a:rPr lang="en-US" dirty="0"/>
              <a:t>Lorazepam should be reserved for patients with severe hepatic dysfunction</a:t>
            </a:r>
          </a:p>
        </p:txBody>
      </p:sp>
      <p:sp>
        <p:nvSpPr>
          <p:cNvPr id="9" name="Title 8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General Management Guidelines</a:t>
            </a:r>
          </a:p>
        </p:txBody>
      </p:sp>
    </p:spTree>
    <p:extLst>
      <p:ext uri="{BB962C8B-B14F-4D97-AF65-F5344CB8AC3E}">
        <p14:creationId xmlns:p14="http://schemas.microsoft.com/office/powerpoint/2010/main" val="1203243255"/>
      </p:ext>
    </p:extLst>
  </p:cSld>
  <p:clrMapOvr>
    <a:masterClrMapping/>
  </p:clrMapOvr>
</p:sld>
</file>

<file path=ppt/theme/theme1.xml><?xml version="1.0" encoding="utf-8"?>
<a:theme xmlns:a="http://schemas.openxmlformats.org/drawingml/2006/main" name="NYU Theme">
  <a:themeElements>
    <a:clrScheme name="NYULangone">
      <a:dk1>
        <a:srgbClr val="000000"/>
      </a:dk1>
      <a:lt1>
        <a:srgbClr val="FFFFFF"/>
      </a:lt1>
      <a:dk2>
        <a:srgbClr val="4D4C47"/>
      </a:dk2>
      <a:lt2>
        <a:srgbClr val="EDEDEB"/>
      </a:lt2>
      <a:accent1>
        <a:srgbClr val="580F8B"/>
      </a:accent1>
      <a:accent2>
        <a:srgbClr val="EEA337"/>
      </a:accent2>
      <a:accent3>
        <a:srgbClr val="1C9AD6"/>
      </a:accent3>
      <a:accent4>
        <a:srgbClr val="F15B4E"/>
      </a:accent4>
      <a:accent5>
        <a:srgbClr val="49B6A2"/>
      </a:accent5>
      <a:accent6>
        <a:srgbClr val="99A6CA"/>
      </a:accent6>
      <a:hlink>
        <a:srgbClr val="F47A55"/>
      </a:hlink>
      <a:folHlink>
        <a:srgbClr val="167696"/>
      </a:folHlink>
    </a:clrScheme>
    <a:fontScheme name="NYULangone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effectLst/>
      </a:spPr>
      <a:bodyPr rtlCol="0" anchor="ctr"/>
      <a:lstStyle>
        <a:defPPr algn="ctr">
          <a:defRPr/>
        </a:defPPr>
      </a:lstStyle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NYU Theme" id="{D17D2AA5-9983-4B31-B4FF-AEA782B74FB6}" vid="{8D6FCC2C-8A40-4F0B-9840-BD5296428BDC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NYU Theme</Template>
  <TotalTime>451</TotalTime>
  <Words>1557</Words>
  <Application>Microsoft Macintosh PowerPoint</Application>
  <PresentationFormat>On-screen Show (4:3)</PresentationFormat>
  <Paragraphs>171</Paragraphs>
  <Slides>14</Slides>
  <Notes>1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8" baseType="lpstr">
      <vt:lpstr>Arial</vt:lpstr>
      <vt:lpstr>Calibri</vt:lpstr>
      <vt:lpstr>Lucida Grande</vt:lpstr>
      <vt:lpstr>NYU Theme</vt:lpstr>
      <vt:lpstr>Emergency Department Observation Unit Management of Alcohol Withdrawal</vt:lpstr>
      <vt:lpstr>Epidemiology of Alcohol Withdrawal</vt:lpstr>
      <vt:lpstr>Pathophysiology of Alcohol Withdrawal</vt:lpstr>
      <vt:lpstr>Clinical Presentation and Course</vt:lpstr>
      <vt:lpstr>Initial Approach and Risk Stratification</vt:lpstr>
      <vt:lpstr>CIWA-Ar Scoring</vt:lpstr>
      <vt:lpstr>Triage Decision</vt:lpstr>
      <vt:lpstr>Critical Care Indications</vt:lpstr>
      <vt:lpstr>General Management Guidelines</vt:lpstr>
      <vt:lpstr>Management of Mild AWS in the ED Observation Unit</vt:lpstr>
      <vt:lpstr>Consideration of Escalation in Level of Care</vt:lpstr>
      <vt:lpstr>Indication for Toxicology Consultation</vt:lpstr>
      <vt:lpstr>Treatment Endpoint</vt:lpstr>
      <vt:lpstr>References</vt:lpstr>
    </vt:vector>
  </TitlesOfParts>
  <Company>NYU Langone Medical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tion title in this area</dc:title>
  <dc:creator>Mccarty, Matthew</dc:creator>
  <cp:lastModifiedBy>Alisa Wray</cp:lastModifiedBy>
  <cp:revision>110</cp:revision>
  <dcterms:created xsi:type="dcterms:W3CDTF">2019-01-16T15:42:18Z</dcterms:created>
  <dcterms:modified xsi:type="dcterms:W3CDTF">2021-04-12T19:12:12Z</dcterms:modified>
</cp:coreProperties>
</file>